
<file path=[Content_Types].xml><?xml version="1.0" encoding="utf-8"?>
<Types xmlns="http://schemas.openxmlformats.org/package/2006/content-types">
  <Default Extension="bin" ContentType="application/vnd.openxmlformats-officedocument.oleObject"/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4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4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5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5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5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5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5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5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5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charts/chart5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charts/chart5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charts/chart5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ppt/charts/chart60.xml" ContentType="application/vnd.openxmlformats-officedocument.drawingml.chart+xml"/>
  <Override PartName="/ppt/charts/style40.xml" ContentType="application/vnd.ms-office.chartstyle+xml"/>
  <Override PartName="/ppt/charts/colors40.xml" ContentType="application/vnd.ms-office.chartcolorstyle+xml"/>
  <Override PartName="/ppt/charts/chart61.xml" ContentType="application/vnd.openxmlformats-officedocument.drawingml.chart+xml"/>
  <Override PartName="/ppt/charts/style41.xml" ContentType="application/vnd.ms-office.chartstyle+xml"/>
  <Override PartName="/ppt/charts/colors41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1" r:id="rId2"/>
    <p:sldId id="256" r:id="rId3"/>
    <p:sldId id="258" r:id="rId4"/>
    <p:sldId id="257" r:id="rId5"/>
    <p:sldId id="259" r:id="rId6"/>
    <p:sldId id="260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81" autoAdjust="0"/>
    <p:restoredTop sz="94660"/>
  </p:normalViewPr>
  <p:slideViewPr>
    <p:cSldViewPr snapToGrid="0">
      <p:cViewPr varScale="1">
        <p:scale>
          <a:sx n="61" d="100"/>
          <a:sy n="61" d="100"/>
        </p:scale>
        <p:origin x="23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7\%231617%20%20%20%20&#12467;&#12495;&#12463;&#37240;&#12398;&#21177;&#26524;&#12288;&#12288;2025.8.8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b6458cc994763cb2/&#12487;&#12473;&#12463;&#12488;&#12483;&#12503;/&#20182;&#12398;&#20808;&#29983;&#26041;&#12398;&#12487;&#12540;&#12479;/&#12495;&#34892;/&#21407;&#30000;/&#35542;&#25991;/&#21407;&#30000;&#35542;&#25991;&#65298;/&#12464;&#12521;&#12501;&#20184;&#12365;.xlsx" TargetMode="External"/></Relationships>
</file>

<file path=ppt/charts/_rels/chart4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4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4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5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5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5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5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5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5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5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7.xml"/><Relationship Id="rId1" Type="http://schemas.microsoft.com/office/2011/relationships/chartStyle" Target="style37.xml"/></Relationships>
</file>

<file path=ppt/charts/_rels/chart5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8.xml"/><Relationship Id="rId1" Type="http://schemas.microsoft.com/office/2011/relationships/chartStyle" Target="style38.xml"/></Relationships>
</file>

<file path=ppt/charts/_rels/chart5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39.xml"/><Relationship Id="rId1" Type="http://schemas.microsoft.com/office/2011/relationships/chartStyle" Target="style39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6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Mirror\&#12487;&#12540;&#12479;\&#22338;&#19978;&#12398;&#12487;&#12540;&#12479;\&#23455;&#39443;&#12487;&#12540;&#12479;\2025&#24180;\%231614\%231614%20%202025-7-23.xlsx" TargetMode="External"/><Relationship Id="rId2" Type="http://schemas.microsoft.com/office/2011/relationships/chartColorStyle" Target="colors40.xml"/><Relationship Id="rId1" Type="http://schemas.microsoft.com/office/2011/relationships/chartStyle" Target="style40.xml"/></Relationships>
</file>

<file path=ppt/charts/_rels/chart6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41.xml"/><Relationship Id="rId1" Type="http://schemas.microsoft.com/office/2011/relationships/chartStyle" Target="style41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6458cc994763cb2/&#12487;&#12473;&#12463;&#12488;&#12483;&#12503;/&#22338;&#19978;&#12398;&#12487;&#12540;&#12479;/&#23455;&#39443;&#12487;&#12540;&#12479;/2025&#24180;/%5eN1610%20(H%5eN1)/Harada%202025.04.30%5eLN1%20(1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4.2083333333333355E-2"/>
          <c:w val="0.87122462817147861"/>
          <c:h val="0.84646580635753865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AQ$54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58:$BA$58</c:f>
                <c:numCache>
                  <c:formatCode>General</c:formatCode>
                  <c:ptCount val="10"/>
                  <c:pt idx="0">
                    <c:v>4.4185828941756267E-2</c:v>
                  </c:pt>
                  <c:pt idx="1">
                    <c:v>3.6449233433866565E-2</c:v>
                  </c:pt>
                  <c:pt idx="2">
                    <c:v>2.9792661580507192E-2</c:v>
                  </c:pt>
                  <c:pt idx="3">
                    <c:v>4.1239295143469558E-2</c:v>
                  </c:pt>
                  <c:pt idx="4">
                    <c:v>2.7602954050258224E-2</c:v>
                  </c:pt>
                  <c:pt idx="5">
                    <c:v>2.9099330760677441E-2</c:v>
                  </c:pt>
                  <c:pt idx="6">
                    <c:v>4.86274638481985E-2</c:v>
                  </c:pt>
                  <c:pt idx="7">
                    <c:v>1.0588814968432376E-2</c:v>
                  </c:pt>
                  <c:pt idx="8">
                    <c:v>4.2468812749059436E-3</c:v>
                  </c:pt>
                  <c:pt idx="9">
                    <c:v>3.5517126293482019E-3</c:v>
                  </c:pt>
                </c:numCache>
              </c:numRef>
            </c:plus>
            <c:minus>
              <c:numRef>
                <c:f>'[^N1610.2025.04.30.xlsx]計算'!$AR$58:$BA$58</c:f>
                <c:numCache>
                  <c:formatCode>General</c:formatCode>
                  <c:ptCount val="10"/>
                  <c:pt idx="0">
                    <c:v>4.4185828941756267E-2</c:v>
                  </c:pt>
                  <c:pt idx="1">
                    <c:v>3.6449233433866565E-2</c:v>
                  </c:pt>
                  <c:pt idx="2">
                    <c:v>2.9792661580507192E-2</c:v>
                  </c:pt>
                  <c:pt idx="3">
                    <c:v>4.1239295143469558E-2</c:v>
                  </c:pt>
                  <c:pt idx="4">
                    <c:v>2.7602954050258224E-2</c:v>
                  </c:pt>
                  <c:pt idx="5">
                    <c:v>2.9099330760677441E-2</c:v>
                  </c:pt>
                  <c:pt idx="6">
                    <c:v>4.86274638481985E-2</c:v>
                  </c:pt>
                  <c:pt idx="7">
                    <c:v>1.0588814968432376E-2</c:v>
                  </c:pt>
                  <c:pt idx="8">
                    <c:v>4.2468812749059436E-3</c:v>
                  </c:pt>
                  <c:pt idx="9">
                    <c:v>3.551712629348201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3:$BA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AR$54:$BA$54</c:f>
              <c:numCache>
                <c:formatCode>General</c:formatCode>
                <c:ptCount val="10"/>
                <c:pt idx="0">
                  <c:v>0.25365000342329341</c:v>
                </c:pt>
                <c:pt idx="1">
                  <c:v>0.50394999856750167</c:v>
                </c:pt>
                <c:pt idx="2">
                  <c:v>0.45643333469827968</c:v>
                </c:pt>
                <c:pt idx="3">
                  <c:v>0.41170000409086543</c:v>
                </c:pt>
                <c:pt idx="4">
                  <c:v>0.41056667144099873</c:v>
                </c:pt>
                <c:pt idx="5">
                  <c:v>0.32435000315308571</c:v>
                </c:pt>
                <c:pt idx="6">
                  <c:v>0.25726666425665218</c:v>
                </c:pt>
                <c:pt idx="7">
                  <c:v>8.2349999497334167E-2</c:v>
                </c:pt>
                <c:pt idx="8">
                  <c:v>2.2699999312559765E-2</c:v>
                </c:pt>
                <c:pt idx="9">
                  <c:v>4.0333333114782972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7CB-41CA-AFA8-E37E52B38FF0}"/>
            </c:ext>
          </c:extLst>
        </c:ser>
        <c:ser>
          <c:idx val="1"/>
          <c:order val="1"/>
          <c:tx>
            <c:strRef>
              <c:f>'[^N1610.2025.04.30.xlsx]計算'!$AQ$55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59:$BA$59</c:f>
                <c:numCache>
                  <c:formatCode>General</c:formatCode>
                  <c:ptCount val="10"/>
                  <c:pt idx="0">
                    <c:v>3.8782903016991513E-2</c:v>
                  </c:pt>
                  <c:pt idx="1">
                    <c:v>2.7704922464978594E-2</c:v>
                  </c:pt>
                  <c:pt idx="2">
                    <c:v>4.7356253345765965E-2</c:v>
                  </c:pt>
                  <c:pt idx="3">
                    <c:v>2.6905091088019997E-2</c:v>
                  </c:pt>
                  <c:pt idx="4">
                    <c:v>1.8901647472945423E-2</c:v>
                  </c:pt>
                  <c:pt idx="5">
                    <c:v>3.8918640380138543E-2</c:v>
                  </c:pt>
                  <c:pt idx="6">
                    <c:v>3.1419217837122503E-2</c:v>
                  </c:pt>
                  <c:pt idx="7">
                    <c:v>1.5571769803722574E-2</c:v>
                  </c:pt>
                  <c:pt idx="8">
                    <c:v>2.5018004556937581E-3</c:v>
                  </c:pt>
                  <c:pt idx="9">
                    <c:v>6.3691935864993744E-4</c:v>
                  </c:pt>
                </c:numCache>
              </c:numRef>
            </c:plus>
            <c:minus>
              <c:numRef>
                <c:f>'[^N1610.2025.04.30.xlsx]計算'!$AR$59:$BA$59</c:f>
                <c:numCache>
                  <c:formatCode>General</c:formatCode>
                  <c:ptCount val="10"/>
                  <c:pt idx="0">
                    <c:v>3.8782903016991513E-2</c:v>
                  </c:pt>
                  <c:pt idx="1">
                    <c:v>2.7704922464978594E-2</c:v>
                  </c:pt>
                  <c:pt idx="2">
                    <c:v>4.7356253345765965E-2</c:v>
                  </c:pt>
                  <c:pt idx="3">
                    <c:v>2.6905091088019997E-2</c:v>
                  </c:pt>
                  <c:pt idx="4">
                    <c:v>1.8901647472945423E-2</c:v>
                  </c:pt>
                  <c:pt idx="5">
                    <c:v>3.8918640380138543E-2</c:v>
                  </c:pt>
                  <c:pt idx="6">
                    <c:v>3.1419217837122503E-2</c:v>
                  </c:pt>
                  <c:pt idx="7">
                    <c:v>1.5571769803722574E-2</c:v>
                  </c:pt>
                  <c:pt idx="8">
                    <c:v>2.5018004556937581E-3</c:v>
                  </c:pt>
                  <c:pt idx="9">
                    <c:v>6.3691935864993744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3:$BA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AR$55:$BA$55</c:f>
              <c:numCache>
                <c:formatCode>General</c:formatCode>
                <c:ptCount val="10"/>
                <c:pt idx="0">
                  <c:v>0.31251666819055873</c:v>
                </c:pt>
                <c:pt idx="1">
                  <c:v>0.57883334035674727</c:v>
                </c:pt>
                <c:pt idx="2">
                  <c:v>0.55083332334955537</c:v>
                </c:pt>
                <c:pt idx="3">
                  <c:v>0.4766000049809615</c:v>
                </c:pt>
                <c:pt idx="4">
                  <c:v>0.46350000674525899</c:v>
                </c:pt>
                <c:pt idx="5">
                  <c:v>0.40570000186562538</c:v>
                </c:pt>
                <c:pt idx="6">
                  <c:v>0.2708500015238921</c:v>
                </c:pt>
                <c:pt idx="7">
                  <c:v>0.1307000033557415</c:v>
                </c:pt>
                <c:pt idx="8">
                  <c:v>4.1450001299381256E-2</c:v>
                </c:pt>
                <c:pt idx="9">
                  <c:v>3.0833339939514794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7CB-41CA-AFA8-E37E52B38FF0}"/>
            </c:ext>
          </c:extLst>
        </c:ser>
        <c:ser>
          <c:idx val="2"/>
          <c:order val="2"/>
          <c:tx>
            <c:strRef>
              <c:f>'[^N1610.2025.04.30.xlsx]計算'!$AQ$56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60:$BA$60</c:f>
                <c:numCache>
                  <c:formatCode>General</c:formatCode>
                  <c:ptCount val="10"/>
                  <c:pt idx="0">
                    <c:v>2.8182955742181548E-2</c:v>
                  </c:pt>
                  <c:pt idx="1">
                    <c:v>2.8015781303286434E-2</c:v>
                  </c:pt>
                  <c:pt idx="2">
                    <c:v>2.7085900856351656E-2</c:v>
                  </c:pt>
                  <c:pt idx="3">
                    <c:v>2.8873348439803423E-2</c:v>
                  </c:pt>
                  <c:pt idx="4">
                    <c:v>6.0417980705614181E-2</c:v>
                  </c:pt>
                  <c:pt idx="5">
                    <c:v>3.2727870577580302E-2</c:v>
                  </c:pt>
                  <c:pt idx="6">
                    <c:v>1.9495500619944397E-2</c:v>
                  </c:pt>
                  <c:pt idx="7">
                    <c:v>1.3811124674150943E-2</c:v>
                  </c:pt>
                  <c:pt idx="8">
                    <c:v>5.5211103200099483E-3</c:v>
                  </c:pt>
                  <c:pt idx="9">
                    <c:v>1.3441234245706582E-3</c:v>
                  </c:pt>
                </c:numCache>
              </c:numRef>
            </c:plus>
            <c:minus>
              <c:numRef>
                <c:f>'[^N1610.2025.04.30.xlsx]計算'!$AR$60:$BA$60</c:f>
                <c:numCache>
                  <c:formatCode>General</c:formatCode>
                  <c:ptCount val="10"/>
                  <c:pt idx="0">
                    <c:v>2.8182955742181548E-2</c:v>
                  </c:pt>
                  <c:pt idx="1">
                    <c:v>2.8015781303286434E-2</c:v>
                  </c:pt>
                  <c:pt idx="2">
                    <c:v>2.7085900856351656E-2</c:v>
                  </c:pt>
                  <c:pt idx="3">
                    <c:v>2.8873348439803423E-2</c:v>
                  </c:pt>
                  <c:pt idx="4">
                    <c:v>6.0417980705614181E-2</c:v>
                  </c:pt>
                  <c:pt idx="5">
                    <c:v>3.2727870577580302E-2</c:v>
                  </c:pt>
                  <c:pt idx="6">
                    <c:v>1.9495500619944397E-2</c:v>
                  </c:pt>
                  <c:pt idx="7">
                    <c:v>1.3811124674150943E-2</c:v>
                  </c:pt>
                  <c:pt idx="8">
                    <c:v>5.5211103200099483E-3</c:v>
                  </c:pt>
                  <c:pt idx="9">
                    <c:v>1.344123424570658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3:$BA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AR$56:$BA$56</c:f>
              <c:numCache>
                <c:formatCode>General</c:formatCode>
                <c:ptCount val="10"/>
                <c:pt idx="0">
                  <c:v>0.37074999387065571</c:v>
                </c:pt>
                <c:pt idx="1">
                  <c:v>0.70070000862081849</c:v>
                </c:pt>
                <c:pt idx="2">
                  <c:v>0.64833332474033034</c:v>
                </c:pt>
                <c:pt idx="3">
                  <c:v>0.6074333327511946</c:v>
                </c:pt>
                <c:pt idx="4">
                  <c:v>0.5699499982098738</c:v>
                </c:pt>
                <c:pt idx="5">
                  <c:v>0.4604833262662093</c:v>
                </c:pt>
                <c:pt idx="6">
                  <c:v>0.34323333079616231</c:v>
                </c:pt>
                <c:pt idx="7">
                  <c:v>0.19094999755422273</c:v>
                </c:pt>
                <c:pt idx="8">
                  <c:v>9.0433333069086075E-2</c:v>
                </c:pt>
                <c:pt idx="9">
                  <c:v>2.1333321928977966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7CB-41CA-AFA8-E37E52B38FF0}"/>
            </c:ext>
          </c:extLst>
        </c:ser>
        <c:ser>
          <c:idx val="3"/>
          <c:order val="3"/>
          <c:tx>
            <c:strRef>
              <c:f>'[^N1610.2025.04.30.xlsx]計算'!$AQ$57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61:$BA$61</c:f>
                <c:numCache>
                  <c:formatCode>General</c:formatCode>
                  <c:ptCount val="10"/>
                  <c:pt idx="0">
                    <c:v>3.2274174187268898E-2</c:v>
                  </c:pt>
                  <c:pt idx="1">
                    <c:v>5.4039965174576744E-2</c:v>
                  </c:pt>
                  <c:pt idx="2">
                    <c:v>5.2104925274853137E-2</c:v>
                  </c:pt>
                  <c:pt idx="3">
                    <c:v>6.0502802051744395E-2</c:v>
                  </c:pt>
                  <c:pt idx="4">
                    <c:v>5.8834754101209849E-2</c:v>
                  </c:pt>
                  <c:pt idx="5">
                    <c:v>1.8805595696771944E-2</c:v>
                  </c:pt>
                  <c:pt idx="6">
                    <c:v>1.8255694422299018E-2</c:v>
                  </c:pt>
                  <c:pt idx="7">
                    <c:v>1.9581797759077028E-2</c:v>
                  </c:pt>
                  <c:pt idx="8">
                    <c:v>9.0143787443487423E-3</c:v>
                  </c:pt>
                  <c:pt idx="9">
                    <c:v>1.7798874179593984E-3</c:v>
                  </c:pt>
                </c:numCache>
              </c:numRef>
            </c:plus>
            <c:minus>
              <c:numRef>
                <c:f>'[^N1610.2025.04.30.xlsx]計算'!$AR$61:$BA$61</c:f>
                <c:numCache>
                  <c:formatCode>General</c:formatCode>
                  <c:ptCount val="10"/>
                  <c:pt idx="0">
                    <c:v>3.2274174187268898E-2</c:v>
                  </c:pt>
                  <c:pt idx="1">
                    <c:v>5.4039965174576744E-2</c:v>
                  </c:pt>
                  <c:pt idx="2">
                    <c:v>5.2104925274853137E-2</c:v>
                  </c:pt>
                  <c:pt idx="3">
                    <c:v>6.0502802051744395E-2</c:v>
                  </c:pt>
                  <c:pt idx="4">
                    <c:v>5.8834754101209849E-2</c:v>
                  </c:pt>
                  <c:pt idx="5">
                    <c:v>1.8805595696771944E-2</c:v>
                  </c:pt>
                  <c:pt idx="6">
                    <c:v>1.8255694422299018E-2</c:v>
                  </c:pt>
                  <c:pt idx="7">
                    <c:v>1.9581797759077028E-2</c:v>
                  </c:pt>
                  <c:pt idx="8">
                    <c:v>9.0143787443487423E-3</c:v>
                  </c:pt>
                  <c:pt idx="9">
                    <c:v>1.779887417959398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3:$BA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AR$57:$BA$57</c:f>
              <c:numCache>
                <c:formatCode>General</c:formatCode>
                <c:ptCount val="10"/>
                <c:pt idx="0">
                  <c:v>0.43993333478768665</c:v>
                </c:pt>
                <c:pt idx="1">
                  <c:v>0.80558332304159797</c:v>
                </c:pt>
                <c:pt idx="2">
                  <c:v>0.73815000553925836</c:v>
                </c:pt>
                <c:pt idx="3">
                  <c:v>0.68358334402243293</c:v>
                </c:pt>
                <c:pt idx="4">
                  <c:v>0.66079999506473541</c:v>
                </c:pt>
                <c:pt idx="5">
                  <c:v>0.61695000032583869</c:v>
                </c:pt>
                <c:pt idx="6">
                  <c:v>0.46356667081514996</c:v>
                </c:pt>
                <c:pt idx="7">
                  <c:v>0.28305000066757202</c:v>
                </c:pt>
                <c:pt idx="8">
                  <c:v>0.16654999802509943</c:v>
                </c:pt>
                <c:pt idx="9">
                  <c:v>-2.7000010013580322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7CB-41CA-AFA8-E37E52B38F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3330239"/>
        <c:axId val="743331679"/>
      </c:lineChart>
      <c:catAx>
        <c:axId val="7433302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3331679"/>
        <c:crosses val="autoZero"/>
        <c:auto val="1"/>
        <c:lblAlgn val="ctr"/>
        <c:lblOffset val="100"/>
        <c:noMultiLvlLbl val="0"/>
      </c:catAx>
      <c:valAx>
        <c:axId val="743331679"/>
        <c:scaling>
          <c:orientation val="minMax"/>
          <c:max val="0.85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3330239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Harada 2025.04.30^LN1 (1).xlsx]計算'!$AP$149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53:$AZ$153</c:f>
                <c:numCache>
                  <c:formatCode>General</c:formatCode>
                  <c:ptCount val="10"/>
                  <c:pt idx="0">
                    <c:v>1.5818683742323373E-2</c:v>
                  </c:pt>
                  <c:pt idx="1">
                    <c:v>1.6555605300787934E-2</c:v>
                  </c:pt>
                  <c:pt idx="2">
                    <c:v>1.0464559221512961E-2</c:v>
                  </c:pt>
                  <c:pt idx="3">
                    <c:v>3.6112104323356341E-2</c:v>
                  </c:pt>
                  <c:pt idx="4">
                    <c:v>1.3985367903634326E-2</c:v>
                  </c:pt>
                  <c:pt idx="5">
                    <c:v>2.9625350059864681E-2</c:v>
                  </c:pt>
                  <c:pt idx="6">
                    <c:v>5.0796047709951699E-2</c:v>
                  </c:pt>
                  <c:pt idx="7">
                    <c:v>3.7151400725270359E-2</c:v>
                  </c:pt>
                  <c:pt idx="8">
                    <c:v>2.6887444154655039E-2</c:v>
                  </c:pt>
                  <c:pt idx="9">
                    <c:v>3.4107149174022008E-2</c:v>
                  </c:pt>
                </c:numCache>
              </c:numRef>
            </c:plus>
            <c:minus>
              <c:numRef>
                <c:f>'[Harada 2025.04.30^LN1 (1).xlsx]計算'!$AQ$153:$AZ$153</c:f>
                <c:numCache>
                  <c:formatCode>General</c:formatCode>
                  <c:ptCount val="10"/>
                  <c:pt idx="0">
                    <c:v>1.5818683742323373E-2</c:v>
                  </c:pt>
                  <c:pt idx="1">
                    <c:v>1.6555605300787934E-2</c:v>
                  </c:pt>
                  <c:pt idx="2">
                    <c:v>1.0464559221512961E-2</c:v>
                  </c:pt>
                  <c:pt idx="3">
                    <c:v>3.6112104323356341E-2</c:v>
                  </c:pt>
                  <c:pt idx="4">
                    <c:v>1.3985367903634326E-2</c:v>
                  </c:pt>
                  <c:pt idx="5">
                    <c:v>2.9625350059864681E-2</c:v>
                  </c:pt>
                  <c:pt idx="6">
                    <c:v>5.0796047709951699E-2</c:v>
                  </c:pt>
                  <c:pt idx="7">
                    <c:v>3.7151400725270359E-2</c:v>
                  </c:pt>
                  <c:pt idx="8">
                    <c:v>2.6887444154655039E-2</c:v>
                  </c:pt>
                  <c:pt idx="9">
                    <c:v>3.41071491740220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48:$AZ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AQ$149:$AZ$149</c:f>
              <c:numCache>
                <c:formatCode>General</c:formatCode>
                <c:ptCount val="10"/>
                <c:pt idx="0">
                  <c:v>0.14666666959722838</c:v>
                </c:pt>
                <c:pt idx="1">
                  <c:v>0.16569999977946281</c:v>
                </c:pt>
                <c:pt idx="2">
                  <c:v>0.18624999498327574</c:v>
                </c:pt>
                <c:pt idx="3">
                  <c:v>0.22310000113745532</c:v>
                </c:pt>
                <c:pt idx="4">
                  <c:v>0.21506666516264281</c:v>
                </c:pt>
                <c:pt idx="5">
                  <c:v>0.22188333297769228</c:v>
                </c:pt>
                <c:pt idx="6">
                  <c:v>0.22873332972327867</c:v>
                </c:pt>
                <c:pt idx="7">
                  <c:v>0.24664999917149544</c:v>
                </c:pt>
                <c:pt idx="8">
                  <c:v>0.22693332905570665</c:v>
                </c:pt>
                <c:pt idx="9">
                  <c:v>7.271666576464970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22B-4886-AA33-5E367498D159}"/>
            </c:ext>
          </c:extLst>
        </c:ser>
        <c:ser>
          <c:idx val="1"/>
          <c:order val="1"/>
          <c:tx>
            <c:strRef>
              <c:f>'[Harada 2025.04.30^LN1 (1).xlsx]計算'!$AP$150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54:$AZ$154</c:f>
                <c:numCache>
                  <c:formatCode>General</c:formatCode>
                  <c:ptCount val="10"/>
                  <c:pt idx="0">
                    <c:v>8.7723234323919923E-3</c:v>
                  </c:pt>
                  <c:pt idx="1">
                    <c:v>1.5288259170662045E-2</c:v>
                  </c:pt>
                  <c:pt idx="2">
                    <c:v>1.9895321961957761E-2</c:v>
                  </c:pt>
                  <c:pt idx="3">
                    <c:v>1.9839502523073708E-2</c:v>
                  </c:pt>
                  <c:pt idx="4">
                    <c:v>1.6207859164261318E-2</c:v>
                  </c:pt>
                  <c:pt idx="5">
                    <c:v>2.4977544493099565E-2</c:v>
                  </c:pt>
                  <c:pt idx="6">
                    <c:v>4.2267579454535686E-2</c:v>
                  </c:pt>
                  <c:pt idx="7">
                    <c:v>3.2883640329575428E-2</c:v>
                  </c:pt>
                  <c:pt idx="8">
                    <c:v>2.598718966242862E-2</c:v>
                  </c:pt>
                  <c:pt idx="9">
                    <c:v>2.2518654641267875E-2</c:v>
                  </c:pt>
                </c:numCache>
              </c:numRef>
            </c:plus>
            <c:minus>
              <c:numRef>
                <c:f>'[Harada 2025.04.30^LN1 (1).xlsx]計算'!$AQ$154:$AZ$154</c:f>
                <c:numCache>
                  <c:formatCode>General</c:formatCode>
                  <c:ptCount val="10"/>
                  <c:pt idx="0">
                    <c:v>8.7723234323919923E-3</c:v>
                  </c:pt>
                  <c:pt idx="1">
                    <c:v>1.5288259170662045E-2</c:v>
                  </c:pt>
                  <c:pt idx="2">
                    <c:v>1.9895321961957761E-2</c:v>
                  </c:pt>
                  <c:pt idx="3">
                    <c:v>1.9839502523073708E-2</c:v>
                  </c:pt>
                  <c:pt idx="4">
                    <c:v>1.6207859164261318E-2</c:v>
                  </c:pt>
                  <c:pt idx="5">
                    <c:v>2.4977544493099565E-2</c:v>
                  </c:pt>
                  <c:pt idx="6">
                    <c:v>4.2267579454535686E-2</c:v>
                  </c:pt>
                  <c:pt idx="7">
                    <c:v>3.2883640329575428E-2</c:v>
                  </c:pt>
                  <c:pt idx="8">
                    <c:v>2.598718966242862E-2</c:v>
                  </c:pt>
                  <c:pt idx="9">
                    <c:v>2.25186546412678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48:$AZ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AQ$150:$AZ$150</c:f>
              <c:numCache>
                <c:formatCode>General</c:formatCode>
                <c:ptCount val="10"/>
                <c:pt idx="0">
                  <c:v>0.22161667173107466</c:v>
                </c:pt>
                <c:pt idx="1">
                  <c:v>0.25056666259964305</c:v>
                </c:pt>
                <c:pt idx="2">
                  <c:v>0.27399999027450878</c:v>
                </c:pt>
                <c:pt idx="3">
                  <c:v>0.27231666569908458</c:v>
                </c:pt>
                <c:pt idx="4">
                  <c:v>0.28083332503835362</c:v>
                </c:pt>
                <c:pt idx="5">
                  <c:v>0.28248333061734837</c:v>
                </c:pt>
                <c:pt idx="6">
                  <c:v>0.30019999668002129</c:v>
                </c:pt>
                <c:pt idx="7">
                  <c:v>0.28041666870315868</c:v>
                </c:pt>
                <c:pt idx="8">
                  <c:v>0.29358333473404247</c:v>
                </c:pt>
                <c:pt idx="9">
                  <c:v>0.202883329242467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22B-4886-AA33-5E367498D159}"/>
            </c:ext>
          </c:extLst>
        </c:ser>
        <c:ser>
          <c:idx val="2"/>
          <c:order val="2"/>
          <c:tx>
            <c:strRef>
              <c:f>'[Harada 2025.04.30^LN1 (1).xlsx]計算'!$AP$151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55:$AZ$155</c:f>
                <c:numCache>
                  <c:formatCode>General</c:formatCode>
                  <c:ptCount val="10"/>
                  <c:pt idx="0">
                    <c:v>1.9428163307362332E-2</c:v>
                  </c:pt>
                  <c:pt idx="1">
                    <c:v>1.948866507017695E-2</c:v>
                  </c:pt>
                  <c:pt idx="2">
                    <c:v>3.9604776331867632E-2</c:v>
                  </c:pt>
                  <c:pt idx="3">
                    <c:v>3.4343762596803003E-2</c:v>
                  </c:pt>
                  <c:pt idx="4">
                    <c:v>1.5696958699699708E-2</c:v>
                  </c:pt>
                  <c:pt idx="5">
                    <c:v>4.5422851531165084E-2</c:v>
                  </c:pt>
                  <c:pt idx="6">
                    <c:v>2.8063062122129834E-2</c:v>
                  </c:pt>
                  <c:pt idx="7">
                    <c:v>1.3457246855417477E-2</c:v>
                  </c:pt>
                  <c:pt idx="8">
                    <c:v>1.265471770442078E-2</c:v>
                  </c:pt>
                  <c:pt idx="9">
                    <c:v>2.4315679143208521E-2</c:v>
                  </c:pt>
                </c:numCache>
              </c:numRef>
            </c:plus>
            <c:minus>
              <c:numRef>
                <c:f>'[Harada 2025.04.30^LN1 (1).xlsx]計算'!$AQ$155:$AZ$155</c:f>
                <c:numCache>
                  <c:formatCode>General</c:formatCode>
                  <c:ptCount val="10"/>
                  <c:pt idx="0">
                    <c:v>1.9428163307362332E-2</c:v>
                  </c:pt>
                  <c:pt idx="1">
                    <c:v>1.948866507017695E-2</c:v>
                  </c:pt>
                  <c:pt idx="2">
                    <c:v>3.9604776331867632E-2</c:v>
                  </c:pt>
                  <c:pt idx="3">
                    <c:v>3.4343762596803003E-2</c:v>
                  </c:pt>
                  <c:pt idx="4">
                    <c:v>1.5696958699699708E-2</c:v>
                  </c:pt>
                  <c:pt idx="5">
                    <c:v>4.5422851531165084E-2</c:v>
                  </c:pt>
                  <c:pt idx="6">
                    <c:v>2.8063062122129834E-2</c:v>
                  </c:pt>
                  <c:pt idx="7">
                    <c:v>1.3457246855417477E-2</c:v>
                  </c:pt>
                  <c:pt idx="8">
                    <c:v>1.265471770442078E-2</c:v>
                  </c:pt>
                  <c:pt idx="9">
                    <c:v>2.43156791432085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48:$AZ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AQ$151:$AZ$151</c:f>
              <c:numCache>
                <c:formatCode>General</c:formatCode>
                <c:ptCount val="10"/>
                <c:pt idx="0">
                  <c:v>0.25071666389703751</c:v>
                </c:pt>
                <c:pt idx="1">
                  <c:v>0.30229999870061874</c:v>
                </c:pt>
                <c:pt idx="2">
                  <c:v>0.29094999780257541</c:v>
                </c:pt>
                <c:pt idx="3">
                  <c:v>0.31898333380619687</c:v>
                </c:pt>
                <c:pt idx="4">
                  <c:v>0.3203333392739296</c:v>
                </c:pt>
                <c:pt idx="5">
                  <c:v>0.31955000509818393</c:v>
                </c:pt>
                <c:pt idx="6">
                  <c:v>0.32124999910593033</c:v>
                </c:pt>
                <c:pt idx="7">
                  <c:v>0.30871666719516117</c:v>
                </c:pt>
                <c:pt idx="8">
                  <c:v>0.30918333182732266</c:v>
                </c:pt>
                <c:pt idx="9">
                  <c:v>0.225399998327096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22B-4886-AA33-5E367498D159}"/>
            </c:ext>
          </c:extLst>
        </c:ser>
        <c:ser>
          <c:idx val="3"/>
          <c:order val="3"/>
          <c:tx>
            <c:strRef>
              <c:f>'[Harada 2025.04.30^LN1 (1).xlsx]計算'!$AP$152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56:$AZ$156</c:f>
                <c:numCache>
                  <c:formatCode>General</c:formatCode>
                  <c:ptCount val="10"/>
                  <c:pt idx="0">
                    <c:v>3.2742881521120509E-2</c:v>
                  </c:pt>
                  <c:pt idx="1">
                    <c:v>3.8005616736955773E-2</c:v>
                  </c:pt>
                  <c:pt idx="2">
                    <c:v>2.6862424568566828E-2</c:v>
                  </c:pt>
                  <c:pt idx="3">
                    <c:v>4.3356196609603825E-2</c:v>
                  </c:pt>
                  <c:pt idx="4">
                    <c:v>2.1667307038876781E-2</c:v>
                  </c:pt>
                  <c:pt idx="5">
                    <c:v>2.5015406922191463E-2</c:v>
                  </c:pt>
                  <c:pt idx="6">
                    <c:v>4.5423544914918242E-2</c:v>
                  </c:pt>
                  <c:pt idx="7">
                    <c:v>2.7182242568891138E-2</c:v>
                  </c:pt>
                  <c:pt idx="8">
                    <c:v>2.3368188585272023E-2</c:v>
                  </c:pt>
                  <c:pt idx="9">
                    <c:v>2.1035562181564955E-2</c:v>
                  </c:pt>
                </c:numCache>
              </c:numRef>
            </c:plus>
            <c:minus>
              <c:numRef>
                <c:f>'[Harada 2025.04.30^LN1 (1).xlsx]計算'!$AQ$156:$AZ$156</c:f>
                <c:numCache>
                  <c:formatCode>General</c:formatCode>
                  <c:ptCount val="10"/>
                  <c:pt idx="0">
                    <c:v>3.2742881521120509E-2</c:v>
                  </c:pt>
                  <c:pt idx="1">
                    <c:v>3.8005616736955773E-2</c:v>
                  </c:pt>
                  <c:pt idx="2">
                    <c:v>2.6862424568566828E-2</c:v>
                  </c:pt>
                  <c:pt idx="3">
                    <c:v>4.3356196609603825E-2</c:v>
                  </c:pt>
                  <c:pt idx="4">
                    <c:v>2.1667307038876781E-2</c:v>
                  </c:pt>
                  <c:pt idx="5">
                    <c:v>2.5015406922191463E-2</c:v>
                  </c:pt>
                  <c:pt idx="6">
                    <c:v>4.5423544914918242E-2</c:v>
                  </c:pt>
                  <c:pt idx="7">
                    <c:v>2.7182242568891138E-2</c:v>
                  </c:pt>
                  <c:pt idx="8">
                    <c:v>2.3368188585272023E-2</c:v>
                  </c:pt>
                  <c:pt idx="9">
                    <c:v>2.10355621815649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48:$AZ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AQ$152:$AZ$152</c:f>
              <c:numCache>
                <c:formatCode>General</c:formatCode>
                <c:ptCount val="10"/>
                <c:pt idx="0">
                  <c:v>0.36759999394416809</c:v>
                </c:pt>
                <c:pt idx="1">
                  <c:v>0.41146667301654816</c:v>
                </c:pt>
                <c:pt idx="2">
                  <c:v>0.40098333358764648</c:v>
                </c:pt>
                <c:pt idx="3">
                  <c:v>0.41190000375111896</c:v>
                </c:pt>
                <c:pt idx="4">
                  <c:v>0.38489999373753864</c:v>
                </c:pt>
                <c:pt idx="5">
                  <c:v>0.40376666684945423</c:v>
                </c:pt>
                <c:pt idx="6">
                  <c:v>0.40416666865348816</c:v>
                </c:pt>
                <c:pt idx="7">
                  <c:v>0.39063333471616107</c:v>
                </c:pt>
                <c:pt idx="8">
                  <c:v>0.42120000223318738</c:v>
                </c:pt>
                <c:pt idx="9">
                  <c:v>0.26976667344570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22B-4886-AA33-5E367498D1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8118672"/>
        <c:axId val="333745056"/>
      </c:lineChart>
      <c:catAx>
        <c:axId val="128118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3745056"/>
        <c:crosses val="autoZero"/>
        <c:auto val="1"/>
        <c:lblAlgn val="ctr"/>
        <c:lblOffset val="100"/>
        <c:noMultiLvlLbl val="0"/>
      </c:catAx>
      <c:valAx>
        <c:axId val="333745056"/>
        <c:scaling>
          <c:orientation val="minMax"/>
          <c:max val="0.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8118672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50" dirty="0"/>
              <a:t>Blank</a:t>
            </a:r>
            <a:endParaRPr lang="ja-JP" sz="1050" dirty="0"/>
          </a:p>
        </c:rich>
      </c:tx>
      <c:layout>
        <c:manualLayout>
          <c:xMode val="edge"/>
          <c:yMode val="edge"/>
          <c:x val="0.14450355951959906"/>
          <c:y val="5.61093690994955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2701183518675425E-2"/>
          <c:y val="8.2591498121887069E-2"/>
          <c:w val="0.37803727686017896"/>
          <c:h val="0.79625758322102302"/>
        </c:manualLayout>
      </c:layout>
      <c:lineChart>
        <c:grouping val="standard"/>
        <c:varyColors val="0"/>
        <c:ser>
          <c:idx val="0"/>
          <c:order val="0"/>
          <c:tx>
            <c:strRef>
              <c:f>'[Harada 2025.04.30^LN1 (1).xlsx]計算'!$AP$6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0:$AZ$10</c:f>
                <c:numCache>
                  <c:formatCode>General</c:formatCode>
                  <c:ptCount val="10"/>
                  <c:pt idx="0">
                    <c:v>1.2581679945915017E-2</c:v>
                  </c:pt>
                  <c:pt idx="1">
                    <c:v>4.499064401434083E-2</c:v>
                  </c:pt>
                  <c:pt idx="2">
                    <c:v>2.3250270407140883E-2</c:v>
                  </c:pt>
                  <c:pt idx="3">
                    <c:v>1.055412769927253E-2</c:v>
                  </c:pt>
                  <c:pt idx="4">
                    <c:v>3.0975641278137976E-2</c:v>
                  </c:pt>
                  <c:pt idx="5">
                    <c:v>4.8278995435894735E-2</c:v>
                  </c:pt>
                  <c:pt idx="6">
                    <c:v>2.3564013967011598E-2</c:v>
                  </c:pt>
                  <c:pt idx="7">
                    <c:v>2.0213523792581484E-2</c:v>
                  </c:pt>
                  <c:pt idx="8">
                    <c:v>3.0553131278827871E-2</c:v>
                  </c:pt>
                  <c:pt idx="9">
                    <c:v>3.9176186864992565E-2</c:v>
                  </c:pt>
                </c:numCache>
              </c:numRef>
            </c:plus>
            <c:minus>
              <c:numRef>
                <c:f>'[Harada 2025.04.30^LN1 (1).xlsx]計算'!$AQ$10:$AZ$10</c:f>
                <c:numCache>
                  <c:formatCode>General</c:formatCode>
                  <c:ptCount val="10"/>
                  <c:pt idx="0">
                    <c:v>1.2581679945915017E-2</c:v>
                  </c:pt>
                  <c:pt idx="1">
                    <c:v>4.499064401434083E-2</c:v>
                  </c:pt>
                  <c:pt idx="2">
                    <c:v>2.3250270407140883E-2</c:v>
                  </c:pt>
                  <c:pt idx="3">
                    <c:v>1.055412769927253E-2</c:v>
                  </c:pt>
                  <c:pt idx="4">
                    <c:v>3.0975641278137976E-2</c:v>
                  </c:pt>
                  <c:pt idx="5">
                    <c:v>4.8278995435894735E-2</c:v>
                  </c:pt>
                  <c:pt idx="6">
                    <c:v>2.3564013967011598E-2</c:v>
                  </c:pt>
                  <c:pt idx="7">
                    <c:v>2.0213523792581484E-2</c:v>
                  </c:pt>
                  <c:pt idx="8">
                    <c:v>3.0553131278827871E-2</c:v>
                  </c:pt>
                  <c:pt idx="9">
                    <c:v>3.917618686499256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:$AZ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Harada 2025.04.30^LN1 (1).xlsx]計算'!$AQ$6:$AZ$6</c:f>
              <c:numCache>
                <c:formatCode>General</c:formatCode>
                <c:ptCount val="10"/>
                <c:pt idx="0">
                  <c:v>0.20773332814375559</c:v>
                </c:pt>
                <c:pt idx="1">
                  <c:v>0.22131667286157608</c:v>
                </c:pt>
                <c:pt idx="2">
                  <c:v>0.27195000151793164</c:v>
                </c:pt>
                <c:pt idx="3">
                  <c:v>0.29241666197776794</c:v>
                </c:pt>
                <c:pt idx="4">
                  <c:v>0.27823333442211151</c:v>
                </c:pt>
                <c:pt idx="5">
                  <c:v>0.30508332947889966</c:v>
                </c:pt>
                <c:pt idx="6">
                  <c:v>0.27946667373180389</c:v>
                </c:pt>
                <c:pt idx="7">
                  <c:v>0.27473332981268567</c:v>
                </c:pt>
                <c:pt idx="8">
                  <c:v>0.24918333689371744</c:v>
                </c:pt>
                <c:pt idx="9">
                  <c:v>0.236083336174488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8EB-40BF-8FC8-8BE74B9D71FE}"/>
            </c:ext>
          </c:extLst>
        </c:ser>
        <c:ser>
          <c:idx val="1"/>
          <c:order val="1"/>
          <c:tx>
            <c:strRef>
              <c:f>'[Harada 2025.04.30^LN1 (1).xlsx]計算'!$AP$7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1:$AZ$11</c:f>
                <c:numCache>
                  <c:formatCode>General</c:formatCode>
                  <c:ptCount val="10"/>
                  <c:pt idx="0">
                    <c:v>3.8694789568000702E-2</c:v>
                  </c:pt>
                  <c:pt idx="1">
                    <c:v>1.681082590542287E-2</c:v>
                  </c:pt>
                  <c:pt idx="2">
                    <c:v>1.5411120587077221E-2</c:v>
                  </c:pt>
                  <c:pt idx="3">
                    <c:v>5.1724629112261993E-2</c:v>
                  </c:pt>
                  <c:pt idx="4">
                    <c:v>4.1494481056509852E-2</c:v>
                  </c:pt>
                  <c:pt idx="5">
                    <c:v>1.1341082714074E-2</c:v>
                  </c:pt>
                  <c:pt idx="6">
                    <c:v>3.1094336485078998E-2</c:v>
                  </c:pt>
                  <c:pt idx="7">
                    <c:v>2.8283758061026454E-2</c:v>
                  </c:pt>
                  <c:pt idx="8">
                    <c:v>3.239151726603838E-2</c:v>
                  </c:pt>
                  <c:pt idx="9">
                    <c:v>1.8357644452209974E-2</c:v>
                  </c:pt>
                </c:numCache>
              </c:numRef>
            </c:plus>
            <c:minus>
              <c:numRef>
                <c:f>'[Harada 2025.04.30^LN1 (1).xlsx]計算'!$AQ$11:$AZ$11</c:f>
                <c:numCache>
                  <c:formatCode>General</c:formatCode>
                  <c:ptCount val="10"/>
                  <c:pt idx="0">
                    <c:v>3.8694789568000702E-2</c:v>
                  </c:pt>
                  <c:pt idx="1">
                    <c:v>1.681082590542287E-2</c:v>
                  </c:pt>
                  <c:pt idx="2">
                    <c:v>1.5411120587077221E-2</c:v>
                  </c:pt>
                  <c:pt idx="3">
                    <c:v>5.1724629112261993E-2</c:v>
                  </c:pt>
                  <c:pt idx="4">
                    <c:v>4.1494481056509852E-2</c:v>
                  </c:pt>
                  <c:pt idx="5">
                    <c:v>1.1341082714074E-2</c:v>
                  </c:pt>
                  <c:pt idx="6">
                    <c:v>3.1094336485078998E-2</c:v>
                  </c:pt>
                  <c:pt idx="7">
                    <c:v>2.8283758061026454E-2</c:v>
                  </c:pt>
                  <c:pt idx="8">
                    <c:v>3.239151726603838E-2</c:v>
                  </c:pt>
                  <c:pt idx="9">
                    <c:v>1.83576444522099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:$AZ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Harada 2025.04.30^LN1 (1).xlsx]計算'!$AQ$7:$AZ$7</c:f>
              <c:numCache>
                <c:formatCode>General</c:formatCode>
                <c:ptCount val="10"/>
                <c:pt idx="0">
                  <c:v>0.29963333408037823</c:v>
                </c:pt>
                <c:pt idx="1">
                  <c:v>0.31370000044504803</c:v>
                </c:pt>
                <c:pt idx="2">
                  <c:v>0.32983333369096118</c:v>
                </c:pt>
                <c:pt idx="3">
                  <c:v>0.3434833288192749</c:v>
                </c:pt>
                <c:pt idx="4">
                  <c:v>0.37070000171661377</c:v>
                </c:pt>
                <c:pt idx="5">
                  <c:v>0.33830000460147858</c:v>
                </c:pt>
                <c:pt idx="6">
                  <c:v>0.3294166624546051</c:v>
                </c:pt>
                <c:pt idx="7">
                  <c:v>0.32666665812333423</c:v>
                </c:pt>
                <c:pt idx="8">
                  <c:v>0.32526665925979614</c:v>
                </c:pt>
                <c:pt idx="9">
                  <c:v>0.286349996924400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8EB-40BF-8FC8-8BE74B9D71FE}"/>
            </c:ext>
          </c:extLst>
        </c:ser>
        <c:ser>
          <c:idx val="2"/>
          <c:order val="2"/>
          <c:tx>
            <c:strRef>
              <c:f>'[Harada 2025.04.30^LN1 (1).xlsx]計算'!$AP$8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2:$AZ$12</c:f>
                <c:numCache>
                  <c:formatCode>General</c:formatCode>
                  <c:ptCount val="10"/>
                  <c:pt idx="0">
                    <c:v>4.7098892840043677E-2</c:v>
                  </c:pt>
                  <c:pt idx="1">
                    <c:v>3.6602709867063606E-2</c:v>
                  </c:pt>
                  <c:pt idx="2">
                    <c:v>2.4810788211822792E-2</c:v>
                  </c:pt>
                  <c:pt idx="3">
                    <c:v>3.4656184998723187E-2</c:v>
                  </c:pt>
                  <c:pt idx="4">
                    <c:v>2.8347096083264987E-2</c:v>
                  </c:pt>
                  <c:pt idx="5">
                    <c:v>2.9293185970151188E-2</c:v>
                  </c:pt>
                  <c:pt idx="6">
                    <c:v>4.2701645738377009E-2</c:v>
                  </c:pt>
                  <c:pt idx="7">
                    <c:v>3.6108592476703623E-2</c:v>
                  </c:pt>
                  <c:pt idx="8">
                    <c:v>3.4154319535157698E-2</c:v>
                  </c:pt>
                  <c:pt idx="9">
                    <c:v>1.9572270004873195E-2</c:v>
                  </c:pt>
                </c:numCache>
              </c:numRef>
            </c:plus>
            <c:minus>
              <c:numRef>
                <c:f>'[Harada 2025.04.30^LN1 (1).xlsx]計算'!$AQ$12:$AZ$12</c:f>
                <c:numCache>
                  <c:formatCode>General</c:formatCode>
                  <c:ptCount val="10"/>
                  <c:pt idx="0">
                    <c:v>4.7098892840043677E-2</c:v>
                  </c:pt>
                  <c:pt idx="1">
                    <c:v>3.6602709867063606E-2</c:v>
                  </c:pt>
                  <c:pt idx="2">
                    <c:v>2.4810788211822792E-2</c:v>
                  </c:pt>
                  <c:pt idx="3">
                    <c:v>3.4656184998723187E-2</c:v>
                  </c:pt>
                  <c:pt idx="4">
                    <c:v>2.8347096083264987E-2</c:v>
                  </c:pt>
                  <c:pt idx="5">
                    <c:v>2.9293185970151188E-2</c:v>
                  </c:pt>
                  <c:pt idx="6">
                    <c:v>4.2701645738377009E-2</c:v>
                  </c:pt>
                  <c:pt idx="7">
                    <c:v>3.6108592476703623E-2</c:v>
                  </c:pt>
                  <c:pt idx="8">
                    <c:v>3.4154319535157698E-2</c:v>
                  </c:pt>
                  <c:pt idx="9">
                    <c:v>1.95722700048731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:$AZ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Harada 2025.04.30^LN1 (1).xlsx]計算'!$AQ$8:$AZ$8</c:f>
              <c:numCache>
                <c:formatCode>General</c:formatCode>
                <c:ptCount val="10"/>
                <c:pt idx="0">
                  <c:v>0.33958333730697632</c:v>
                </c:pt>
                <c:pt idx="1">
                  <c:v>0.36226666967074078</c:v>
                </c:pt>
                <c:pt idx="2">
                  <c:v>0.36965000132719678</c:v>
                </c:pt>
                <c:pt idx="3">
                  <c:v>0.38704999784628552</c:v>
                </c:pt>
                <c:pt idx="4">
                  <c:v>0.4080166717370351</c:v>
                </c:pt>
                <c:pt idx="5">
                  <c:v>0.40773333112398785</c:v>
                </c:pt>
                <c:pt idx="6">
                  <c:v>0.40773334105809528</c:v>
                </c:pt>
                <c:pt idx="7">
                  <c:v>0.38466666638851166</c:v>
                </c:pt>
                <c:pt idx="8">
                  <c:v>0.37011667092641193</c:v>
                </c:pt>
                <c:pt idx="9">
                  <c:v>0.337116673588752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8EB-40BF-8FC8-8BE74B9D71FE}"/>
            </c:ext>
          </c:extLst>
        </c:ser>
        <c:ser>
          <c:idx val="3"/>
          <c:order val="3"/>
          <c:tx>
            <c:strRef>
              <c:f>'[Harada 2025.04.30^LN1 (1).xlsx]計算'!$AP$9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3:$AZ$13</c:f>
                <c:numCache>
                  <c:formatCode>General</c:formatCode>
                  <c:ptCount val="10"/>
                  <c:pt idx="0">
                    <c:v>4.0531653737299472E-2</c:v>
                  </c:pt>
                  <c:pt idx="1">
                    <c:v>4.5605068094245409E-2</c:v>
                  </c:pt>
                  <c:pt idx="2">
                    <c:v>2.9423240371010205E-2</c:v>
                  </c:pt>
                  <c:pt idx="3">
                    <c:v>4.4384859985497356E-2</c:v>
                  </c:pt>
                  <c:pt idx="4">
                    <c:v>3.8296074633833416E-2</c:v>
                  </c:pt>
                  <c:pt idx="5">
                    <c:v>4.3164986850521066E-2</c:v>
                  </c:pt>
                  <c:pt idx="6">
                    <c:v>6.9336971308755047E-2</c:v>
                  </c:pt>
                  <c:pt idx="7">
                    <c:v>3.407936620568533E-2</c:v>
                  </c:pt>
                  <c:pt idx="8">
                    <c:v>2.0685998634482415E-2</c:v>
                  </c:pt>
                  <c:pt idx="9">
                    <c:v>1.7785721222222915E-2</c:v>
                  </c:pt>
                </c:numCache>
              </c:numRef>
            </c:plus>
            <c:minus>
              <c:numRef>
                <c:f>'[Harada 2025.04.30^LN1 (1).xlsx]計算'!$AQ$13:$AZ$13</c:f>
                <c:numCache>
                  <c:formatCode>General</c:formatCode>
                  <c:ptCount val="10"/>
                  <c:pt idx="0">
                    <c:v>4.0531653737299472E-2</c:v>
                  </c:pt>
                  <c:pt idx="1">
                    <c:v>4.5605068094245409E-2</c:v>
                  </c:pt>
                  <c:pt idx="2">
                    <c:v>2.9423240371010205E-2</c:v>
                  </c:pt>
                  <c:pt idx="3">
                    <c:v>4.4384859985497356E-2</c:v>
                  </c:pt>
                  <c:pt idx="4">
                    <c:v>3.8296074633833416E-2</c:v>
                  </c:pt>
                  <c:pt idx="5">
                    <c:v>4.3164986850521066E-2</c:v>
                  </c:pt>
                  <c:pt idx="6">
                    <c:v>6.9336971308755047E-2</c:v>
                  </c:pt>
                  <c:pt idx="7">
                    <c:v>3.407936620568533E-2</c:v>
                  </c:pt>
                  <c:pt idx="8">
                    <c:v>2.0685998634482415E-2</c:v>
                  </c:pt>
                  <c:pt idx="9">
                    <c:v>1.77857212222229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:$AZ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Harada 2025.04.30^LN1 (1).xlsx]計算'!$AQ$9:$AZ$9</c:f>
              <c:numCache>
                <c:formatCode>General</c:formatCode>
                <c:ptCount val="10"/>
                <c:pt idx="0">
                  <c:v>0.45633334045608798</c:v>
                </c:pt>
                <c:pt idx="1">
                  <c:v>0.45366666341821354</c:v>
                </c:pt>
                <c:pt idx="2">
                  <c:v>0.47223333641886711</c:v>
                </c:pt>
                <c:pt idx="3">
                  <c:v>0.48165000105897587</c:v>
                </c:pt>
                <c:pt idx="4">
                  <c:v>0.51311667884389556</c:v>
                </c:pt>
                <c:pt idx="5">
                  <c:v>0.45960000281532604</c:v>
                </c:pt>
                <c:pt idx="6">
                  <c:v>0.5290000053743521</c:v>
                </c:pt>
                <c:pt idx="7">
                  <c:v>0.49604999149839085</c:v>
                </c:pt>
                <c:pt idx="8">
                  <c:v>0.44953332965572673</c:v>
                </c:pt>
                <c:pt idx="9">
                  <c:v>0.410499996195237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8EB-40BF-8FC8-8BE74B9D71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156144"/>
        <c:axId val="176172464"/>
      </c:lineChart>
      <c:catAx>
        <c:axId val="176156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rgbClr val="00206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72464"/>
        <c:crosses val="autoZero"/>
        <c:auto val="1"/>
        <c:lblAlgn val="ctr"/>
        <c:lblOffset val="100"/>
        <c:noMultiLvlLbl val="0"/>
      </c:catAx>
      <c:valAx>
        <c:axId val="176172464"/>
        <c:scaling>
          <c:orientation val="minMax"/>
          <c:max val="0.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56144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5847830122706841"/>
          <c:y val="0.53551483161418711"/>
          <c:w val="0.24925848334402981"/>
          <c:h val="0.398397820764684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27450086434528"/>
          <c:y val="4.8441498589311745E-2"/>
          <c:w val="0.81664899982903061"/>
          <c:h val="0.81591511141252426"/>
        </c:manualLayout>
      </c:layout>
      <c:lineChart>
        <c:grouping val="standard"/>
        <c:varyColors val="0"/>
        <c:ser>
          <c:idx val="0"/>
          <c:order val="0"/>
          <c:tx>
            <c:strRef>
              <c:f>'[Harada 2025.04.30^LN1 (1).xlsx]計算'!$BF$76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Harada 2025.04.30^LN1 (1).xlsx]計算'!$BG$75:$BP$7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BG$76:$BP$76</c:f>
              <c:numCache>
                <c:formatCode>General</c:formatCode>
                <c:ptCount val="10"/>
                <c:pt idx="0">
                  <c:v>0.21225000048677126</c:v>
                </c:pt>
                <c:pt idx="1">
                  <c:v>0.57071667537093163</c:v>
                </c:pt>
                <c:pt idx="2">
                  <c:v>0.47468333070476848</c:v>
                </c:pt>
                <c:pt idx="3">
                  <c:v>0.45784999057650566</c:v>
                </c:pt>
                <c:pt idx="4">
                  <c:v>0.4088500055174033</c:v>
                </c:pt>
                <c:pt idx="5">
                  <c:v>0.3536166710158189</c:v>
                </c:pt>
                <c:pt idx="6">
                  <c:v>0.18055000031987825</c:v>
                </c:pt>
                <c:pt idx="7">
                  <c:v>5.9733333686987557E-2</c:v>
                </c:pt>
                <c:pt idx="8">
                  <c:v>2.2833328694105148E-3</c:v>
                </c:pt>
                <c:pt idx="9">
                  <c:v>-7.6500003536542254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94-4CD2-88CF-33A178419144}"/>
            </c:ext>
          </c:extLst>
        </c:ser>
        <c:ser>
          <c:idx val="1"/>
          <c:order val="1"/>
          <c:tx>
            <c:strRef>
              <c:f>'[Harada 2025.04.30^LN1 (1).xlsx]計算'!$BF$77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Harada 2025.04.30^LN1 (1).xlsx]計算'!$BG$75:$BP$7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BG$77:$BP$77</c:f>
              <c:numCache>
                <c:formatCode>General</c:formatCode>
                <c:ptCount val="10"/>
                <c:pt idx="0">
                  <c:v>0.29796666279435158</c:v>
                </c:pt>
                <c:pt idx="1">
                  <c:v>0.61483332887291908</c:v>
                </c:pt>
                <c:pt idx="2">
                  <c:v>0.57228334620594978</c:v>
                </c:pt>
                <c:pt idx="3">
                  <c:v>0.50100000078479456</c:v>
                </c:pt>
                <c:pt idx="4">
                  <c:v>0.404466662555933</c:v>
                </c:pt>
                <c:pt idx="5">
                  <c:v>0.40353333329161012</c:v>
                </c:pt>
                <c:pt idx="6">
                  <c:v>0.28111667310198152</c:v>
                </c:pt>
                <c:pt idx="7">
                  <c:v>0.10481667146086696</c:v>
                </c:pt>
                <c:pt idx="8">
                  <c:v>-1.1333264410495585E-3</c:v>
                </c:pt>
                <c:pt idx="9">
                  <c:v>1.1383336658279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394-4CD2-88CF-33A178419144}"/>
            </c:ext>
          </c:extLst>
        </c:ser>
        <c:ser>
          <c:idx val="2"/>
          <c:order val="2"/>
          <c:tx>
            <c:strRef>
              <c:f>'[Harada 2025.04.30^LN1 (1).xlsx]計算'!$BF$78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[Harada 2025.04.30^LN1 (1).xlsx]計算'!$BG$75:$BP$7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BG$78:$BP$78</c:f>
              <c:numCache>
                <c:formatCode>General</c:formatCode>
                <c:ptCount val="10"/>
                <c:pt idx="0">
                  <c:v>0.29428333913286525</c:v>
                </c:pt>
                <c:pt idx="1">
                  <c:v>0.75926665837566065</c:v>
                </c:pt>
                <c:pt idx="2">
                  <c:v>0.64443332826097799</c:v>
                </c:pt>
                <c:pt idx="3">
                  <c:v>0.59898333624005318</c:v>
                </c:pt>
                <c:pt idx="4">
                  <c:v>0.50589998935659719</c:v>
                </c:pt>
                <c:pt idx="5">
                  <c:v>0.49206666524211568</c:v>
                </c:pt>
                <c:pt idx="6">
                  <c:v>0.3628166603545348</c:v>
                </c:pt>
                <c:pt idx="7">
                  <c:v>0.17045000071326891</c:v>
                </c:pt>
                <c:pt idx="8">
                  <c:v>3.459999834497772E-2</c:v>
                </c:pt>
                <c:pt idx="9">
                  <c:v>2.383329595128695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394-4CD2-88CF-33A178419144}"/>
            </c:ext>
          </c:extLst>
        </c:ser>
        <c:ser>
          <c:idx val="3"/>
          <c:order val="3"/>
          <c:tx>
            <c:strRef>
              <c:f>'[Harada 2025.04.30^LN1 (1).xlsx]計算'!$BF$79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[Harada 2025.04.30^LN1 (1).xlsx]計算'!$BG$75:$BP$7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BG$79:$BP$79</c:f>
              <c:numCache>
                <c:formatCode>General</c:formatCode>
                <c:ptCount val="10"/>
                <c:pt idx="0">
                  <c:v>0.43228333195050556</c:v>
                </c:pt>
                <c:pt idx="1">
                  <c:v>0.93150001267592075</c:v>
                </c:pt>
                <c:pt idx="2">
                  <c:v>0.80408333738644877</c:v>
                </c:pt>
                <c:pt idx="3">
                  <c:v>0.78340000410874633</c:v>
                </c:pt>
                <c:pt idx="4">
                  <c:v>0.66268332799275675</c:v>
                </c:pt>
                <c:pt idx="5">
                  <c:v>0.64528333147366812</c:v>
                </c:pt>
                <c:pt idx="6">
                  <c:v>0.45054999987284305</c:v>
                </c:pt>
                <c:pt idx="7">
                  <c:v>0.27165002127488413</c:v>
                </c:pt>
                <c:pt idx="8">
                  <c:v>0.14193334678808808</c:v>
                </c:pt>
                <c:pt idx="9">
                  <c:v>4.340001257757286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394-4CD2-88CF-33A178419144}"/>
            </c:ext>
          </c:extLst>
        </c:ser>
        <c:ser>
          <c:idx val="4"/>
          <c:order val="4"/>
          <c:tx>
            <c:strRef>
              <c:f>'[Harada 2025.04.30^LN1 (1).xlsx]計算'!$BF$80</c:f>
              <c:strCache>
                <c:ptCount val="1"/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[Harada 2025.04.30^LN1 (1).xlsx]計算'!$BG$75:$BP$7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BG$80:$BP$80</c:f>
              <c:numCache>
                <c:formatCode>General</c:formatCode>
                <c:ptCount val="10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394-4CD2-88CF-33A1784191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5605231"/>
        <c:axId val="405608111"/>
      </c:lineChart>
      <c:catAx>
        <c:axId val="4056052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5608111"/>
        <c:crosses val="autoZero"/>
        <c:auto val="1"/>
        <c:lblAlgn val="ctr"/>
        <c:lblOffset val="100"/>
        <c:noMultiLvlLbl val="0"/>
      </c:catAx>
      <c:valAx>
        <c:axId val="40560811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5605231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0196260259592657E-2"/>
          <c:y val="6.5639420767277468E-2"/>
          <c:w val="0.93299972536438025"/>
          <c:h val="0.75061697893075285"/>
        </c:manualLayout>
      </c:layout>
      <c:lineChart>
        <c:grouping val="standard"/>
        <c:varyColors val="0"/>
        <c:ser>
          <c:idx val="0"/>
          <c:order val="0"/>
          <c:tx>
            <c:strRef>
              <c:f>'[Harada 2025.04.30^LN1 (1).xlsx]計算'!$BE$120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Harada 2025.04.30^LN1 (1).xlsx]計算'!$BF$119:$BO$11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BF$120:$BO$120</c:f>
              <c:numCache>
                <c:formatCode>General</c:formatCode>
                <c:ptCount val="10"/>
                <c:pt idx="0">
                  <c:v>0.15558333198229471</c:v>
                </c:pt>
                <c:pt idx="1">
                  <c:v>0.15538332114617029</c:v>
                </c:pt>
                <c:pt idx="2">
                  <c:v>0.1191666598121329</c:v>
                </c:pt>
                <c:pt idx="3">
                  <c:v>0.12861666828393978</c:v>
                </c:pt>
                <c:pt idx="4">
                  <c:v>0.15016665558020315</c:v>
                </c:pt>
                <c:pt idx="5">
                  <c:v>0.15124999731779137</c:v>
                </c:pt>
                <c:pt idx="6">
                  <c:v>0.19048331926266393</c:v>
                </c:pt>
                <c:pt idx="7">
                  <c:v>0.17138333370288253</c:v>
                </c:pt>
                <c:pt idx="8">
                  <c:v>0.10036665946245235</c:v>
                </c:pt>
                <c:pt idx="9">
                  <c:v>-7.2833423813180032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ABB-4B85-AC3C-9D272DA3B99E}"/>
            </c:ext>
          </c:extLst>
        </c:ser>
        <c:ser>
          <c:idx val="1"/>
          <c:order val="1"/>
          <c:tx>
            <c:strRef>
              <c:f>'[Harada 2025.04.30^LN1 (1).xlsx]計算'!$BE$121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Harada 2025.04.30^LN1 (1).xlsx]計算'!$BF$119:$BO$11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BF$121:$BO$121</c:f>
              <c:numCache>
                <c:formatCode>General</c:formatCode>
                <c:ptCount val="10"/>
                <c:pt idx="0">
                  <c:v>0.22796666870514551</c:v>
                </c:pt>
                <c:pt idx="1">
                  <c:v>0.24929999560117722</c:v>
                </c:pt>
                <c:pt idx="2">
                  <c:v>0.22863332678874337</c:v>
                </c:pt>
                <c:pt idx="3">
                  <c:v>0.23120000710090005</c:v>
                </c:pt>
                <c:pt idx="4">
                  <c:v>0.22848333666721982</c:v>
                </c:pt>
                <c:pt idx="5">
                  <c:v>0.26934999475876492</c:v>
                </c:pt>
                <c:pt idx="6">
                  <c:v>0.30703333765268326</c:v>
                </c:pt>
                <c:pt idx="7">
                  <c:v>0.28861666967471444</c:v>
                </c:pt>
                <c:pt idx="8">
                  <c:v>0.15638333807388943</c:v>
                </c:pt>
                <c:pt idx="9">
                  <c:v>6.448333834608396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ABB-4B85-AC3C-9D272DA3B99E}"/>
            </c:ext>
          </c:extLst>
        </c:ser>
        <c:ser>
          <c:idx val="2"/>
          <c:order val="2"/>
          <c:tx>
            <c:strRef>
              <c:f>'[Harada 2025.04.30^LN1 (1).xlsx]計算'!$BE$122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[Harada 2025.04.30^LN1 (1).xlsx]計算'!$BF$119:$BO$11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BF$122:$BO$122</c:f>
              <c:numCache>
                <c:formatCode>General</c:formatCode>
                <c:ptCount val="10"/>
                <c:pt idx="0">
                  <c:v>0.28823333978652954</c:v>
                </c:pt>
                <c:pt idx="1">
                  <c:v>0.28066666424274445</c:v>
                </c:pt>
                <c:pt idx="2">
                  <c:v>0.27623334030310309</c:v>
                </c:pt>
                <c:pt idx="3">
                  <c:v>0.29616667330265045</c:v>
                </c:pt>
                <c:pt idx="4">
                  <c:v>0.27913332978884381</c:v>
                </c:pt>
                <c:pt idx="5">
                  <c:v>0.31213333706061042</c:v>
                </c:pt>
                <c:pt idx="6">
                  <c:v>0.34111666679382324</c:v>
                </c:pt>
                <c:pt idx="7">
                  <c:v>0.35626667737960815</c:v>
                </c:pt>
                <c:pt idx="8">
                  <c:v>0.24673333267370862</c:v>
                </c:pt>
                <c:pt idx="9">
                  <c:v>0.112566667298475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ABB-4B85-AC3C-9D272DA3B99E}"/>
            </c:ext>
          </c:extLst>
        </c:ser>
        <c:ser>
          <c:idx val="3"/>
          <c:order val="3"/>
          <c:tx>
            <c:strRef>
              <c:f>'[Harada 2025.04.30^LN1 (1).xlsx]計算'!$BE$123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[Harada 2025.04.30^LN1 (1).xlsx]計算'!$BF$119:$BO$11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BF$123:$BO$123</c:f>
              <c:numCache>
                <c:formatCode>General</c:formatCode>
                <c:ptCount val="10"/>
                <c:pt idx="0">
                  <c:v>0.361566665271918</c:v>
                </c:pt>
                <c:pt idx="1">
                  <c:v>0.39571667462587312</c:v>
                </c:pt>
                <c:pt idx="2">
                  <c:v>0.40388333549102107</c:v>
                </c:pt>
                <c:pt idx="3">
                  <c:v>0.41495001067717829</c:v>
                </c:pt>
                <c:pt idx="4">
                  <c:v>0.39960000167290333</c:v>
                </c:pt>
                <c:pt idx="5">
                  <c:v>0.46036666383345881</c:v>
                </c:pt>
                <c:pt idx="6">
                  <c:v>0.45298335204521778</c:v>
                </c:pt>
                <c:pt idx="7">
                  <c:v>0.48213335126638374</c:v>
                </c:pt>
                <c:pt idx="8">
                  <c:v>0.4019833380977309</c:v>
                </c:pt>
                <c:pt idx="9">
                  <c:v>0.283483338852722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ABB-4B85-AC3C-9D272DA3B9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4488383"/>
        <c:axId val="404488863"/>
      </c:lineChart>
      <c:catAx>
        <c:axId val="4044883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4488863"/>
        <c:crosses val="autoZero"/>
        <c:auto val="1"/>
        <c:lblAlgn val="ctr"/>
        <c:lblOffset val="100"/>
        <c:noMultiLvlLbl val="0"/>
      </c:catAx>
      <c:valAx>
        <c:axId val="404488863"/>
        <c:scaling>
          <c:orientation val="minMax"/>
          <c:max val="0.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4488383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6157563759441814E-2"/>
          <c:y val="8.4532286059431444E-2"/>
          <c:w val="0.93823944687756389"/>
          <c:h val="0.78092891491494154"/>
        </c:manualLayout>
      </c:layout>
      <c:lineChart>
        <c:grouping val="standard"/>
        <c:varyColors val="0"/>
        <c:ser>
          <c:idx val="0"/>
          <c:order val="0"/>
          <c:tx>
            <c:strRef>
              <c:f>'[Harada 2025.04.30^LN1 (1).xlsx]計算'!$BE$167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Harada 2025.04.30^LN1 (1).xlsx]計算'!$BF$166:$BO$166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BF$167:$BO$167</c:f>
              <c:numCache>
                <c:formatCode>General</c:formatCode>
                <c:ptCount val="10"/>
                <c:pt idx="0">
                  <c:v>0.14666666959722838</c:v>
                </c:pt>
                <c:pt idx="1">
                  <c:v>0.15211665506164232</c:v>
                </c:pt>
                <c:pt idx="2">
                  <c:v>0.1220333216091001</c:v>
                </c:pt>
                <c:pt idx="3">
                  <c:v>0.13841666730344337</c:v>
                </c:pt>
                <c:pt idx="4">
                  <c:v>0.1445666588842873</c:v>
                </c:pt>
                <c:pt idx="5">
                  <c:v>0.12453333164254862</c:v>
                </c:pt>
                <c:pt idx="6">
                  <c:v>0.15699998413523078</c:v>
                </c:pt>
                <c:pt idx="7">
                  <c:v>0.17964999750256577</c:v>
                </c:pt>
                <c:pt idx="8">
                  <c:v>0.18548332030574521</c:v>
                </c:pt>
                <c:pt idx="9">
                  <c:v>4.436665773391763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A45-4C47-A09E-1EEF2FBB8C19}"/>
            </c:ext>
          </c:extLst>
        </c:ser>
        <c:ser>
          <c:idx val="1"/>
          <c:order val="1"/>
          <c:tx>
            <c:strRef>
              <c:f>'[Harada 2025.04.30^LN1 (1).xlsx]計算'!$BE$168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Harada 2025.04.30^LN1 (1).xlsx]計算'!$BF$166:$BO$166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BF$168:$BO$168</c:f>
              <c:numCache>
                <c:formatCode>General</c:formatCode>
                <c:ptCount val="10"/>
                <c:pt idx="0">
                  <c:v>0.22161667173107466</c:v>
                </c:pt>
                <c:pt idx="1">
                  <c:v>0.23649999623497325</c:v>
                </c:pt>
                <c:pt idx="2">
                  <c:v>0.24379999066392583</c:v>
                </c:pt>
                <c:pt idx="3">
                  <c:v>0.22846667096018791</c:v>
                </c:pt>
                <c:pt idx="4">
                  <c:v>0.20976665740211808</c:v>
                </c:pt>
                <c:pt idx="5">
                  <c:v>0.24381666009624803</c:v>
                </c:pt>
                <c:pt idx="6">
                  <c:v>0.27041666830579442</c:v>
                </c:pt>
                <c:pt idx="7">
                  <c:v>0.25338334466020268</c:v>
                </c:pt>
                <c:pt idx="8">
                  <c:v>0.26795000955462456</c:v>
                </c:pt>
                <c:pt idx="9">
                  <c:v>0.216166666398445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A45-4C47-A09E-1EEF2FBB8C19}"/>
            </c:ext>
          </c:extLst>
        </c:ser>
        <c:ser>
          <c:idx val="2"/>
          <c:order val="2"/>
          <c:tx>
            <c:strRef>
              <c:f>'[Harada 2025.04.30^LN1 (1).xlsx]計算'!$BE$169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[Harada 2025.04.30^LN1 (1).xlsx]計算'!$BF$166:$BO$166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BF$169:$BO$169</c:f>
              <c:numCache>
                <c:formatCode>General</c:formatCode>
                <c:ptCount val="10"/>
                <c:pt idx="0">
                  <c:v>0.25071666389703751</c:v>
                </c:pt>
                <c:pt idx="1">
                  <c:v>0.27961666633685428</c:v>
                </c:pt>
                <c:pt idx="2">
                  <c:v>0.26088333378235495</c:v>
                </c:pt>
                <c:pt idx="3">
                  <c:v>0.27151667326688766</c:v>
                </c:pt>
                <c:pt idx="4">
                  <c:v>0.25190000484387082</c:v>
                </c:pt>
                <c:pt idx="5">
                  <c:v>0.2514000112811724</c:v>
                </c:pt>
                <c:pt idx="6">
                  <c:v>0.25309999535481137</c:v>
                </c:pt>
                <c:pt idx="7">
                  <c:v>0.26363333811362583</c:v>
                </c:pt>
                <c:pt idx="8">
                  <c:v>0.27864999820788705</c:v>
                </c:pt>
                <c:pt idx="9">
                  <c:v>0.22786666204531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A45-4C47-A09E-1EEF2FBB8C19}"/>
            </c:ext>
          </c:extLst>
        </c:ser>
        <c:ser>
          <c:idx val="3"/>
          <c:order val="3"/>
          <c:tx>
            <c:strRef>
              <c:f>'[Harada 2025.04.30^LN1 (1).xlsx]計算'!$BE$170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[Harada 2025.04.30^LN1 (1).xlsx]計算'!$BF$166:$BO$166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E-2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Harada 2025.04.30^LN1 (1).xlsx]計算'!$BF$170:$BO$170</c:f>
              <c:numCache>
                <c:formatCode>General</c:formatCode>
                <c:ptCount val="10"/>
                <c:pt idx="0">
                  <c:v>0.36759999394416809</c:v>
                </c:pt>
                <c:pt idx="1">
                  <c:v>0.41413335005442259</c:v>
                </c:pt>
                <c:pt idx="2">
                  <c:v>0.38508333762486735</c:v>
                </c:pt>
                <c:pt idx="3">
                  <c:v>0.38658334314823106</c:v>
                </c:pt>
                <c:pt idx="4">
                  <c:v>0.32811665534973106</c:v>
                </c:pt>
                <c:pt idx="5">
                  <c:v>0.40050000449021617</c:v>
                </c:pt>
                <c:pt idx="6">
                  <c:v>0.33150000373522404</c:v>
                </c:pt>
                <c:pt idx="7">
                  <c:v>0.3509166836738582</c:v>
                </c:pt>
                <c:pt idx="8">
                  <c:v>0.42800001303354862</c:v>
                </c:pt>
                <c:pt idx="9">
                  <c:v>0.315600017706552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A45-4C47-A09E-1EEF2FBB8C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3858239"/>
        <c:axId val="503861599"/>
      </c:lineChart>
      <c:catAx>
        <c:axId val="5038582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3861599"/>
        <c:crosses val="autoZero"/>
        <c:auto val="1"/>
        <c:lblAlgn val="ctr"/>
        <c:lblOffset val="100"/>
        <c:noMultiLvlLbl val="0"/>
      </c:catAx>
      <c:valAx>
        <c:axId val="503861599"/>
        <c:scaling>
          <c:orientation val="minMax"/>
          <c:max val="0.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3858239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0553149606299199E-2"/>
          <c:y val="2.9768518518518517E-2"/>
          <c:w val="0.88389129483814521"/>
          <c:h val="0.86803988043161284"/>
        </c:manualLayout>
      </c:layout>
      <c:lineChart>
        <c:grouping val="standard"/>
        <c:varyColors val="0"/>
        <c:ser>
          <c:idx val="0"/>
          <c:order val="0"/>
          <c:tx>
            <c:strRef>
              <c:f>計算!$CB$7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6:$CL$6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7:$CL$7</c:f>
              <c:numCache>
                <c:formatCode>General</c:formatCode>
                <c:ptCount val="10"/>
                <c:pt idx="0">
                  <c:v>0.33521665756901103</c:v>
                </c:pt>
                <c:pt idx="1">
                  <c:v>0.30176666751503944</c:v>
                </c:pt>
                <c:pt idx="2">
                  <c:v>0.35558332627018291</c:v>
                </c:pt>
                <c:pt idx="3">
                  <c:v>0.33701667313774425</c:v>
                </c:pt>
                <c:pt idx="4">
                  <c:v>0.33263332769274712</c:v>
                </c:pt>
                <c:pt idx="5">
                  <c:v>0.36779999857147533</c:v>
                </c:pt>
                <c:pt idx="6">
                  <c:v>0.33456666395068169</c:v>
                </c:pt>
                <c:pt idx="7">
                  <c:v>0.35431666796406108</c:v>
                </c:pt>
                <c:pt idx="8">
                  <c:v>0.34121666476130486</c:v>
                </c:pt>
                <c:pt idx="9">
                  <c:v>0.321633335202932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A95-431E-BCF6-0842ED638FCE}"/>
            </c:ext>
          </c:extLst>
        </c:ser>
        <c:ser>
          <c:idx val="1"/>
          <c:order val="1"/>
          <c:tx>
            <c:strRef>
              <c:f>計算!$CB$8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3175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10:$CL$10</c:f>
                <c:numCache>
                  <c:formatCode>General</c:formatCode>
                  <c:ptCount val="10"/>
                  <c:pt idx="0">
                    <c:v>8.7474357907129773E-3</c:v>
                  </c:pt>
                  <c:pt idx="1">
                    <c:v>5.5497626665321917E-2</c:v>
                  </c:pt>
                  <c:pt idx="2">
                    <c:v>1.5386806108886359E-2</c:v>
                  </c:pt>
                  <c:pt idx="3">
                    <c:v>3.7445025543406001E-2</c:v>
                  </c:pt>
                  <c:pt idx="4">
                    <c:v>3.6697011839226502E-2</c:v>
                  </c:pt>
                  <c:pt idx="5">
                    <c:v>1.7151328507843649E-2</c:v>
                  </c:pt>
                  <c:pt idx="6">
                    <c:v>3.9671488142718134E-2</c:v>
                  </c:pt>
                  <c:pt idx="7">
                    <c:v>1.0641134220572722E-2</c:v>
                  </c:pt>
                  <c:pt idx="8">
                    <c:v>2.1933850115319037E-2</c:v>
                  </c:pt>
                  <c:pt idx="9">
                    <c:v>4.550488868278707E-2</c:v>
                  </c:pt>
                </c:numCache>
              </c:numRef>
            </c:plus>
            <c:minus>
              <c:numRef>
                <c:f>計算!$CC$10:$CL$10</c:f>
                <c:numCache>
                  <c:formatCode>General</c:formatCode>
                  <c:ptCount val="10"/>
                  <c:pt idx="0">
                    <c:v>8.7474357907129773E-3</c:v>
                  </c:pt>
                  <c:pt idx="1">
                    <c:v>5.5497626665321917E-2</c:v>
                  </c:pt>
                  <c:pt idx="2">
                    <c:v>1.5386806108886359E-2</c:v>
                  </c:pt>
                  <c:pt idx="3">
                    <c:v>3.7445025543406001E-2</c:v>
                  </c:pt>
                  <c:pt idx="4">
                    <c:v>3.6697011839226502E-2</c:v>
                  </c:pt>
                  <c:pt idx="5">
                    <c:v>1.7151328507843649E-2</c:v>
                  </c:pt>
                  <c:pt idx="6">
                    <c:v>3.9671488142718134E-2</c:v>
                  </c:pt>
                  <c:pt idx="7">
                    <c:v>1.0641134220572722E-2</c:v>
                  </c:pt>
                  <c:pt idx="8">
                    <c:v>2.1933850115319037E-2</c:v>
                  </c:pt>
                  <c:pt idx="9">
                    <c:v>4.55048886827870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6:$CL$6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8:$CL$8</c:f>
              <c:numCache>
                <c:formatCode>General</c:formatCode>
                <c:ptCount val="10"/>
                <c:pt idx="0">
                  <c:v>0.33521665756901103</c:v>
                </c:pt>
                <c:pt idx="1">
                  <c:v>0.33521665756901103</c:v>
                </c:pt>
                <c:pt idx="2">
                  <c:v>0.33521665756901103</c:v>
                </c:pt>
                <c:pt idx="3">
                  <c:v>0.33521665756901103</c:v>
                </c:pt>
                <c:pt idx="4">
                  <c:v>0.33521665756901103</c:v>
                </c:pt>
                <c:pt idx="5">
                  <c:v>0.33521665756901103</c:v>
                </c:pt>
                <c:pt idx="6">
                  <c:v>0.33521665756901103</c:v>
                </c:pt>
                <c:pt idx="7">
                  <c:v>0.33521665756901103</c:v>
                </c:pt>
                <c:pt idx="8">
                  <c:v>0.33521665756901103</c:v>
                </c:pt>
                <c:pt idx="9">
                  <c:v>0.335216657569011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A95-431E-BCF6-0842ED638F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63196592"/>
        <c:axId val="2063194192"/>
      </c:lineChart>
      <c:catAx>
        <c:axId val="2063196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3194192"/>
        <c:crosses val="autoZero"/>
        <c:auto val="1"/>
        <c:lblAlgn val="ctr"/>
        <c:lblOffset val="100"/>
        <c:noMultiLvlLbl val="0"/>
      </c:catAx>
      <c:valAx>
        <c:axId val="2063194192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3196592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2.5428331875182269E-2"/>
          <c:w val="0.89655796150481193"/>
          <c:h val="0.86903579760863225"/>
        </c:manualLayout>
      </c:layout>
      <c:lineChart>
        <c:grouping val="standard"/>
        <c:varyColors val="0"/>
        <c:ser>
          <c:idx val="0"/>
          <c:order val="0"/>
          <c:tx>
            <c:strRef>
              <c:f>計算!$CB$19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計算!$CC$18:$CL$18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19:$CL$19</c:f>
              <c:numCache>
                <c:formatCode>General</c:formatCode>
                <c:ptCount val="10"/>
                <c:pt idx="0">
                  <c:v>0.32149999837080639</c:v>
                </c:pt>
                <c:pt idx="1">
                  <c:v>0.35846665998299915</c:v>
                </c:pt>
                <c:pt idx="2">
                  <c:v>0.40958333015441895</c:v>
                </c:pt>
                <c:pt idx="3">
                  <c:v>0.42803333202997845</c:v>
                </c:pt>
                <c:pt idx="4">
                  <c:v>0.47721667587757111</c:v>
                </c:pt>
                <c:pt idx="5">
                  <c:v>0.4840499957402547</c:v>
                </c:pt>
                <c:pt idx="6">
                  <c:v>0.47989999254544574</c:v>
                </c:pt>
                <c:pt idx="7">
                  <c:v>0.48265000184377033</c:v>
                </c:pt>
                <c:pt idx="8">
                  <c:v>0.47868333260218304</c:v>
                </c:pt>
                <c:pt idx="9">
                  <c:v>0.433016667763392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C6-46F0-AE39-ED9B2DF87EAD}"/>
            </c:ext>
          </c:extLst>
        </c:ser>
        <c:ser>
          <c:idx val="1"/>
          <c:order val="1"/>
          <c:tx>
            <c:strRef>
              <c:f>計算!$CB$20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22:$CL$22</c:f>
                <c:numCache>
                  <c:formatCode>General</c:formatCode>
                  <c:ptCount val="10"/>
                  <c:pt idx="0">
                    <c:v>9.9940012162519701E-3</c:v>
                  </c:pt>
                  <c:pt idx="1">
                    <c:v>1.8300895282963636E-2</c:v>
                  </c:pt>
                  <c:pt idx="2">
                    <c:v>2.694004440787278E-2</c:v>
                  </c:pt>
                  <c:pt idx="3">
                    <c:v>2.1432846777689144E-2</c:v>
                  </c:pt>
                  <c:pt idx="4">
                    <c:v>2.2510924405387437E-2</c:v>
                  </c:pt>
                  <c:pt idx="5">
                    <c:v>1.592679883275664E-2</c:v>
                  </c:pt>
                  <c:pt idx="6">
                    <c:v>2.0267204952260132E-2</c:v>
                  </c:pt>
                  <c:pt idx="7">
                    <c:v>1.2739983014657579E-2</c:v>
                  </c:pt>
                  <c:pt idx="8">
                    <c:v>1.0475374313810059E-2</c:v>
                  </c:pt>
                  <c:pt idx="9">
                    <c:v>2.2028478397879411E-2</c:v>
                  </c:pt>
                </c:numCache>
              </c:numRef>
            </c:plus>
            <c:minus>
              <c:numRef>
                <c:f>計算!$CC$22:$CL$22</c:f>
                <c:numCache>
                  <c:formatCode>General</c:formatCode>
                  <c:ptCount val="10"/>
                  <c:pt idx="0">
                    <c:v>9.9940012162519701E-3</c:v>
                  </c:pt>
                  <c:pt idx="1">
                    <c:v>1.8300895282963636E-2</c:v>
                  </c:pt>
                  <c:pt idx="2">
                    <c:v>2.694004440787278E-2</c:v>
                  </c:pt>
                  <c:pt idx="3">
                    <c:v>2.1432846777689144E-2</c:v>
                  </c:pt>
                  <c:pt idx="4">
                    <c:v>2.2510924405387437E-2</c:v>
                  </c:pt>
                  <c:pt idx="5">
                    <c:v>1.592679883275664E-2</c:v>
                  </c:pt>
                  <c:pt idx="6">
                    <c:v>2.0267204952260132E-2</c:v>
                  </c:pt>
                  <c:pt idx="7">
                    <c:v>1.2739983014657579E-2</c:v>
                  </c:pt>
                  <c:pt idx="8">
                    <c:v>1.0475374313810059E-2</c:v>
                  </c:pt>
                  <c:pt idx="9">
                    <c:v>2.20284783978794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18:$CL$18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20:$CL$20</c:f>
              <c:numCache>
                <c:formatCode>General</c:formatCode>
                <c:ptCount val="10"/>
                <c:pt idx="0">
                  <c:v>0.32149999837080639</c:v>
                </c:pt>
                <c:pt idx="1">
                  <c:v>0.39191665003697079</c:v>
                </c:pt>
                <c:pt idx="2">
                  <c:v>0.38921666145324707</c:v>
                </c:pt>
                <c:pt idx="3">
                  <c:v>0.42623331646124524</c:v>
                </c:pt>
                <c:pt idx="4">
                  <c:v>0.47980000575383502</c:v>
                </c:pt>
                <c:pt idx="5">
                  <c:v>0.45146665473779041</c:v>
                </c:pt>
                <c:pt idx="6">
                  <c:v>0.48054998616377514</c:v>
                </c:pt>
                <c:pt idx="7">
                  <c:v>0.46354999144872028</c:v>
                </c:pt>
                <c:pt idx="8">
                  <c:v>0.47268332540988922</c:v>
                </c:pt>
                <c:pt idx="9">
                  <c:v>0.446599990129470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C6-46F0-AE39-ED9B2DF87E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63181712"/>
        <c:axId val="2063211472"/>
      </c:lineChart>
      <c:catAx>
        <c:axId val="2063181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3211472"/>
        <c:crosses val="autoZero"/>
        <c:auto val="1"/>
        <c:lblAlgn val="ctr"/>
        <c:lblOffset val="100"/>
        <c:noMultiLvlLbl val="0"/>
      </c:catAx>
      <c:valAx>
        <c:axId val="2063211472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3181712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2.5428331875182269E-2"/>
          <c:w val="0.89655796150481193"/>
          <c:h val="0.86035469524642749"/>
        </c:manualLayout>
      </c:layout>
      <c:lineChart>
        <c:grouping val="standard"/>
        <c:varyColors val="0"/>
        <c:ser>
          <c:idx val="0"/>
          <c:order val="0"/>
          <c:tx>
            <c:strRef>
              <c:f>計算!$CB$31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30:$CL$30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31:$CL$31</c:f>
              <c:numCache>
                <c:formatCode>General</c:formatCode>
                <c:ptCount val="10"/>
                <c:pt idx="0">
                  <c:v>0.30085000023245811</c:v>
                </c:pt>
                <c:pt idx="1">
                  <c:v>0.30813334013024968</c:v>
                </c:pt>
                <c:pt idx="2">
                  <c:v>0.3096500001847744</c:v>
                </c:pt>
                <c:pt idx="3">
                  <c:v>0.30758333330353099</c:v>
                </c:pt>
                <c:pt idx="4">
                  <c:v>0.30873333041866619</c:v>
                </c:pt>
                <c:pt idx="5">
                  <c:v>0.31815000002582866</c:v>
                </c:pt>
                <c:pt idx="6">
                  <c:v>0.30898332720001537</c:v>
                </c:pt>
                <c:pt idx="7">
                  <c:v>0.30385000134507817</c:v>
                </c:pt>
                <c:pt idx="8">
                  <c:v>0.30935000007351238</c:v>
                </c:pt>
                <c:pt idx="9">
                  <c:v>0.291950003554423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C17-4243-916C-1AE5FCB99944}"/>
            </c:ext>
          </c:extLst>
        </c:ser>
        <c:ser>
          <c:idx val="1"/>
          <c:order val="1"/>
          <c:tx>
            <c:strRef>
              <c:f>計算!$CB$32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34:$CL$34</c:f>
                <c:numCache>
                  <c:formatCode>General</c:formatCode>
                  <c:ptCount val="10"/>
                  <c:pt idx="0">
                    <c:v>5.9112592945473729E-3</c:v>
                  </c:pt>
                  <c:pt idx="1">
                    <c:v>7.1659437442947076E-3</c:v>
                  </c:pt>
                  <c:pt idx="2">
                    <c:v>1.6452693766451747E-2</c:v>
                  </c:pt>
                  <c:pt idx="3">
                    <c:v>2.0956084247408392E-2</c:v>
                  </c:pt>
                  <c:pt idx="4">
                    <c:v>1.6137251143978779E-2</c:v>
                  </c:pt>
                  <c:pt idx="5">
                    <c:v>2.0626267861372262E-2</c:v>
                  </c:pt>
                  <c:pt idx="6">
                    <c:v>2.0957426065691561E-2</c:v>
                  </c:pt>
                  <c:pt idx="7">
                    <c:v>1.0357357846015273E-2</c:v>
                  </c:pt>
                  <c:pt idx="8">
                    <c:v>7.5213666134114777E-3</c:v>
                  </c:pt>
                  <c:pt idx="9">
                    <c:v>1.002770886983069E-2</c:v>
                  </c:pt>
                </c:numCache>
              </c:numRef>
            </c:plus>
            <c:minus>
              <c:numRef>
                <c:f>計算!$CC$34:$CL$34</c:f>
                <c:numCache>
                  <c:formatCode>General</c:formatCode>
                  <c:ptCount val="10"/>
                  <c:pt idx="0">
                    <c:v>5.9112592945473729E-3</c:v>
                  </c:pt>
                  <c:pt idx="1">
                    <c:v>7.1659437442947076E-3</c:v>
                  </c:pt>
                  <c:pt idx="2">
                    <c:v>1.6452693766451747E-2</c:v>
                  </c:pt>
                  <c:pt idx="3">
                    <c:v>2.0956084247408392E-2</c:v>
                  </c:pt>
                  <c:pt idx="4">
                    <c:v>1.6137251143978779E-2</c:v>
                  </c:pt>
                  <c:pt idx="5">
                    <c:v>2.0626267861372262E-2</c:v>
                  </c:pt>
                  <c:pt idx="6">
                    <c:v>2.0957426065691561E-2</c:v>
                  </c:pt>
                  <c:pt idx="7">
                    <c:v>1.0357357846015273E-2</c:v>
                  </c:pt>
                  <c:pt idx="8">
                    <c:v>7.5213666134114777E-3</c:v>
                  </c:pt>
                  <c:pt idx="9">
                    <c:v>1.0027708869830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30:$CL$30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32:$CL$32</c:f>
              <c:numCache>
                <c:formatCode>General</c:formatCode>
                <c:ptCount val="10"/>
                <c:pt idx="0">
                  <c:v>0.30085000023245811</c:v>
                </c:pt>
                <c:pt idx="1">
                  <c:v>0.34158333018422127</c:v>
                </c:pt>
                <c:pt idx="2">
                  <c:v>0.28928333148360252</c:v>
                </c:pt>
                <c:pt idx="3">
                  <c:v>0.30578331773479778</c:v>
                </c:pt>
                <c:pt idx="4">
                  <c:v>0.3113166602949301</c:v>
                </c:pt>
                <c:pt idx="5">
                  <c:v>0.28556665902336437</c:v>
                </c:pt>
                <c:pt idx="6">
                  <c:v>0.30963332081834471</c:v>
                </c:pt>
                <c:pt idx="7">
                  <c:v>0.28474999095002812</c:v>
                </c:pt>
                <c:pt idx="8">
                  <c:v>0.30334999288121856</c:v>
                </c:pt>
                <c:pt idx="9">
                  <c:v>0.305533325920502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C17-4243-916C-1AE5FCB999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45613168"/>
        <c:axId val="1845605488"/>
      </c:lineChart>
      <c:catAx>
        <c:axId val="1845613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5605488"/>
        <c:crosses val="autoZero"/>
        <c:auto val="1"/>
        <c:lblAlgn val="ctr"/>
        <c:lblOffset val="100"/>
        <c:noMultiLvlLbl val="0"/>
      </c:catAx>
      <c:valAx>
        <c:axId val="1845605488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561316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531496062992E-2"/>
          <c:y val="4.2083333333333334E-2"/>
          <c:w val="0.88389129483814521"/>
          <c:h val="0.841836176727909"/>
        </c:manualLayout>
      </c:layout>
      <c:lineChart>
        <c:grouping val="standard"/>
        <c:varyColors val="0"/>
        <c:ser>
          <c:idx val="0"/>
          <c:order val="0"/>
          <c:tx>
            <c:strRef>
              <c:f>計算!$CB$43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42:$CL$42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43:$CL$43</c:f>
              <c:numCache>
                <c:formatCode>General</c:formatCode>
                <c:ptCount val="10"/>
                <c:pt idx="0">
                  <c:v>7.7033328513304397E-2</c:v>
                </c:pt>
                <c:pt idx="1">
                  <c:v>9.3283330400784806E-2</c:v>
                </c:pt>
                <c:pt idx="2">
                  <c:v>9.1099997361501053E-2</c:v>
                </c:pt>
                <c:pt idx="3">
                  <c:v>8.4649997452894851E-2</c:v>
                </c:pt>
                <c:pt idx="4">
                  <c:v>8.6700002352396652E-2</c:v>
                </c:pt>
                <c:pt idx="5">
                  <c:v>8.8449999690055847E-2</c:v>
                </c:pt>
                <c:pt idx="6">
                  <c:v>8.8983332117398575E-2</c:v>
                </c:pt>
                <c:pt idx="7">
                  <c:v>8.138333261013031E-2</c:v>
                </c:pt>
                <c:pt idx="8">
                  <c:v>8.1300000349680587E-2</c:v>
                </c:pt>
                <c:pt idx="9">
                  <c:v>7.654999817411105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49D-4DE9-8107-88254C344324}"/>
            </c:ext>
          </c:extLst>
        </c:ser>
        <c:ser>
          <c:idx val="1"/>
          <c:order val="1"/>
          <c:tx>
            <c:strRef>
              <c:f>計算!$CB$44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46:$CL$46</c:f>
                <c:numCache>
                  <c:formatCode>General</c:formatCode>
                  <c:ptCount val="10"/>
                  <c:pt idx="0">
                    <c:v>3.2178651963167258E-3</c:v>
                  </c:pt>
                  <c:pt idx="1">
                    <c:v>5.8201115257582071E-3</c:v>
                  </c:pt>
                  <c:pt idx="2">
                    <c:v>1.3612051234874795E-2</c:v>
                  </c:pt>
                  <c:pt idx="3">
                    <c:v>4.6710834349059241E-3</c:v>
                  </c:pt>
                  <c:pt idx="4">
                    <c:v>5.1718446922689402E-3</c:v>
                  </c:pt>
                  <c:pt idx="5">
                    <c:v>8.3811106470122743E-3</c:v>
                  </c:pt>
                  <c:pt idx="6">
                    <c:v>8.6430125192453466E-3</c:v>
                  </c:pt>
                  <c:pt idx="7">
                    <c:v>4.8966958215715664E-3</c:v>
                  </c:pt>
                  <c:pt idx="8">
                    <c:v>1.1841622359313906E-2</c:v>
                  </c:pt>
                  <c:pt idx="9">
                    <c:v>8.9489092482266594E-3</c:v>
                  </c:pt>
                </c:numCache>
              </c:numRef>
            </c:plus>
            <c:minus>
              <c:numRef>
                <c:f>計算!$CC$46:$CL$46</c:f>
                <c:numCache>
                  <c:formatCode>General</c:formatCode>
                  <c:ptCount val="10"/>
                  <c:pt idx="0">
                    <c:v>3.2178651963167258E-3</c:v>
                  </c:pt>
                  <c:pt idx="1">
                    <c:v>5.8201115257582071E-3</c:v>
                  </c:pt>
                  <c:pt idx="2">
                    <c:v>1.3612051234874795E-2</c:v>
                  </c:pt>
                  <c:pt idx="3">
                    <c:v>4.6710834349059241E-3</c:v>
                  </c:pt>
                  <c:pt idx="4">
                    <c:v>5.1718446922689402E-3</c:v>
                  </c:pt>
                  <c:pt idx="5">
                    <c:v>8.3811106470122743E-3</c:v>
                  </c:pt>
                  <c:pt idx="6">
                    <c:v>8.6430125192453466E-3</c:v>
                  </c:pt>
                  <c:pt idx="7">
                    <c:v>4.8966958215715664E-3</c:v>
                  </c:pt>
                  <c:pt idx="8">
                    <c:v>1.1841622359313906E-2</c:v>
                  </c:pt>
                  <c:pt idx="9">
                    <c:v>8.948909248226659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42:$CL$42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44:$CL$44</c:f>
              <c:numCache>
                <c:formatCode>General</c:formatCode>
                <c:ptCount val="10"/>
                <c:pt idx="0">
                  <c:v>7.7033328513304397E-2</c:v>
                </c:pt>
                <c:pt idx="1">
                  <c:v>7.7033328513304411E-2</c:v>
                </c:pt>
                <c:pt idx="2">
                  <c:v>7.7033328513304411E-2</c:v>
                </c:pt>
                <c:pt idx="3">
                  <c:v>7.7033328513304397E-2</c:v>
                </c:pt>
                <c:pt idx="4">
                  <c:v>7.7033328513304397E-2</c:v>
                </c:pt>
                <c:pt idx="5">
                  <c:v>7.7033328513304397E-2</c:v>
                </c:pt>
                <c:pt idx="6">
                  <c:v>7.7033328513304411E-2</c:v>
                </c:pt>
                <c:pt idx="7">
                  <c:v>7.7033328513304397E-2</c:v>
                </c:pt>
                <c:pt idx="8">
                  <c:v>7.7033328513304397E-2</c:v>
                </c:pt>
                <c:pt idx="9">
                  <c:v>7.703332851330439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49D-4DE9-8107-88254C3443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2918432"/>
        <c:axId val="1902918912"/>
      </c:lineChart>
      <c:catAx>
        <c:axId val="1902918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2918912"/>
        <c:crosses val="autoZero"/>
        <c:auto val="1"/>
        <c:lblAlgn val="ctr"/>
        <c:lblOffset val="100"/>
        <c:noMultiLvlLbl val="0"/>
      </c:catAx>
      <c:valAx>
        <c:axId val="1902918912"/>
        <c:scaling>
          <c:orientation val="minMax"/>
          <c:max val="0.1500000000000000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2918432"/>
        <c:crosses val="autoZero"/>
        <c:crossBetween val="midCat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53149606299214E-2"/>
          <c:y val="3.7788968687579798E-2"/>
          <c:w val="0.87122462817147861"/>
          <c:h val="0.70166982257427479"/>
        </c:manualLayout>
      </c:layout>
      <c:lineChart>
        <c:grouping val="standard"/>
        <c:varyColors val="0"/>
        <c:ser>
          <c:idx val="0"/>
          <c:order val="0"/>
          <c:tx>
            <c:strRef>
              <c:f>計算!$CB$55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54:$CL$54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55:$CL$55</c:f>
              <c:numCache>
                <c:formatCode>General</c:formatCode>
                <c:ptCount val="10"/>
                <c:pt idx="0">
                  <c:v>9.3050004293521241E-2</c:v>
                </c:pt>
                <c:pt idx="1">
                  <c:v>0.10713333760698636</c:v>
                </c:pt>
                <c:pt idx="2">
                  <c:v>0.11694999660054843</c:v>
                </c:pt>
                <c:pt idx="3">
                  <c:v>0.12448333327968915</c:v>
                </c:pt>
                <c:pt idx="4">
                  <c:v>0.12483333423733711</c:v>
                </c:pt>
                <c:pt idx="5">
                  <c:v>0.13496666525801024</c:v>
                </c:pt>
                <c:pt idx="6">
                  <c:v>0.13163333013653755</c:v>
                </c:pt>
                <c:pt idx="7">
                  <c:v>0.12414999927083652</c:v>
                </c:pt>
                <c:pt idx="8">
                  <c:v>0.1226000003516674</c:v>
                </c:pt>
                <c:pt idx="9">
                  <c:v>0.111416668941577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C64-4403-8718-54D6D5FB28FB}"/>
            </c:ext>
          </c:extLst>
        </c:ser>
        <c:ser>
          <c:idx val="1"/>
          <c:order val="1"/>
          <c:tx>
            <c:strRef>
              <c:f>計算!$CB$56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58:$CL$58</c:f>
                <c:numCache>
                  <c:formatCode>General</c:formatCode>
                  <c:ptCount val="10"/>
                  <c:pt idx="0">
                    <c:v>5.8677951376396188E-3</c:v>
                  </c:pt>
                  <c:pt idx="1">
                    <c:v>1.3140573646496638E-2</c:v>
                  </c:pt>
                  <c:pt idx="2">
                    <c:v>1.0140757386882351E-2</c:v>
                  </c:pt>
                  <c:pt idx="3">
                    <c:v>1.4497502961408497E-2</c:v>
                  </c:pt>
                  <c:pt idx="4">
                    <c:v>7.5682637545223235E-3</c:v>
                  </c:pt>
                  <c:pt idx="5">
                    <c:v>9.952216892705916E-3</c:v>
                  </c:pt>
                  <c:pt idx="6">
                    <c:v>8.4490645022461258E-3</c:v>
                  </c:pt>
                  <c:pt idx="7">
                    <c:v>1.2112432951255143E-2</c:v>
                  </c:pt>
                  <c:pt idx="8">
                    <c:v>8.2629262357769937E-3</c:v>
                  </c:pt>
                  <c:pt idx="9">
                    <c:v>1.345115555344391E-2</c:v>
                  </c:pt>
                </c:numCache>
              </c:numRef>
            </c:plus>
            <c:minus>
              <c:numRef>
                <c:f>計算!$CC$58:$CL$58</c:f>
                <c:numCache>
                  <c:formatCode>General</c:formatCode>
                  <c:ptCount val="10"/>
                  <c:pt idx="0">
                    <c:v>5.8677951376396188E-3</c:v>
                  </c:pt>
                  <c:pt idx="1">
                    <c:v>1.3140573646496638E-2</c:v>
                  </c:pt>
                  <c:pt idx="2">
                    <c:v>1.0140757386882351E-2</c:v>
                  </c:pt>
                  <c:pt idx="3">
                    <c:v>1.4497502961408497E-2</c:v>
                  </c:pt>
                  <c:pt idx="4">
                    <c:v>7.5682637545223235E-3</c:v>
                  </c:pt>
                  <c:pt idx="5">
                    <c:v>9.952216892705916E-3</c:v>
                  </c:pt>
                  <c:pt idx="6">
                    <c:v>8.4490645022461258E-3</c:v>
                  </c:pt>
                  <c:pt idx="7">
                    <c:v>1.2112432951255143E-2</c:v>
                  </c:pt>
                  <c:pt idx="8">
                    <c:v>8.2629262357769937E-3</c:v>
                  </c:pt>
                  <c:pt idx="9">
                    <c:v>1.34511555534439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54:$CL$54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56:$CL$56</c:f>
              <c:numCache>
                <c:formatCode>General</c:formatCode>
                <c:ptCount val="10"/>
                <c:pt idx="0">
                  <c:v>9.3050004293521241E-2</c:v>
                </c:pt>
                <c:pt idx="1">
                  <c:v>9.0883335719505964E-2</c:v>
                </c:pt>
                <c:pt idx="2">
                  <c:v>0.10288332775235177</c:v>
                </c:pt>
                <c:pt idx="3">
                  <c:v>0.11686666434009869</c:v>
                </c:pt>
                <c:pt idx="4">
                  <c:v>0.11516666039824486</c:v>
                </c:pt>
                <c:pt idx="5">
                  <c:v>0.12354999408125877</c:v>
                </c:pt>
                <c:pt idx="6">
                  <c:v>0.11968332653244339</c:v>
                </c:pt>
                <c:pt idx="7">
                  <c:v>0.11979999517401059</c:v>
                </c:pt>
                <c:pt idx="8">
                  <c:v>0.11833332851529121</c:v>
                </c:pt>
                <c:pt idx="9">
                  <c:v>0.111899999280770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C64-4403-8718-54D6D5FB28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362976"/>
        <c:axId val="149377376"/>
      </c:lineChart>
      <c:catAx>
        <c:axId val="149362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77376"/>
        <c:crosses val="autoZero"/>
        <c:auto val="1"/>
        <c:lblAlgn val="ctr"/>
        <c:lblOffset val="100"/>
        <c:noMultiLvlLbl val="0"/>
      </c:catAx>
      <c:valAx>
        <c:axId val="149377376"/>
        <c:scaling>
          <c:orientation val="minMax"/>
          <c:max val="0.1500000000000000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62976"/>
        <c:crosses val="autoZero"/>
        <c:crossBetween val="midCat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3.2824074074074089E-2"/>
          <c:w val="0.87755796150481191"/>
          <c:h val="0.73936816277702389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AQ$102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09:$BA$109</c:f>
                <c:numCache>
                  <c:formatCode>General</c:formatCode>
                  <c:ptCount val="10"/>
                  <c:pt idx="0">
                    <c:v>4.0664201375088777E-2</c:v>
                  </c:pt>
                  <c:pt idx="1">
                    <c:v>3.4890643154641035E-2</c:v>
                  </c:pt>
                  <c:pt idx="2">
                    <c:v>3.0033403202097117E-2</c:v>
                  </c:pt>
                  <c:pt idx="3">
                    <c:v>4.3933624037519284E-2</c:v>
                  </c:pt>
                  <c:pt idx="4">
                    <c:v>3.9805813241869957E-2</c:v>
                  </c:pt>
                  <c:pt idx="5">
                    <c:v>4.9579379779015713E-2</c:v>
                  </c:pt>
                  <c:pt idx="6">
                    <c:v>4.9733425534991285E-2</c:v>
                  </c:pt>
                  <c:pt idx="7">
                    <c:v>4.6203352814234488E-2</c:v>
                  </c:pt>
                  <c:pt idx="8">
                    <c:v>1.1372364215414387E-2</c:v>
                  </c:pt>
                  <c:pt idx="9">
                    <c:v>2.0894366805695477E-2</c:v>
                  </c:pt>
                </c:numCache>
              </c:numRef>
            </c:plus>
            <c:minus>
              <c:numRef>
                <c:f>'[^N1610.2025.04.30.xlsx]計算'!$AR$109:$BA$109</c:f>
                <c:numCache>
                  <c:formatCode>General</c:formatCode>
                  <c:ptCount val="10"/>
                  <c:pt idx="0">
                    <c:v>4.0664201375088777E-2</c:v>
                  </c:pt>
                  <c:pt idx="1">
                    <c:v>3.4890643154641035E-2</c:v>
                  </c:pt>
                  <c:pt idx="2">
                    <c:v>3.0033403202097117E-2</c:v>
                  </c:pt>
                  <c:pt idx="3">
                    <c:v>4.3933624037519284E-2</c:v>
                  </c:pt>
                  <c:pt idx="4">
                    <c:v>3.9805813241869957E-2</c:v>
                  </c:pt>
                  <c:pt idx="5">
                    <c:v>4.9579379779015713E-2</c:v>
                  </c:pt>
                  <c:pt idx="6">
                    <c:v>4.9733425534991285E-2</c:v>
                  </c:pt>
                  <c:pt idx="7">
                    <c:v>4.6203352814234488E-2</c:v>
                  </c:pt>
                  <c:pt idx="8">
                    <c:v>1.1372364215414387E-2</c:v>
                  </c:pt>
                  <c:pt idx="9">
                    <c:v>2.08943668056954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01:$BA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AR$102:$BA$102</c:f>
              <c:numCache>
                <c:formatCode>General</c:formatCode>
                <c:ptCount val="10"/>
                <c:pt idx="0">
                  <c:v>0.24998333429296812</c:v>
                </c:pt>
                <c:pt idx="1">
                  <c:v>0.27415000274777412</c:v>
                </c:pt>
                <c:pt idx="2">
                  <c:v>0.28291666880249977</c:v>
                </c:pt>
                <c:pt idx="3">
                  <c:v>0.31703332935770351</c:v>
                </c:pt>
                <c:pt idx="4">
                  <c:v>0.33034999544421834</c:v>
                </c:pt>
                <c:pt idx="5">
                  <c:v>0.32181666667262715</c:v>
                </c:pt>
                <c:pt idx="6">
                  <c:v>0.3570000020166238</c:v>
                </c:pt>
                <c:pt idx="7">
                  <c:v>0.35103332872192067</c:v>
                </c:pt>
                <c:pt idx="8">
                  <c:v>0.11353332921862602</c:v>
                </c:pt>
                <c:pt idx="9">
                  <c:v>4.518333325783411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77E-4BB5-9941-15E67AB64AA9}"/>
            </c:ext>
          </c:extLst>
        </c:ser>
        <c:ser>
          <c:idx val="1"/>
          <c:order val="1"/>
          <c:tx>
            <c:strRef>
              <c:f>'[^N1610.2025.04.30.xlsx]計算'!$AQ$103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07:$BA$107</c:f>
                <c:numCache>
                  <c:formatCode>General</c:formatCode>
                  <c:ptCount val="10"/>
                  <c:pt idx="0">
                    <c:v>2.1132634810503328E-2</c:v>
                  </c:pt>
                  <c:pt idx="1">
                    <c:v>1.771604079381495E-2</c:v>
                  </c:pt>
                  <c:pt idx="2">
                    <c:v>3.0205679932629924E-2</c:v>
                  </c:pt>
                  <c:pt idx="3">
                    <c:v>5.1660493487572644E-2</c:v>
                  </c:pt>
                  <c:pt idx="4">
                    <c:v>7.3411655302882434E-2</c:v>
                  </c:pt>
                  <c:pt idx="5">
                    <c:v>6.9500319129834787E-2</c:v>
                  </c:pt>
                  <c:pt idx="6">
                    <c:v>6.033342948101425E-2</c:v>
                  </c:pt>
                  <c:pt idx="7">
                    <c:v>3.9707151419933452E-2</c:v>
                  </c:pt>
                  <c:pt idx="8">
                    <c:v>2.658690916329505E-2</c:v>
                  </c:pt>
                  <c:pt idx="9">
                    <c:v>6.8500374632537017E-3</c:v>
                  </c:pt>
                </c:numCache>
              </c:numRef>
            </c:plus>
            <c:minus>
              <c:numRef>
                <c:f>'[^N1610.2025.04.30.xlsx]計算'!$AR$107:$BA$107</c:f>
                <c:numCache>
                  <c:formatCode>General</c:formatCode>
                  <c:ptCount val="10"/>
                  <c:pt idx="0">
                    <c:v>2.1132634810503328E-2</c:v>
                  </c:pt>
                  <c:pt idx="1">
                    <c:v>1.771604079381495E-2</c:v>
                  </c:pt>
                  <c:pt idx="2">
                    <c:v>3.0205679932629924E-2</c:v>
                  </c:pt>
                  <c:pt idx="3">
                    <c:v>5.1660493487572644E-2</c:v>
                  </c:pt>
                  <c:pt idx="4">
                    <c:v>7.3411655302882434E-2</c:v>
                  </c:pt>
                  <c:pt idx="5">
                    <c:v>6.9500319129834787E-2</c:v>
                  </c:pt>
                  <c:pt idx="6">
                    <c:v>6.033342948101425E-2</c:v>
                  </c:pt>
                  <c:pt idx="7">
                    <c:v>3.9707151419933452E-2</c:v>
                  </c:pt>
                  <c:pt idx="8">
                    <c:v>2.658690916329505E-2</c:v>
                  </c:pt>
                  <c:pt idx="9">
                    <c:v>6.850037463253701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01:$BA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AR$103:$BA$103</c:f>
              <c:numCache>
                <c:formatCode>General</c:formatCode>
                <c:ptCount val="10"/>
                <c:pt idx="0">
                  <c:v>0.2589000016450882</c:v>
                </c:pt>
                <c:pt idx="1">
                  <c:v>0.32625000178813934</c:v>
                </c:pt>
                <c:pt idx="2">
                  <c:v>0.32123333215713501</c:v>
                </c:pt>
                <c:pt idx="3">
                  <c:v>0.32854999601840973</c:v>
                </c:pt>
                <c:pt idx="4">
                  <c:v>0.36526666581630707</c:v>
                </c:pt>
                <c:pt idx="5">
                  <c:v>0.40446666876475018</c:v>
                </c:pt>
                <c:pt idx="6">
                  <c:v>0.41686666508515674</c:v>
                </c:pt>
                <c:pt idx="7">
                  <c:v>0.34141667187213898</c:v>
                </c:pt>
                <c:pt idx="8">
                  <c:v>0.12899999817212424</c:v>
                </c:pt>
                <c:pt idx="9">
                  <c:v>4.425000399351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77E-4BB5-9941-15E67AB64AA9}"/>
            </c:ext>
          </c:extLst>
        </c:ser>
        <c:ser>
          <c:idx val="2"/>
          <c:order val="2"/>
          <c:tx>
            <c:strRef>
              <c:f>'[^N1610.2025.04.30.xlsx]計算'!$AQ$104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08:$BA$108</c:f>
                <c:numCache>
                  <c:formatCode>General</c:formatCode>
                  <c:ptCount val="10"/>
                  <c:pt idx="0">
                    <c:v>1.994048087962489E-2</c:v>
                  </c:pt>
                  <c:pt idx="1">
                    <c:v>1.7389283054616182E-2</c:v>
                  </c:pt>
                  <c:pt idx="2">
                    <c:v>3.2530951052595167E-2</c:v>
                  </c:pt>
                  <c:pt idx="3">
                    <c:v>5.5501410963132096E-2</c:v>
                  </c:pt>
                  <c:pt idx="4">
                    <c:v>6.1521031342812456E-2</c:v>
                  </c:pt>
                  <c:pt idx="5">
                    <c:v>5.1934401897087569E-2</c:v>
                  </c:pt>
                  <c:pt idx="6">
                    <c:v>5.9073595050084221E-2</c:v>
                  </c:pt>
                  <c:pt idx="7">
                    <c:v>9.3158951993139782E-2</c:v>
                  </c:pt>
                  <c:pt idx="8">
                    <c:v>2.18223532014531E-2</c:v>
                  </c:pt>
                  <c:pt idx="9">
                    <c:v>1.1658202591530158E-2</c:v>
                  </c:pt>
                </c:numCache>
              </c:numRef>
            </c:plus>
            <c:minus>
              <c:numRef>
                <c:f>'[^N1610.2025.04.30.xlsx]計算'!$AR$108:$BA$108</c:f>
                <c:numCache>
                  <c:formatCode>General</c:formatCode>
                  <c:ptCount val="10"/>
                  <c:pt idx="0">
                    <c:v>1.994048087962489E-2</c:v>
                  </c:pt>
                  <c:pt idx="1">
                    <c:v>1.7389283054616182E-2</c:v>
                  </c:pt>
                  <c:pt idx="2">
                    <c:v>3.2530951052595167E-2</c:v>
                  </c:pt>
                  <c:pt idx="3">
                    <c:v>5.5501410963132096E-2</c:v>
                  </c:pt>
                  <c:pt idx="4">
                    <c:v>6.1521031342812456E-2</c:v>
                  </c:pt>
                  <c:pt idx="5">
                    <c:v>5.1934401897087569E-2</c:v>
                  </c:pt>
                  <c:pt idx="6">
                    <c:v>5.9073595050084221E-2</c:v>
                  </c:pt>
                  <c:pt idx="7">
                    <c:v>9.3158951993139782E-2</c:v>
                  </c:pt>
                  <c:pt idx="8">
                    <c:v>2.18223532014531E-2</c:v>
                  </c:pt>
                  <c:pt idx="9">
                    <c:v>1.16582025915301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01:$BA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AR$104:$BA$104</c:f>
              <c:numCache>
                <c:formatCode>General</c:formatCode>
                <c:ptCount val="10"/>
                <c:pt idx="0">
                  <c:v>0.34326666841904324</c:v>
                </c:pt>
                <c:pt idx="1">
                  <c:v>0.36844999343156815</c:v>
                </c:pt>
                <c:pt idx="2">
                  <c:v>0.394849993288517</c:v>
                </c:pt>
                <c:pt idx="3">
                  <c:v>0.41305000334978104</c:v>
                </c:pt>
                <c:pt idx="4">
                  <c:v>0.42551666746536893</c:v>
                </c:pt>
                <c:pt idx="5">
                  <c:v>0.44993332773447037</c:v>
                </c:pt>
                <c:pt idx="6">
                  <c:v>0.46640000492334366</c:v>
                </c:pt>
                <c:pt idx="7">
                  <c:v>0.51868332674105966</c:v>
                </c:pt>
                <c:pt idx="8">
                  <c:v>0.25304999699195224</c:v>
                </c:pt>
                <c:pt idx="9">
                  <c:v>0.142783333857854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77E-4BB5-9941-15E67AB64AA9}"/>
            </c:ext>
          </c:extLst>
        </c:ser>
        <c:ser>
          <c:idx val="3"/>
          <c:order val="3"/>
          <c:tx>
            <c:strRef>
              <c:f>'[^N1610.2025.04.30.xlsx]計算'!$AQ$105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09:$BA$109</c:f>
                <c:numCache>
                  <c:formatCode>General</c:formatCode>
                  <c:ptCount val="10"/>
                  <c:pt idx="0">
                    <c:v>4.0664201375088777E-2</c:v>
                  </c:pt>
                  <c:pt idx="1">
                    <c:v>3.4890643154641035E-2</c:v>
                  </c:pt>
                  <c:pt idx="2">
                    <c:v>3.0033403202097117E-2</c:v>
                  </c:pt>
                  <c:pt idx="3">
                    <c:v>4.3933624037519284E-2</c:v>
                  </c:pt>
                  <c:pt idx="4">
                    <c:v>3.9805813241869957E-2</c:v>
                  </c:pt>
                  <c:pt idx="5">
                    <c:v>4.9579379779015713E-2</c:v>
                  </c:pt>
                  <c:pt idx="6">
                    <c:v>4.9733425534991285E-2</c:v>
                  </c:pt>
                  <c:pt idx="7">
                    <c:v>4.6203352814234488E-2</c:v>
                  </c:pt>
                  <c:pt idx="8">
                    <c:v>1.1372364215414387E-2</c:v>
                  </c:pt>
                  <c:pt idx="9">
                    <c:v>2.0894366805695477E-2</c:v>
                  </c:pt>
                </c:numCache>
              </c:numRef>
            </c:plus>
            <c:minus>
              <c:numRef>
                <c:f>'[^N1610.2025.04.30.xlsx]計算'!$AR$109:$BA$109</c:f>
                <c:numCache>
                  <c:formatCode>General</c:formatCode>
                  <c:ptCount val="10"/>
                  <c:pt idx="0">
                    <c:v>4.0664201375088777E-2</c:v>
                  </c:pt>
                  <c:pt idx="1">
                    <c:v>3.4890643154641035E-2</c:v>
                  </c:pt>
                  <c:pt idx="2">
                    <c:v>3.0033403202097117E-2</c:v>
                  </c:pt>
                  <c:pt idx="3">
                    <c:v>4.3933624037519284E-2</c:v>
                  </c:pt>
                  <c:pt idx="4">
                    <c:v>3.9805813241869957E-2</c:v>
                  </c:pt>
                  <c:pt idx="5">
                    <c:v>4.9579379779015713E-2</c:v>
                  </c:pt>
                  <c:pt idx="6">
                    <c:v>4.9733425534991285E-2</c:v>
                  </c:pt>
                  <c:pt idx="7">
                    <c:v>4.6203352814234488E-2</c:v>
                  </c:pt>
                  <c:pt idx="8">
                    <c:v>1.1372364215414387E-2</c:v>
                  </c:pt>
                  <c:pt idx="9">
                    <c:v>2.08943668056954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01:$BA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AR$105:$BA$105</c:f>
              <c:numCache>
                <c:formatCode>General</c:formatCode>
                <c:ptCount val="10"/>
                <c:pt idx="0">
                  <c:v>0.3577750027179718</c:v>
                </c:pt>
                <c:pt idx="1">
                  <c:v>0.3890249952673912</c:v>
                </c:pt>
                <c:pt idx="2">
                  <c:v>0.45098332564036053</c:v>
                </c:pt>
                <c:pt idx="3">
                  <c:v>0.4717666705449422</c:v>
                </c:pt>
                <c:pt idx="4">
                  <c:v>0.49956667423248291</c:v>
                </c:pt>
                <c:pt idx="5">
                  <c:v>0.50363334019978845</c:v>
                </c:pt>
                <c:pt idx="6">
                  <c:v>0.53751667340596521</c:v>
                </c:pt>
                <c:pt idx="7">
                  <c:v>0.51668333013852441</c:v>
                </c:pt>
                <c:pt idx="8">
                  <c:v>0.30716666579246521</c:v>
                </c:pt>
                <c:pt idx="9">
                  <c:v>0.248733336726824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77E-4BB5-9941-15E67AB64A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0732127"/>
        <c:axId val="900735007"/>
      </c:lineChart>
      <c:catAx>
        <c:axId val="9007321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00735007"/>
        <c:crosses val="autoZero"/>
        <c:auto val="1"/>
        <c:lblAlgn val="ctr"/>
        <c:lblOffset val="100"/>
        <c:noMultiLvlLbl val="0"/>
      </c:catAx>
      <c:valAx>
        <c:axId val="900735007"/>
        <c:scaling>
          <c:orientation val="minMax"/>
          <c:max val="0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00732127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53149606299214E-2"/>
          <c:y val="4.2083333333333355E-2"/>
          <c:w val="0.88389129483814521"/>
          <c:h val="0.82794728783902016"/>
        </c:manualLayout>
      </c:layout>
      <c:lineChart>
        <c:grouping val="standard"/>
        <c:varyColors val="0"/>
        <c:ser>
          <c:idx val="0"/>
          <c:order val="0"/>
          <c:tx>
            <c:strRef>
              <c:f>計算!$CB$67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66:$CL$66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67:$CL$67</c:f>
              <c:numCache>
                <c:formatCode>General</c:formatCode>
                <c:ptCount val="10"/>
                <c:pt idx="0">
                  <c:v>9.5166667054096862E-2</c:v>
                </c:pt>
                <c:pt idx="1">
                  <c:v>0.10346666847666104</c:v>
                </c:pt>
                <c:pt idx="2">
                  <c:v>9.9116666863361999E-2</c:v>
                </c:pt>
                <c:pt idx="3">
                  <c:v>9.8216666529575988E-2</c:v>
                </c:pt>
                <c:pt idx="4">
                  <c:v>9.7500002632538482E-2</c:v>
                </c:pt>
                <c:pt idx="5">
                  <c:v>0.10171666617194812</c:v>
                </c:pt>
                <c:pt idx="6">
                  <c:v>9.2066666732231781E-2</c:v>
                </c:pt>
                <c:pt idx="7">
                  <c:v>9.7633330772320434E-2</c:v>
                </c:pt>
                <c:pt idx="8">
                  <c:v>9.8200002064307526E-2</c:v>
                </c:pt>
                <c:pt idx="9">
                  <c:v>8.543333535393078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822-459B-8E5C-5683ACB3629B}"/>
            </c:ext>
          </c:extLst>
        </c:ser>
        <c:ser>
          <c:idx val="1"/>
          <c:order val="1"/>
          <c:tx>
            <c:strRef>
              <c:f>計算!$CB$68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70:$CL$70</c:f>
                <c:numCache>
                  <c:formatCode>General</c:formatCode>
                  <c:ptCount val="10"/>
                  <c:pt idx="0">
                    <c:v>9.5407897076186278E-3</c:v>
                  </c:pt>
                  <c:pt idx="1">
                    <c:v>8.3672385252360464E-3</c:v>
                  </c:pt>
                  <c:pt idx="2">
                    <c:v>5.4411094450006877E-3</c:v>
                  </c:pt>
                  <c:pt idx="3">
                    <c:v>3.7488205729889952E-3</c:v>
                  </c:pt>
                  <c:pt idx="4">
                    <c:v>1.117604452030763E-2</c:v>
                  </c:pt>
                  <c:pt idx="5">
                    <c:v>8.0392581877287532E-3</c:v>
                  </c:pt>
                  <c:pt idx="6">
                    <c:v>6.9549017815662903E-3</c:v>
                  </c:pt>
                  <c:pt idx="7">
                    <c:v>1.1310642877634235E-2</c:v>
                  </c:pt>
                  <c:pt idx="8">
                    <c:v>8.0783621048229233E-3</c:v>
                  </c:pt>
                  <c:pt idx="9">
                    <c:v>3.9363275615511084E-3</c:v>
                  </c:pt>
                </c:numCache>
              </c:numRef>
            </c:plus>
            <c:minus>
              <c:numRef>
                <c:f>計算!$CC$70:$CL$70</c:f>
                <c:numCache>
                  <c:formatCode>General</c:formatCode>
                  <c:ptCount val="10"/>
                  <c:pt idx="0">
                    <c:v>9.5407897076186278E-3</c:v>
                  </c:pt>
                  <c:pt idx="1">
                    <c:v>8.3672385252360464E-3</c:v>
                  </c:pt>
                  <c:pt idx="2">
                    <c:v>5.4411094450006877E-3</c:v>
                  </c:pt>
                  <c:pt idx="3">
                    <c:v>3.7488205729889952E-3</c:v>
                  </c:pt>
                  <c:pt idx="4">
                    <c:v>1.117604452030763E-2</c:v>
                  </c:pt>
                  <c:pt idx="5">
                    <c:v>8.0392581877287532E-3</c:v>
                  </c:pt>
                  <c:pt idx="6">
                    <c:v>6.9549017815662903E-3</c:v>
                  </c:pt>
                  <c:pt idx="7">
                    <c:v>1.1310642877634235E-2</c:v>
                  </c:pt>
                  <c:pt idx="8">
                    <c:v>8.0783621048229233E-3</c:v>
                  </c:pt>
                  <c:pt idx="9">
                    <c:v>3.936327561551108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66:$CL$66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68:$CL$68</c:f>
              <c:numCache>
                <c:formatCode>General</c:formatCode>
                <c:ptCount val="10"/>
                <c:pt idx="0">
                  <c:v>9.5166667054096862E-2</c:v>
                </c:pt>
                <c:pt idx="1">
                  <c:v>8.7216666589180647E-2</c:v>
                </c:pt>
                <c:pt idx="2">
                  <c:v>8.5049998015165343E-2</c:v>
                </c:pt>
                <c:pt idx="3">
                  <c:v>9.0599997589985534E-2</c:v>
                </c:pt>
                <c:pt idx="4">
                  <c:v>8.7833328793446228E-2</c:v>
                </c:pt>
                <c:pt idx="5">
                  <c:v>9.0299994995196656E-2</c:v>
                </c:pt>
                <c:pt idx="6">
                  <c:v>8.0116663128137602E-2</c:v>
                </c:pt>
                <c:pt idx="7">
                  <c:v>9.3283326675494507E-2</c:v>
                </c:pt>
                <c:pt idx="8">
                  <c:v>9.3933330227931336E-2</c:v>
                </c:pt>
                <c:pt idx="9">
                  <c:v>8.591666569312413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822-459B-8E5C-5683ACB362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373056"/>
        <c:axId val="149378336"/>
      </c:lineChart>
      <c:catAx>
        <c:axId val="1493730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78336"/>
        <c:crosses val="autoZero"/>
        <c:auto val="1"/>
        <c:lblAlgn val="ctr"/>
        <c:lblOffset val="100"/>
        <c:noMultiLvlLbl val="0"/>
      </c:catAx>
      <c:valAx>
        <c:axId val="149378336"/>
        <c:scaling>
          <c:orientation val="minMax"/>
          <c:max val="0.1500000000000000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73056"/>
        <c:crosses val="autoZero"/>
        <c:crossBetween val="midCat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6.0601851851851872E-2"/>
          <c:w val="0.89655796150481193"/>
          <c:h val="0.85514690871974319"/>
        </c:manualLayout>
      </c:layout>
      <c:lineChart>
        <c:grouping val="standard"/>
        <c:varyColors val="0"/>
        <c:ser>
          <c:idx val="0"/>
          <c:order val="0"/>
          <c:tx>
            <c:strRef>
              <c:f>計算!$CB$79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78:$CL$78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79:$CL$79</c:f>
              <c:numCache>
                <c:formatCode>General</c:formatCode>
                <c:ptCount val="10"/>
                <c:pt idx="0">
                  <c:v>0.22749999538064003</c:v>
                </c:pt>
                <c:pt idx="1">
                  <c:v>0.27059999729196232</c:v>
                </c:pt>
                <c:pt idx="2">
                  <c:v>0.27015000209212303</c:v>
                </c:pt>
                <c:pt idx="3">
                  <c:v>0.27778333549698192</c:v>
                </c:pt>
                <c:pt idx="4">
                  <c:v>0.27078333124518394</c:v>
                </c:pt>
                <c:pt idx="5">
                  <c:v>0.29379999761780101</c:v>
                </c:pt>
                <c:pt idx="6">
                  <c:v>0.29203333084781963</c:v>
                </c:pt>
                <c:pt idx="7">
                  <c:v>0.27385000015298527</c:v>
                </c:pt>
                <c:pt idx="8">
                  <c:v>0.27415000523130101</c:v>
                </c:pt>
                <c:pt idx="9">
                  <c:v>0.266066671659549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808-4809-BC74-60122315AB02}"/>
            </c:ext>
          </c:extLst>
        </c:ser>
        <c:ser>
          <c:idx val="1"/>
          <c:order val="1"/>
          <c:tx>
            <c:strRef>
              <c:f>計算!$CB$80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82:$CL$82</c:f>
                <c:numCache>
                  <c:formatCode>General</c:formatCode>
                  <c:ptCount val="10"/>
                  <c:pt idx="0">
                    <c:v>2.1036446901485345E-2</c:v>
                  </c:pt>
                  <c:pt idx="1">
                    <c:v>3.2638387617960077E-2</c:v>
                  </c:pt>
                  <c:pt idx="2">
                    <c:v>2.387256079693369E-2</c:v>
                  </c:pt>
                  <c:pt idx="3">
                    <c:v>2.2628598569921988E-2</c:v>
                  </c:pt>
                  <c:pt idx="4">
                    <c:v>1.8557312660624561E-2</c:v>
                  </c:pt>
                  <c:pt idx="5">
                    <c:v>4.3556670823896852E-2</c:v>
                  </c:pt>
                  <c:pt idx="6">
                    <c:v>2.8595848659535412E-2</c:v>
                  </c:pt>
                  <c:pt idx="7">
                    <c:v>2.4998858558480996E-2</c:v>
                  </c:pt>
                  <c:pt idx="8">
                    <c:v>1.7869829039311058E-2</c:v>
                  </c:pt>
                  <c:pt idx="9">
                    <c:v>1.9859875818166985E-2</c:v>
                  </c:pt>
                </c:numCache>
              </c:numRef>
            </c:plus>
            <c:minus>
              <c:numRef>
                <c:f>計算!$CC$82:$CL$82</c:f>
                <c:numCache>
                  <c:formatCode>General</c:formatCode>
                  <c:ptCount val="10"/>
                  <c:pt idx="0">
                    <c:v>2.1036446901485345E-2</c:v>
                  </c:pt>
                  <c:pt idx="1">
                    <c:v>3.2638387617960077E-2</c:v>
                  </c:pt>
                  <c:pt idx="2">
                    <c:v>2.387256079693369E-2</c:v>
                  </c:pt>
                  <c:pt idx="3">
                    <c:v>2.2628598569921988E-2</c:v>
                  </c:pt>
                  <c:pt idx="4">
                    <c:v>1.8557312660624561E-2</c:v>
                  </c:pt>
                  <c:pt idx="5">
                    <c:v>4.3556670823896852E-2</c:v>
                  </c:pt>
                  <c:pt idx="6">
                    <c:v>2.8595848659535412E-2</c:v>
                  </c:pt>
                  <c:pt idx="7">
                    <c:v>2.4998858558480996E-2</c:v>
                  </c:pt>
                  <c:pt idx="8">
                    <c:v>1.7869829039311058E-2</c:v>
                  </c:pt>
                  <c:pt idx="9">
                    <c:v>1.985987581816698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78:$CL$78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80:$CL$80</c:f>
              <c:numCache>
                <c:formatCode>General</c:formatCode>
                <c:ptCount val="10"/>
                <c:pt idx="0">
                  <c:v>0.22749999538064003</c:v>
                </c:pt>
                <c:pt idx="1">
                  <c:v>0.22749999538064</c:v>
                </c:pt>
                <c:pt idx="2">
                  <c:v>0.22749999538064003</c:v>
                </c:pt>
                <c:pt idx="3">
                  <c:v>0.22749999538064006</c:v>
                </c:pt>
                <c:pt idx="4">
                  <c:v>0.22749999538064003</c:v>
                </c:pt>
                <c:pt idx="5">
                  <c:v>0.22749999538064006</c:v>
                </c:pt>
                <c:pt idx="6">
                  <c:v>0.22749999538064006</c:v>
                </c:pt>
                <c:pt idx="7">
                  <c:v>0.22749999538064</c:v>
                </c:pt>
                <c:pt idx="8">
                  <c:v>0.22749999538064</c:v>
                </c:pt>
                <c:pt idx="9">
                  <c:v>0.22749999538064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808-4809-BC74-60122315AB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420096"/>
        <c:axId val="149414336"/>
      </c:lineChart>
      <c:catAx>
        <c:axId val="149420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414336"/>
        <c:crosses val="autoZero"/>
        <c:auto val="1"/>
        <c:lblAlgn val="ctr"/>
        <c:lblOffset val="100"/>
        <c:noMultiLvlLbl val="0"/>
      </c:catAx>
      <c:valAx>
        <c:axId val="149414336"/>
        <c:scaling>
          <c:orientation val="minMax"/>
          <c:max val="0.4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42009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3.7453703703703718E-2"/>
          <c:w val="0.89655796150481193"/>
          <c:h val="0.85514690871974319"/>
        </c:manualLayout>
      </c:layout>
      <c:lineChart>
        <c:grouping val="standard"/>
        <c:varyColors val="0"/>
        <c:ser>
          <c:idx val="0"/>
          <c:order val="0"/>
          <c:tx>
            <c:strRef>
              <c:f>計算!$CB$91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90:$CL$90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91:$CL$91</c:f>
              <c:numCache>
                <c:formatCode>General</c:formatCode>
                <c:ptCount val="10"/>
                <c:pt idx="0">
                  <c:v>0.23320000121990839</c:v>
                </c:pt>
                <c:pt idx="1">
                  <c:v>0.26011667400598526</c:v>
                </c:pt>
                <c:pt idx="2">
                  <c:v>0.27604999889930087</c:v>
                </c:pt>
                <c:pt idx="3">
                  <c:v>0.28220000118017197</c:v>
                </c:pt>
                <c:pt idx="4">
                  <c:v>0.27510000516970951</c:v>
                </c:pt>
                <c:pt idx="5">
                  <c:v>0.28575000415245694</c:v>
                </c:pt>
                <c:pt idx="6">
                  <c:v>0.27638333787520725</c:v>
                </c:pt>
                <c:pt idx="7">
                  <c:v>0.26280000557502109</c:v>
                </c:pt>
                <c:pt idx="8">
                  <c:v>0.25818333278099698</c:v>
                </c:pt>
                <c:pt idx="9">
                  <c:v>0.228166672090689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6E2-47E3-A5E6-18191700DF15}"/>
            </c:ext>
          </c:extLst>
        </c:ser>
        <c:ser>
          <c:idx val="1"/>
          <c:order val="1"/>
          <c:tx>
            <c:strRef>
              <c:f>計算!$CB$92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94:$CL$94</c:f>
                <c:numCache>
                  <c:formatCode>General</c:formatCode>
                  <c:ptCount val="10"/>
                  <c:pt idx="0">
                    <c:v>1.1231205324017082E-2</c:v>
                  </c:pt>
                  <c:pt idx="1">
                    <c:v>2.8359437177058171E-2</c:v>
                  </c:pt>
                  <c:pt idx="2">
                    <c:v>2.8872324498627918E-2</c:v>
                  </c:pt>
                  <c:pt idx="3">
                    <c:v>9.5580357344011053E-3</c:v>
                  </c:pt>
                  <c:pt idx="4">
                    <c:v>1.1624975783211899E-2</c:v>
                  </c:pt>
                  <c:pt idx="5">
                    <c:v>1.8041371644940348E-2</c:v>
                  </c:pt>
                  <c:pt idx="6">
                    <c:v>3.0443281983791762E-2</c:v>
                  </c:pt>
                  <c:pt idx="7">
                    <c:v>2.8342685748324943E-2</c:v>
                  </c:pt>
                  <c:pt idx="8">
                    <c:v>2.171868743810984E-2</c:v>
                  </c:pt>
                  <c:pt idx="9">
                    <c:v>1.9069623601245651E-2</c:v>
                  </c:pt>
                </c:numCache>
              </c:numRef>
            </c:plus>
            <c:minus>
              <c:numRef>
                <c:f>計算!$CC$94:$CL$94</c:f>
                <c:numCache>
                  <c:formatCode>General</c:formatCode>
                  <c:ptCount val="10"/>
                  <c:pt idx="0">
                    <c:v>1.1231205324017082E-2</c:v>
                  </c:pt>
                  <c:pt idx="1">
                    <c:v>2.8359437177058171E-2</c:v>
                  </c:pt>
                  <c:pt idx="2">
                    <c:v>2.8872324498627918E-2</c:v>
                  </c:pt>
                  <c:pt idx="3">
                    <c:v>9.5580357344011053E-3</c:v>
                  </c:pt>
                  <c:pt idx="4">
                    <c:v>1.1624975783211899E-2</c:v>
                  </c:pt>
                  <c:pt idx="5">
                    <c:v>1.8041371644940348E-2</c:v>
                  </c:pt>
                  <c:pt idx="6">
                    <c:v>3.0443281983791762E-2</c:v>
                  </c:pt>
                  <c:pt idx="7">
                    <c:v>2.8342685748324943E-2</c:v>
                  </c:pt>
                  <c:pt idx="8">
                    <c:v>2.171868743810984E-2</c:v>
                  </c:pt>
                  <c:pt idx="9">
                    <c:v>1.906962360124565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90:$CL$90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92:$CL$92</c:f>
              <c:numCache>
                <c:formatCode>General</c:formatCode>
                <c:ptCount val="10"/>
                <c:pt idx="0">
                  <c:v>0.23320000121990839</c:v>
                </c:pt>
                <c:pt idx="1">
                  <c:v>0.21701667209466294</c:v>
                </c:pt>
                <c:pt idx="2">
                  <c:v>0.2333999921878179</c:v>
                </c:pt>
                <c:pt idx="3">
                  <c:v>0.2319166610638301</c:v>
                </c:pt>
                <c:pt idx="4">
                  <c:v>0.23181666930516562</c:v>
                </c:pt>
                <c:pt idx="5">
                  <c:v>0.21945000191529596</c:v>
                </c:pt>
                <c:pt idx="6">
                  <c:v>0.21185000240802768</c:v>
                </c:pt>
                <c:pt idx="7">
                  <c:v>0.21645000080267585</c:v>
                </c:pt>
                <c:pt idx="8">
                  <c:v>0.21153332293033597</c:v>
                </c:pt>
                <c:pt idx="9">
                  <c:v>0.189599995811780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6E2-47E3-A5E6-18191700DF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403776"/>
        <c:axId val="149408096"/>
      </c:lineChart>
      <c:catAx>
        <c:axId val="149403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408096"/>
        <c:crosses val="autoZero"/>
        <c:auto val="1"/>
        <c:lblAlgn val="ctr"/>
        <c:lblOffset val="100"/>
        <c:noMultiLvlLbl val="0"/>
      </c:catAx>
      <c:valAx>
        <c:axId val="149408096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40377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2.5428331875182269E-2"/>
          <c:w val="0.87122462817147861"/>
          <c:h val="0.86903579760863225"/>
        </c:manualLayout>
      </c:layout>
      <c:lineChart>
        <c:grouping val="standard"/>
        <c:varyColors val="0"/>
        <c:ser>
          <c:idx val="0"/>
          <c:order val="0"/>
          <c:tx>
            <c:strRef>
              <c:f>計算!$CB$103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102:$CL$102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103:$CL$103</c:f>
              <c:numCache>
                <c:formatCode>General</c:formatCode>
                <c:ptCount val="10"/>
                <c:pt idx="0">
                  <c:v>0.25193333129088086</c:v>
                </c:pt>
                <c:pt idx="1">
                  <c:v>0.2656833330790202</c:v>
                </c:pt>
                <c:pt idx="2">
                  <c:v>0.29545000195503235</c:v>
                </c:pt>
                <c:pt idx="3">
                  <c:v>0.2773333340883255</c:v>
                </c:pt>
                <c:pt idx="4">
                  <c:v>0.28376666704813641</c:v>
                </c:pt>
                <c:pt idx="5">
                  <c:v>0.2952333390712738</c:v>
                </c:pt>
                <c:pt idx="6">
                  <c:v>0.28396667043368023</c:v>
                </c:pt>
                <c:pt idx="7">
                  <c:v>0.28019998967647552</c:v>
                </c:pt>
                <c:pt idx="8">
                  <c:v>0.28051667412122089</c:v>
                </c:pt>
                <c:pt idx="9">
                  <c:v>0.235416670640309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984-4F70-88BF-FBBDE59512DE}"/>
            </c:ext>
          </c:extLst>
        </c:ser>
        <c:ser>
          <c:idx val="1"/>
          <c:order val="1"/>
          <c:tx>
            <c:strRef>
              <c:f>計算!$CB$104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106:$CL$106</c:f>
                <c:numCache>
                  <c:formatCode>General</c:formatCode>
                  <c:ptCount val="10"/>
                  <c:pt idx="0">
                    <c:v>1.4441839295949043E-2</c:v>
                  </c:pt>
                  <c:pt idx="1">
                    <c:v>2.6099453707895268E-2</c:v>
                  </c:pt>
                  <c:pt idx="2">
                    <c:v>2.4081256221096067E-2</c:v>
                  </c:pt>
                  <c:pt idx="3">
                    <c:v>2.2905597549107148E-2</c:v>
                  </c:pt>
                  <c:pt idx="4">
                    <c:v>2.2068867771062782E-2</c:v>
                  </c:pt>
                  <c:pt idx="5">
                    <c:v>2.6447579753840815E-2</c:v>
                  </c:pt>
                  <c:pt idx="6">
                    <c:v>2.4798676366030153E-2</c:v>
                  </c:pt>
                  <c:pt idx="7">
                    <c:v>1.3725451169198674E-2</c:v>
                  </c:pt>
                  <c:pt idx="8">
                    <c:v>1.9780332366969924E-2</c:v>
                  </c:pt>
                  <c:pt idx="9">
                    <c:v>1.4695493929502661E-2</c:v>
                  </c:pt>
                </c:numCache>
              </c:numRef>
            </c:plus>
            <c:minus>
              <c:numRef>
                <c:f>計算!$CC$106:$CL$106</c:f>
                <c:numCache>
                  <c:formatCode>General</c:formatCode>
                  <c:ptCount val="10"/>
                  <c:pt idx="0">
                    <c:v>1.4441839295949043E-2</c:v>
                  </c:pt>
                  <c:pt idx="1">
                    <c:v>2.6099453707895268E-2</c:v>
                  </c:pt>
                  <c:pt idx="2">
                    <c:v>2.4081256221096067E-2</c:v>
                  </c:pt>
                  <c:pt idx="3">
                    <c:v>2.2905597549107148E-2</c:v>
                  </c:pt>
                  <c:pt idx="4">
                    <c:v>2.2068867771062782E-2</c:v>
                  </c:pt>
                  <c:pt idx="5">
                    <c:v>2.6447579753840815E-2</c:v>
                  </c:pt>
                  <c:pt idx="6">
                    <c:v>2.4798676366030153E-2</c:v>
                  </c:pt>
                  <c:pt idx="7">
                    <c:v>1.3725451169198674E-2</c:v>
                  </c:pt>
                  <c:pt idx="8">
                    <c:v>1.9780332366969924E-2</c:v>
                  </c:pt>
                  <c:pt idx="9">
                    <c:v>1.469549392950266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102:$CL$102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104:$CL$104</c:f>
              <c:numCache>
                <c:formatCode>General</c:formatCode>
                <c:ptCount val="10"/>
                <c:pt idx="0">
                  <c:v>0.25193333129088086</c:v>
                </c:pt>
                <c:pt idx="1">
                  <c:v>0.22258333116769788</c:v>
                </c:pt>
                <c:pt idx="2">
                  <c:v>0.25279999524354935</c:v>
                </c:pt>
                <c:pt idx="3">
                  <c:v>0.22704999397198364</c:v>
                </c:pt>
                <c:pt idx="4">
                  <c:v>0.24048333118359247</c:v>
                </c:pt>
                <c:pt idx="5">
                  <c:v>0.22893333683411285</c:v>
                </c:pt>
                <c:pt idx="6">
                  <c:v>0.21943333496650064</c:v>
                </c:pt>
                <c:pt idx="7">
                  <c:v>0.23384998490413025</c:v>
                </c:pt>
                <c:pt idx="8">
                  <c:v>0.23386666427055991</c:v>
                </c:pt>
                <c:pt idx="9">
                  <c:v>0.196849994361400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984-4F70-88BF-FBBDE59512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398496"/>
        <c:axId val="149392256"/>
      </c:lineChart>
      <c:catAx>
        <c:axId val="149398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92256"/>
        <c:crosses val="autoZero"/>
        <c:auto val="1"/>
        <c:lblAlgn val="ctr"/>
        <c:lblOffset val="100"/>
        <c:noMultiLvlLbl val="0"/>
      </c:catAx>
      <c:valAx>
        <c:axId val="149392256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9849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54630719745834"/>
          <c:y val="3.7788968687579805E-2"/>
          <c:w val="0.87122462817147861"/>
          <c:h val="0.87424358413531644"/>
        </c:manualLayout>
      </c:layout>
      <c:lineChart>
        <c:grouping val="standard"/>
        <c:varyColors val="0"/>
        <c:ser>
          <c:idx val="0"/>
          <c:order val="0"/>
          <c:tx>
            <c:strRef>
              <c:f>計算!$CB$115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114:$CL$11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115:$CL$115</c:f>
              <c:numCache>
                <c:formatCode>General</c:formatCode>
                <c:ptCount val="10"/>
                <c:pt idx="0">
                  <c:v>0.20478333036104837</c:v>
                </c:pt>
                <c:pt idx="1">
                  <c:v>0.21288333088159561</c:v>
                </c:pt>
                <c:pt idx="2">
                  <c:v>0.22391666968663534</c:v>
                </c:pt>
                <c:pt idx="3">
                  <c:v>0.25283333162466687</c:v>
                </c:pt>
                <c:pt idx="4">
                  <c:v>0.23480000098546347</c:v>
                </c:pt>
                <c:pt idx="5">
                  <c:v>0.23826666673024496</c:v>
                </c:pt>
                <c:pt idx="6">
                  <c:v>0.24798333644866943</c:v>
                </c:pt>
                <c:pt idx="7">
                  <c:v>0.23891666531562805</c:v>
                </c:pt>
                <c:pt idx="8">
                  <c:v>0.23316665987173715</c:v>
                </c:pt>
                <c:pt idx="9">
                  <c:v>0.232233330607414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468-4C07-B8F1-7F970A11F0EA}"/>
            </c:ext>
          </c:extLst>
        </c:ser>
        <c:ser>
          <c:idx val="1"/>
          <c:order val="1"/>
          <c:tx>
            <c:strRef>
              <c:f>計算!$CB$116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118:$CL$118</c:f>
                <c:numCache>
                  <c:formatCode>General</c:formatCode>
                  <c:ptCount val="10"/>
                  <c:pt idx="0">
                    <c:v>1.1880805884605636E-2</c:v>
                  </c:pt>
                  <c:pt idx="1">
                    <c:v>1.9430117212269185E-2</c:v>
                  </c:pt>
                  <c:pt idx="2">
                    <c:v>1.3924574105413159E-2</c:v>
                  </c:pt>
                  <c:pt idx="3">
                    <c:v>1.1598222039626913E-2</c:v>
                  </c:pt>
                  <c:pt idx="4">
                    <c:v>1.0951523651045137E-2</c:v>
                  </c:pt>
                  <c:pt idx="5">
                    <c:v>1.0492986510398681E-2</c:v>
                  </c:pt>
                  <c:pt idx="6">
                    <c:v>1.3977757779176491E-2</c:v>
                  </c:pt>
                  <c:pt idx="7">
                    <c:v>1.4788975477456105E-2</c:v>
                  </c:pt>
                  <c:pt idx="8">
                    <c:v>7.3112728379496209E-3</c:v>
                  </c:pt>
                  <c:pt idx="9">
                    <c:v>7.9487593754884855E-3</c:v>
                  </c:pt>
                </c:numCache>
              </c:numRef>
            </c:plus>
            <c:minus>
              <c:numRef>
                <c:f>計算!$CC$118:$CL$118</c:f>
                <c:numCache>
                  <c:formatCode>General</c:formatCode>
                  <c:ptCount val="10"/>
                  <c:pt idx="0">
                    <c:v>1.1880805884605636E-2</c:v>
                  </c:pt>
                  <c:pt idx="1">
                    <c:v>1.9430117212269185E-2</c:v>
                  </c:pt>
                  <c:pt idx="2">
                    <c:v>1.3924574105413159E-2</c:v>
                  </c:pt>
                  <c:pt idx="3">
                    <c:v>1.1598222039626913E-2</c:v>
                  </c:pt>
                  <c:pt idx="4">
                    <c:v>1.0951523651045137E-2</c:v>
                  </c:pt>
                  <c:pt idx="5">
                    <c:v>1.0492986510398681E-2</c:v>
                  </c:pt>
                  <c:pt idx="6">
                    <c:v>1.3977757779176491E-2</c:v>
                  </c:pt>
                  <c:pt idx="7">
                    <c:v>1.4788975477456105E-2</c:v>
                  </c:pt>
                  <c:pt idx="8">
                    <c:v>7.3112728379496209E-3</c:v>
                  </c:pt>
                  <c:pt idx="9">
                    <c:v>7.948759375488485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114:$CL$11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C$116:$CL$116</c:f>
              <c:numCache>
                <c:formatCode>General</c:formatCode>
                <c:ptCount val="10"/>
                <c:pt idx="0">
                  <c:v>0.20478333036104837</c:v>
                </c:pt>
                <c:pt idx="1">
                  <c:v>0.20478333036104837</c:v>
                </c:pt>
                <c:pt idx="2">
                  <c:v>0.20478333036104834</c:v>
                </c:pt>
                <c:pt idx="3">
                  <c:v>0.20478333036104834</c:v>
                </c:pt>
                <c:pt idx="4">
                  <c:v>0.20478333036104834</c:v>
                </c:pt>
                <c:pt idx="5">
                  <c:v>0.20478333036104834</c:v>
                </c:pt>
                <c:pt idx="6">
                  <c:v>0.20478333036104837</c:v>
                </c:pt>
                <c:pt idx="7">
                  <c:v>0.20478333036104837</c:v>
                </c:pt>
                <c:pt idx="8">
                  <c:v>0.20478333036104837</c:v>
                </c:pt>
                <c:pt idx="9">
                  <c:v>0.204783330361048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468-4C07-B8F1-7F970A11F0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381696"/>
        <c:axId val="149382176"/>
      </c:lineChart>
      <c:catAx>
        <c:axId val="149381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82176"/>
        <c:crosses val="autoZero"/>
        <c:auto val="1"/>
        <c:lblAlgn val="ctr"/>
        <c:lblOffset val="100"/>
        <c:noMultiLvlLbl val="0"/>
      </c:catAx>
      <c:valAx>
        <c:axId val="149382176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38169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48059835844875"/>
          <c:y val="3.615238205693859E-2"/>
          <c:w val="0.88389129483814521"/>
          <c:h val="0.87424358413531644"/>
        </c:manualLayout>
      </c:layout>
      <c:lineChart>
        <c:grouping val="standard"/>
        <c:varyColors val="0"/>
        <c:ser>
          <c:idx val="0"/>
          <c:order val="0"/>
          <c:tx>
            <c:strRef>
              <c:f>計算!$CB$127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126:$CL$126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127:$CL$127</c:f>
              <c:numCache>
                <c:formatCode>General</c:formatCode>
                <c:ptCount val="10"/>
                <c:pt idx="0">
                  <c:v>0.24731666470567384</c:v>
                </c:pt>
                <c:pt idx="1">
                  <c:v>0.26653333132465679</c:v>
                </c:pt>
                <c:pt idx="2">
                  <c:v>0.28076666221022606</c:v>
                </c:pt>
                <c:pt idx="3">
                  <c:v>0.26591666166981059</c:v>
                </c:pt>
                <c:pt idx="4">
                  <c:v>0.25564999505877495</c:v>
                </c:pt>
                <c:pt idx="5">
                  <c:v>0.24223333224654198</c:v>
                </c:pt>
                <c:pt idx="6">
                  <c:v>0.23985000078876814</c:v>
                </c:pt>
                <c:pt idx="7">
                  <c:v>0.22443333392341933</c:v>
                </c:pt>
                <c:pt idx="8">
                  <c:v>0.22123332942525545</c:v>
                </c:pt>
                <c:pt idx="9">
                  <c:v>0.200149999310572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88E-4480-BAC5-D5D6AC3DBFEF}"/>
            </c:ext>
          </c:extLst>
        </c:ser>
        <c:ser>
          <c:idx val="1"/>
          <c:order val="1"/>
          <c:tx>
            <c:strRef>
              <c:f>計算!$CB$128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130:$CL$130</c:f>
                <c:numCache>
                  <c:formatCode>General</c:formatCode>
                  <c:ptCount val="10"/>
                  <c:pt idx="0">
                    <c:v>7.4861029645800639E-3</c:v>
                  </c:pt>
                  <c:pt idx="1">
                    <c:v>1.8390938997963537E-2</c:v>
                  </c:pt>
                  <c:pt idx="2">
                    <c:v>1.8955069995918814E-2</c:v>
                  </c:pt>
                  <c:pt idx="3">
                    <c:v>2.6009650464418058E-2</c:v>
                  </c:pt>
                  <c:pt idx="4">
                    <c:v>1.436882237293911E-2</c:v>
                  </c:pt>
                  <c:pt idx="5">
                    <c:v>1.3654108258053471E-2</c:v>
                  </c:pt>
                  <c:pt idx="6">
                    <c:v>1.0350022458181308E-2</c:v>
                  </c:pt>
                  <c:pt idx="7">
                    <c:v>1.2893512162644586E-2</c:v>
                  </c:pt>
                  <c:pt idx="8">
                    <c:v>6.9017818674007615E-3</c:v>
                  </c:pt>
                  <c:pt idx="9">
                    <c:v>9.7463327655865593E-3</c:v>
                  </c:pt>
                </c:numCache>
              </c:numRef>
            </c:plus>
            <c:minus>
              <c:numRef>
                <c:f>計算!$CC$130:$CL$130</c:f>
                <c:numCache>
                  <c:formatCode>General</c:formatCode>
                  <c:ptCount val="10"/>
                  <c:pt idx="0">
                    <c:v>7.4861029645800639E-3</c:v>
                  </c:pt>
                  <c:pt idx="1">
                    <c:v>1.8390938997963537E-2</c:v>
                  </c:pt>
                  <c:pt idx="2">
                    <c:v>1.8955069995918814E-2</c:v>
                  </c:pt>
                  <c:pt idx="3">
                    <c:v>2.6009650464418058E-2</c:v>
                  </c:pt>
                  <c:pt idx="4">
                    <c:v>1.436882237293911E-2</c:v>
                  </c:pt>
                  <c:pt idx="5">
                    <c:v>1.3654108258053471E-2</c:v>
                  </c:pt>
                  <c:pt idx="6">
                    <c:v>1.0350022458181308E-2</c:v>
                  </c:pt>
                  <c:pt idx="7">
                    <c:v>1.2893512162644586E-2</c:v>
                  </c:pt>
                  <c:pt idx="8">
                    <c:v>6.9017818674007615E-3</c:v>
                  </c:pt>
                  <c:pt idx="9">
                    <c:v>9.746332765586559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126:$CL$126</c:f>
              <c:numCache>
                <c:formatCode>General</c:formatCode>
                <c:ptCount val="10"/>
                <c:pt idx="0">
                  <c:v>0</c:v>
                </c:pt>
                <c:pt idx="1">
                  <c:v>1E-3</c:v>
                </c:pt>
                <c:pt idx="2">
                  <c:v>3.2000000000000002E-3</c:v>
                </c:pt>
                <c:pt idx="3">
                  <c:v>0.01</c:v>
                </c:pt>
                <c:pt idx="4">
                  <c:v>3.2000000000000001E-2</c:v>
                </c:pt>
                <c:pt idx="5">
                  <c:v>0.1</c:v>
                </c:pt>
                <c:pt idx="6">
                  <c:v>0.32</c:v>
                </c:pt>
                <c:pt idx="7">
                  <c:v>1</c:v>
                </c:pt>
                <c:pt idx="8">
                  <c:v>3.2</c:v>
                </c:pt>
                <c:pt idx="9">
                  <c:v>10</c:v>
                </c:pt>
              </c:numCache>
            </c:numRef>
          </c:cat>
          <c:val>
            <c:numRef>
              <c:f>計算!$CC$128:$CL$128</c:f>
              <c:numCache>
                <c:formatCode>General</c:formatCode>
                <c:ptCount val="10"/>
                <c:pt idx="0">
                  <c:v>0.24731666470567384</c:v>
                </c:pt>
                <c:pt idx="1">
                  <c:v>0.25843333080410957</c:v>
                </c:pt>
                <c:pt idx="2">
                  <c:v>0.26163332288463909</c:v>
                </c:pt>
                <c:pt idx="3">
                  <c:v>0.2178666604061921</c:v>
                </c:pt>
                <c:pt idx="4">
                  <c:v>0.22563332443435982</c:v>
                </c:pt>
                <c:pt idx="5">
                  <c:v>0.20874999587734536</c:v>
                </c:pt>
                <c:pt idx="6">
                  <c:v>0.19664999470114708</c:v>
                </c:pt>
                <c:pt idx="7">
                  <c:v>0.19029999896883965</c:v>
                </c:pt>
                <c:pt idx="8">
                  <c:v>0.19284999991456667</c:v>
                </c:pt>
                <c:pt idx="9">
                  <c:v>0.172699999064207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88E-4480-BAC5-D5D6AC3DBF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45613648"/>
        <c:axId val="1910037408"/>
      </c:lineChart>
      <c:catAx>
        <c:axId val="1845613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10037408"/>
        <c:crosses val="autoZero"/>
        <c:auto val="1"/>
        <c:lblAlgn val="ctr"/>
        <c:lblOffset val="100"/>
        <c:noMultiLvlLbl val="0"/>
      </c:catAx>
      <c:valAx>
        <c:axId val="1910037408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45613648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53149606299214E-2"/>
          <c:y val="5.1342592592592606E-2"/>
          <c:w val="0.39936034231908768"/>
          <c:h val="0.84125801983085446"/>
        </c:manualLayout>
      </c:layout>
      <c:lineChart>
        <c:grouping val="standard"/>
        <c:varyColors val="0"/>
        <c:ser>
          <c:idx val="0"/>
          <c:order val="0"/>
          <c:tx>
            <c:strRef>
              <c:f>計算!$CB$139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計算!$CC$138:$CL$138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139:$CL$139</c:f>
              <c:numCache>
                <c:formatCode>General</c:formatCode>
                <c:ptCount val="10"/>
                <c:pt idx="0">
                  <c:v>0.27833332866430283</c:v>
                </c:pt>
                <c:pt idx="1">
                  <c:v>0.27098332842191059</c:v>
                </c:pt>
                <c:pt idx="2">
                  <c:v>0.31048332899808884</c:v>
                </c:pt>
                <c:pt idx="3">
                  <c:v>0.30896666397651035</c:v>
                </c:pt>
                <c:pt idx="4">
                  <c:v>0.31181666006644565</c:v>
                </c:pt>
                <c:pt idx="5">
                  <c:v>0.32189999769131344</c:v>
                </c:pt>
                <c:pt idx="6">
                  <c:v>0.3146333321928978</c:v>
                </c:pt>
                <c:pt idx="7">
                  <c:v>0.30556666602691013</c:v>
                </c:pt>
                <c:pt idx="8">
                  <c:v>0.2867833251754443</c:v>
                </c:pt>
                <c:pt idx="9">
                  <c:v>0.248066666225592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478-4612-A39F-EEE4D5F3415A}"/>
            </c:ext>
          </c:extLst>
        </c:ser>
        <c:ser>
          <c:idx val="1"/>
          <c:order val="1"/>
          <c:tx>
            <c:strRef>
              <c:f>計算!$CB$140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C$142:$CL$142</c:f>
                <c:numCache>
                  <c:formatCode>General</c:formatCode>
                  <c:ptCount val="10"/>
                  <c:pt idx="0">
                    <c:v>2.5273592476850855E-2</c:v>
                  </c:pt>
                  <c:pt idx="1">
                    <c:v>6.7250765211546659E-2</c:v>
                  </c:pt>
                  <c:pt idx="2">
                    <c:v>9.7737226461065297E-3</c:v>
                  </c:pt>
                  <c:pt idx="3">
                    <c:v>1.287146587910179E-2</c:v>
                  </c:pt>
                  <c:pt idx="4">
                    <c:v>1.2648063924385101E-2</c:v>
                  </c:pt>
                  <c:pt idx="5">
                    <c:v>1.1428564280623285E-2</c:v>
                  </c:pt>
                  <c:pt idx="6">
                    <c:v>2.010112128535619E-2</c:v>
                  </c:pt>
                  <c:pt idx="7">
                    <c:v>1.6514921253813975E-2</c:v>
                  </c:pt>
                  <c:pt idx="8">
                    <c:v>1.5259931144793428E-2</c:v>
                  </c:pt>
                  <c:pt idx="9">
                    <c:v>1.413049086000975E-2</c:v>
                  </c:pt>
                </c:numCache>
              </c:numRef>
            </c:plus>
            <c:minus>
              <c:numRef>
                <c:f>計算!$CC$142:$CL$142</c:f>
                <c:numCache>
                  <c:formatCode>General</c:formatCode>
                  <c:ptCount val="10"/>
                  <c:pt idx="0">
                    <c:v>2.5273592476850855E-2</c:v>
                  </c:pt>
                  <c:pt idx="1">
                    <c:v>6.7250765211546659E-2</c:v>
                  </c:pt>
                  <c:pt idx="2">
                    <c:v>9.7737226461065297E-3</c:v>
                  </c:pt>
                  <c:pt idx="3">
                    <c:v>1.287146587910179E-2</c:v>
                  </c:pt>
                  <c:pt idx="4">
                    <c:v>1.2648063924385101E-2</c:v>
                  </c:pt>
                  <c:pt idx="5">
                    <c:v>1.1428564280623285E-2</c:v>
                  </c:pt>
                  <c:pt idx="6">
                    <c:v>2.010112128535619E-2</c:v>
                  </c:pt>
                  <c:pt idx="7">
                    <c:v>1.6514921253813975E-2</c:v>
                  </c:pt>
                  <c:pt idx="8">
                    <c:v>1.5259931144793428E-2</c:v>
                  </c:pt>
                  <c:pt idx="9">
                    <c:v>1.4130490860009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C$138:$CL$138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C$140:$CL$140</c:f>
              <c:numCache>
                <c:formatCode>General</c:formatCode>
                <c:ptCount val="10"/>
                <c:pt idx="0">
                  <c:v>0.27833332866430283</c:v>
                </c:pt>
                <c:pt idx="1">
                  <c:v>0.26288332790136332</c:v>
                </c:pt>
                <c:pt idx="2">
                  <c:v>0.29134998967250186</c:v>
                </c:pt>
                <c:pt idx="3">
                  <c:v>0.26091666271289188</c:v>
                </c:pt>
                <c:pt idx="4">
                  <c:v>0.28179998944203055</c:v>
                </c:pt>
                <c:pt idx="5">
                  <c:v>0.2884166613221168</c:v>
                </c:pt>
                <c:pt idx="6">
                  <c:v>0.27143332610527665</c:v>
                </c:pt>
                <c:pt idx="7">
                  <c:v>0.27143333107233042</c:v>
                </c:pt>
                <c:pt idx="8">
                  <c:v>0.25839999566475552</c:v>
                </c:pt>
                <c:pt idx="9">
                  <c:v>0.220616665979226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478-4612-A39F-EEE4D5F341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1178192"/>
        <c:axId val="171165712"/>
      </c:lineChart>
      <c:catAx>
        <c:axId val="171178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165712"/>
        <c:crosses val="autoZero"/>
        <c:auto val="1"/>
        <c:lblAlgn val="ctr"/>
        <c:lblOffset val="100"/>
        <c:noMultiLvlLbl val="0"/>
      </c:catAx>
      <c:valAx>
        <c:axId val="171165712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178192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6427975530903097"/>
          <c:y val="0.49365366184078108"/>
          <c:w val="0.64762127299910732"/>
          <c:h val="0.25799361536468551"/>
        </c:manualLayout>
      </c:layout>
      <c:overlay val="0"/>
      <c:spPr>
        <a:noFill/>
        <a:ln>
          <a:solidFill>
            <a:schemeClr val="accent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900"/>
            </a:pPr>
            <a:r>
              <a:rPr lang="en-US" sz="900" dirty="0"/>
              <a:t>Blank</a:t>
            </a:r>
          </a:p>
        </c:rich>
      </c:tx>
      <c:layout>
        <c:manualLayout>
          <c:xMode val="edge"/>
          <c:yMode val="edge"/>
          <c:x val="0.38807153082324064"/>
          <c:y val="0.600816109216549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60222259451611"/>
          <c:y val="3.5695059646135077E-2"/>
          <c:w val="0.88485087091386305"/>
          <c:h val="0.86283983424740496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7:$BA$7</c:f>
                <c:numCache>
                  <c:formatCode>General</c:formatCode>
                  <c:ptCount val="10"/>
                  <c:pt idx="0">
                    <c:v>1.6068533494587808E-2</c:v>
                  </c:pt>
                  <c:pt idx="1">
                    <c:v>1.7920562814150928E-2</c:v>
                  </c:pt>
                  <c:pt idx="2">
                    <c:v>1.4417720269104119E-2</c:v>
                  </c:pt>
                  <c:pt idx="3">
                    <c:v>3.0125790294190651E-2</c:v>
                  </c:pt>
                  <c:pt idx="4">
                    <c:v>3.0151907651944129E-2</c:v>
                  </c:pt>
                  <c:pt idx="5">
                    <c:v>2.2101795005046814E-2</c:v>
                  </c:pt>
                  <c:pt idx="6">
                    <c:v>2.6644056001231306E-2</c:v>
                  </c:pt>
                  <c:pt idx="7">
                    <c:v>3.0275787605308632E-2</c:v>
                  </c:pt>
                  <c:pt idx="8">
                    <c:v>1.7474264323432041E-2</c:v>
                  </c:pt>
                  <c:pt idx="9">
                    <c:v>1.2169904647228993E-2</c:v>
                  </c:pt>
                </c:numCache>
              </c:numRef>
            </c:plus>
            <c:minus>
              <c:numRef>
                <c:f>計算!$AR$7:$BA$7</c:f>
                <c:numCache>
                  <c:formatCode>General</c:formatCode>
                  <c:ptCount val="10"/>
                  <c:pt idx="0">
                    <c:v>1.6068533494587808E-2</c:v>
                  </c:pt>
                  <c:pt idx="1">
                    <c:v>1.7920562814150928E-2</c:v>
                  </c:pt>
                  <c:pt idx="2">
                    <c:v>1.4417720269104119E-2</c:v>
                  </c:pt>
                  <c:pt idx="3">
                    <c:v>3.0125790294190651E-2</c:v>
                  </c:pt>
                  <c:pt idx="4">
                    <c:v>3.0151907651944129E-2</c:v>
                  </c:pt>
                  <c:pt idx="5">
                    <c:v>2.2101795005046814E-2</c:v>
                  </c:pt>
                  <c:pt idx="6">
                    <c:v>2.6644056001231306E-2</c:v>
                  </c:pt>
                  <c:pt idx="7">
                    <c:v>3.0275787605308632E-2</c:v>
                  </c:pt>
                  <c:pt idx="8">
                    <c:v>1.7474264323432041E-2</c:v>
                  </c:pt>
                  <c:pt idx="9">
                    <c:v>1.21699046472289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5:$BA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AR$6:$BA$6</c:f>
              <c:numCache>
                <c:formatCode>General</c:formatCode>
                <c:ptCount val="10"/>
                <c:pt idx="0">
                  <c:v>0.27541666850447655</c:v>
                </c:pt>
                <c:pt idx="1">
                  <c:v>0.320166668544213</c:v>
                </c:pt>
                <c:pt idx="2">
                  <c:v>0.32536667212843895</c:v>
                </c:pt>
                <c:pt idx="3">
                  <c:v>0.35714999958872795</c:v>
                </c:pt>
                <c:pt idx="4">
                  <c:v>0.34351666395862895</c:v>
                </c:pt>
                <c:pt idx="5">
                  <c:v>0.34118333583076793</c:v>
                </c:pt>
                <c:pt idx="6">
                  <c:v>0.34298332656423253</c:v>
                </c:pt>
                <c:pt idx="7">
                  <c:v>0.32275000338753063</c:v>
                </c:pt>
                <c:pt idx="8">
                  <c:v>0.31951666995882988</c:v>
                </c:pt>
                <c:pt idx="9">
                  <c:v>0.29976666097839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EA-4DA9-8AC1-C13EE4B0B170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7:$CW$7</c:f>
                <c:numCache>
                  <c:formatCode>General</c:formatCode>
                  <c:ptCount val="10"/>
                  <c:pt idx="0">
                    <c:v>1.6068533494587808E-2</c:v>
                  </c:pt>
                  <c:pt idx="1">
                    <c:v>1.7920562814150928E-2</c:v>
                  </c:pt>
                  <c:pt idx="2">
                    <c:v>1.4417720269104119E-2</c:v>
                  </c:pt>
                  <c:pt idx="3">
                    <c:v>3.0125790294190651E-2</c:v>
                  </c:pt>
                  <c:pt idx="4">
                    <c:v>3.0151907651944129E-2</c:v>
                  </c:pt>
                  <c:pt idx="5">
                    <c:v>2.2101795005046814E-2</c:v>
                  </c:pt>
                  <c:pt idx="6">
                    <c:v>2.6644056001231306E-2</c:v>
                  </c:pt>
                  <c:pt idx="7">
                    <c:v>3.0275787605308632E-2</c:v>
                  </c:pt>
                  <c:pt idx="8">
                    <c:v>1.7474264323432041E-2</c:v>
                  </c:pt>
                  <c:pt idx="9">
                    <c:v>1.2169904647228991E-2</c:v>
                  </c:pt>
                </c:numCache>
              </c:numRef>
            </c:plus>
            <c:minus>
              <c:numRef>
                <c:f>計算!$CN$7:$CW$7</c:f>
                <c:numCache>
                  <c:formatCode>General</c:formatCode>
                  <c:ptCount val="10"/>
                  <c:pt idx="0">
                    <c:v>1.6068533494587808E-2</c:v>
                  </c:pt>
                  <c:pt idx="1">
                    <c:v>1.7920562814150928E-2</c:v>
                  </c:pt>
                  <c:pt idx="2">
                    <c:v>1.4417720269104119E-2</c:v>
                  </c:pt>
                  <c:pt idx="3">
                    <c:v>3.0125790294190651E-2</c:v>
                  </c:pt>
                  <c:pt idx="4">
                    <c:v>3.0151907651944129E-2</c:v>
                  </c:pt>
                  <c:pt idx="5">
                    <c:v>2.2101795005046814E-2</c:v>
                  </c:pt>
                  <c:pt idx="6">
                    <c:v>2.6644056001231306E-2</c:v>
                  </c:pt>
                  <c:pt idx="7">
                    <c:v>3.0275787605308632E-2</c:v>
                  </c:pt>
                  <c:pt idx="8">
                    <c:v>1.7474264323432041E-2</c:v>
                  </c:pt>
                  <c:pt idx="9">
                    <c:v>1.2169904647228991E-2</c:v>
                  </c:pt>
                </c:numCache>
              </c:numRef>
            </c:minus>
          </c:errBars>
          <c:cat>
            <c:numRef>
              <c:f>計算!$CN$5:$CW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N$6:$CW$6</c:f>
              <c:numCache>
                <c:formatCode>General</c:formatCode>
                <c:ptCount val="10"/>
                <c:pt idx="0">
                  <c:v>0.27541666850447655</c:v>
                </c:pt>
                <c:pt idx="1">
                  <c:v>0.27541666850447694</c:v>
                </c:pt>
                <c:pt idx="2">
                  <c:v>0.27541666850447699</c:v>
                </c:pt>
                <c:pt idx="3">
                  <c:v>0.27541666850447699</c:v>
                </c:pt>
                <c:pt idx="4">
                  <c:v>0.27541666850447705</c:v>
                </c:pt>
                <c:pt idx="5">
                  <c:v>0.27541666850447705</c:v>
                </c:pt>
                <c:pt idx="6">
                  <c:v>0.27541666850447694</c:v>
                </c:pt>
                <c:pt idx="7">
                  <c:v>0.27541666850447705</c:v>
                </c:pt>
                <c:pt idx="8">
                  <c:v>0.27541666850447699</c:v>
                </c:pt>
                <c:pt idx="9">
                  <c:v>0.275416668504477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7EA-4DA9-8AC1-C13EE4B0B1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6291919"/>
        <c:axId val="706289519"/>
      </c:lineChart>
      <c:catAx>
        <c:axId val="7062919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500">
                <a:solidFill>
                  <a:schemeClr val="tx1"/>
                </a:solidFill>
              </a:defRPr>
            </a:pPr>
            <a:endParaRPr lang="en-US"/>
          </a:p>
        </c:txPr>
        <c:crossAx val="706289519"/>
        <c:crosses val="autoZero"/>
        <c:auto val="1"/>
        <c:lblAlgn val="ctr"/>
        <c:lblOffset val="100"/>
        <c:noMultiLvlLbl val="0"/>
      </c:catAx>
      <c:valAx>
        <c:axId val="706289519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706291919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cortisone succinate</a:t>
            </a:r>
          </a:p>
        </c:rich>
      </c:tx>
      <c:layout>
        <c:manualLayout>
          <c:xMode val="edge"/>
          <c:yMode val="edge"/>
          <c:x val="0.17208595500598936"/>
          <c:y val="0.5908811968221849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8130958175151693"/>
          <c:y val="3.9032576295522849E-2"/>
          <c:w val="0.87856987917832585"/>
          <c:h val="0.86765090955538759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19:$BA$19</c:f>
                <c:numCache>
                  <c:formatCode>General</c:formatCode>
                  <c:ptCount val="10"/>
                  <c:pt idx="0">
                    <c:v>1.4701664305760434E-2</c:v>
                  </c:pt>
                  <c:pt idx="1">
                    <c:v>6.0883706541567273E-2</c:v>
                  </c:pt>
                  <c:pt idx="2">
                    <c:v>2.8304227888948499E-2</c:v>
                  </c:pt>
                  <c:pt idx="3">
                    <c:v>3.1459253009730966E-2</c:v>
                  </c:pt>
                  <c:pt idx="4">
                    <c:v>1.0960047799749042E-2</c:v>
                  </c:pt>
                  <c:pt idx="5">
                    <c:v>2.0043022140185059E-2</c:v>
                  </c:pt>
                  <c:pt idx="6">
                    <c:v>3.8835141720145745E-2</c:v>
                  </c:pt>
                  <c:pt idx="7">
                    <c:v>2.3203342580168412E-2</c:v>
                  </c:pt>
                  <c:pt idx="8">
                    <c:v>1.71978791115289E-2</c:v>
                  </c:pt>
                  <c:pt idx="9">
                    <c:v>8.5621623655898274E-3</c:v>
                  </c:pt>
                </c:numCache>
              </c:numRef>
            </c:plus>
            <c:minus>
              <c:numRef>
                <c:f>計算!$AR$19:$AZ$19</c:f>
                <c:numCache>
                  <c:formatCode>General</c:formatCode>
                  <c:ptCount val="9"/>
                  <c:pt idx="0">
                    <c:v>1.4701664305760434E-2</c:v>
                  </c:pt>
                  <c:pt idx="1">
                    <c:v>6.0883706541567273E-2</c:v>
                  </c:pt>
                  <c:pt idx="2">
                    <c:v>2.8304227888948499E-2</c:v>
                  </c:pt>
                  <c:pt idx="3">
                    <c:v>3.1459253009730966E-2</c:v>
                  </c:pt>
                  <c:pt idx="4">
                    <c:v>1.0960047799749042E-2</c:v>
                  </c:pt>
                  <c:pt idx="5">
                    <c:v>2.0043022140185059E-2</c:v>
                  </c:pt>
                  <c:pt idx="6">
                    <c:v>3.8835141720145745E-2</c:v>
                  </c:pt>
                  <c:pt idx="7">
                    <c:v>2.3203342580168412E-2</c:v>
                  </c:pt>
                  <c:pt idx="8">
                    <c:v>1.7197879111528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17:$BA$17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AR$18:$BA$18</c:f>
              <c:numCache>
                <c:formatCode>General</c:formatCode>
                <c:ptCount val="10"/>
                <c:pt idx="0">
                  <c:v>0.27634999776879948</c:v>
                </c:pt>
                <c:pt idx="1">
                  <c:v>0.4817499928176403</c:v>
                </c:pt>
                <c:pt idx="2">
                  <c:v>0.54068333531419432</c:v>
                </c:pt>
                <c:pt idx="3">
                  <c:v>0.52601666872700059</c:v>
                </c:pt>
                <c:pt idx="4">
                  <c:v>0.46623332922657329</c:v>
                </c:pt>
                <c:pt idx="5">
                  <c:v>0.4476666661600272</c:v>
                </c:pt>
                <c:pt idx="6">
                  <c:v>0.40540000920494396</c:v>
                </c:pt>
                <c:pt idx="7">
                  <c:v>0.37264999871452648</c:v>
                </c:pt>
                <c:pt idx="8">
                  <c:v>0.28094999616344768</c:v>
                </c:pt>
                <c:pt idx="9">
                  <c:v>0.164333332329988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81F-4384-A929-D8E6B470ACE0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19:$CW$19</c:f>
                <c:numCache>
                  <c:formatCode>General</c:formatCode>
                  <c:ptCount val="10"/>
                  <c:pt idx="0">
                    <c:v>1.4701664305760434E-2</c:v>
                  </c:pt>
                  <c:pt idx="1">
                    <c:v>6.0883706541567273E-2</c:v>
                  </c:pt>
                  <c:pt idx="2">
                    <c:v>2.8304227888948496E-2</c:v>
                  </c:pt>
                  <c:pt idx="3">
                    <c:v>3.1459253009730959E-2</c:v>
                  </c:pt>
                  <c:pt idx="4">
                    <c:v>1.0960047799749042E-2</c:v>
                  </c:pt>
                  <c:pt idx="5">
                    <c:v>2.0043022140185059E-2</c:v>
                  </c:pt>
                  <c:pt idx="6">
                    <c:v>3.8835141720145273E-2</c:v>
                  </c:pt>
                  <c:pt idx="7">
                    <c:v>2.3203342580168415E-2</c:v>
                  </c:pt>
                  <c:pt idx="8">
                    <c:v>1.71978791115289E-2</c:v>
                  </c:pt>
                  <c:pt idx="9">
                    <c:v>8.5621623655898274E-3</c:v>
                  </c:pt>
                </c:numCache>
              </c:numRef>
            </c:plus>
            <c:minus>
              <c:numRef>
                <c:f>計算!$CN$19:$CW$19</c:f>
                <c:numCache>
                  <c:formatCode>General</c:formatCode>
                  <c:ptCount val="10"/>
                  <c:pt idx="0">
                    <c:v>1.4701664305760434E-2</c:v>
                  </c:pt>
                  <c:pt idx="1">
                    <c:v>6.0883706541567273E-2</c:v>
                  </c:pt>
                  <c:pt idx="2">
                    <c:v>2.8304227888948496E-2</c:v>
                  </c:pt>
                  <c:pt idx="3">
                    <c:v>3.1459253009730959E-2</c:v>
                  </c:pt>
                  <c:pt idx="4">
                    <c:v>1.0960047799749042E-2</c:v>
                  </c:pt>
                  <c:pt idx="5">
                    <c:v>2.0043022140185059E-2</c:v>
                  </c:pt>
                  <c:pt idx="6">
                    <c:v>3.8835141720145273E-2</c:v>
                  </c:pt>
                  <c:pt idx="7">
                    <c:v>2.3203342580168415E-2</c:v>
                  </c:pt>
                  <c:pt idx="8">
                    <c:v>1.71978791115289E-2</c:v>
                  </c:pt>
                  <c:pt idx="9">
                    <c:v>8.5621623655898274E-3</c:v>
                  </c:pt>
                </c:numCache>
              </c:numRef>
            </c:minus>
          </c:errBars>
          <c:cat>
            <c:numRef>
              <c:f>計算!$CN$17:$CW$17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CN$18:$CW$18</c:f>
              <c:numCache>
                <c:formatCode>General</c:formatCode>
                <c:ptCount val="10"/>
                <c:pt idx="0">
                  <c:v>0.27634999776879948</c:v>
                </c:pt>
                <c:pt idx="1">
                  <c:v>0.4369999927779043</c:v>
                </c:pt>
                <c:pt idx="2">
                  <c:v>0.49073333169023242</c:v>
                </c:pt>
                <c:pt idx="3">
                  <c:v>0.44428333764274958</c:v>
                </c:pt>
                <c:pt idx="4">
                  <c:v>0.39813333377242133</c:v>
                </c:pt>
                <c:pt idx="5">
                  <c:v>0.38189999883373621</c:v>
                </c:pt>
                <c:pt idx="6">
                  <c:v>0.33783335114518848</c:v>
                </c:pt>
                <c:pt idx="7">
                  <c:v>0.3253166638314729</c:v>
                </c:pt>
                <c:pt idx="8">
                  <c:v>0.23684999470909482</c:v>
                </c:pt>
                <c:pt idx="9">
                  <c:v>0.139983339856068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81F-4384-A929-D8E6B470AC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6230479"/>
        <c:axId val="706229519"/>
      </c:lineChart>
      <c:catAx>
        <c:axId val="70623047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06229519"/>
        <c:crosses val="autoZero"/>
        <c:auto val="1"/>
        <c:lblAlgn val="ctr"/>
        <c:lblOffset val="100"/>
        <c:noMultiLvlLbl val="0"/>
      </c:catAx>
      <c:valAx>
        <c:axId val="706229519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06230479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8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Quercetin</a:t>
            </a:r>
          </a:p>
        </c:rich>
      </c:tx>
      <c:layout>
        <c:manualLayout>
          <c:xMode val="edge"/>
          <c:yMode val="edge"/>
          <c:x val="0.23108124117362783"/>
          <c:y val="0.651668660554284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7.2284115312032271E-2"/>
          <c:y val="5.0083868423476341E-2"/>
          <c:w val="0.87856987917832585"/>
          <c:h val="0.74118367195787938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31:$BA$31</c:f>
                <c:numCache>
                  <c:formatCode>General</c:formatCode>
                  <c:ptCount val="10"/>
                  <c:pt idx="0">
                    <c:v>1.5097200529201906E-2</c:v>
                  </c:pt>
                  <c:pt idx="1">
                    <c:v>1.2035183821617872E-2</c:v>
                  </c:pt>
                  <c:pt idx="2">
                    <c:v>1.311497920820311E-2</c:v>
                  </c:pt>
                  <c:pt idx="3">
                    <c:v>2.8227217324187304E-2</c:v>
                  </c:pt>
                  <c:pt idx="4">
                    <c:v>3.1782671786935432E-2</c:v>
                  </c:pt>
                  <c:pt idx="5">
                    <c:v>3.1418879824360708E-2</c:v>
                  </c:pt>
                  <c:pt idx="6">
                    <c:v>2.9259298073091178E-2</c:v>
                  </c:pt>
                  <c:pt idx="7">
                    <c:v>2.7228934709745762E-2</c:v>
                  </c:pt>
                  <c:pt idx="8">
                    <c:v>1.0892339612803382E-2</c:v>
                  </c:pt>
                  <c:pt idx="9">
                    <c:v>4.1045102166338112E-3</c:v>
                  </c:pt>
                </c:numCache>
              </c:numRef>
            </c:plus>
            <c:minus>
              <c:numRef>
                <c:f>計算!$AR$31:$BA$31</c:f>
                <c:numCache>
                  <c:formatCode>General</c:formatCode>
                  <c:ptCount val="10"/>
                  <c:pt idx="0">
                    <c:v>1.5097200529201906E-2</c:v>
                  </c:pt>
                  <c:pt idx="1">
                    <c:v>1.2035183821617872E-2</c:v>
                  </c:pt>
                  <c:pt idx="2">
                    <c:v>1.311497920820311E-2</c:v>
                  </c:pt>
                  <c:pt idx="3">
                    <c:v>2.8227217324187304E-2</c:v>
                  </c:pt>
                  <c:pt idx="4">
                    <c:v>3.1782671786935432E-2</c:v>
                  </c:pt>
                  <c:pt idx="5">
                    <c:v>3.1418879824360708E-2</c:v>
                  </c:pt>
                  <c:pt idx="6">
                    <c:v>2.9259298073091178E-2</c:v>
                  </c:pt>
                  <c:pt idx="7">
                    <c:v>2.7228934709745762E-2</c:v>
                  </c:pt>
                  <c:pt idx="8">
                    <c:v>1.0892339612803382E-2</c:v>
                  </c:pt>
                  <c:pt idx="9">
                    <c:v>4.104510216633811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29:$BA$2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AR$30:$BA$30</c:f>
              <c:numCache>
                <c:formatCode>General</c:formatCode>
                <c:ptCount val="10"/>
                <c:pt idx="0">
                  <c:v>0.25591666996479034</c:v>
                </c:pt>
                <c:pt idx="1">
                  <c:v>0.2729833374420802</c:v>
                </c:pt>
                <c:pt idx="2">
                  <c:v>0.2846333384513855</c:v>
                </c:pt>
                <c:pt idx="3">
                  <c:v>0.31399999558925629</c:v>
                </c:pt>
                <c:pt idx="4">
                  <c:v>0.32276666661103565</c:v>
                </c:pt>
                <c:pt idx="5">
                  <c:v>0.33631666501363117</c:v>
                </c:pt>
                <c:pt idx="6">
                  <c:v>0.32576666275660199</c:v>
                </c:pt>
                <c:pt idx="7">
                  <c:v>0.34693333009878796</c:v>
                </c:pt>
                <c:pt idx="8">
                  <c:v>0.22324999670187631</c:v>
                </c:pt>
                <c:pt idx="9">
                  <c:v>0.124450000623861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A14-490B-A59F-7E17DEB83E2A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31:$CW$31</c:f>
                <c:numCache>
                  <c:formatCode>General</c:formatCode>
                  <c:ptCount val="10"/>
                  <c:pt idx="0">
                    <c:v>1.5097200529201906E-2</c:v>
                  </c:pt>
                  <c:pt idx="1">
                    <c:v>1.2035183821617872E-2</c:v>
                  </c:pt>
                  <c:pt idx="2">
                    <c:v>1.311497920820311E-2</c:v>
                  </c:pt>
                  <c:pt idx="3">
                    <c:v>2.8227217324187502E-2</c:v>
                  </c:pt>
                  <c:pt idx="4">
                    <c:v>3.1782671786935196E-2</c:v>
                  </c:pt>
                  <c:pt idx="5">
                    <c:v>3.1418879824360826E-2</c:v>
                  </c:pt>
                  <c:pt idx="6">
                    <c:v>2.9259298073091307E-2</c:v>
                  </c:pt>
                  <c:pt idx="7">
                    <c:v>2.7228934709745762E-2</c:v>
                  </c:pt>
                  <c:pt idx="8">
                    <c:v>1.0892339612803382E-2</c:v>
                  </c:pt>
                  <c:pt idx="9">
                    <c:v>4.1045102166338112E-3</c:v>
                  </c:pt>
                </c:numCache>
              </c:numRef>
            </c:plus>
            <c:minus>
              <c:numRef>
                <c:f>計算!$CN$31:$CW$31</c:f>
                <c:numCache>
                  <c:formatCode>General</c:formatCode>
                  <c:ptCount val="10"/>
                  <c:pt idx="0">
                    <c:v>1.5097200529201906E-2</c:v>
                  </c:pt>
                  <c:pt idx="1">
                    <c:v>1.2035183821617872E-2</c:v>
                  </c:pt>
                  <c:pt idx="2">
                    <c:v>1.311497920820311E-2</c:v>
                  </c:pt>
                  <c:pt idx="3">
                    <c:v>2.8227217324187502E-2</c:v>
                  </c:pt>
                  <c:pt idx="4">
                    <c:v>3.1782671786935196E-2</c:v>
                  </c:pt>
                  <c:pt idx="5">
                    <c:v>3.1418879824360826E-2</c:v>
                  </c:pt>
                  <c:pt idx="6">
                    <c:v>2.9259298073091307E-2</c:v>
                  </c:pt>
                  <c:pt idx="7">
                    <c:v>2.7228934709745762E-2</c:v>
                  </c:pt>
                  <c:pt idx="8">
                    <c:v>1.0892339612803382E-2</c:v>
                  </c:pt>
                  <c:pt idx="9">
                    <c:v>4.1045102166338112E-3</c:v>
                  </c:pt>
                </c:numCache>
              </c:numRef>
            </c:minus>
          </c:errBars>
          <c:cat>
            <c:numRef>
              <c:f>計算!$CN$29:$CW$2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CN$30:$CW$30</c:f>
              <c:numCache>
                <c:formatCode>General</c:formatCode>
                <c:ptCount val="10"/>
                <c:pt idx="0">
                  <c:v>0.25591666996479034</c:v>
                </c:pt>
                <c:pt idx="1">
                  <c:v>0.22823333740234417</c:v>
                </c:pt>
                <c:pt idx="2">
                  <c:v>0.23468333482742354</c:v>
                </c:pt>
                <c:pt idx="3">
                  <c:v>0.23226666450500533</c:v>
                </c:pt>
                <c:pt idx="4">
                  <c:v>0.25466667115688374</c:v>
                </c:pt>
                <c:pt idx="5">
                  <c:v>0.27054999768734028</c:v>
                </c:pt>
                <c:pt idx="6">
                  <c:v>0.2582000046968464</c:v>
                </c:pt>
                <c:pt idx="7">
                  <c:v>0.29959999521573433</c:v>
                </c:pt>
                <c:pt idx="8">
                  <c:v>0.17914999524752342</c:v>
                </c:pt>
                <c:pt idx="9">
                  <c:v>0.100100008149942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A14-490B-A59F-7E17DEB83E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6257359"/>
        <c:axId val="706256399"/>
      </c:lineChart>
      <c:catAx>
        <c:axId val="7062573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06256399"/>
        <c:crosses val="autoZero"/>
        <c:auto val="1"/>
        <c:lblAlgn val="ctr"/>
        <c:lblOffset val="100"/>
        <c:noMultiLvlLbl val="0"/>
      </c:catAx>
      <c:valAx>
        <c:axId val="706256399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06257359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943825503787659"/>
          <c:y val="3.7018991124560897E-2"/>
          <c:w val="0.73987629768363872"/>
          <c:h val="0.69958675360441902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AQ$149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53:$BA$153</c:f>
                <c:numCache>
                  <c:formatCode>General</c:formatCode>
                  <c:ptCount val="10"/>
                  <c:pt idx="0">
                    <c:v>1.9105371000783005E-2</c:v>
                  </c:pt>
                  <c:pt idx="1">
                    <c:v>3.1605027166836705E-2</c:v>
                  </c:pt>
                  <c:pt idx="2">
                    <c:v>2.9151369267558763E-2</c:v>
                  </c:pt>
                  <c:pt idx="3">
                    <c:v>2.7975164546637506E-2</c:v>
                  </c:pt>
                  <c:pt idx="4">
                    <c:v>4.1831601034201991E-2</c:v>
                  </c:pt>
                  <c:pt idx="5">
                    <c:v>2.3916416931507218E-2</c:v>
                  </c:pt>
                  <c:pt idx="6">
                    <c:v>3.5782045031320014E-2</c:v>
                  </c:pt>
                  <c:pt idx="7">
                    <c:v>2.1881926563231489E-2</c:v>
                  </c:pt>
                  <c:pt idx="8">
                    <c:v>3.1322557872525345E-2</c:v>
                  </c:pt>
                  <c:pt idx="9">
                    <c:v>1.5560645281706463E-2</c:v>
                  </c:pt>
                </c:numCache>
              </c:numRef>
            </c:plus>
            <c:minus>
              <c:numRef>
                <c:f>'[^N1610.2025.04.30.xlsx]計算'!$AR$153:$BA$153</c:f>
                <c:numCache>
                  <c:formatCode>General</c:formatCode>
                  <c:ptCount val="10"/>
                  <c:pt idx="0">
                    <c:v>1.9105371000783005E-2</c:v>
                  </c:pt>
                  <c:pt idx="1">
                    <c:v>3.1605027166836705E-2</c:v>
                  </c:pt>
                  <c:pt idx="2">
                    <c:v>2.9151369267558763E-2</c:v>
                  </c:pt>
                  <c:pt idx="3">
                    <c:v>2.7975164546637506E-2</c:v>
                  </c:pt>
                  <c:pt idx="4">
                    <c:v>4.1831601034201991E-2</c:v>
                  </c:pt>
                  <c:pt idx="5">
                    <c:v>2.3916416931507218E-2</c:v>
                  </c:pt>
                  <c:pt idx="6">
                    <c:v>3.5782045031320014E-2</c:v>
                  </c:pt>
                  <c:pt idx="7">
                    <c:v>2.1881926563231489E-2</c:v>
                  </c:pt>
                  <c:pt idx="8">
                    <c:v>3.1322557872525345E-2</c:v>
                  </c:pt>
                  <c:pt idx="9">
                    <c:v>1.55606452817064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48:$BA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AR$149:$BA$149</c:f>
              <c:numCache>
                <c:formatCode>General</c:formatCode>
                <c:ptCount val="10"/>
                <c:pt idx="0">
                  <c:v>0.223150002459685</c:v>
                </c:pt>
                <c:pt idx="1">
                  <c:v>0.25411666184663773</c:v>
                </c:pt>
                <c:pt idx="2">
                  <c:v>0.26796667029460269</c:v>
                </c:pt>
                <c:pt idx="3">
                  <c:v>0.26038334021965664</c:v>
                </c:pt>
                <c:pt idx="4">
                  <c:v>0.27143333107233047</c:v>
                </c:pt>
                <c:pt idx="5">
                  <c:v>0.27883333712816238</c:v>
                </c:pt>
                <c:pt idx="6">
                  <c:v>0.27916666120290756</c:v>
                </c:pt>
                <c:pt idx="7">
                  <c:v>0.24466667324304581</c:v>
                </c:pt>
                <c:pt idx="8">
                  <c:v>0.2563333387176196</c:v>
                </c:pt>
                <c:pt idx="9">
                  <c:v>0.148783338566621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D3F-4DA9-A07C-AEBFFF09609E}"/>
            </c:ext>
          </c:extLst>
        </c:ser>
        <c:ser>
          <c:idx val="1"/>
          <c:order val="1"/>
          <c:tx>
            <c:strRef>
              <c:f>'[^N1610.2025.04.30.xlsx]計算'!$AQ$150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54:$BA$154</c:f>
                <c:numCache>
                  <c:formatCode>General</c:formatCode>
                  <c:ptCount val="10"/>
                  <c:pt idx="0">
                    <c:v>4.4422947985583119E-2</c:v>
                  </c:pt>
                  <c:pt idx="1">
                    <c:v>2.4749436701329491E-2</c:v>
                  </c:pt>
                  <c:pt idx="2">
                    <c:v>2.2443937976561197E-2</c:v>
                  </c:pt>
                  <c:pt idx="3">
                    <c:v>3.8565268526531318E-2</c:v>
                  </c:pt>
                  <c:pt idx="4">
                    <c:v>3.2565338989062997E-2</c:v>
                  </c:pt>
                  <c:pt idx="5">
                    <c:v>3.0644848301450939E-2</c:v>
                  </c:pt>
                  <c:pt idx="6">
                    <c:v>2.2376148325646553E-2</c:v>
                  </c:pt>
                  <c:pt idx="7">
                    <c:v>1.4590952845046194E-2</c:v>
                  </c:pt>
                  <c:pt idx="8">
                    <c:v>2.610491414036465E-2</c:v>
                  </c:pt>
                  <c:pt idx="9">
                    <c:v>2.4076346100194494E-2</c:v>
                  </c:pt>
                </c:numCache>
              </c:numRef>
            </c:plus>
            <c:minus>
              <c:numRef>
                <c:f>'[^N1610.2025.04.30.xlsx]計算'!$AR$154:$BA$154</c:f>
                <c:numCache>
                  <c:formatCode>General</c:formatCode>
                  <c:ptCount val="10"/>
                  <c:pt idx="0">
                    <c:v>4.4422947985583119E-2</c:v>
                  </c:pt>
                  <c:pt idx="1">
                    <c:v>2.4749436701329491E-2</c:v>
                  </c:pt>
                  <c:pt idx="2">
                    <c:v>2.2443937976561197E-2</c:v>
                  </c:pt>
                  <c:pt idx="3">
                    <c:v>3.8565268526531318E-2</c:v>
                  </c:pt>
                  <c:pt idx="4">
                    <c:v>3.2565338989062997E-2</c:v>
                  </c:pt>
                  <c:pt idx="5">
                    <c:v>3.0644848301450939E-2</c:v>
                  </c:pt>
                  <c:pt idx="6">
                    <c:v>2.2376148325646553E-2</c:v>
                  </c:pt>
                  <c:pt idx="7">
                    <c:v>1.4590952845046194E-2</c:v>
                  </c:pt>
                  <c:pt idx="8">
                    <c:v>2.610491414036465E-2</c:v>
                  </c:pt>
                  <c:pt idx="9">
                    <c:v>2.40763461001944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48:$BA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AR$150:$BA$150</c:f>
              <c:numCache>
                <c:formatCode>General</c:formatCode>
                <c:ptCount val="10"/>
                <c:pt idx="0">
                  <c:v>0.26915000379085541</c:v>
                </c:pt>
                <c:pt idx="1">
                  <c:v>0.29865000148614246</c:v>
                </c:pt>
                <c:pt idx="2">
                  <c:v>0.3114333301782608</c:v>
                </c:pt>
                <c:pt idx="3">
                  <c:v>0.31580000619093579</c:v>
                </c:pt>
                <c:pt idx="4">
                  <c:v>0.31318333248297375</c:v>
                </c:pt>
                <c:pt idx="5">
                  <c:v>0.32186666627724964</c:v>
                </c:pt>
                <c:pt idx="6">
                  <c:v>0.29809999465942383</c:v>
                </c:pt>
                <c:pt idx="7">
                  <c:v>0.28219999869664508</c:v>
                </c:pt>
                <c:pt idx="8">
                  <c:v>0.27203333377838135</c:v>
                </c:pt>
                <c:pt idx="9">
                  <c:v>0.223533332347869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D3F-4DA9-A07C-AEBFFF09609E}"/>
            </c:ext>
          </c:extLst>
        </c:ser>
        <c:ser>
          <c:idx val="2"/>
          <c:order val="2"/>
          <c:tx>
            <c:strRef>
              <c:f>'[^N1610.2025.04.30.xlsx]計算'!$AQ$151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55:$BA$155</c:f>
                <c:numCache>
                  <c:formatCode>General</c:formatCode>
                  <c:ptCount val="10"/>
                  <c:pt idx="0">
                    <c:v>2.5275974372852384E-2</c:v>
                  </c:pt>
                  <c:pt idx="1">
                    <c:v>2.7341021776704725E-2</c:v>
                  </c:pt>
                  <c:pt idx="2">
                    <c:v>2.8308367439563702E-2</c:v>
                  </c:pt>
                  <c:pt idx="3">
                    <c:v>3.3928485794097317E-2</c:v>
                  </c:pt>
                  <c:pt idx="4">
                    <c:v>4.1116369866565167E-2</c:v>
                  </c:pt>
                  <c:pt idx="5">
                    <c:v>5.0208795268250207E-2</c:v>
                  </c:pt>
                  <c:pt idx="6">
                    <c:v>5.1378787647515869E-2</c:v>
                  </c:pt>
                  <c:pt idx="7">
                    <c:v>3.0060970693196354E-2</c:v>
                  </c:pt>
                  <c:pt idx="8">
                    <c:v>3.3547125074517466E-2</c:v>
                  </c:pt>
                  <c:pt idx="9">
                    <c:v>2.6529490242064416E-2</c:v>
                  </c:pt>
                </c:numCache>
              </c:numRef>
            </c:plus>
            <c:minus>
              <c:numRef>
                <c:f>'[^N1610.2025.04.30.xlsx]計算'!$AR$155:$BA$155</c:f>
                <c:numCache>
                  <c:formatCode>General</c:formatCode>
                  <c:ptCount val="10"/>
                  <c:pt idx="0">
                    <c:v>2.5275974372852384E-2</c:v>
                  </c:pt>
                  <c:pt idx="1">
                    <c:v>2.7341021776704725E-2</c:v>
                  </c:pt>
                  <c:pt idx="2">
                    <c:v>2.8308367439563702E-2</c:v>
                  </c:pt>
                  <c:pt idx="3">
                    <c:v>3.3928485794097317E-2</c:v>
                  </c:pt>
                  <c:pt idx="4">
                    <c:v>4.1116369866565167E-2</c:v>
                  </c:pt>
                  <c:pt idx="5">
                    <c:v>5.0208795268250207E-2</c:v>
                  </c:pt>
                  <c:pt idx="6">
                    <c:v>5.1378787647515869E-2</c:v>
                  </c:pt>
                  <c:pt idx="7">
                    <c:v>3.0060970693196354E-2</c:v>
                  </c:pt>
                  <c:pt idx="8">
                    <c:v>3.3547125074517466E-2</c:v>
                  </c:pt>
                  <c:pt idx="9">
                    <c:v>2.65294902420644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48:$BA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AR$151:$BA$151</c:f>
              <c:numCache>
                <c:formatCode>General</c:formatCode>
                <c:ptCount val="10"/>
                <c:pt idx="0">
                  <c:v>0.36806666602691013</c:v>
                </c:pt>
                <c:pt idx="1">
                  <c:v>0.37710000326236087</c:v>
                </c:pt>
                <c:pt idx="2">
                  <c:v>0.40410000334183377</c:v>
                </c:pt>
                <c:pt idx="3">
                  <c:v>0.38961666574080783</c:v>
                </c:pt>
                <c:pt idx="4">
                  <c:v>0.38590000321467716</c:v>
                </c:pt>
                <c:pt idx="5">
                  <c:v>0.39463333040475845</c:v>
                </c:pt>
                <c:pt idx="6">
                  <c:v>0.35945000002781552</c:v>
                </c:pt>
                <c:pt idx="7">
                  <c:v>0.3416166678071022</c:v>
                </c:pt>
                <c:pt idx="8">
                  <c:v>0.35428333530823392</c:v>
                </c:pt>
                <c:pt idx="9">
                  <c:v>0.289683329562346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D3F-4DA9-A07C-AEBFFF09609E}"/>
            </c:ext>
          </c:extLst>
        </c:ser>
        <c:ser>
          <c:idx val="3"/>
          <c:order val="3"/>
          <c:tx>
            <c:strRef>
              <c:f>'[^N1610.2025.04.30.xlsx]計算'!$AQ$152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56:$BA$156</c:f>
                <c:numCache>
                  <c:formatCode>General</c:formatCode>
                  <c:ptCount val="10"/>
                  <c:pt idx="0">
                    <c:v>3.4253918802526463E-2</c:v>
                  </c:pt>
                  <c:pt idx="1">
                    <c:v>3.5150580979240079E-2</c:v>
                  </c:pt>
                  <c:pt idx="2">
                    <c:v>9.8975693326323194E-3</c:v>
                  </c:pt>
                  <c:pt idx="3">
                    <c:v>5.4872232181928403E-2</c:v>
                  </c:pt>
                  <c:pt idx="4">
                    <c:v>5.3693266065205358E-2</c:v>
                  </c:pt>
                  <c:pt idx="5">
                    <c:v>4.4197601916380391E-2</c:v>
                  </c:pt>
                  <c:pt idx="6">
                    <c:v>5.6068290131375396E-2</c:v>
                  </c:pt>
                  <c:pt idx="7">
                    <c:v>4.0497644944843252E-2</c:v>
                  </c:pt>
                  <c:pt idx="8">
                    <c:v>5.2566515853618927E-2</c:v>
                  </c:pt>
                  <c:pt idx="9">
                    <c:v>1.6509079080637864E-2</c:v>
                  </c:pt>
                </c:numCache>
              </c:numRef>
            </c:plus>
            <c:minus>
              <c:numRef>
                <c:f>'[^N1610.2025.04.30.xlsx]計算'!$AR$156:$BA$156</c:f>
                <c:numCache>
                  <c:formatCode>General</c:formatCode>
                  <c:ptCount val="10"/>
                  <c:pt idx="0">
                    <c:v>3.4253918802526463E-2</c:v>
                  </c:pt>
                  <c:pt idx="1">
                    <c:v>3.5150580979240079E-2</c:v>
                  </c:pt>
                  <c:pt idx="2">
                    <c:v>9.8975693326323194E-3</c:v>
                  </c:pt>
                  <c:pt idx="3">
                    <c:v>5.4872232181928403E-2</c:v>
                  </c:pt>
                  <c:pt idx="4">
                    <c:v>5.3693266065205358E-2</c:v>
                  </c:pt>
                  <c:pt idx="5">
                    <c:v>4.4197601916380391E-2</c:v>
                  </c:pt>
                  <c:pt idx="6">
                    <c:v>5.6068290131375396E-2</c:v>
                  </c:pt>
                  <c:pt idx="7">
                    <c:v>4.0497644944843252E-2</c:v>
                  </c:pt>
                  <c:pt idx="8">
                    <c:v>5.2566515853618927E-2</c:v>
                  </c:pt>
                  <c:pt idx="9">
                    <c:v>1.650907908063786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148:$BA$148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AR$152:$BA$152</c:f>
              <c:numCache>
                <c:formatCode>General</c:formatCode>
                <c:ptCount val="10"/>
                <c:pt idx="0">
                  <c:v>0.43974998965859413</c:v>
                </c:pt>
                <c:pt idx="1">
                  <c:v>0.47309999540448189</c:v>
                </c:pt>
                <c:pt idx="2">
                  <c:v>0.49641667678952217</c:v>
                </c:pt>
                <c:pt idx="3">
                  <c:v>0.47501667216420174</c:v>
                </c:pt>
                <c:pt idx="4">
                  <c:v>0.4945666678249836</c:v>
                </c:pt>
                <c:pt idx="5">
                  <c:v>0.45425001159310341</c:v>
                </c:pt>
                <c:pt idx="6">
                  <c:v>0.45391665771603584</c:v>
                </c:pt>
                <c:pt idx="7">
                  <c:v>0.41624999915560085</c:v>
                </c:pt>
                <c:pt idx="8">
                  <c:v>0.42008333280682564</c:v>
                </c:pt>
                <c:pt idx="9">
                  <c:v>0.304216666767994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D3F-4DA9-A07C-AEBFFF0960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2251599"/>
        <c:axId val="742235279"/>
      </c:lineChart>
      <c:catAx>
        <c:axId val="7422515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2235279"/>
        <c:crosses val="autoZero"/>
        <c:auto val="1"/>
        <c:lblAlgn val="ctr"/>
        <c:lblOffset val="100"/>
        <c:noMultiLvlLbl val="0"/>
      </c:catAx>
      <c:valAx>
        <c:axId val="742235279"/>
        <c:scaling>
          <c:orientation val="minMax"/>
          <c:max val="0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2251599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900"/>
            </a:pPr>
            <a:r>
              <a:rPr lang="en-US" sz="900"/>
              <a:t>sodium ascorbate</a:t>
            </a:r>
          </a:p>
        </c:rich>
      </c:tx>
      <c:layout>
        <c:manualLayout>
          <c:xMode val="edge"/>
          <c:yMode val="edge"/>
          <c:x val="0.31029181823908647"/>
          <c:y val="0.55180293212412457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60222259451611"/>
          <c:y val="4.5567682192947268E-2"/>
          <c:w val="0.87228888744278865"/>
          <c:h val="0.84966589536876325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43:$BA$43</c:f>
                <c:numCache>
                  <c:formatCode>General</c:formatCode>
                  <c:ptCount val="10"/>
                  <c:pt idx="0">
                    <c:v>1.7281285415449332E-2</c:v>
                  </c:pt>
                  <c:pt idx="1">
                    <c:v>1.495095418462212E-2</c:v>
                  </c:pt>
                  <c:pt idx="2">
                    <c:v>3.4519775638542118E-2</c:v>
                  </c:pt>
                  <c:pt idx="3">
                    <c:v>3.7232693583301751E-2</c:v>
                  </c:pt>
                  <c:pt idx="4">
                    <c:v>2.7577578922054275E-2</c:v>
                  </c:pt>
                  <c:pt idx="5">
                    <c:v>3.6643096743948458E-2</c:v>
                  </c:pt>
                  <c:pt idx="6">
                    <c:v>4.3510796998807215E-2</c:v>
                  </c:pt>
                  <c:pt idx="7">
                    <c:v>2.7460190790638949E-2</c:v>
                  </c:pt>
                  <c:pt idx="8">
                    <c:v>3.0783432327694218E-2</c:v>
                  </c:pt>
                  <c:pt idx="9">
                    <c:v>4.3300828869702206E-2</c:v>
                  </c:pt>
                </c:numCache>
              </c:numRef>
            </c:plus>
            <c:minus>
              <c:numRef>
                <c:f>計算!$AR$43:$BA$43</c:f>
                <c:numCache>
                  <c:formatCode>General</c:formatCode>
                  <c:ptCount val="10"/>
                  <c:pt idx="0">
                    <c:v>1.7281285415449332E-2</c:v>
                  </c:pt>
                  <c:pt idx="1">
                    <c:v>1.495095418462212E-2</c:v>
                  </c:pt>
                  <c:pt idx="2">
                    <c:v>3.4519775638542118E-2</c:v>
                  </c:pt>
                  <c:pt idx="3">
                    <c:v>3.7232693583301751E-2</c:v>
                  </c:pt>
                  <c:pt idx="4">
                    <c:v>2.7577578922054275E-2</c:v>
                  </c:pt>
                  <c:pt idx="5">
                    <c:v>3.6643096743948458E-2</c:v>
                  </c:pt>
                  <c:pt idx="6">
                    <c:v>4.3510796998807215E-2</c:v>
                  </c:pt>
                  <c:pt idx="7">
                    <c:v>2.7460190790638949E-2</c:v>
                  </c:pt>
                  <c:pt idx="8">
                    <c:v>3.0783432327694218E-2</c:v>
                  </c:pt>
                  <c:pt idx="9">
                    <c:v>4.33008288697022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41:$BA$41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1.6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AR$42:$BA$42</c:f>
              <c:numCache>
                <c:formatCode>General</c:formatCode>
                <c:ptCount val="10"/>
                <c:pt idx="0">
                  <c:v>0.2586499924461047</c:v>
                </c:pt>
                <c:pt idx="1">
                  <c:v>0.28375000009934109</c:v>
                </c:pt>
                <c:pt idx="2">
                  <c:v>0.31734999269247055</c:v>
                </c:pt>
                <c:pt idx="3">
                  <c:v>0.3674166624744733</c:v>
                </c:pt>
                <c:pt idx="4">
                  <c:v>0.37656666586796445</c:v>
                </c:pt>
                <c:pt idx="5">
                  <c:v>0.42009999603033066</c:v>
                </c:pt>
                <c:pt idx="6">
                  <c:v>0.41591665893793106</c:v>
                </c:pt>
                <c:pt idx="7">
                  <c:v>0.42791666338841122</c:v>
                </c:pt>
                <c:pt idx="8">
                  <c:v>0.41734999666611355</c:v>
                </c:pt>
                <c:pt idx="9">
                  <c:v>0.196516667803128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B46-47E3-B4AF-E2CBB941E7FA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fixedVal"/>
            <c:noEndCap val="0"/>
            <c:val val="0.05"/>
          </c:errBars>
          <c:cat>
            <c:numRef>
              <c:f>計算!$CN$41:$CW$41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1.6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計算!$CN$42:$CW$42</c:f>
              <c:numCache>
                <c:formatCode>General</c:formatCode>
                <c:ptCount val="10"/>
                <c:pt idx="0">
                  <c:v>0.2586499924461047</c:v>
                </c:pt>
                <c:pt idx="1">
                  <c:v>0.23900000005960506</c:v>
                </c:pt>
                <c:pt idx="2">
                  <c:v>0.26739998906850859</c:v>
                </c:pt>
                <c:pt idx="3">
                  <c:v>0.28568333139022234</c:v>
                </c:pt>
                <c:pt idx="4">
                  <c:v>0.30846667041381248</c:v>
                </c:pt>
                <c:pt idx="5">
                  <c:v>0.35433332870403972</c:v>
                </c:pt>
                <c:pt idx="6">
                  <c:v>0.34835000087817553</c:v>
                </c:pt>
                <c:pt idx="7">
                  <c:v>0.38058332850535753</c:v>
                </c:pt>
                <c:pt idx="8">
                  <c:v>0.37324999521176067</c:v>
                </c:pt>
                <c:pt idx="9">
                  <c:v>0.172166675329208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B46-47E3-B4AF-E2CBB941E7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3370256"/>
        <c:axId val="653371216"/>
      </c:lineChart>
      <c:catAx>
        <c:axId val="653370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 b="1">
                <a:solidFill>
                  <a:schemeClr val="tx1"/>
                </a:solidFill>
              </a:defRPr>
            </a:pPr>
            <a:endParaRPr lang="en-US"/>
          </a:p>
        </c:txPr>
        <c:crossAx val="653371216"/>
        <c:crosses val="autoZero"/>
        <c:auto val="1"/>
        <c:lblAlgn val="ctr"/>
        <c:lblOffset val="100"/>
        <c:noMultiLvlLbl val="0"/>
      </c:catAx>
      <c:valAx>
        <c:axId val="653371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 b="1">
                <a:solidFill>
                  <a:schemeClr val="tx1"/>
                </a:solidFill>
              </a:defRPr>
            </a:pPr>
            <a:endParaRPr lang="en-US"/>
          </a:p>
        </c:txPr>
        <c:crossAx val="653370256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900"/>
            </a:pPr>
            <a:r>
              <a:rPr lang="en-US" sz="900" dirty="0"/>
              <a:t>Curcumin</a:t>
            </a:r>
          </a:p>
        </c:rich>
      </c:tx>
      <c:layout>
        <c:manualLayout>
          <c:xMode val="edge"/>
          <c:yMode val="edge"/>
          <c:x val="0.10650328518648094"/>
          <c:y val="0.64342124826597635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8130958175151693"/>
          <c:y val="4.7477936182753519E-2"/>
          <c:w val="0.87856987917832585"/>
          <c:h val="0.84063363776308675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55:$BA$55</c:f>
                <c:numCache>
                  <c:formatCode>General</c:formatCode>
                  <c:ptCount val="10"/>
                  <c:pt idx="0">
                    <c:v>4.9401955928911313E-2</c:v>
                  </c:pt>
                  <c:pt idx="1">
                    <c:v>4.0979186554522949E-2</c:v>
                  </c:pt>
                  <c:pt idx="2">
                    <c:v>4.1390893956580327E-2</c:v>
                  </c:pt>
                  <c:pt idx="3">
                    <c:v>5.7410184823249354E-2</c:v>
                  </c:pt>
                  <c:pt idx="4">
                    <c:v>4.7460018891710823E-2</c:v>
                  </c:pt>
                  <c:pt idx="5">
                    <c:v>3.1344587696844534E-2</c:v>
                  </c:pt>
                  <c:pt idx="6">
                    <c:v>4.567190174765897E-2</c:v>
                  </c:pt>
                  <c:pt idx="7">
                    <c:v>2.2874563139298431E-2</c:v>
                  </c:pt>
                  <c:pt idx="8">
                    <c:v>4.3665399834719426E-4</c:v>
                  </c:pt>
                  <c:pt idx="9">
                    <c:v>9.968282607314661E-4</c:v>
                  </c:pt>
                </c:numCache>
              </c:numRef>
            </c:plus>
            <c:minus>
              <c:numRef>
                <c:f>計算!$AR$55:$BA$55</c:f>
                <c:numCache>
                  <c:formatCode>General</c:formatCode>
                  <c:ptCount val="10"/>
                  <c:pt idx="0">
                    <c:v>4.9401955928911313E-2</c:v>
                  </c:pt>
                  <c:pt idx="1">
                    <c:v>4.0979186554522949E-2</c:v>
                  </c:pt>
                  <c:pt idx="2">
                    <c:v>4.1390893956580327E-2</c:v>
                  </c:pt>
                  <c:pt idx="3">
                    <c:v>5.7410184823249354E-2</c:v>
                  </c:pt>
                  <c:pt idx="4">
                    <c:v>4.7460018891710823E-2</c:v>
                  </c:pt>
                  <c:pt idx="5">
                    <c:v>3.1344587696844534E-2</c:v>
                  </c:pt>
                  <c:pt idx="6">
                    <c:v>4.567190174765897E-2</c:v>
                  </c:pt>
                  <c:pt idx="7">
                    <c:v>2.2874563139298431E-2</c:v>
                  </c:pt>
                  <c:pt idx="8">
                    <c:v>4.3665399834719426E-4</c:v>
                  </c:pt>
                  <c:pt idx="9">
                    <c:v>9.968282607314661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53:$BA$53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AR$54:$BA$54</c:f>
              <c:numCache>
                <c:formatCode>General</c:formatCode>
                <c:ptCount val="10"/>
                <c:pt idx="0">
                  <c:v>0.28108333175381023</c:v>
                </c:pt>
                <c:pt idx="1">
                  <c:v>0.28138333186507225</c:v>
                </c:pt>
                <c:pt idx="2">
                  <c:v>0.31001666312416393</c:v>
                </c:pt>
                <c:pt idx="3">
                  <c:v>0.30198333039879799</c:v>
                </c:pt>
                <c:pt idx="4">
                  <c:v>0.29668334250648815</c:v>
                </c:pt>
                <c:pt idx="5">
                  <c:v>0.30356666569908458</c:v>
                </c:pt>
                <c:pt idx="6">
                  <c:v>0.23284999902049699</c:v>
                </c:pt>
                <c:pt idx="7">
                  <c:v>7.4183332423369094E-2</c:v>
                </c:pt>
                <c:pt idx="8">
                  <c:v>-2.1666660904884338E-3</c:v>
                </c:pt>
                <c:pt idx="9">
                  <c:v>6.166671713193258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ED5-47E0-87FC-E61CE2695F6D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55:$CW$55</c:f>
                <c:numCache>
                  <c:formatCode>General</c:formatCode>
                  <c:ptCount val="10"/>
                  <c:pt idx="0">
                    <c:v>4.9401955928911313E-2</c:v>
                  </c:pt>
                  <c:pt idx="1">
                    <c:v>4.0979186554523088E-2</c:v>
                  </c:pt>
                  <c:pt idx="2">
                    <c:v>4.1390893956580056E-2</c:v>
                  </c:pt>
                  <c:pt idx="3">
                    <c:v>5.7410184823249256E-2</c:v>
                  </c:pt>
                  <c:pt idx="4">
                    <c:v>4.7460018891710698E-2</c:v>
                  </c:pt>
                  <c:pt idx="5">
                    <c:v>3.1344587696844117E-2</c:v>
                  </c:pt>
                  <c:pt idx="6">
                    <c:v>4.5671901747659033E-2</c:v>
                  </c:pt>
                  <c:pt idx="7">
                    <c:v>2.2874563139298417E-2</c:v>
                  </c:pt>
                  <c:pt idx="8">
                    <c:v>4.3665399834719426E-4</c:v>
                  </c:pt>
                  <c:pt idx="9">
                    <c:v>9.9682826073146588E-4</c:v>
                  </c:pt>
                </c:numCache>
              </c:numRef>
            </c:plus>
            <c:minus>
              <c:numRef>
                <c:f>計算!$CN$55:$CW$55</c:f>
                <c:numCache>
                  <c:formatCode>General</c:formatCode>
                  <c:ptCount val="10"/>
                  <c:pt idx="0">
                    <c:v>4.9401955928911313E-2</c:v>
                  </c:pt>
                  <c:pt idx="1">
                    <c:v>4.0979186554523088E-2</c:v>
                  </c:pt>
                  <c:pt idx="2">
                    <c:v>4.1390893956580056E-2</c:v>
                  </c:pt>
                  <c:pt idx="3">
                    <c:v>5.7410184823249256E-2</c:v>
                  </c:pt>
                  <c:pt idx="4">
                    <c:v>4.7460018891710698E-2</c:v>
                  </c:pt>
                  <c:pt idx="5">
                    <c:v>3.1344587696844117E-2</c:v>
                  </c:pt>
                  <c:pt idx="6">
                    <c:v>4.5671901747659033E-2</c:v>
                  </c:pt>
                  <c:pt idx="7">
                    <c:v>2.2874563139298417E-2</c:v>
                  </c:pt>
                  <c:pt idx="8">
                    <c:v>4.3665399834719426E-4</c:v>
                  </c:pt>
                  <c:pt idx="9">
                    <c:v>9.9682826073146588E-4</c:v>
                  </c:pt>
                </c:numCache>
              </c:numRef>
            </c:minus>
          </c:errBars>
          <c:cat>
            <c:numRef>
              <c:f>計算!$CN$53:$CW$53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CN$54:$CW$54</c:f>
              <c:numCache>
                <c:formatCode>General</c:formatCode>
                <c:ptCount val="10"/>
                <c:pt idx="0">
                  <c:v>0.28108333175381023</c:v>
                </c:pt>
                <c:pt idx="1">
                  <c:v>0.23663333182533622</c:v>
                </c:pt>
                <c:pt idx="2">
                  <c:v>0.26006665950020197</c:v>
                </c:pt>
                <c:pt idx="3">
                  <c:v>0.22024999931454703</c:v>
                </c:pt>
                <c:pt idx="4">
                  <c:v>0.22858334705233621</c:v>
                </c:pt>
                <c:pt idx="5">
                  <c:v>0.23779999837279367</c:v>
                </c:pt>
                <c:pt idx="6">
                  <c:v>0.16528334096074146</c:v>
                </c:pt>
                <c:pt idx="7">
                  <c:v>2.6849997540315456E-2</c:v>
                </c:pt>
                <c:pt idx="8">
                  <c:v>-4.6266667544841322E-2</c:v>
                </c:pt>
                <c:pt idx="9">
                  <c:v>-2.373332530260039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ED5-47E0-87FC-E61CE2695F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3380816"/>
        <c:axId val="653381776"/>
      </c:lineChart>
      <c:catAx>
        <c:axId val="653380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500"/>
            </a:pPr>
            <a:endParaRPr lang="en-US"/>
          </a:p>
        </c:txPr>
        <c:crossAx val="653381776"/>
        <c:crosses val="autoZero"/>
        <c:auto val="1"/>
        <c:lblAlgn val="ctr"/>
        <c:lblOffset val="100"/>
        <c:noMultiLvlLbl val="0"/>
      </c:catAx>
      <c:valAx>
        <c:axId val="653381776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653380816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veratrol</a:t>
            </a:r>
          </a:p>
        </c:rich>
      </c:tx>
      <c:layout>
        <c:manualLayout>
          <c:xMode val="edge"/>
          <c:yMode val="edge"/>
          <c:x val="0.24926506375936922"/>
          <c:y val="0.5774487898530410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076056977838346"/>
          <c:y val="3.1748136782726401E-2"/>
          <c:w val="0.88485087091386305"/>
          <c:h val="0.85901235093545647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67:$BA$67</c:f>
                <c:numCache>
                  <c:formatCode>General</c:formatCode>
                  <c:ptCount val="10"/>
                  <c:pt idx="0">
                    <c:v>1.93464949340354E-2</c:v>
                  </c:pt>
                  <c:pt idx="1">
                    <c:v>1.8539552450736758E-2</c:v>
                  </c:pt>
                  <c:pt idx="2">
                    <c:v>2.8920771470313501E-2</c:v>
                  </c:pt>
                  <c:pt idx="3">
                    <c:v>3.2411173446909573E-2</c:v>
                  </c:pt>
                  <c:pt idx="4">
                    <c:v>5.0089793912178819E-2</c:v>
                  </c:pt>
                  <c:pt idx="5">
                    <c:v>4.4426120127938035E-2</c:v>
                  </c:pt>
                  <c:pt idx="6">
                    <c:v>2.9628363050800546E-2</c:v>
                  </c:pt>
                  <c:pt idx="7">
                    <c:v>1.6613199812706866E-2</c:v>
                  </c:pt>
                  <c:pt idx="8">
                    <c:v>1.6631499066379399E-2</c:v>
                  </c:pt>
                  <c:pt idx="9">
                    <c:v>1.0255856763224437E-2</c:v>
                  </c:pt>
                </c:numCache>
              </c:numRef>
            </c:plus>
            <c:minus>
              <c:numRef>
                <c:f>計算!$AR$67:$BA$67</c:f>
                <c:numCache>
                  <c:formatCode>General</c:formatCode>
                  <c:ptCount val="10"/>
                  <c:pt idx="0">
                    <c:v>1.93464949340354E-2</c:v>
                  </c:pt>
                  <c:pt idx="1">
                    <c:v>1.8539552450736758E-2</c:v>
                  </c:pt>
                  <c:pt idx="2">
                    <c:v>2.8920771470313501E-2</c:v>
                  </c:pt>
                  <c:pt idx="3">
                    <c:v>3.2411173446909573E-2</c:v>
                  </c:pt>
                  <c:pt idx="4">
                    <c:v>5.0089793912178819E-2</c:v>
                  </c:pt>
                  <c:pt idx="5">
                    <c:v>4.4426120127938035E-2</c:v>
                  </c:pt>
                  <c:pt idx="6">
                    <c:v>2.9628363050800546E-2</c:v>
                  </c:pt>
                  <c:pt idx="7">
                    <c:v>1.6613199812706866E-2</c:v>
                  </c:pt>
                  <c:pt idx="8">
                    <c:v>1.6631499066379399E-2</c:v>
                  </c:pt>
                  <c:pt idx="9">
                    <c:v>1.02558567632244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65:$BA$65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計算!$AR$66:$BA$66</c:f>
              <c:numCache>
                <c:formatCode>General</c:formatCode>
                <c:ptCount val="10"/>
                <c:pt idx="0">
                  <c:v>0.30116666729251546</c:v>
                </c:pt>
                <c:pt idx="1">
                  <c:v>0.35044999793171883</c:v>
                </c:pt>
                <c:pt idx="2">
                  <c:v>0.35044999793171883</c:v>
                </c:pt>
                <c:pt idx="3">
                  <c:v>0.37829999998211861</c:v>
                </c:pt>
                <c:pt idx="4">
                  <c:v>0.34385000541806221</c:v>
                </c:pt>
                <c:pt idx="5">
                  <c:v>0.37220000599821407</c:v>
                </c:pt>
                <c:pt idx="6">
                  <c:v>0.35900000110268593</c:v>
                </c:pt>
                <c:pt idx="7">
                  <c:v>0.31266666824618977</c:v>
                </c:pt>
                <c:pt idx="8">
                  <c:v>0.22313333426912627</c:v>
                </c:pt>
                <c:pt idx="9">
                  <c:v>0.11393333350618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4F4-4E05-B706-0393D45CB78C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67:$CW$67</c:f>
                <c:numCache>
                  <c:formatCode>General</c:formatCode>
                  <c:ptCount val="10"/>
                  <c:pt idx="0">
                    <c:v>1.93464949340354E-2</c:v>
                  </c:pt>
                  <c:pt idx="1">
                    <c:v>1.8539552450736758E-2</c:v>
                  </c:pt>
                  <c:pt idx="2">
                    <c:v>2.8920771470313501E-2</c:v>
                  </c:pt>
                  <c:pt idx="3">
                    <c:v>3.2411173446909573E-2</c:v>
                  </c:pt>
                  <c:pt idx="4">
                    <c:v>5.008979391217893E-2</c:v>
                  </c:pt>
                  <c:pt idx="5">
                    <c:v>4.4426120127938284E-2</c:v>
                  </c:pt>
                  <c:pt idx="6">
                    <c:v>2.9628363050800546E-2</c:v>
                  </c:pt>
                  <c:pt idx="7">
                    <c:v>1.6613199812706866E-2</c:v>
                  </c:pt>
                  <c:pt idx="8">
                    <c:v>1.6631499066379399E-2</c:v>
                  </c:pt>
                  <c:pt idx="9">
                    <c:v>1.0255856763224392E-2</c:v>
                  </c:pt>
                </c:numCache>
              </c:numRef>
            </c:plus>
            <c:minus>
              <c:numRef>
                <c:f>計算!$CN$67:$CW$67</c:f>
                <c:numCache>
                  <c:formatCode>General</c:formatCode>
                  <c:ptCount val="10"/>
                  <c:pt idx="0">
                    <c:v>1.93464949340354E-2</c:v>
                  </c:pt>
                  <c:pt idx="1">
                    <c:v>1.8539552450736758E-2</c:v>
                  </c:pt>
                  <c:pt idx="2">
                    <c:v>2.8920771470313501E-2</c:v>
                  </c:pt>
                  <c:pt idx="3">
                    <c:v>3.2411173446909573E-2</c:v>
                  </c:pt>
                  <c:pt idx="4">
                    <c:v>5.008979391217893E-2</c:v>
                  </c:pt>
                  <c:pt idx="5">
                    <c:v>4.4426120127938284E-2</c:v>
                  </c:pt>
                  <c:pt idx="6">
                    <c:v>2.9628363050800546E-2</c:v>
                  </c:pt>
                  <c:pt idx="7">
                    <c:v>1.6613199812706866E-2</c:v>
                  </c:pt>
                  <c:pt idx="8">
                    <c:v>1.6631499066379399E-2</c:v>
                  </c:pt>
                  <c:pt idx="9">
                    <c:v>1.0255856763224392E-2</c:v>
                  </c:pt>
                </c:numCache>
              </c:numRef>
            </c:minus>
          </c:errBars>
          <c:cat>
            <c:numRef>
              <c:f>計算!$CN$65:$CW$65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計算!$CN$66:$CW$66</c:f>
              <c:numCache>
                <c:formatCode>General</c:formatCode>
                <c:ptCount val="10"/>
                <c:pt idx="0">
                  <c:v>0.30116666729251546</c:v>
                </c:pt>
                <c:pt idx="1">
                  <c:v>0.30569999789198282</c:v>
                </c:pt>
                <c:pt idx="2">
                  <c:v>0.30049999430775687</c:v>
                </c:pt>
                <c:pt idx="3">
                  <c:v>0.29656666889786765</c:v>
                </c:pt>
                <c:pt idx="4">
                  <c:v>0.27575000996391025</c:v>
                </c:pt>
                <c:pt idx="5">
                  <c:v>0.30643333867192318</c:v>
                </c:pt>
                <c:pt idx="6">
                  <c:v>0.29143334304293039</c:v>
                </c:pt>
                <c:pt idx="7">
                  <c:v>0.26533333336313614</c:v>
                </c:pt>
                <c:pt idx="8">
                  <c:v>0.17903333281477338</c:v>
                </c:pt>
                <c:pt idx="9">
                  <c:v>8.958334103226707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4F4-4E05-B706-0393D45CB7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76079616"/>
        <c:axId val="476063296"/>
      </c:lineChart>
      <c:catAx>
        <c:axId val="476079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6063296"/>
        <c:crosses val="autoZero"/>
        <c:auto val="1"/>
        <c:lblAlgn val="ctr"/>
        <c:lblOffset val="100"/>
        <c:noMultiLvlLbl val="0"/>
      </c:catAx>
      <c:valAx>
        <c:axId val="476063296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6079616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900"/>
            </a:pPr>
            <a:r>
              <a:rPr lang="en-US" sz="900" dirty="0"/>
              <a:t>Astaxanthin</a:t>
            </a:r>
          </a:p>
        </c:rich>
      </c:tx>
      <c:layout>
        <c:manualLayout>
          <c:xMode val="edge"/>
          <c:yMode val="edge"/>
          <c:x val="0.18652077919243842"/>
          <c:y val="0.5843058987471101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076056977838346"/>
          <c:y val="3.1748136782726401E-2"/>
          <c:w val="0.88485087091386305"/>
          <c:h val="0.85901235093545647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79:$BA$79</c:f>
                <c:numCache>
                  <c:formatCode>General</c:formatCode>
                  <c:ptCount val="10"/>
                  <c:pt idx="0">
                    <c:v>2.3781121026791859E-2</c:v>
                  </c:pt>
                  <c:pt idx="1">
                    <c:v>3.1060333993195459E-2</c:v>
                  </c:pt>
                  <c:pt idx="2">
                    <c:v>2.1638988583483145E-2</c:v>
                  </c:pt>
                  <c:pt idx="3">
                    <c:v>3.3648716253419877E-2</c:v>
                  </c:pt>
                  <c:pt idx="4">
                    <c:v>3.3196948669610343E-2</c:v>
                  </c:pt>
                  <c:pt idx="5">
                    <c:v>2.5916134056043611E-2</c:v>
                  </c:pt>
                  <c:pt idx="6">
                    <c:v>3.8971450425987916E-2</c:v>
                  </c:pt>
                  <c:pt idx="7">
                    <c:v>3.2540173948858261E-2</c:v>
                  </c:pt>
                  <c:pt idx="8">
                    <c:v>2.3097324323855344E-2</c:v>
                  </c:pt>
                  <c:pt idx="9">
                    <c:v>2.4978159614925836E-2</c:v>
                  </c:pt>
                </c:numCache>
              </c:numRef>
            </c:plus>
            <c:minus>
              <c:numRef>
                <c:f>計算!$AR$79:$BA$79</c:f>
                <c:numCache>
                  <c:formatCode>General</c:formatCode>
                  <c:ptCount val="10"/>
                  <c:pt idx="0">
                    <c:v>2.3781121026791859E-2</c:v>
                  </c:pt>
                  <c:pt idx="1">
                    <c:v>3.1060333993195459E-2</c:v>
                  </c:pt>
                  <c:pt idx="2">
                    <c:v>2.1638988583483145E-2</c:v>
                  </c:pt>
                  <c:pt idx="3">
                    <c:v>3.3648716253419877E-2</c:v>
                  </c:pt>
                  <c:pt idx="4">
                    <c:v>3.3196948669610343E-2</c:v>
                  </c:pt>
                  <c:pt idx="5">
                    <c:v>2.5916134056043611E-2</c:v>
                  </c:pt>
                  <c:pt idx="6">
                    <c:v>3.8971450425987916E-2</c:v>
                  </c:pt>
                  <c:pt idx="7">
                    <c:v>3.2540173948858261E-2</c:v>
                  </c:pt>
                  <c:pt idx="8">
                    <c:v>2.3097324323855344E-2</c:v>
                  </c:pt>
                  <c:pt idx="9">
                    <c:v>2.49781596149258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77:$BA$77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計算!$AR$78:$BA$78</c:f>
              <c:numCache>
                <c:formatCode>General</c:formatCode>
                <c:ptCount val="10"/>
                <c:pt idx="0">
                  <c:v>0.29598332817355794</c:v>
                </c:pt>
                <c:pt idx="1">
                  <c:v>0.32279999926686287</c:v>
                </c:pt>
                <c:pt idx="2">
                  <c:v>0.3473166711628437</c:v>
                </c:pt>
                <c:pt idx="3">
                  <c:v>0.36549999689062435</c:v>
                </c:pt>
                <c:pt idx="4">
                  <c:v>0.36971666291356087</c:v>
                </c:pt>
                <c:pt idx="5">
                  <c:v>0.36668333287040394</c:v>
                </c:pt>
                <c:pt idx="6">
                  <c:v>0.38191666578253108</c:v>
                </c:pt>
                <c:pt idx="7">
                  <c:v>0.37016666804750759</c:v>
                </c:pt>
                <c:pt idx="8">
                  <c:v>0.39213333403070766</c:v>
                </c:pt>
                <c:pt idx="9">
                  <c:v>0.452800009399652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DC1-472C-8ED7-9940F7024320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79:$CW$79</c:f>
                <c:numCache>
                  <c:formatCode>General</c:formatCode>
                  <c:ptCount val="10"/>
                  <c:pt idx="0">
                    <c:v>2.3781121026791859E-2</c:v>
                  </c:pt>
                  <c:pt idx="1">
                    <c:v>3.1060333993195636E-2</c:v>
                  </c:pt>
                  <c:pt idx="2">
                    <c:v>2.1638988583483145E-2</c:v>
                  </c:pt>
                  <c:pt idx="3">
                    <c:v>3.3648716253419655E-2</c:v>
                  </c:pt>
                  <c:pt idx="4">
                    <c:v>3.3196948669610343E-2</c:v>
                  </c:pt>
                  <c:pt idx="5">
                    <c:v>2.5916134056043611E-2</c:v>
                  </c:pt>
                  <c:pt idx="6">
                    <c:v>3.8971450425988007E-2</c:v>
                  </c:pt>
                  <c:pt idx="7">
                    <c:v>3.2540173948858261E-2</c:v>
                  </c:pt>
                  <c:pt idx="8">
                    <c:v>2.3097324323855344E-2</c:v>
                  </c:pt>
                  <c:pt idx="9">
                    <c:v>2.4978159614925836E-2</c:v>
                  </c:pt>
                </c:numCache>
              </c:numRef>
            </c:plus>
            <c:minus>
              <c:numRef>
                <c:f>計算!$CN$79:$CW$79</c:f>
                <c:numCache>
                  <c:formatCode>General</c:formatCode>
                  <c:ptCount val="10"/>
                  <c:pt idx="0">
                    <c:v>2.3781121026791859E-2</c:v>
                  </c:pt>
                  <c:pt idx="1">
                    <c:v>3.1060333993195636E-2</c:v>
                  </c:pt>
                  <c:pt idx="2">
                    <c:v>2.1638988583483145E-2</c:v>
                  </c:pt>
                  <c:pt idx="3">
                    <c:v>3.3648716253419655E-2</c:v>
                  </c:pt>
                  <c:pt idx="4">
                    <c:v>3.3196948669610343E-2</c:v>
                  </c:pt>
                  <c:pt idx="5">
                    <c:v>2.5916134056043611E-2</c:v>
                  </c:pt>
                  <c:pt idx="6">
                    <c:v>3.8971450425988007E-2</c:v>
                  </c:pt>
                  <c:pt idx="7">
                    <c:v>3.2540173948858261E-2</c:v>
                  </c:pt>
                  <c:pt idx="8">
                    <c:v>2.3097324323855344E-2</c:v>
                  </c:pt>
                  <c:pt idx="9">
                    <c:v>2.4978159614925836E-2</c:v>
                  </c:pt>
                </c:numCache>
              </c:numRef>
            </c:minus>
          </c:errBars>
          <c:cat>
            <c:numRef>
              <c:f>計算!$CN$77:$CW$77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計算!$CN$78:$CW$78</c:f>
              <c:numCache>
                <c:formatCode>General</c:formatCode>
                <c:ptCount val="10"/>
                <c:pt idx="0">
                  <c:v>0.29598332817355794</c:v>
                </c:pt>
                <c:pt idx="1">
                  <c:v>0.27804999922712686</c:v>
                </c:pt>
                <c:pt idx="2">
                  <c:v>0.29736666753888175</c:v>
                </c:pt>
                <c:pt idx="3">
                  <c:v>0.28376666580637339</c:v>
                </c:pt>
                <c:pt idx="4">
                  <c:v>0.3016166674594089</c:v>
                </c:pt>
                <c:pt idx="5">
                  <c:v>0.300916665544113</c:v>
                </c:pt>
                <c:pt idx="6">
                  <c:v>0.31435000772277555</c:v>
                </c:pt>
                <c:pt idx="7">
                  <c:v>0.32283333316445401</c:v>
                </c:pt>
                <c:pt idx="8">
                  <c:v>0.34803333257635477</c:v>
                </c:pt>
                <c:pt idx="9">
                  <c:v>0.428450016925732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DC1-472C-8ED7-9940F70243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74770400"/>
        <c:axId val="774767040"/>
      </c:lineChart>
      <c:catAx>
        <c:axId val="774770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774767040"/>
        <c:crosses val="autoZero"/>
        <c:auto val="1"/>
        <c:lblAlgn val="ctr"/>
        <c:lblOffset val="100"/>
        <c:noMultiLvlLbl val="0"/>
      </c:catAx>
      <c:valAx>
        <c:axId val="774767040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774770400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900"/>
            </a:pPr>
            <a:r>
              <a:rPr lang="en-US" sz="900" dirty="0"/>
              <a:t>DHA</a:t>
            </a:r>
          </a:p>
        </c:rich>
      </c:tx>
      <c:layout>
        <c:manualLayout>
          <c:xMode val="edge"/>
          <c:yMode val="edge"/>
          <c:x val="0.35547785109451718"/>
          <c:y val="0.5852394960813814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076056977838346"/>
          <c:y val="3.1748119017535693E-2"/>
          <c:w val="0.88485087091386305"/>
          <c:h val="0.85000023062640617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91:$BA$91</c:f>
                <c:numCache>
                  <c:formatCode>General</c:formatCode>
                  <c:ptCount val="10"/>
                  <c:pt idx="0">
                    <c:v>1.9678084210820564E-2</c:v>
                  </c:pt>
                  <c:pt idx="1">
                    <c:v>1.6427002270230345E-2</c:v>
                  </c:pt>
                  <c:pt idx="2">
                    <c:v>1.6603813560337074E-2</c:v>
                  </c:pt>
                  <c:pt idx="3">
                    <c:v>3.01220477097272E-2</c:v>
                  </c:pt>
                  <c:pt idx="4">
                    <c:v>2.630543606866494E-2</c:v>
                  </c:pt>
                  <c:pt idx="5">
                    <c:v>5.0116055704322864E-2</c:v>
                  </c:pt>
                  <c:pt idx="6">
                    <c:v>3.3592963167608798E-2</c:v>
                  </c:pt>
                  <c:pt idx="7">
                    <c:v>2.2871025972543427E-2</c:v>
                  </c:pt>
                  <c:pt idx="8">
                    <c:v>3.0564161695962239E-2</c:v>
                  </c:pt>
                  <c:pt idx="9">
                    <c:v>1.0773300535663444E-2</c:v>
                  </c:pt>
                </c:numCache>
              </c:numRef>
            </c:plus>
            <c:minus>
              <c:numRef>
                <c:f>計算!$AR$91:$BA$91</c:f>
                <c:numCache>
                  <c:formatCode>General</c:formatCode>
                  <c:ptCount val="10"/>
                  <c:pt idx="0">
                    <c:v>1.9678084210820564E-2</c:v>
                  </c:pt>
                  <c:pt idx="1">
                    <c:v>1.6427002270230345E-2</c:v>
                  </c:pt>
                  <c:pt idx="2">
                    <c:v>1.6603813560337074E-2</c:v>
                  </c:pt>
                  <c:pt idx="3">
                    <c:v>3.01220477097272E-2</c:v>
                  </c:pt>
                  <c:pt idx="4">
                    <c:v>2.630543606866494E-2</c:v>
                  </c:pt>
                  <c:pt idx="5">
                    <c:v>5.0116055704322864E-2</c:v>
                  </c:pt>
                  <c:pt idx="6">
                    <c:v>3.3592963167608798E-2</c:v>
                  </c:pt>
                  <c:pt idx="7">
                    <c:v>2.2871025972543427E-2</c:v>
                  </c:pt>
                  <c:pt idx="8">
                    <c:v>3.0564161695962239E-2</c:v>
                  </c:pt>
                  <c:pt idx="9">
                    <c:v>1.077330053566344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89:$BA$89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計算!$AR$90:$BA$90</c:f>
              <c:numCache>
                <c:formatCode>General</c:formatCode>
                <c:ptCount val="10"/>
                <c:pt idx="0">
                  <c:v>0.30194999650120735</c:v>
                </c:pt>
                <c:pt idx="1">
                  <c:v>0.32576666648189229</c:v>
                </c:pt>
                <c:pt idx="2">
                  <c:v>0.33136666690309841</c:v>
                </c:pt>
                <c:pt idx="3">
                  <c:v>0.35161666447917622</c:v>
                </c:pt>
                <c:pt idx="4">
                  <c:v>0.34839999551574391</c:v>
                </c:pt>
                <c:pt idx="5">
                  <c:v>0.33833333229025203</c:v>
                </c:pt>
                <c:pt idx="6">
                  <c:v>0.35814999416470528</c:v>
                </c:pt>
                <c:pt idx="7">
                  <c:v>0.33750000471870106</c:v>
                </c:pt>
                <c:pt idx="8">
                  <c:v>0.26559999460975331</c:v>
                </c:pt>
                <c:pt idx="9">
                  <c:v>1.489999890327453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0A7-4B63-889B-518DCD553E84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91:$CW$91</c:f>
                <c:numCache>
                  <c:formatCode>General</c:formatCode>
                  <c:ptCount val="10"/>
                  <c:pt idx="0">
                    <c:v>1.9678084210820564E-2</c:v>
                  </c:pt>
                  <c:pt idx="1">
                    <c:v>1.6427002270230345E-2</c:v>
                  </c:pt>
                  <c:pt idx="2">
                    <c:v>1.6603813560337074E-2</c:v>
                  </c:pt>
                  <c:pt idx="3">
                    <c:v>3.0122047709727141E-2</c:v>
                  </c:pt>
                  <c:pt idx="4">
                    <c:v>2.630543606866494E-2</c:v>
                  </c:pt>
                  <c:pt idx="5">
                    <c:v>5.0116055704323197E-2</c:v>
                  </c:pt>
                  <c:pt idx="6">
                    <c:v>3.3592963167608798E-2</c:v>
                  </c:pt>
                  <c:pt idx="7">
                    <c:v>2.2871025972543427E-2</c:v>
                  </c:pt>
                  <c:pt idx="8">
                    <c:v>3.0564161695962239E-2</c:v>
                  </c:pt>
                  <c:pt idx="9">
                    <c:v>1.0773300535663445E-2</c:v>
                  </c:pt>
                </c:numCache>
              </c:numRef>
            </c:plus>
            <c:minus>
              <c:numRef>
                <c:f>計算!$CN$91:$CW$91</c:f>
                <c:numCache>
                  <c:formatCode>General</c:formatCode>
                  <c:ptCount val="10"/>
                  <c:pt idx="0">
                    <c:v>1.9678084210820564E-2</c:v>
                  </c:pt>
                  <c:pt idx="1">
                    <c:v>1.6427002270230345E-2</c:v>
                  </c:pt>
                  <c:pt idx="2">
                    <c:v>1.6603813560337074E-2</c:v>
                  </c:pt>
                  <c:pt idx="3">
                    <c:v>3.0122047709727141E-2</c:v>
                  </c:pt>
                  <c:pt idx="4">
                    <c:v>2.630543606866494E-2</c:v>
                  </c:pt>
                  <c:pt idx="5">
                    <c:v>5.0116055704323197E-2</c:v>
                  </c:pt>
                  <c:pt idx="6">
                    <c:v>3.3592963167608798E-2</c:v>
                  </c:pt>
                  <c:pt idx="7">
                    <c:v>2.2871025972543427E-2</c:v>
                  </c:pt>
                  <c:pt idx="8">
                    <c:v>3.0564161695962239E-2</c:v>
                  </c:pt>
                  <c:pt idx="9">
                    <c:v>1.0773300535663445E-2</c:v>
                  </c:pt>
                </c:numCache>
              </c:numRef>
            </c:minus>
          </c:errBars>
          <c:cat>
            <c:numRef>
              <c:f>計算!$CN$89:$CW$89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計算!$CN$90:$CW$90</c:f>
              <c:numCache>
                <c:formatCode>General</c:formatCode>
                <c:ptCount val="10"/>
                <c:pt idx="0">
                  <c:v>0.30194999650120735</c:v>
                </c:pt>
                <c:pt idx="1">
                  <c:v>0.28101666644215623</c:v>
                </c:pt>
                <c:pt idx="2">
                  <c:v>0.28141666327913645</c:v>
                </c:pt>
                <c:pt idx="3">
                  <c:v>0.26988333339492526</c:v>
                </c:pt>
                <c:pt idx="4">
                  <c:v>0.28030000006159195</c:v>
                </c:pt>
                <c:pt idx="5">
                  <c:v>0.27256666496396115</c:v>
                </c:pt>
                <c:pt idx="6">
                  <c:v>0.29058333610494974</c:v>
                </c:pt>
                <c:pt idx="7">
                  <c:v>0.29016666983564743</c:v>
                </c:pt>
                <c:pt idx="8">
                  <c:v>0.22149999315540039</c:v>
                </c:pt>
                <c:pt idx="9">
                  <c:v>-9.4499935706451876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0A7-4B63-889B-518DCD553E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76083456"/>
        <c:axId val="476067136"/>
      </c:lineChart>
      <c:catAx>
        <c:axId val="476083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476067136"/>
        <c:crosses val="autoZero"/>
        <c:auto val="1"/>
        <c:lblAlgn val="ctr"/>
        <c:lblOffset val="100"/>
        <c:noMultiLvlLbl val="0"/>
      </c:catAx>
      <c:valAx>
        <c:axId val="476067136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476083456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800"/>
            </a:pPr>
            <a:r>
              <a:rPr lang="en-US" sz="800"/>
              <a:t>CoenzymeQ1</a:t>
            </a:r>
            <a:r>
              <a:rPr lang="ja-JP" sz="800"/>
              <a:t>０</a:t>
            </a:r>
            <a:endParaRPr lang="en-US" sz="800"/>
          </a:p>
        </c:rich>
      </c:tx>
      <c:layout>
        <c:manualLayout>
          <c:xMode val="edge"/>
          <c:yMode val="edge"/>
          <c:x val="0.18778118662282706"/>
          <c:y val="0.6038156162256883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076056977838346"/>
          <c:y val="3.1748136782726401E-2"/>
          <c:w val="0.87856987917832585"/>
          <c:h val="0.86351843770068937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103:$BA$103</c:f>
                <c:numCache>
                  <c:formatCode>General</c:formatCode>
                  <c:ptCount val="10"/>
                  <c:pt idx="0">
                    <c:v>2.5163932436173663E-2</c:v>
                  </c:pt>
                  <c:pt idx="1">
                    <c:v>1.9651768515456591E-2</c:v>
                  </c:pt>
                  <c:pt idx="2">
                    <c:v>3.3471632731731323E-2</c:v>
                  </c:pt>
                  <c:pt idx="3">
                    <c:v>2.9495469728110853E-2</c:v>
                  </c:pt>
                  <c:pt idx="4">
                    <c:v>3.6819002023661E-2</c:v>
                  </c:pt>
                  <c:pt idx="5">
                    <c:v>2.92443130744478E-2</c:v>
                  </c:pt>
                  <c:pt idx="6">
                    <c:v>3.7253587169595037E-2</c:v>
                  </c:pt>
                  <c:pt idx="7">
                    <c:v>3.4849093582429609E-2</c:v>
                  </c:pt>
                  <c:pt idx="8">
                    <c:v>2.3678122133374717E-2</c:v>
                  </c:pt>
                  <c:pt idx="9">
                    <c:v>1.5494213352177091E-2</c:v>
                  </c:pt>
                </c:numCache>
              </c:numRef>
            </c:plus>
            <c:minus>
              <c:numRef>
                <c:f>計算!$AR$103:$BA$103</c:f>
                <c:numCache>
                  <c:formatCode>General</c:formatCode>
                  <c:ptCount val="10"/>
                  <c:pt idx="0">
                    <c:v>2.5163932436173663E-2</c:v>
                  </c:pt>
                  <c:pt idx="1">
                    <c:v>1.9651768515456591E-2</c:v>
                  </c:pt>
                  <c:pt idx="2">
                    <c:v>3.3471632731731323E-2</c:v>
                  </c:pt>
                  <c:pt idx="3">
                    <c:v>2.9495469728110853E-2</c:v>
                  </c:pt>
                  <c:pt idx="4">
                    <c:v>3.6819002023661E-2</c:v>
                  </c:pt>
                  <c:pt idx="5">
                    <c:v>2.92443130744478E-2</c:v>
                  </c:pt>
                  <c:pt idx="6">
                    <c:v>3.7253587169595037E-2</c:v>
                  </c:pt>
                  <c:pt idx="7">
                    <c:v>3.4849093582429609E-2</c:v>
                  </c:pt>
                  <c:pt idx="8">
                    <c:v>2.3678122133374717E-2</c:v>
                  </c:pt>
                  <c:pt idx="9">
                    <c:v>1.549421335217709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101:$BA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AR$102:$BA$102</c:f>
              <c:numCache>
                <c:formatCode>General</c:formatCode>
                <c:ptCount val="10"/>
                <c:pt idx="0">
                  <c:v>0.31505000218749046</c:v>
                </c:pt>
                <c:pt idx="1">
                  <c:v>0.33109999820590019</c:v>
                </c:pt>
                <c:pt idx="2">
                  <c:v>0.35526666666070622</c:v>
                </c:pt>
                <c:pt idx="3">
                  <c:v>0.3647499990959962</c:v>
                </c:pt>
                <c:pt idx="4">
                  <c:v>0.35883333906531334</c:v>
                </c:pt>
                <c:pt idx="5">
                  <c:v>0.37468333666523296</c:v>
                </c:pt>
                <c:pt idx="6">
                  <c:v>0.35158333306511241</c:v>
                </c:pt>
                <c:pt idx="7">
                  <c:v>0.31055000548561412</c:v>
                </c:pt>
                <c:pt idx="8">
                  <c:v>0.25438333178559941</c:v>
                </c:pt>
                <c:pt idx="9">
                  <c:v>0.181433333704868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30-46C5-B7AF-74B6059A427F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103:$CW$103</c:f>
                <c:numCache>
                  <c:formatCode>General</c:formatCode>
                  <c:ptCount val="10"/>
                  <c:pt idx="0">
                    <c:v>2.5163932436173663E-2</c:v>
                  </c:pt>
                  <c:pt idx="1">
                    <c:v>1.9651768515456591E-2</c:v>
                  </c:pt>
                  <c:pt idx="2">
                    <c:v>3.3471632731731323E-2</c:v>
                  </c:pt>
                  <c:pt idx="3">
                    <c:v>2.9495469728110853E-2</c:v>
                  </c:pt>
                  <c:pt idx="4">
                    <c:v>3.6819002023660702E-2</c:v>
                  </c:pt>
                  <c:pt idx="5">
                    <c:v>2.92443130744478E-2</c:v>
                  </c:pt>
                  <c:pt idx="6">
                    <c:v>3.7253587169595134E-2</c:v>
                  </c:pt>
                  <c:pt idx="7">
                    <c:v>3.484909358242929E-2</c:v>
                  </c:pt>
                  <c:pt idx="8">
                    <c:v>2.3678122133374641E-2</c:v>
                  </c:pt>
                  <c:pt idx="9">
                    <c:v>1.5494213352177093E-2</c:v>
                  </c:pt>
                </c:numCache>
              </c:numRef>
            </c:plus>
            <c:minus>
              <c:numRef>
                <c:f>計算!$CN$103:$CW$103</c:f>
                <c:numCache>
                  <c:formatCode>General</c:formatCode>
                  <c:ptCount val="10"/>
                  <c:pt idx="0">
                    <c:v>2.5163932436173663E-2</c:v>
                  </c:pt>
                  <c:pt idx="1">
                    <c:v>1.9651768515456591E-2</c:v>
                  </c:pt>
                  <c:pt idx="2">
                    <c:v>3.3471632731731323E-2</c:v>
                  </c:pt>
                  <c:pt idx="3">
                    <c:v>2.9495469728110853E-2</c:v>
                  </c:pt>
                  <c:pt idx="4">
                    <c:v>3.6819002023660702E-2</c:v>
                  </c:pt>
                  <c:pt idx="5">
                    <c:v>2.92443130744478E-2</c:v>
                  </c:pt>
                  <c:pt idx="6">
                    <c:v>3.7253587169595134E-2</c:v>
                  </c:pt>
                  <c:pt idx="7">
                    <c:v>3.484909358242929E-2</c:v>
                  </c:pt>
                  <c:pt idx="8">
                    <c:v>2.3678122133374641E-2</c:v>
                  </c:pt>
                  <c:pt idx="9">
                    <c:v>1.5494213352177093E-2</c:v>
                  </c:pt>
                </c:numCache>
              </c:numRef>
            </c:minus>
          </c:errBars>
          <c:cat>
            <c:numRef>
              <c:f>計算!$CN$101:$CW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計算!$CN$102:$CW$102</c:f>
              <c:numCache>
                <c:formatCode>General</c:formatCode>
                <c:ptCount val="10"/>
                <c:pt idx="0">
                  <c:v>0.31505000218749046</c:v>
                </c:pt>
                <c:pt idx="1">
                  <c:v>0.28634999816616419</c:v>
                </c:pt>
                <c:pt idx="2">
                  <c:v>0.30531666303674426</c:v>
                </c:pt>
                <c:pt idx="3">
                  <c:v>0.28301666801174524</c:v>
                </c:pt>
                <c:pt idx="4">
                  <c:v>0.29073334361116138</c:v>
                </c:pt>
                <c:pt idx="5">
                  <c:v>0.30891666933894207</c:v>
                </c:pt>
                <c:pt idx="6">
                  <c:v>0.28401667500535688</c:v>
                </c:pt>
                <c:pt idx="7">
                  <c:v>0.26321667060256054</c:v>
                </c:pt>
                <c:pt idx="8">
                  <c:v>0.21028333033124649</c:v>
                </c:pt>
                <c:pt idx="9">
                  <c:v>0.157083341230949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30-46C5-B7AF-74B6059A42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3406256"/>
        <c:axId val="653405296"/>
      </c:lineChart>
      <c:catAx>
        <c:axId val="653406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653405296"/>
        <c:crosses val="autoZero"/>
        <c:auto val="1"/>
        <c:lblAlgn val="ctr"/>
        <c:lblOffset val="100"/>
        <c:noMultiLvlLbl val="0"/>
      </c:catAx>
      <c:valAx>
        <c:axId val="653405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653406256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6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9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CG</a:t>
            </a:r>
          </a:p>
        </c:rich>
      </c:tx>
      <c:layout>
        <c:manualLayout>
          <c:xMode val="edge"/>
          <c:yMode val="edge"/>
          <c:x val="0.20660941217431675"/>
          <c:y val="0.64102525423562629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60222259451611"/>
          <c:y val="3.5615688569128029E-2"/>
          <c:w val="0.87667708741110772"/>
          <c:h val="0.86058381028414666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AR$115:$BA$115</c:f>
                <c:numCache>
                  <c:formatCode>General</c:formatCode>
                  <c:ptCount val="10"/>
                  <c:pt idx="0">
                    <c:v>1.4408420287198501E-2</c:v>
                  </c:pt>
                  <c:pt idx="1">
                    <c:v>1.4266604378885619E-2</c:v>
                  </c:pt>
                  <c:pt idx="2">
                    <c:v>2.4331019032746159E-2</c:v>
                  </c:pt>
                  <c:pt idx="3">
                    <c:v>1.7809397769078542E-2</c:v>
                  </c:pt>
                  <c:pt idx="4">
                    <c:v>3.8839238654587438E-2</c:v>
                  </c:pt>
                  <c:pt idx="5">
                    <c:v>2.7577412888821162E-2</c:v>
                  </c:pt>
                  <c:pt idx="6">
                    <c:v>4.060765240207577E-2</c:v>
                  </c:pt>
                  <c:pt idx="7">
                    <c:v>2.8729864729390497E-2</c:v>
                  </c:pt>
                  <c:pt idx="8">
                    <c:v>5.2700707520953946E-3</c:v>
                  </c:pt>
                  <c:pt idx="9">
                    <c:v>9.647104418629357E-4</c:v>
                  </c:pt>
                </c:numCache>
              </c:numRef>
            </c:plus>
            <c:minus>
              <c:numRef>
                <c:f>計算!$AR$115:$BA$115</c:f>
                <c:numCache>
                  <c:formatCode>General</c:formatCode>
                  <c:ptCount val="10"/>
                  <c:pt idx="0">
                    <c:v>1.4408420287198501E-2</c:v>
                  </c:pt>
                  <c:pt idx="1">
                    <c:v>1.4266604378885619E-2</c:v>
                  </c:pt>
                  <c:pt idx="2">
                    <c:v>2.4331019032746159E-2</c:v>
                  </c:pt>
                  <c:pt idx="3">
                    <c:v>1.7809397769078542E-2</c:v>
                  </c:pt>
                  <c:pt idx="4">
                    <c:v>3.8839238654587438E-2</c:v>
                  </c:pt>
                  <c:pt idx="5">
                    <c:v>2.7577412888821162E-2</c:v>
                  </c:pt>
                  <c:pt idx="6">
                    <c:v>4.060765240207577E-2</c:v>
                  </c:pt>
                  <c:pt idx="7">
                    <c:v>2.8729864729390497E-2</c:v>
                  </c:pt>
                  <c:pt idx="8">
                    <c:v>5.2700707520953946E-3</c:v>
                  </c:pt>
                  <c:pt idx="9">
                    <c:v>9.647104418629357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AR$113:$BA$113</c:f>
              <c:numCache>
                <c:formatCode>General</c:formatCode>
                <c:ptCount val="10"/>
                <c:pt idx="0">
                  <c:v>0</c:v>
                </c:pt>
                <c:pt idx="1">
                  <c:v>0.08</c:v>
                </c:pt>
                <c:pt idx="2">
                  <c:v>0.25</c:v>
                </c:pt>
                <c:pt idx="3">
                  <c:v>0.8</c:v>
                </c:pt>
                <c:pt idx="4">
                  <c:v>2.5299999999999998</c:v>
                </c:pt>
                <c:pt idx="5">
                  <c:v>8</c:v>
                </c:pt>
                <c:pt idx="6">
                  <c:v>25.3</c:v>
                </c:pt>
                <c:pt idx="7">
                  <c:v>80</c:v>
                </c:pt>
                <c:pt idx="8">
                  <c:v>253</c:v>
                </c:pt>
                <c:pt idx="9">
                  <c:v>800</c:v>
                </c:pt>
              </c:numCache>
            </c:numRef>
          </c:cat>
          <c:val>
            <c:numRef>
              <c:f>計算!$AR$114:$BA$114</c:f>
              <c:numCache>
                <c:formatCode>General</c:formatCode>
                <c:ptCount val="10"/>
                <c:pt idx="0">
                  <c:v>0.28193333620826405</c:v>
                </c:pt>
                <c:pt idx="1">
                  <c:v>0.32950000340739888</c:v>
                </c:pt>
                <c:pt idx="2">
                  <c:v>0.32706667358676594</c:v>
                </c:pt>
                <c:pt idx="3">
                  <c:v>0.35366667186220485</c:v>
                </c:pt>
                <c:pt idx="4">
                  <c:v>0.38003333285450935</c:v>
                </c:pt>
                <c:pt idx="5">
                  <c:v>0.37101667001843452</c:v>
                </c:pt>
                <c:pt idx="6">
                  <c:v>0.35801666850845021</c:v>
                </c:pt>
                <c:pt idx="7">
                  <c:v>0.29151667033632594</c:v>
                </c:pt>
                <c:pt idx="8">
                  <c:v>4.8516667137543358E-2</c:v>
                </c:pt>
                <c:pt idx="9">
                  <c:v>-3.6666480203469593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0C8-4F5A-861D-6E9BE0276FDD}"/>
            </c:ext>
          </c:extLst>
        </c:ser>
        <c:ser>
          <c:idx val="1"/>
          <c:order val="1"/>
          <c:tx>
            <c:v>補正後</c:v>
          </c:tx>
          <c:marker>
            <c:symbol val="circle"/>
            <c:size val="7"/>
          </c:marker>
          <c:errBars>
            <c:errDir val="y"/>
            <c:errBarType val="both"/>
            <c:errValType val="cust"/>
            <c:noEndCap val="0"/>
            <c:plus>
              <c:numRef>
                <c:f>計算!$CN$115:$CW$115</c:f>
                <c:numCache>
                  <c:formatCode>General</c:formatCode>
                  <c:ptCount val="10"/>
                  <c:pt idx="0">
                    <c:v>1.4408420287198501E-2</c:v>
                  </c:pt>
                  <c:pt idx="1">
                    <c:v>1.4266604378885619E-2</c:v>
                  </c:pt>
                  <c:pt idx="2">
                    <c:v>2.4331019032746159E-2</c:v>
                  </c:pt>
                  <c:pt idx="3">
                    <c:v>1.7809397769078542E-2</c:v>
                  </c:pt>
                  <c:pt idx="4">
                    <c:v>3.8839238654587438E-2</c:v>
                  </c:pt>
                  <c:pt idx="5">
                    <c:v>2.7577412888821162E-2</c:v>
                  </c:pt>
                  <c:pt idx="6">
                    <c:v>4.0607652402076318E-2</c:v>
                  </c:pt>
                  <c:pt idx="7">
                    <c:v>2.8729864729390233E-2</c:v>
                  </c:pt>
                  <c:pt idx="8">
                    <c:v>5.2700707520953946E-3</c:v>
                  </c:pt>
                  <c:pt idx="9">
                    <c:v>9.647104418629357E-4</c:v>
                  </c:pt>
                </c:numCache>
              </c:numRef>
            </c:plus>
            <c:minus>
              <c:numRef>
                <c:f>計算!$CN$115:$CW$115</c:f>
                <c:numCache>
                  <c:formatCode>General</c:formatCode>
                  <c:ptCount val="10"/>
                  <c:pt idx="0">
                    <c:v>1.4408420287198501E-2</c:v>
                  </c:pt>
                  <c:pt idx="1">
                    <c:v>1.4266604378885619E-2</c:v>
                  </c:pt>
                  <c:pt idx="2">
                    <c:v>2.4331019032746159E-2</c:v>
                  </c:pt>
                  <c:pt idx="3">
                    <c:v>1.7809397769078542E-2</c:v>
                  </c:pt>
                  <c:pt idx="4">
                    <c:v>3.8839238654587438E-2</c:v>
                  </c:pt>
                  <c:pt idx="5">
                    <c:v>2.7577412888821162E-2</c:v>
                  </c:pt>
                  <c:pt idx="6">
                    <c:v>4.0607652402076318E-2</c:v>
                  </c:pt>
                  <c:pt idx="7">
                    <c:v>2.8729864729390233E-2</c:v>
                  </c:pt>
                  <c:pt idx="8">
                    <c:v>5.2700707520953946E-3</c:v>
                  </c:pt>
                  <c:pt idx="9">
                    <c:v>9.647104418629357E-4</c:v>
                  </c:pt>
                </c:numCache>
              </c:numRef>
            </c:minus>
          </c:errBars>
          <c:cat>
            <c:numRef>
              <c:f>計算!$CN$113:$CW$113</c:f>
              <c:numCache>
                <c:formatCode>General</c:formatCode>
                <c:ptCount val="10"/>
                <c:pt idx="0">
                  <c:v>0</c:v>
                </c:pt>
                <c:pt idx="1">
                  <c:v>0.08</c:v>
                </c:pt>
                <c:pt idx="2">
                  <c:v>0.25</c:v>
                </c:pt>
                <c:pt idx="3">
                  <c:v>0.8</c:v>
                </c:pt>
                <c:pt idx="4">
                  <c:v>2.5299999999999998</c:v>
                </c:pt>
                <c:pt idx="5">
                  <c:v>8</c:v>
                </c:pt>
                <c:pt idx="6">
                  <c:v>25.3</c:v>
                </c:pt>
                <c:pt idx="7">
                  <c:v>80</c:v>
                </c:pt>
                <c:pt idx="8">
                  <c:v>253</c:v>
                </c:pt>
                <c:pt idx="9">
                  <c:v>800</c:v>
                </c:pt>
              </c:numCache>
            </c:numRef>
          </c:cat>
          <c:val>
            <c:numRef>
              <c:f>計算!$CN$114:$CW$114</c:f>
              <c:numCache>
                <c:formatCode>General</c:formatCode>
                <c:ptCount val="10"/>
                <c:pt idx="0">
                  <c:v>0.28193333620826405</c:v>
                </c:pt>
                <c:pt idx="1">
                  <c:v>0.28475000336766282</c:v>
                </c:pt>
                <c:pt idx="2">
                  <c:v>0.27711666996280399</c:v>
                </c:pt>
                <c:pt idx="3">
                  <c:v>0.27193334077795389</c:v>
                </c:pt>
                <c:pt idx="4">
                  <c:v>0.31193333740035739</c:v>
                </c:pt>
                <c:pt idx="5">
                  <c:v>0.30525000269214358</c:v>
                </c:pt>
                <c:pt idx="6">
                  <c:v>0.29045001044869462</c:v>
                </c:pt>
                <c:pt idx="7">
                  <c:v>0.24418333545327234</c:v>
                </c:pt>
                <c:pt idx="8">
                  <c:v>4.4166656831904723E-3</c:v>
                </c:pt>
                <c:pt idx="9">
                  <c:v>-2.471665727595441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0C8-4F5A-861D-6E9BE0276F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3401936"/>
        <c:axId val="653404336"/>
      </c:lineChart>
      <c:catAx>
        <c:axId val="653401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3404336"/>
        <c:crosses val="autoZero"/>
        <c:auto val="1"/>
        <c:lblAlgn val="ctr"/>
        <c:lblOffset val="100"/>
        <c:noMultiLvlLbl val="0"/>
      </c:catAx>
      <c:valAx>
        <c:axId val="653404336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3401936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800"/>
            </a:pPr>
            <a:r>
              <a:rPr lang="en-US" sz="800"/>
              <a:t>Blank</a:t>
            </a:r>
            <a:endParaRPr lang="ja-JP" sz="800"/>
          </a:p>
        </c:rich>
      </c:tx>
      <c:layout>
        <c:manualLayout>
          <c:xMode val="edge"/>
          <c:yMode val="edge"/>
          <c:x val="0.47096176322284095"/>
          <c:y val="0.55851270703881339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850751588791699"/>
          <c:y val="5.084702520665374E-2"/>
          <c:w val="0.88262273724690377"/>
          <c:h val="0.85383861914632131"/>
        </c:manualLayout>
      </c:layout>
      <c:lineChart>
        <c:grouping val="standard"/>
        <c:varyColors val="0"/>
        <c:ser>
          <c:idx val="1"/>
          <c:order val="0"/>
          <c:tx>
            <c:v>補正前</c:v>
          </c:tx>
          <c:spPr>
            <a:ln w="28575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7:$BC$7</c:f>
                <c:numCache>
                  <c:formatCode>General</c:formatCode>
                  <c:ptCount val="10"/>
                  <c:pt idx="0">
                    <c:v>1.7826908995340299E-2</c:v>
                  </c:pt>
                  <c:pt idx="1">
                    <c:v>3.8975974821135559E-2</c:v>
                  </c:pt>
                  <c:pt idx="2">
                    <c:v>3.4051924330992453E-2</c:v>
                  </c:pt>
                  <c:pt idx="3">
                    <c:v>3.6744073368473226E-2</c:v>
                  </c:pt>
                  <c:pt idx="4">
                    <c:v>3.7598218689136188E-2</c:v>
                  </c:pt>
                  <c:pt idx="5">
                    <c:v>3.5705115633892677E-2</c:v>
                  </c:pt>
                  <c:pt idx="6">
                    <c:v>4.2170196080005211E-2</c:v>
                  </c:pt>
                  <c:pt idx="7">
                    <c:v>4.753666672524149E-2</c:v>
                  </c:pt>
                  <c:pt idx="8">
                    <c:v>4.1093103063723983E-2</c:v>
                  </c:pt>
                  <c:pt idx="9">
                    <c:v>3.0838198503754539E-2</c:v>
                  </c:pt>
                </c:numCache>
              </c:numRef>
            </c:plus>
            <c:minus>
              <c:numRef>
                <c:f>[1]補正前!$AT$7:$BC$7</c:f>
                <c:numCache>
                  <c:formatCode>General</c:formatCode>
                  <c:ptCount val="10"/>
                  <c:pt idx="0">
                    <c:v>1.7826908995340299E-2</c:v>
                  </c:pt>
                  <c:pt idx="1">
                    <c:v>3.8975974821135559E-2</c:v>
                  </c:pt>
                  <c:pt idx="2">
                    <c:v>3.4051924330992453E-2</c:v>
                  </c:pt>
                  <c:pt idx="3">
                    <c:v>3.6744073368473226E-2</c:v>
                  </c:pt>
                  <c:pt idx="4">
                    <c:v>3.7598218689136188E-2</c:v>
                  </c:pt>
                  <c:pt idx="5">
                    <c:v>3.5705115633892677E-2</c:v>
                  </c:pt>
                  <c:pt idx="6">
                    <c:v>4.2170196080005211E-2</c:v>
                  </c:pt>
                  <c:pt idx="7">
                    <c:v>4.753666672524149E-2</c:v>
                  </c:pt>
                  <c:pt idx="8">
                    <c:v>4.1093103063723983E-2</c:v>
                  </c:pt>
                  <c:pt idx="9">
                    <c:v>3.0838198503754539E-2</c:v>
                  </c:pt>
                </c:numCache>
              </c:numRef>
            </c:minus>
          </c:errBars>
          <c:cat>
            <c:numRef>
              <c:f>[1]補正前!$AT$5:$BC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[1]補正前!$AT$6:$BC$6</c:f>
              <c:numCache>
                <c:formatCode>General</c:formatCode>
                <c:ptCount val="10"/>
                <c:pt idx="0">
                  <c:v>0.28696667154630023</c:v>
                </c:pt>
                <c:pt idx="1">
                  <c:v>0.32856667041778564</c:v>
                </c:pt>
                <c:pt idx="2">
                  <c:v>0.34268333514531452</c:v>
                </c:pt>
                <c:pt idx="3">
                  <c:v>0.3744500031073888</c:v>
                </c:pt>
                <c:pt idx="4">
                  <c:v>0.38268334170182544</c:v>
                </c:pt>
                <c:pt idx="5">
                  <c:v>0.37786666552225751</c:v>
                </c:pt>
                <c:pt idx="6">
                  <c:v>0.39711666107177734</c:v>
                </c:pt>
                <c:pt idx="7">
                  <c:v>0.37598333259423572</c:v>
                </c:pt>
                <c:pt idx="8">
                  <c:v>0.34863334397474927</c:v>
                </c:pt>
                <c:pt idx="9">
                  <c:v>0.324266672134399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1B-4A08-81D1-0B1CF1961246}"/>
            </c:ext>
          </c:extLst>
        </c:ser>
        <c:ser>
          <c:idx val="0"/>
          <c:order val="1"/>
          <c:tx>
            <c:v>補正後</c:v>
          </c:tx>
          <c:spPr>
            <a:ln w="38100"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7:$AZ$7</c:f>
                <c:numCache>
                  <c:formatCode>General</c:formatCode>
                  <c:ptCount val="10"/>
                  <c:pt idx="0">
                    <c:v>1.7826908995340299E-2</c:v>
                  </c:pt>
                  <c:pt idx="1">
                    <c:v>3.8975974821135698E-2</c:v>
                  </c:pt>
                  <c:pt idx="2">
                    <c:v>3.4051924330992397E-2</c:v>
                  </c:pt>
                  <c:pt idx="3">
                    <c:v>3.6744073368473178E-2</c:v>
                  </c:pt>
                  <c:pt idx="4">
                    <c:v>3.759821868913614E-2</c:v>
                  </c:pt>
                  <c:pt idx="5">
                    <c:v>3.5705115633892309E-2</c:v>
                  </c:pt>
                  <c:pt idx="6">
                    <c:v>4.2170196080005343E-2</c:v>
                  </c:pt>
                  <c:pt idx="7">
                    <c:v>4.7536666725241372E-2</c:v>
                  </c:pt>
                  <c:pt idx="8">
                    <c:v>4.1093103063723581E-2</c:v>
                  </c:pt>
                  <c:pt idx="9">
                    <c:v>3.0838198503754539E-2</c:v>
                  </c:pt>
                </c:numCache>
              </c:numRef>
            </c:plus>
            <c:minus>
              <c:numRef>
                <c:f>[1]補正後!$AQ$7:$AZ$7</c:f>
                <c:numCache>
                  <c:formatCode>General</c:formatCode>
                  <c:ptCount val="10"/>
                  <c:pt idx="0">
                    <c:v>1.7826908995340299E-2</c:v>
                  </c:pt>
                  <c:pt idx="1">
                    <c:v>3.8975974821135698E-2</c:v>
                  </c:pt>
                  <c:pt idx="2">
                    <c:v>3.4051924330992397E-2</c:v>
                  </c:pt>
                  <c:pt idx="3">
                    <c:v>3.6744073368473178E-2</c:v>
                  </c:pt>
                  <c:pt idx="4">
                    <c:v>3.759821868913614E-2</c:v>
                  </c:pt>
                  <c:pt idx="5">
                    <c:v>3.5705115633892309E-2</c:v>
                  </c:pt>
                  <c:pt idx="6">
                    <c:v>4.2170196080005343E-2</c:v>
                  </c:pt>
                  <c:pt idx="7">
                    <c:v>4.7536666725241372E-2</c:v>
                  </c:pt>
                  <c:pt idx="8">
                    <c:v>4.1093103063723581E-2</c:v>
                  </c:pt>
                  <c:pt idx="9">
                    <c:v>3.0838198503754539E-2</c:v>
                  </c:pt>
                </c:numCache>
              </c:numRef>
            </c:minus>
          </c:errBars>
          <c:cat>
            <c:numRef>
              <c:f>[1]補正後!$AQ$5:$AZ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[1]補正後!$AQ$6:$AZ$6</c:f>
              <c:numCache>
                <c:formatCode>General</c:formatCode>
                <c:ptCount val="10"/>
                <c:pt idx="0">
                  <c:v>0.28696667154630023</c:v>
                </c:pt>
                <c:pt idx="1">
                  <c:v>0.28696667154630001</c:v>
                </c:pt>
                <c:pt idx="2">
                  <c:v>0.28696667154630001</c:v>
                </c:pt>
                <c:pt idx="3">
                  <c:v>0.28696667154630001</c:v>
                </c:pt>
                <c:pt idx="4">
                  <c:v>0.28696667154630001</c:v>
                </c:pt>
                <c:pt idx="5">
                  <c:v>0.28696667154630001</c:v>
                </c:pt>
                <c:pt idx="6">
                  <c:v>0.28696667154630001</c:v>
                </c:pt>
                <c:pt idx="7">
                  <c:v>0.28696667154630001</c:v>
                </c:pt>
                <c:pt idx="8">
                  <c:v>0.28696667154630001</c:v>
                </c:pt>
                <c:pt idx="9">
                  <c:v>0.2869666715463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C1B-4A08-81D1-0B1CF19612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6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cortisone Succinate</a:t>
            </a:r>
          </a:p>
        </c:rich>
      </c:tx>
      <c:layout>
        <c:manualLayout>
          <c:xMode val="edge"/>
          <c:yMode val="edge"/>
          <c:x val="0.1217741441481911"/>
          <c:y val="0.5257002468291995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455332379585397"/>
          <c:y val="4.990052801347182E-2"/>
          <c:w val="0.87912484404912172"/>
          <c:h val="0.85236609346428316"/>
        </c:manualLayout>
      </c:layout>
      <c:lineChart>
        <c:grouping val="standard"/>
        <c:varyColors val="0"/>
        <c:ser>
          <c:idx val="1"/>
          <c:order val="0"/>
          <c:tx>
            <c:v>補正前</c:v>
          </c:tx>
          <c:spPr>
            <a:ln w="28575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21:$BC$21</c:f>
                <c:numCache>
                  <c:formatCode>General</c:formatCode>
                  <c:ptCount val="10"/>
                  <c:pt idx="0">
                    <c:v>9.8905391065802206E-3</c:v>
                  </c:pt>
                  <c:pt idx="1">
                    <c:v>4.5820108632593864E-2</c:v>
                  </c:pt>
                  <c:pt idx="2">
                    <c:v>2.9286968368028615E-2</c:v>
                  </c:pt>
                  <c:pt idx="3">
                    <c:v>4.7401675264198181E-2</c:v>
                  </c:pt>
                  <c:pt idx="4">
                    <c:v>2.1392517682892132E-2</c:v>
                  </c:pt>
                  <c:pt idx="5">
                    <c:v>3.5192586174240106E-2</c:v>
                  </c:pt>
                  <c:pt idx="6">
                    <c:v>1.6855434867399616E-2</c:v>
                  </c:pt>
                  <c:pt idx="7">
                    <c:v>2.7561664366297547E-2</c:v>
                  </c:pt>
                  <c:pt idx="8">
                    <c:v>6.9239863193213116E-3</c:v>
                  </c:pt>
                  <c:pt idx="9">
                    <c:v>1.0918132374245312E-2</c:v>
                  </c:pt>
                </c:numCache>
              </c:numRef>
            </c:plus>
            <c:minus>
              <c:numRef>
                <c:f>[1]補正前!$AT$21:$BC$21</c:f>
                <c:numCache>
                  <c:formatCode>General</c:formatCode>
                  <c:ptCount val="10"/>
                  <c:pt idx="0">
                    <c:v>9.8905391065802206E-3</c:v>
                  </c:pt>
                  <c:pt idx="1">
                    <c:v>4.5820108632593864E-2</c:v>
                  </c:pt>
                  <c:pt idx="2">
                    <c:v>2.9286968368028615E-2</c:v>
                  </c:pt>
                  <c:pt idx="3">
                    <c:v>4.7401675264198181E-2</c:v>
                  </c:pt>
                  <c:pt idx="4">
                    <c:v>2.1392517682892132E-2</c:v>
                  </c:pt>
                  <c:pt idx="5">
                    <c:v>3.5192586174240106E-2</c:v>
                  </c:pt>
                  <c:pt idx="6">
                    <c:v>1.6855434867399616E-2</c:v>
                  </c:pt>
                  <c:pt idx="7">
                    <c:v>2.7561664366297547E-2</c:v>
                  </c:pt>
                  <c:pt idx="8">
                    <c:v>6.9239863193213116E-3</c:v>
                  </c:pt>
                  <c:pt idx="9">
                    <c:v>1.0918132374245312E-2</c:v>
                  </c:pt>
                </c:numCache>
              </c:numRef>
            </c:minus>
          </c:errBars>
          <c:cat>
            <c:numRef>
              <c:f>[1]補正前!$AT$19:$BC$1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前!$AT$20:$BC$20</c:f>
              <c:numCache>
                <c:formatCode>General</c:formatCode>
                <c:ptCount val="10"/>
                <c:pt idx="0">
                  <c:v>0.25283333162466687</c:v>
                </c:pt>
                <c:pt idx="1">
                  <c:v>0.50306666394074762</c:v>
                </c:pt>
                <c:pt idx="2">
                  <c:v>0.55513333777586615</c:v>
                </c:pt>
                <c:pt idx="3">
                  <c:v>0.52216667433579766</c:v>
                </c:pt>
                <c:pt idx="4">
                  <c:v>0.47479999562104541</c:v>
                </c:pt>
                <c:pt idx="5">
                  <c:v>0.47661666572093964</c:v>
                </c:pt>
                <c:pt idx="6">
                  <c:v>0.4278166840473811</c:v>
                </c:pt>
                <c:pt idx="7">
                  <c:v>0.38561666011810303</c:v>
                </c:pt>
                <c:pt idx="8">
                  <c:v>0.26988333463668823</c:v>
                </c:pt>
                <c:pt idx="9">
                  <c:v>0.136816663046677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00C-4198-B641-63D444E52830}"/>
            </c:ext>
          </c:extLst>
        </c:ser>
        <c:ser>
          <c:idx val="0"/>
          <c:order val="1"/>
          <c:tx>
            <c:v>補正後</c:v>
          </c:tx>
          <c:spPr>
            <a:ln w="38100"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22:$AZ$22</c:f>
                <c:numCache>
                  <c:formatCode>General</c:formatCode>
                  <c:ptCount val="10"/>
                  <c:pt idx="0">
                    <c:v>9.8905391065802206E-3</c:v>
                  </c:pt>
                  <c:pt idx="1">
                    <c:v>4.5820108632593851E-2</c:v>
                  </c:pt>
                  <c:pt idx="2">
                    <c:v>2.9286968368028618E-2</c:v>
                  </c:pt>
                  <c:pt idx="3">
                    <c:v>4.7401675264198188E-2</c:v>
                  </c:pt>
                  <c:pt idx="4">
                    <c:v>2.1392517682892132E-2</c:v>
                  </c:pt>
                  <c:pt idx="5">
                    <c:v>3.5192586174240106E-2</c:v>
                  </c:pt>
                  <c:pt idx="6">
                    <c:v>1.6855434867399616E-2</c:v>
                  </c:pt>
                  <c:pt idx="7">
                    <c:v>2.7561664366297547E-2</c:v>
                  </c:pt>
                  <c:pt idx="8">
                    <c:v>6.9239863193213116E-3</c:v>
                  </c:pt>
                  <c:pt idx="9">
                    <c:v>1.0918132374245312E-2</c:v>
                  </c:pt>
                </c:numCache>
              </c:numRef>
            </c:plus>
            <c:minus>
              <c:numRef>
                <c:f>[1]補正後!$AQ$22:$AZ$22</c:f>
                <c:numCache>
                  <c:formatCode>General</c:formatCode>
                  <c:ptCount val="10"/>
                  <c:pt idx="0">
                    <c:v>9.8905391065802206E-3</c:v>
                  </c:pt>
                  <c:pt idx="1">
                    <c:v>4.5820108632593851E-2</c:v>
                  </c:pt>
                  <c:pt idx="2">
                    <c:v>2.9286968368028618E-2</c:v>
                  </c:pt>
                  <c:pt idx="3">
                    <c:v>4.7401675264198188E-2</c:v>
                  </c:pt>
                  <c:pt idx="4">
                    <c:v>2.1392517682892132E-2</c:v>
                  </c:pt>
                  <c:pt idx="5">
                    <c:v>3.5192586174240106E-2</c:v>
                  </c:pt>
                  <c:pt idx="6">
                    <c:v>1.6855434867399616E-2</c:v>
                  </c:pt>
                  <c:pt idx="7">
                    <c:v>2.7561664366297547E-2</c:v>
                  </c:pt>
                  <c:pt idx="8">
                    <c:v>6.9239863193213116E-3</c:v>
                  </c:pt>
                  <c:pt idx="9">
                    <c:v>1.0918132374245312E-2</c:v>
                  </c:pt>
                </c:numCache>
              </c:numRef>
            </c:minus>
          </c:errBars>
          <c:cat>
            <c:numRef>
              <c:f>[1]補正後!$AQ$20:$AZ$20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後!$AQ$21:$AZ$21</c:f>
              <c:numCache>
                <c:formatCode>General</c:formatCode>
                <c:ptCount val="10"/>
                <c:pt idx="0">
                  <c:v>0.25283333162466687</c:v>
                </c:pt>
                <c:pt idx="1">
                  <c:v>0.46146666506926187</c:v>
                </c:pt>
                <c:pt idx="2">
                  <c:v>0.49941667417685176</c:v>
                </c:pt>
                <c:pt idx="3">
                  <c:v>0.43468334277470894</c:v>
                </c:pt>
                <c:pt idx="4">
                  <c:v>0.37908332546551998</c:v>
                </c:pt>
                <c:pt idx="5">
                  <c:v>0.3857166717449822</c:v>
                </c:pt>
                <c:pt idx="6">
                  <c:v>0.31766669452190371</c:v>
                </c:pt>
                <c:pt idx="7">
                  <c:v>0.29659999907016732</c:v>
                </c:pt>
                <c:pt idx="8">
                  <c:v>0.20821666220823901</c:v>
                </c:pt>
                <c:pt idx="9">
                  <c:v>9.951666245857848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00C-4198-B641-63D444E528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05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05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uercetin</a:t>
            </a:r>
            <a:endParaRPr lang="ja-JP" altLang="en-US" sz="105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991982610594195"/>
          <c:y val="0.5467276979993681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4617054922230877"/>
          <c:y val="3.7199726862279479E-2"/>
          <c:w val="0.80419646439613868"/>
          <c:h val="0.73065104617861998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35:$BC$35</c:f>
                <c:numCache>
                  <c:formatCode>General</c:formatCode>
                  <c:ptCount val="10"/>
                  <c:pt idx="0">
                    <c:v>2.1713621135362848E-2</c:v>
                  </c:pt>
                  <c:pt idx="1">
                    <c:v>2.316448844715539E-2</c:v>
                  </c:pt>
                  <c:pt idx="2">
                    <c:v>2.4706675059385726E-2</c:v>
                  </c:pt>
                  <c:pt idx="3">
                    <c:v>2.8853051464344494E-2</c:v>
                  </c:pt>
                  <c:pt idx="4">
                    <c:v>1.9470738024180995E-2</c:v>
                  </c:pt>
                  <c:pt idx="5">
                    <c:v>4.3993222652592499E-2</c:v>
                  </c:pt>
                  <c:pt idx="6">
                    <c:v>5.0045324269488142E-2</c:v>
                  </c:pt>
                  <c:pt idx="7">
                    <c:v>2.3357433160921124E-2</c:v>
                  </c:pt>
                  <c:pt idx="8">
                    <c:v>2.6993318383313179E-2</c:v>
                  </c:pt>
                  <c:pt idx="9">
                    <c:v>9.7058027943843668E-3</c:v>
                  </c:pt>
                </c:numCache>
              </c:numRef>
            </c:plus>
            <c:minus>
              <c:numRef>
                <c:f>[1]補正前!$AT$35:$BC$35</c:f>
                <c:numCache>
                  <c:formatCode>General</c:formatCode>
                  <c:ptCount val="10"/>
                  <c:pt idx="0">
                    <c:v>2.1713621135362848E-2</c:v>
                  </c:pt>
                  <c:pt idx="1">
                    <c:v>2.316448844715539E-2</c:v>
                  </c:pt>
                  <c:pt idx="2">
                    <c:v>2.4706675059385726E-2</c:v>
                  </c:pt>
                  <c:pt idx="3">
                    <c:v>2.8853051464344494E-2</c:v>
                  </c:pt>
                  <c:pt idx="4">
                    <c:v>1.9470738024180995E-2</c:v>
                  </c:pt>
                  <c:pt idx="5">
                    <c:v>4.3993222652592499E-2</c:v>
                  </c:pt>
                  <c:pt idx="6">
                    <c:v>5.0045324269488142E-2</c:v>
                  </c:pt>
                  <c:pt idx="7">
                    <c:v>2.3357433160921124E-2</c:v>
                  </c:pt>
                  <c:pt idx="8">
                    <c:v>2.6993318383313179E-2</c:v>
                  </c:pt>
                  <c:pt idx="9">
                    <c:v>9.7058027943843668E-3</c:v>
                  </c:pt>
                </c:numCache>
              </c:numRef>
            </c:minus>
          </c:errBars>
          <c:cat>
            <c:numRef>
              <c:f>[1]補正前!$AT$33:$BC$33</c:f>
              <c:numCache>
                <c:formatCode>General</c:formatCode>
                <c:ptCount val="10"/>
                <c:pt idx="0">
                  <c:v>0.03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16</c:v>
                </c:pt>
                <c:pt idx="5">
                  <c:v>10</c:v>
                </c:pt>
                <c:pt idx="6">
                  <c:v>31.6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[1]補正前!$AT$34:$BC$34</c:f>
              <c:numCache>
                <c:formatCode>General</c:formatCode>
                <c:ptCount val="10"/>
                <c:pt idx="0">
                  <c:v>0.18541666120290756</c:v>
                </c:pt>
                <c:pt idx="1">
                  <c:v>0.29508332659800846</c:v>
                </c:pt>
                <c:pt idx="2">
                  <c:v>0.31630000223716098</c:v>
                </c:pt>
                <c:pt idx="3">
                  <c:v>0.33886666347583133</c:v>
                </c:pt>
                <c:pt idx="4">
                  <c:v>0.34601666778326035</c:v>
                </c:pt>
                <c:pt idx="5">
                  <c:v>0.38119999816020328</c:v>
                </c:pt>
                <c:pt idx="6">
                  <c:v>0.39846666405598324</c:v>
                </c:pt>
                <c:pt idx="7">
                  <c:v>0.37561666220426559</c:v>
                </c:pt>
                <c:pt idx="8">
                  <c:v>0.25934999932845432</c:v>
                </c:pt>
                <c:pt idx="9">
                  <c:v>0.14216666420300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74E-4AF4-899A-8F8C4545F981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36:$AZ$36</c:f>
                <c:numCache>
                  <c:formatCode>General</c:formatCode>
                  <c:ptCount val="10"/>
                  <c:pt idx="0">
                    <c:v>2.1713621135362848E-2</c:v>
                  </c:pt>
                  <c:pt idx="1">
                    <c:v>2.316448844715539E-2</c:v>
                  </c:pt>
                  <c:pt idx="2">
                    <c:v>2.4706675059385726E-2</c:v>
                  </c:pt>
                  <c:pt idx="3">
                    <c:v>2.8853051464344626E-2</c:v>
                  </c:pt>
                  <c:pt idx="4">
                    <c:v>1.9470738024180995E-2</c:v>
                  </c:pt>
                  <c:pt idx="5">
                    <c:v>4.3993222652592499E-2</c:v>
                  </c:pt>
                  <c:pt idx="6">
                    <c:v>5.0045324269488475E-2</c:v>
                  </c:pt>
                  <c:pt idx="7">
                    <c:v>2.3357433160921124E-2</c:v>
                  </c:pt>
                  <c:pt idx="8">
                    <c:v>2.6993318383313217E-2</c:v>
                  </c:pt>
                  <c:pt idx="9">
                    <c:v>9.7058027943843668E-3</c:v>
                  </c:pt>
                </c:numCache>
              </c:numRef>
            </c:plus>
            <c:minus>
              <c:numRef>
                <c:f>[1]補正後!$AQ$36:$AZ$36</c:f>
                <c:numCache>
                  <c:formatCode>General</c:formatCode>
                  <c:ptCount val="10"/>
                  <c:pt idx="0">
                    <c:v>2.1713621135362848E-2</c:v>
                  </c:pt>
                  <c:pt idx="1">
                    <c:v>2.316448844715539E-2</c:v>
                  </c:pt>
                  <c:pt idx="2">
                    <c:v>2.4706675059385726E-2</c:v>
                  </c:pt>
                  <c:pt idx="3">
                    <c:v>2.8853051464344626E-2</c:v>
                  </c:pt>
                  <c:pt idx="4">
                    <c:v>1.9470738024180995E-2</c:v>
                  </c:pt>
                  <c:pt idx="5">
                    <c:v>4.3993222652592499E-2</c:v>
                  </c:pt>
                  <c:pt idx="6">
                    <c:v>5.0045324269488475E-2</c:v>
                  </c:pt>
                  <c:pt idx="7">
                    <c:v>2.3357433160921124E-2</c:v>
                  </c:pt>
                  <c:pt idx="8">
                    <c:v>2.6993318383313217E-2</c:v>
                  </c:pt>
                  <c:pt idx="9">
                    <c:v>9.7058027943843668E-3</c:v>
                  </c:pt>
                </c:numCache>
              </c:numRef>
            </c:minus>
          </c:errBars>
          <c:cat>
            <c:numRef>
              <c:f>[1]補正後!$AQ$34:$AZ$34</c:f>
              <c:numCache>
                <c:formatCode>General</c:formatCode>
                <c:ptCount val="10"/>
                <c:pt idx="0">
                  <c:v>0.03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16</c:v>
                </c:pt>
                <c:pt idx="5">
                  <c:v>10</c:v>
                </c:pt>
                <c:pt idx="6">
                  <c:v>31.6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[1]補正後!$AQ$35:$AZ$35</c:f>
              <c:numCache>
                <c:formatCode>General</c:formatCode>
                <c:ptCount val="10"/>
                <c:pt idx="0">
                  <c:v>0.18541666120290756</c:v>
                </c:pt>
                <c:pt idx="1">
                  <c:v>0.25348332772652282</c:v>
                </c:pt>
                <c:pt idx="2">
                  <c:v>0.26058333863814648</c:v>
                </c:pt>
                <c:pt idx="3">
                  <c:v>0.25138333191474255</c:v>
                </c:pt>
                <c:pt idx="4">
                  <c:v>0.25029999762773492</c:v>
                </c:pt>
                <c:pt idx="5">
                  <c:v>0.29030000418424584</c:v>
                </c:pt>
                <c:pt idx="6">
                  <c:v>0.28831667453050586</c:v>
                </c:pt>
                <c:pt idx="7">
                  <c:v>0.28660000115632989</c:v>
                </c:pt>
                <c:pt idx="8">
                  <c:v>0.19768332690000509</c:v>
                </c:pt>
                <c:pt idx="9">
                  <c:v>0.10486666361490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74E-4AF4-899A-8F8C4545F9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308913178327737"/>
          <c:y val="0.522149955522510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8426013008484211E-2"/>
          <c:y val="3.6593720992332435E-2"/>
          <c:w val="0.46832617459727449"/>
          <c:h val="0.74350418981981869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AQ$6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0:$BA$10</c:f>
                <c:numCache>
                  <c:formatCode>General</c:formatCode>
                  <c:ptCount val="10"/>
                  <c:pt idx="0">
                    <c:v>2.8301834191849697E-2</c:v>
                  </c:pt>
                  <c:pt idx="1">
                    <c:v>1.3903579150956004E-2</c:v>
                  </c:pt>
                  <c:pt idx="2">
                    <c:v>2.873683484581387E-2</c:v>
                  </c:pt>
                  <c:pt idx="3">
                    <c:v>4.4270332048153525E-2</c:v>
                  </c:pt>
                  <c:pt idx="4">
                    <c:v>4.9676822293630907E-2</c:v>
                  </c:pt>
                  <c:pt idx="5">
                    <c:v>2.4062398839982502E-2</c:v>
                  </c:pt>
                  <c:pt idx="6">
                    <c:v>2.8306095573638623E-2</c:v>
                  </c:pt>
                  <c:pt idx="7">
                    <c:v>5.3043438175002282E-2</c:v>
                  </c:pt>
                  <c:pt idx="8">
                    <c:v>3.2374105484466814E-2</c:v>
                  </c:pt>
                  <c:pt idx="9">
                    <c:v>4.1866439626267897E-2</c:v>
                  </c:pt>
                </c:numCache>
              </c:numRef>
            </c:plus>
            <c:minus>
              <c:numRef>
                <c:f>'[^N1610.2025.04.30.xlsx]計算'!$AR$10:$BA$10</c:f>
                <c:numCache>
                  <c:formatCode>General</c:formatCode>
                  <c:ptCount val="10"/>
                  <c:pt idx="0">
                    <c:v>2.8301834191849697E-2</c:v>
                  </c:pt>
                  <c:pt idx="1">
                    <c:v>1.3903579150956004E-2</c:v>
                  </c:pt>
                  <c:pt idx="2">
                    <c:v>2.873683484581387E-2</c:v>
                  </c:pt>
                  <c:pt idx="3">
                    <c:v>4.4270332048153525E-2</c:v>
                  </c:pt>
                  <c:pt idx="4">
                    <c:v>4.9676822293630907E-2</c:v>
                  </c:pt>
                  <c:pt idx="5">
                    <c:v>2.4062398839982502E-2</c:v>
                  </c:pt>
                  <c:pt idx="6">
                    <c:v>2.8306095573638623E-2</c:v>
                  </c:pt>
                  <c:pt idx="7">
                    <c:v>5.3043438175002282E-2</c:v>
                  </c:pt>
                  <c:pt idx="8">
                    <c:v>3.2374105484466814E-2</c:v>
                  </c:pt>
                  <c:pt idx="9">
                    <c:v>4.18664396262678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:$BA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^N1610.2025.04.30.xlsx]計算'!$AR$6:$BA$6</c:f>
              <c:numCache>
                <c:formatCode>General</c:formatCode>
                <c:ptCount val="10"/>
                <c:pt idx="0">
                  <c:v>0.26818332821130753</c:v>
                </c:pt>
                <c:pt idx="1">
                  <c:v>0.32271999567747117</c:v>
                </c:pt>
                <c:pt idx="2">
                  <c:v>0.34111665934324265</c:v>
                </c:pt>
                <c:pt idx="3">
                  <c:v>0.3498166675368945</c:v>
                </c:pt>
                <c:pt idx="4">
                  <c:v>0.32956666996081668</c:v>
                </c:pt>
                <c:pt idx="5">
                  <c:v>0.34494999796152115</c:v>
                </c:pt>
                <c:pt idx="6">
                  <c:v>0.31676666686932248</c:v>
                </c:pt>
                <c:pt idx="7">
                  <c:v>0.32501666496197384</c:v>
                </c:pt>
                <c:pt idx="8">
                  <c:v>0.31165000051259995</c:v>
                </c:pt>
                <c:pt idx="9">
                  <c:v>0.269533333679040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38E-4172-ACE2-07648A451CD0}"/>
            </c:ext>
          </c:extLst>
        </c:ser>
        <c:ser>
          <c:idx val="1"/>
          <c:order val="1"/>
          <c:tx>
            <c:strRef>
              <c:f>'[^N1610.2025.04.30.xlsx]計算'!$AQ$7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1:$BA$11</c:f>
                <c:numCache>
                  <c:formatCode>General</c:formatCode>
                  <c:ptCount val="10"/>
                  <c:pt idx="0">
                    <c:v>3.266708640255913E-2</c:v>
                  </c:pt>
                  <c:pt idx="1">
                    <c:v>3.1119055504405541E-2</c:v>
                  </c:pt>
                  <c:pt idx="2">
                    <c:v>2.7463718375196206E-2</c:v>
                  </c:pt>
                  <c:pt idx="3">
                    <c:v>2.9349259642536804E-2</c:v>
                  </c:pt>
                  <c:pt idx="4">
                    <c:v>3.5185266814129999E-2</c:v>
                  </c:pt>
                  <c:pt idx="5">
                    <c:v>2.6499486193876987E-2</c:v>
                  </c:pt>
                  <c:pt idx="6">
                    <c:v>2.4505952796344477E-2</c:v>
                  </c:pt>
                  <c:pt idx="7">
                    <c:v>1.9884513965997132E-2</c:v>
                  </c:pt>
                  <c:pt idx="8">
                    <c:v>5.1515435309901277E-2</c:v>
                  </c:pt>
                  <c:pt idx="9">
                    <c:v>2.1058437001016336E-2</c:v>
                  </c:pt>
                </c:numCache>
              </c:numRef>
            </c:plus>
            <c:minus>
              <c:numRef>
                <c:f>'[^N1610.2025.04.30.xlsx]計算'!$AR$11:$BA$11</c:f>
                <c:numCache>
                  <c:formatCode>General</c:formatCode>
                  <c:ptCount val="10"/>
                  <c:pt idx="0">
                    <c:v>3.266708640255913E-2</c:v>
                  </c:pt>
                  <c:pt idx="1">
                    <c:v>3.1119055504405541E-2</c:v>
                  </c:pt>
                  <c:pt idx="2">
                    <c:v>2.7463718375196206E-2</c:v>
                  </c:pt>
                  <c:pt idx="3">
                    <c:v>2.9349259642536804E-2</c:v>
                  </c:pt>
                  <c:pt idx="4">
                    <c:v>3.5185266814129999E-2</c:v>
                  </c:pt>
                  <c:pt idx="5">
                    <c:v>2.6499486193876987E-2</c:v>
                  </c:pt>
                  <c:pt idx="6">
                    <c:v>2.4505952796344477E-2</c:v>
                  </c:pt>
                  <c:pt idx="7">
                    <c:v>1.9884513965997132E-2</c:v>
                  </c:pt>
                  <c:pt idx="8">
                    <c:v>5.1515435309901277E-2</c:v>
                  </c:pt>
                  <c:pt idx="9">
                    <c:v>2.10584370010163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:$BA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^N1610.2025.04.30.xlsx]計算'!$AR$7:$BA$7</c:f>
              <c:numCache>
                <c:formatCode>General</c:formatCode>
                <c:ptCount val="10"/>
                <c:pt idx="0">
                  <c:v>0.30516666918992996</c:v>
                </c:pt>
                <c:pt idx="1">
                  <c:v>0.33450000733137131</c:v>
                </c:pt>
                <c:pt idx="2">
                  <c:v>0.35810000449419022</c:v>
                </c:pt>
                <c:pt idx="3">
                  <c:v>0.35826666404803592</c:v>
                </c:pt>
                <c:pt idx="4">
                  <c:v>0.37733333557844162</c:v>
                </c:pt>
                <c:pt idx="5">
                  <c:v>0.34996667255957919</c:v>
                </c:pt>
                <c:pt idx="6">
                  <c:v>0.35568333913882572</c:v>
                </c:pt>
                <c:pt idx="7">
                  <c:v>0.32918333758910495</c:v>
                </c:pt>
                <c:pt idx="8">
                  <c:v>0.32489999383687973</c:v>
                </c:pt>
                <c:pt idx="9">
                  <c:v>0.292983340720335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38E-4172-ACE2-07648A451CD0}"/>
            </c:ext>
          </c:extLst>
        </c:ser>
        <c:ser>
          <c:idx val="2"/>
          <c:order val="2"/>
          <c:tx>
            <c:strRef>
              <c:f>'[^N1610.2025.04.30.xlsx]計算'!$AQ$8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2:$BA$12</c:f>
                <c:numCache>
                  <c:formatCode>General</c:formatCode>
                  <c:ptCount val="10"/>
                  <c:pt idx="0">
                    <c:v>3.174390025680849E-2</c:v>
                  </c:pt>
                  <c:pt idx="1">
                    <c:v>2.7460772778494041E-2</c:v>
                  </c:pt>
                  <c:pt idx="2">
                    <c:v>3.4089337301200416E-2</c:v>
                  </c:pt>
                  <c:pt idx="3">
                    <c:v>4.2823522486715233E-2</c:v>
                  </c:pt>
                  <c:pt idx="4">
                    <c:v>6.1214298703436518E-2</c:v>
                  </c:pt>
                  <c:pt idx="5">
                    <c:v>4.0764761144647409E-2</c:v>
                  </c:pt>
                  <c:pt idx="6">
                    <c:v>4.2569829513333379E-2</c:v>
                  </c:pt>
                  <c:pt idx="7">
                    <c:v>2.8130946969057793E-2</c:v>
                  </c:pt>
                  <c:pt idx="8">
                    <c:v>2.4825904579643482E-2</c:v>
                  </c:pt>
                  <c:pt idx="9">
                    <c:v>2.2317650427908231E-2</c:v>
                  </c:pt>
                </c:numCache>
              </c:numRef>
            </c:plus>
            <c:minus>
              <c:numRef>
                <c:f>'[^N1610.2025.04.30.xlsx]計算'!$AR$12:$BA$12</c:f>
                <c:numCache>
                  <c:formatCode>General</c:formatCode>
                  <c:ptCount val="10"/>
                  <c:pt idx="0">
                    <c:v>3.174390025680849E-2</c:v>
                  </c:pt>
                  <c:pt idx="1">
                    <c:v>2.7460772778494041E-2</c:v>
                  </c:pt>
                  <c:pt idx="2">
                    <c:v>3.4089337301200416E-2</c:v>
                  </c:pt>
                  <c:pt idx="3">
                    <c:v>4.2823522486715233E-2</c:v>
                  </c:pt>
                  <c:pt idx="4">
                    <c:v>6.1214298703436518E-2</c:v>
                  </c:pt>
                  <c:pt idx="5">
                    <c:v>4.0764761144647409E-2</c:v>
                  </c:pt>
                  <c:pt idx="6">
                    <c:v>4.2569829513333379E-2</c:v>
                  </c:pt>
                  <c:pt idx="7">
                    <c:v>2.8130946969057793E-2</c:v>
                  </c:pt>
                  <c:pt idx="8">
                    <c:v>2.4825904579643482E-2</c:v>
                  </c:pt>
                  <c:pt idx="9">
                    <c:v>2.23176504279082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:$BA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^N1610.2025.04.30.xlsx]計算'!$AR$8:$BA$8</c:f>
              <c:numCache>
                <c:formatCode>General</c:formatCode>
                <c:ptCount val="10"/>
                <c:pt idx="0">
                  <c:v>0.37694999823967618</c:v>
                </c:pt>
                <c:pt idx="1">
                  <c:v>0.41458333283662796</c:v>
                </c:pt>
                <c:pt idx="2">
                  <c:v>0.40355000148216885</c:v>
                </c:pt>
                <c:pt idx="3">
                  <c:v>0.4554833397269249</c:v>
                </c:pt>
                <c:pt idx="4">
                  <c:v>0.41991666704416275</c:v>
                </c:pt>
                <c:pt idx="5">
                  <c:v>0.43458332866430283</c:v>
                </c:pt>
                <c:pt idx="6">
                  <c:v>0.42496666063865024</c:v>
                </c:pt>
                <c:pt idx="7">
                  <c:v>0.42331666996081668</c:v>
                </c:pt>
                <c:pt idx="8">
                  <c:v>0.39071666946013767</c:v>
                </c:pt>
                <c:pt idx="9">
                  <c:v>0.366683336595694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38E-4172-ACE2-07648A451CD0}"/>
            </c:ext>
          </c:extLst>
        </c:ser>
        <c:ser>
          <c:idx val="3"/>
          <c:order val="3"/>
          <c:tx>
            <c:strRef>
              <c:f>'[^N1610.2025.04.30.xlsx]計算'!$AQ$9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^N1610.2025.04.30.xlsx]計算'!$AR$13:$BA$13</c:f>
                <c:numCache>
                  <c:formatCode>General</c:formatCode>
                  <c:ptCount val="10"/>
                  <c:pt idx="0">
                    <c:v>2.2298552483830891E-2</c:v>
                  </c:pt>
                  <c:pt idx="1">
                    <c:v>4.1496476766492818E-2</c:v>
                  </c:pt>
                  <c:pt idx="2">
                    <c:v>3.4009172500647465E-2</c:v>
                  </c:pt>
                  <c:pt idx="3">
                    <c:v>5.0821558381028795E-2</c:v>
                  </c:pt>
                  <c:pt idx="4">
                    <c:v>3.3637514555352098E-2</c:v>
                  </c:pt>
                  <c:pt idx="5">
                    <c:v>2.8287908503583696E-2</c:v>
                  </c:pt>
                  <c:pt idx="6">
                    <c:v>4.5658973621836463E-2</c:v>
                  </c:pt>
                  <c:pt idx="7">
                    <c:v>4.9005261737683138E-2</c:v>
                  </c:pt>
                  <c:pt idx="8">
                    <c:v>4.4583342568262206E-2</c:v>
                  </c:pt>
                  <c:pt idx="9">
                    <c:v>4.6654886818802248E-2</c:v>
                  </c:pt>
                </c:numCache>
              </c:numRef>
            </c:plus>
            <c:minus>
              <c:numRef>
                <c:f>'[^N1610.2025.04.30.xlsx]計算'!$AR$13:$BA$13</c:f>
                <c:numCache>
                  <c:formatCode>General</c:formatCode>
                  <c:ptCount val="10"/>
                  <c:pt idx="0">
                    <c:v>2.2298552483830891E-2</c:v>
                  </c:pt>
                  <c:pt idx="1">
                    <c:v>4.1496476766492818E-2</c:v>
                  </c:pt>
                  <c:pt idx="2">
                    <c:v>3.4009172500647465E-2</c:v>
                  </c:pt>
                  <c:pt idx="3">
                    <c:v>5.0821558381028795E-2</c:v>
                  </c:pt>
                  <c:pt idx="4">
                    <c:v>3.3637514555352098E-2</c:v>
                  </c:pt>
                  <c:pt idx="5">
                    <c:v>2.8287908503583696E-2</c:v>
                  </c:pt>
                  <c:pt idx="6">
                    <c:v>4.5658973621836463E-2</c:v>
                  </c:pt>
                  <c:pt idx="7">
                    <c:v>4.9005261737683138E-2</c:v>
                  </c:pt>
                  <c:pt idx="8">
                    <c:v>4.4583342568262206E-2</c:v>
                  </c:pt>
                  <c:pt idx="9">
                    <c:v>4.665488681880224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^N1610.2025.04.30.xlsx]計算'!$AR$5:$BA$5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[^N1610.2025.04.30.xlsx]計算'!$AR$9:$BA$9</c:f>
              <c:numCache>
                <c:formatCode>General</c:formatCode>
                <c:ptCount val="10"/>
                <c:pt idx="0">
                  <c:v>0.50742499902844429</c:v>
                </c:pt>
                <c:pt idx="1">
                  <c:v>0.53271665548284852</c:v>
                </c:pt>
                <c:pt idx="2">
                  <c:v>0.53890000159541762</c:v>
                </c:pt>
                <c:pt idx="3">
                  <c:v>0.53783333177367842</c:v>
                </c:pt>
                <c:pt idx="4">
                  <c:v>0.56416666880249977</c:v>
                </c:pt>
                <c:pt idx="5">
                  <c:v>0.55611667409539223</c:v>
                </c:pt>
                <c:pt idx="6">
                  <c:v>0.55661666765809059</c:v>
                </c:pt>
                <c:pt idx="7">
                  <c:v>0.54153333480159438</c:v>
                </c:pt>
                <c:pt idx="8">
                  <c:v>0.52523334200183547</c:v>
                </c:pt>
                <c:pt idx="9">
                  <c:v>0.486949993918339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38E-4172-ACE2-07648A451C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17863887"/>
        <c:axId val="317858607"/>
      </c:lineChart>
      <c:catAx>
        <c:axId val="31786388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7858607"/>
        <c:crosses val="autoZero"/>
        <c:auto val="1"/>
        <c:lblAlgn val="ctr"/>
        <c:lblOffset val="100"/>
        <c:noMultiLvlLbl val="0"/>
      </c:catAx>
      <c:valAx>
        <c:axId val="317858607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7863887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007241309523618"/>
          <c:y val="0.4823542200507176"/>
          <c:w val="0.26992746014743479"/>
          <c:h val="0.448471166775306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 dirty="0"/>
              <a:t>Sodium ascorbate</a:t>
            </a:r>
            <a:endParaRPr lang="ja-JP" sz="1050" dirty="0"/>
          </a:p>
        </c:rich>
      </c:tx>
      <c:layout>
        <c:manualLayout>
          <c:xMode val="edge"/>
          <c:yMode val="edge"/>
          <c:x val="0.21948337578759669"/>
          <c:y val="0.4847668928887577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7.1953759511977938E-2"/>
          <c:y val="4.5863636363636377E-2"/>
          <c:w val="0.87912484404912172"/>
          <c:h val="0.84868969219756618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6350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51:$BC$51</c:f>
                <c:numCache>
                  <c:formatCode>General</c:formatCode>
                  <c:ptCount val="10"/>
                  <c:pt idx="0">
                    <c:v>1.8224093243500494E-2</c:v>
                  </c:pt>
                  <c:pt idx="1">
                    <c:v>2.2168950487352148E-2</c:v>
                  </c:pt>
                  <c:pt idx="2">
                    <c:v>3.7940250745350505E-2</c:v>
                  </c:pt>
                  <c:pt idx="3">
                    <c:v>4.7838514572960976E-2</c:v>
                  </c:pt>
                  <c:pt idx="4">
                    <c:v>3.6057732719396815E-2</c:v>
                  </c:pt>
                  <c:pt idx="5">
                    <c:v>3.2625976431625889E-2</c:v>
                  </c:pt>
                  <c:pt idx="6">
                    <c:v>4.3160007235507218E-2</c:v>
                  </c:pt>
                  <c:pt idx="7">
                    <c:v>3.0639622431173772E-2</c:v>
                  </c:pt>
                  <c:pt idx="8">
                    <c:v>3.0567987274045787E-2</c:v>
                  </c:pt>
                  <c:pt idx="9">
                    <c:v>2.236271218421405E-2</c:v>
                  </c:pt>
                </c:numCache>
              </c:numRef>
            </c:plus>
            <c:minus>
              <c:numRef>
                <c:f>[1]補正前!$AT$51:$BC$51</c:f>
                <c:numCache>
                  <c:formatCode>General</c:formatCode>
                  <c:ptCount val="10"/>
                  <c:pt idx="0">
                    <c:v>1.8224093243500494E-2</c:v>
                  </c:pt>
                  <c:pt idx="1">
                    <c:v>2.2168950487352148E-2</c:v>
                  </c:pt>
                  <c:pt idx="2">
                    <c:v>3.7940250745350505E-2</c:v>
                  </c:pt>
                  <c:pt idx="3">
                    <c:v>4.7838514572960976E-2</c:v>
                  </c:pt>
                  <c:pt idx="4">
                    <c:v>3.6057732719396815E-2</c:v>
                  </c:pt>
                  <c:pt idx="5">
                    <c:v>3.2625976431625889E-2</c:v>
                  </c:pt>
                  <c:pt idx="6">
                    <c:v>4.3160007235507218E-2</c:v>
                  </c:pt>
                  <c:pt idx="7">
                    <c:v>3.0639622431173772E-2</c:v>
                  </c:pt>
                  <c:pt idx="8">
                    <c:v>3.0567987274045787E-2</c:v>
                  </c:pt>
                  <c:pt idx="9">
                    <c:v>2.236271218421405E-2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numRef>
              <c:f>[1]補正前!$AT$49:$BC$4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前!$AT$50:$BC$50</c:f>
              <c:numCache>
                <c:formatCode>General</c:formatCode>
                <c:ptCount val="10"/>
                <c:pt idx="0">
                  <c:v>0.27498332659403485</c:v>
                </c:pt>
                <c:pt idx="1">
                  <c:v>0.3106333315372467</c:v>
                </c:pt>
                <c:pt idx="2">
                  <c:v>0.34263332684834796</c:v>
                </c:pt>
                <c:pt idx="3">
                  <c:v>0.39673333863417309</c:v>
                </c:pt>
                <c:pt idx="4">
                  <c:v>0.43139999608198804</c:v>
                </c:pt>
                <c:pt idx="5">
                  <c:v>0.45224999388058978</c:v>
                </c:pt>
                <c:pt idx="6">
                  <c:v>0.48963333666324615</c:v>
                </c:pt>
                <c:pt idx="7">
                  <c:v>0.46944999198118847</c:v>
                </c:pt>
                <c:pt idx="8">
                  <c:v>0.47361665467421216</c:v>
                </c:pt>
                <c:pt idx="9">
                  <c:v>0.30163332819938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809-4C11-928E-B235951D1148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51:$AZ$51</c:f>
                <c:numCache>
                  <c:formatCode>General</c:formatCode>
                  <c:ptCount val="10"/>
                  <c:pt idx="0">
                    <c:v>1.8224093243500494E-2</c:v>
                  </c:pt>
                  <c:pt idx="1">
                    <c:v>2.2168950487352148E-2</c:v>
                  </c:pt>
                  <c:pt idx="2">
                    <c:v>3.7940250745350353E-2</c:v>
                  </c:pt>
                  <c:pt idx="3">
                    <c:v>4.783851457296074E-2</c:v>
                  </c:pt>
                  <c:pt idx="4">
                    <c:v>3.6057732719396815E-2</c:v>
                  </c:pt>
                  <c:pt idx="5">
                    <c:v>3.2625976431625889E-2</c:v>
                  </c:pt>
                  <c:pt idx="6">
                    <c:v>4.3160007235507218E-2</c:v>
                  </c:pt>
                  <c:pt idx="7">
                    <c:v>3.0639622431173772E-2</c:v>
                  </c:pt>
                  <c:pt idx="8">
                    <c:v>3.0567987274045787E-2</c:v>
                  </c:pt>
                  <c:pt idx="9">
                    <c:v>2.236271218421405E-2</c:v>
                  </c:pt>
                </c:numCache>
              </c:numRef>
            </c:plus>
            <c:minus>
              <c:numRef>
                <c:f>[1]補正後!$AQ$51:$AZ$51</c:f>
                <c:numCache>
                  <c:formatCode>General</c:formatCode>
                  <c:ptCount val="10"/>
                  <c:pt idx="0">
                    <c:v>1.8224093243500494E-2</c:v>
                  </c:pt>
                  <c:pt idx="1">
                    <c:v>2.2168950487352148E-2</c:v>
                  </c:pt>
                  <c:pt idx="2">
                    <c:v>3.7940250745350353E-2</c:v>
                  </c:pt>
                  <c:pt idx="3">
                    <c:v>4.783851457296074E-2</c:v>
                  </c:pt>
                  <c:pt idx="4">
                    <c:v>3.6057732719396815E-2</c:v>
                  </c:pt>
                  <c:pt idx="5">
                    <c:v>3.2625976431625889E-2</c:v>
                  </c:pt>
                  <c:pt idx="6">
                    <c:v>4.3160007235507218E-2</c:v>
                  </c:pt>
                  <c:pt idx="7">
                    <c:v>3.0639622431173772E-2</c:v>
                  </c:pt>
                  <c:pt idx="8">
                    <c:v>3.0567987274045787E-2</c:v>
                  </c:pt>
                  <c:pt idx="9">
                    <c:v>2.236271218421405E-2</c:v>
                  </c:pt>
                </c:numCache>
              </c:numRef>
            </c:minus>
          </c:errBars>
          <c:cat>
            <c:numRef>
              <c:f>[1]補正後!$AQ$49:$AZ$49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後!$AQ$50:$AZ$50</c:f>
              <c:numCache>
                <c:formatCode>General</c:formatCode>
                <c:ptCount val="10"/>
                <c:pt idx="0">
                  <c:v>0.27498332659403485</c:v>
                </c:pt>
                <c:pt idx="1">
                  <c:v>0.26903333266576107</c:v>
                </c:pt>
                <c:pt idx="2">
                  <c:v>0.28691666324933346</c:v>
                </c:pt>
                <c:pt idx="3">
                  <c:v>0.30925000707308431</c:v>
                </c:pt>
                <c:pt idx="4">
                  <c:v>0.33568332592646261</c:v>
                </c:pt>
                <c:pt idx="5">
                  <c:v>0.36134999990463235</c:v>
                </c:pt>
                <c:pt idx="6">
                  <c:v>0.37948334713776882</c:v>
                </c:pt>
                <c:pt idx="7">
                  <c:v>0.38043333093325277</c:v>
                </c:pt>
                <c:pt idx="8">
                  <c:v>0.4119499822457629</c:v>
                </c:pt>
                <c:pt idx="9">
                  <c:v>0.264333327611287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809-4C11-928E-B235951D11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 lang="ja-JP" sz="600" b="1">
                <a:solidFill>
                  <a:schemeClr val="tx1"/>
                </a:solidFill>
              </a:defRPr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 lang="ja-JP" sz="600" b="1">
                <a:solidFill>
                  <a:schemeClr val="tx1"/>
                </a:solidFill>
              </a:defRPr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 dirty="0"/>
              <a:t>Curcumin</a:t>
            </a:r>
          </a:p>
        </c:rich>
      </c:tx>
      <c:layout>
        <c:manualLayout>
          <c:xMode val="edge"/>
          <c:yMode val="edge"/>
          <c:x val="0.24649428148346814"/>
          <c:y val="0.5128038930216788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672591287208628"/>
          <c:y val="5.7965703383126253E-2"/>
          <c:w val="0.87890347841135241"/>
          <c:h val="0.85778060128847533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6350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0-0EF7-42A9-987C-48535954372A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[1]補正前!$AT$67:$BC$67</c:f>
                <c:numCache>
                  <c:formatCode>General</c:formatCode>
                  <c:ptCount val="10"/>
                  <c:pt idx="0">
                    <c:v>2.1413307808379592E-2</c:v>
                  </c:pt>
                  <c:pt idx="1">
                    <c:v>2.4522531165531512E-2</c:v>
                  </c:pt>
                  <c:pt idx="2">
                    <c:v>3.2950188764438837E-2</c:v>
                  </c:pt>
                  <c:pt idx="3">
                    <c:v>2.6849320114328116E-2</c:v>
                  </c:pt>
                  <c:pt idx="4">
                    <c:v>3.731952066366355E-2</c:v>
                  </c:pt>
                  <c:pt idx="5">
                    <c:v>3.1973410325817957E-2</c:v>
                  </c:pt>
                  <c:pt idx="6">
                    <c:v>2.3879424673736487E-2</c:v>
                  </c:pt>
                  <c:pt idx="7">
                    <c:v>7.274451897469769E-3</c:v>
                  </c:pt>
                  <c:pt idx="8">
                    <c:v>2.1756991152738717E-3</c:v>
                  </c:pt>
                  <c:pt idx="9">
                    <c:v>1.4292188884086282E-3</c:v>
                  </c:pt>
                </c:numCache>
              </c:numRef>
            </c:plus>
            <c:minus>
              <c:numRef>
                <c:f>[1]補正前!$AT$67:$BC$67</c:f>
                <c:numCache>
                  <c:formatCode>General</c:formatCode>
                  <c:ptCount val="10"/>
                  <c:pt idx="0">
                    <c:v>2.1413307808379592E-2</c:v>
                  </c:pt>
                  <c:pt idx="1">
                    <c:v>2.4522531165531512E-2</c:v>
                  </c:pt>
                  <c:pt idx="2">
                    <c:v>3.2950188764438837E-2</c:v>
                  </c:pt>
                  <c:pt idx="3">
                    <c:v>2.6849320114328116E-2</c:v>
                  </c:pt>
                  <c:pt idx="4">
                    <c:v>3.731952066366355E-2</c:v>
                  </c:pt>
                  <c:pt idx="5">
                    <c:v>3.1973410325817957E-2</c:v>
                  </c:pt>
                  <c:pt idx="6">
                    <c:v>2.3879424673736487E-2</c:v>
                  </c:pt>
                  <c:pt idx="7">
                    <c:v>7.274451897469769E-3</c:v>
                  </c:pt>
                  <c:pt idx="8">
                    <c:v>2.1756991152738717E-3</c:v>
                  </c:pt>
                  <c:pt idx="9">
                    <c:v>1.4292188884086282E-3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numRef>
              <c:f>[1]補正前!$AT$65:$BC$65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前!$AT$66:$BC$66</c:f>
              <c:numCache>
                <c:formatCode>General</c:formatCode>
                <c:ptCount val="10"/>
                <c:pt idx="0">
                  <c:v>0.29271666705608368</c:v>
                </c:pt>
                <c:pt idx="1">
                  <c:v>0.33605000376701355</c:v>
                </c:pt>
                <c:pt idx="2">
                  <c:v>0.35363333423932392</c:v>
                </c:pt>
                <c:pt idx="3">
                  <c:v>0.34441666801770526</c:v>
                </c:pt>
                <c:pt idx="4">
                  <c:v>0.35376666486263275</c:v>
                </c:pt>
                <c:pt idx="5">
                  <c:v>0.34045000374317169</c:v>
                </c:pt>
                <c:pt idx="6">
                  <c:v>0.29635000725587207</c:v>
                </c:pt>
                <c:pt idx="7">
                  <c:v>6.9583334028720856E-2</c:v>
                </c:pt>
                <c:pt idx="8">
                  <c:v>-4.8083332677682243E-2</c:v>
                </c:pt>
                <c:pt idx="9">
                  <c:v>-4.546666642030080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EF7-42A9-987C-48535954372A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67:$AZ$67</c:f>
                <c:numCache>
                  <c:formatCode>General</c:formatCode>
                  <c:ptCount val="10"/>
                  <c:pt idx="0">
                    <c:v>2.1413307808379592E-2</c:v>
                  </c:pt>
                  <c:pt idx="1">
                    <c:v>2.4522531165531512E-2</c:v>
                  </c:pt>
                  <c:pt idx="2">
                    <c:v>3.2950188764438955E-2</c:v>
                  </c:pt>
                  <c:pt idx="3">
                    <c:v>2.6849320114328116E-2</c:v>
                  </c:pt>
                  <c:pt idx="4">
                    <c:v>3.731952066366355E-2</c:v>
                  </c:pt>
                  <c:pt idx="5">
                    <c:v>3.1973410325817436E-2</c:v>
                  </c:pt>
                  <c:pt idx="6">
                    <c:v>2.3879424673736639E-2</c:v>
                  </c:pt>
                  <c:pt idx="7">
                    <c:v>7.2744518974697751E-3</c:v>
                  </c:pt>
                  <c:pt idx="8">
                    <c:v>2.1756991152738717E-3</c:v>
                  </c:pt>
                  <c:pt idx="9">
                    <c:v>1.4292188884086282E-3</c:v>
                  </c:pt>
                </c:numCache>
              </c:numRef>
            </c:plus>
            <c:minus>
              <c:numRef>
                <c:f>[1]補正後!$AQ$67:$AZ$67</c:f>
                <c:numCache>
                  <c:formatCode>General</c:formatCode>
                  <c:ptCount val="10"/>
                  <c:pt idx="0">
                    <c:v>2.1413307808379592E-2</c:v>
                  </c:pt>
                  <c:pt idx="1">
                    <c:v>2.4522531165531512E-2</c:v>
                  </c:pt>
                  <c:pt idx="2">
                    <c:v>3.2950188764438955E-2</c:v>
                  </c:pt>
                  <c:pt idx="3">
                    <c:v>2.6849320114328116E-2</c:v>
                  </c:pt>
                  <c:pt idx="4">
                    <c:v>3.731952066366355E-2</c:v>
                  </c:pt>
                  <c:pt idx="5">
                    <c:v>3.1973410325817436E-2</c:v>
                  </c:pt>
                  <c:pt idx="6">
                    <c:v>2.3879424673736639E-2</c:v>
                  </c:pt>
                  <c:pt idx="7">
                    <c:v>7.2744518974697751E-3</c:v>
                  </c:pt>
                  <c:pt idx="8">
                    <c:v>2.1756991152738717E-3</c:v>
                  </c:pt>
                  <c:pt idx="9">
                    <c:v>1.4292188884086282E-3</c:v>
                  </c:pt>
                </c:numCache>
              </c:numRef>
            </c:minus>
          </c:errBars>
          <c:cat>
            <c:numRef>
              <c:f>[1]補正後!$AQ$65:$AZ$65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後!$AQ$66:$AZ$66</c:f>
              <c:numCache>
                <c:formatCode>General</c:formatCode>
                <c:ptCount val="10"/>
                <c:pt idx="0">
                  <c:v>0.29271666705608368</c:v>
                </c:pt>
                <c:pt idx="1">
                  <c:v>0.29445000489552792</c:v>
                </c:pt>
                <c:pt idx="2">
                  <c:v>0.29791667064030941</c:v>
                </c:pt>
                <c:pt idx="3">
                  <c:v>0.25693333645661648</c:v>
                </c:pt>
                <c:pt idx="4">
                  <c:v>0.25804999470710732</c:v>
                </c:pt>
                <c:pt idx="5">
                  <c:v>0.24955000976721423</c:v>
                </c:pt>
                <c:pt idx="6">
                  <c:v>0.18620001773039474</c:v>
                </c:pt>
                <c:pt idx="7">
                  <c:v>-1.9433327019214852E-2</c:v>
                </c:pt>
                <c:pt idx="8">
                  <c:v>-0.10975000510613149</c:v>
                </c:pt>
                <c:pt idx="9">
                  <c:v>-8.276666700840019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EF7-42A9-987C-4853595437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 lang="ja-JP" sz="600" b="1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 lang="ja-JP" sz="600" b="1">
                <a:solidFill>
                  <a:schemeClr val="tx1"/>
                </a:solidFill>
              </a:defRPr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 dirty="0"/>
              <a:t> Resveratrol</a:t>
            </a:r>
            <a:endParaRPr lang="ja-JP" sz="1050" dirty="0"/>
          </a:p>
        </c:rich>
      </c:tx>
      <c:layout>
        <c:manualLayout>
          <c:xMode val="edge"/>
          <c:yMode val="edge"/>
          <c:x val="0.14590393701649595"/>
          <c:y val="0.6408167089526268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7.1953743975460713E-2"/>
          <c:y val="4.5863636363636377E-2"/>
          <c:w val="0.88537715489087543"/>
          <c:h val="0.84868969219756618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6350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fixedVal"/>
            <c:noEndCap val="0"/>
            <c:val val="0.05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numRef>
              <c:f>[1]補正前!$AT$79:$BC$79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[1]補正前!$AT$80:$BC$80</c:f>
              <c:numCache>
                <c:formatCode>General</c:formatCode>
                <c:ptCount val="10"/>
                <c:pt idx="0">
                  <c:v>0.39563333367307979</c:v>
                </c:pt>
                <c:pt idx="1">
                  <c:v>0.41341666256388027</c:v>
                </c:pt>
                <c:pt idx="2">
                  <c:v>0.43923334156473476</c:v>
                </c:pt>
                <c:pt idx="3">
                  <c:v>0.45228333647052449</c:v>
                </c:pt>
                <c:pt idx="4">
                  <c:v>0.44156667465964955</c:v>
                </c:pt>
                <c:pt idx="5">
                  <c:v>0.44788333649436635</c:v>
                </c:pt>
                <c:pt idx="6">
                  <c:v>0.42900000388423604</c:v>
                </c:pt>
                <c:pt idx="7">
                  <c:v>0.36603333428502083</c:v>
                </c:pt>
                <c:pt idx="8">
                  <c:v>0.277883334706227</c:v>
                </c:pt>
                <c:pt idx="9">
                  <c:v>0.134700001527865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F96-4236-A2FC-2EDBF34469A3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82:$AZ$82</c:f>
                <c:numCache>
                  <c:formatCode>General</c:formatCode>
                  <c:ptCount val="10"/>
                  <c:pt idx="0">
                    <c:v>2.6860356181772453E-2</c:v>
                  </c:pt>
                  <c:pt idx="1">
                    <c:v>3.754774976905019E-2</c:v>
                  </c:pt>
                  <c:pt idx="2">
                    <c:v>3.644946167736754E-2</c:v>
                  </c:pt>
                  <c:pt idx="3">
                    <c:v>5.4419391582839649E-2</c:v>
                  </c:pt>
                  <c:pt idx="4">
                    <c:v>3.9376164623790531E-2</c:v>
                  </c:pt>
                  <c:pt idx="5">
                    <c:v>5.818670826319413E-2</c:v>
                  </c:pt>
                  <c:pt idx="6">
                    <c:v>4.2645665100607376E-2</c:v>
                  </c:pt>
                  <c:pt idx="7">
                    <c:v>2.8498257551123233E-2</c:v>
                  </c:pt>
                  <c:pt idx="8">
                    <c:v>1.1661115425979786E-2</c:v>
                  </c:pt>
                  <c:pt idx="9">
                    <c:v>1.0518933743591403E-2</c:v>
                  </c:pt>
                </c:numCache>
              </c:numRef>
            </c:plus>
            <c:minus>
              <c:numRef>
                <c:f>[1]補正後!$AQ$82:$AZ$82</c:f>
                <c:numCache>
                  <c:formatCode>General</c:formatCode>
                  <c:ptCount val="10"/>
                  <c:pt idx="0">
                    <c:v>2.6860356181772453E-2</c:v>
                  </c:pt>
                  <c:pt idx="1">
                    <c:v>3.754774976905019E-2</c:v>
                  </c:pt>
                  <c:pt idx="2">
                    <c:v>3.644946167736754E-2</c:v>
                  </c:pt>
                  <c:pt idx="3">
                    <c:v>5.4419391582839649E-2</c:v>
                  </c:pt>
                  <c:pt idx="4">
                    <c:v>3.9376164623790531E-2</c:v>
                  </c:pt>
                  <c:pt idx="5">
                    <c:v>5.818670826319413E-2</c:v>
                  </c:pt>
                  <c:pt idx="6">
                    <c:v>4.2645665100607376E-2</c:v>
                  </c:pt>
                  <c:pt idx="7">
                    <c:v>2.8498257551123233E-2</c:v>
                  </c:pt>
                  <c:pt idx="8">
                    <c:v>1.1661115425979786E-2</c:v>
                  </c:pt>
                  <c:pt idx="9">
                    <c:v>1.0518933743591403E-2</c:v>
                  </c:pt>
                </c:numCache>
              </c:numRef>
            </c:minus>
          </c:errBars>
          <c:cat>
            <c:numRef>
              <c:f>[1]補正後!$AQ$80:$AZ$80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[1]補正後!$AQ$81:$AZ$81</c:f>
              <c:numCache>
                <c:formatCode>General</c:formatCode>
                <c:ptCount val="10"/>
                <c:pt idx="0">
                  <c:v>0.39563333367307979</c:v>
                </c:pt>
                <c:pt idx="1">
                  <c:v>0.37181666369239469</c:v>
                </c:pt>
                <c:pt idx="2">
                  <c:v>0.38351667796572025</c:v>
                </c:pt>
                <c:pt idx="3">
                  <c:v>0.3648000049094357</c:v>
                </c:pt>
                <c:pt idx="4">
                  <c:v>0.34585000450412412</c:v>
                </c:pt>
                <c:pt idx="5">
                  <c:v>0.35698334251840885</c:v>
                </c:pt>
                <c:pt idx="6">
                  <c:v>0.31885001435875865</c:v>
                </c:pt>
                <c:pt idx="7">
                  <c:v>0.27701667323708512</c:v>
                </c:pt>
                <c:pt idx="8">
                  <c:v>0.21621666227777778</c:v>
                </c:pt>
                <c:pt idx="9">
                  <c:v>9.740000093976632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F96-4236-A2FC-2EDBF34469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 dirty="0"/>
              <a:t>Astaxanthin</a:t>
            </a:r>
            <a:endParaRPr lang="ja-JP" sz="1050" dirty="0"/>
          </a:p>
        </c:rich>
      </c:tx>
      <c:layout>
        <c:manualLayout>
          <c:xMode val="edge"/>
          <c:yMode val="edge"/>
          <c:x val="0.19331123929092836"/>
          <c:y val="0.63516285931629057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7.1953743975460713E-2"/>
          <c:y val="3.6828536873701967E-2"/>
          <c:w val="0.88537715489087543"/>
          <c:h val="0.85756475632723317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95:$BC$95</c:f>
                <c:numCache>
                  <c:formatCode>General</c:formatCode>
                  <c:ptCount val="10"/>
                  <c:pt idx="0">
                    <c:v>3.8313637095411274E-2</c:v>
                  </c:pt>
                  <c:pt idx="1">
                    <c:v>3.671530263427001E-2</c:v>
                  </c:pt>
                  <c:pt idx="2">
                    <c:v>3.6203406763782225E-2</c:v>
                  </c:pt>
                  <c:pt idx="3">
                    <c:v>3.9504485664461589E-2</c:v>
                  </c:pt>
                  <c:pt idx="4">
                    <c:v>4.2613105444710864E-2</c:v>
                  </c:pt>
                  <c:pt idx="5">
                    <c:v>4.0774549083826647E-2</c:v>
                  </c:pt>
                  <c:pt idx="6">
                    <c:v>4.6028230875361412E-2</c:v>
                  </c:pt>
                  <c:pt idx="7">
                    <c:v>2.8745833982030851E-2</c:v>
                  </c:pt>
                  <c:pt idx="8">
                    <c:v>5.4181588783378455E-2</c:v>
                  </c:pt>
                  <c:pt idx="9">
                    <c:v>3.4662798319559179E-2</c:v>
                  </c:pt>
                </c:numCache>
              </c:numRef>
            </c:plus>
            <c:minus>
              <c:numRef>
                <c:f>[1]補正前!$AT$95:$BC$95</c:f>
                <c:numCache>
                  <c:formatCode>General</c:formatCode>
                  <c:ptCount val="10"/>
                  <c:pt idx="0">
                    <c:v>3.8313637095411274E-2</c:v>
                  </c:pt>
                  <c:pt idx="1">
                    <c:v>3.671530263427001E-2</c:v>
                  </c:pt>
                  <c:pt idx="2">
                    <c:v>3.6203406763782225E-2</c:v>
                  </c:pt>
                  <c:pt idx="3">
                    <c:v>3.9504485664461589E-2</c:v>
                  </c:pt>
                  <c:pt idx="4">
                    <c:v>4.2613105444710864E-2</c:v>
                  </c:pt>
                  <c:pt idx="5">
                    <c:v>4.0774549083826647E-2</c:v>
                  </c:pt>
                  <c:pt idx="6">
                    <c:v>4.6028230875361412E-2</c:v>
                  </c:pt>
                  <c:pt idx="7">
                    <c:v>2.8745833982030851E-2</c:v>
                  </c:pt>
                  <c:pt idx="8">
                    <c:v>5.4181588783378455E-2</c:v>
                  </c:pt>
                  <c:pt idx="9">
                    <c:v>3.4662798319559179E-2</c:v>
                  </c:pt>
                </c:numCache>
              </c:numRef>
            </c:minus>
          </c:errBars>
          <c:cat>
            <c:numRef>
              <c:f>[1]補正前!$AT$93:$BC$93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[1]補正前!$AT$94:$BC$94</c:f>
              <c:numCache>
                <c:formatCode>General</c:formatCode>
                <c:ptCount val="10"/>
                <c:pt idx="0">
                  <c:v>0.28243333846330643</c:v>
                </c:pt>
                <c:pt idx="1">
                  <c:v>0.33951666702826816</c:v>
                </c:pt>
                <c:pt idx="2">
                  <c:v>0.3639666810631752</c:v>
                </c:pt>
                <c:pt idx="3">
                  <c:v>0.38370000571012497</c:v>
                </c:pt>
                <c:pt idx="4">
                  <c:v>0.39480000982681912</c:v>
                </c:pt>
                <c:pt idx="5">
                  <c:v>0.37805000195900601</c:v>
                </c:pt>
                <c:pt idx="6">
                  <c:v>0.37411667654911679</c:v>
                </c:pt>
                <c:pt idx="7">
                  <c:v>0.3853333368897438</c:v>
                </c:pt>
                <c:pt idx="8">
                  <c:v>0.380683330198129</c:v>
                </c:pt>
                <c:pt idx="9">
                  <c:v>0.3922833378116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4F2-431A-B1B3-CFD2DB97DAFD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96:$AZ$96</c:f>
                <c:numCache>
                  <c:formatCode>General</c:formatCode>
                  <c:ptCount val="10"/>
                  <c:pt idx="0">
                    <c:v>3.8313637095411274E-2</c:v>
                  </c:pt>
                  <c:pt idx="1">
                    <c:v>3.6715302634270114E-2</c:v>
                  </c:pt>
                  <c:pt idx="2">
                    <c:v>3.6203406763782225E-2</c:v>
                  </c:pt>
                  <c:pt idx="3">
                    <c:v>3.9504485664461589E-2</c:v>
                  </c:pt>
                  <c:pt idx="4">
                    <c:v>4.2613105444710947E-2</c:v>
                  </c:pt>
                  <c:pt idx="5">
                    <c:v>4.0774549083826328E-2</c:v>
                  </c:pt>
                  <c:pt idx="6">
                    <c:v>4.6028230875361772E-2</c:v>
                  </c:pt>
                  <c:pt idx="7">
                    <c:v>2.8745833982030851E-2</c:v>
                  </c:pt>
                  <c:pt idx="8">
                    <c:v>5.4181588783378455E-2</c:v>
                  </c:pt>
                  <c:pt idx="9">
                    <c:v>3.4662798319559179E-2</c:v>
                  </c:pt>
                </c:numCache>
              </c:numRef>
            </c:plus>
            <c:minus>
              <c:numRef>
                <c:f>[1]補正後!$AQ$96:$AZ$96</c:f>
                <c:numCache>
                  <c:formatCode>General</c:formatCode>
                  <c:ptCount val="10"/>
                  <c:pt idx="0">
                    <c:v>3.8313637095411274E-2</c:v>
                  </c:pt>
                  <c:pt idx="1">
                    <c:v>3.6715302634270114E-2</c:v>
                  </c:pt>
                  <c:pt idx="2">
                    <c:v>3.6203406763782225E-2</c:v>
                  </c:pt>
                  <c:pt idx="3">
                    <c:v>3.9504485664461589E-2</c:v>
                  </c:pt>
                  <c:pt idx="4">
                    <c:v>4.2613105444710947E-2</c:v>
                  </c:pt>
                  <c:pt idx="5">
                    <c:v>4.0774549083826328E-2</c:v>
                  </c:pt>
                  <c:pt idx="6">
                    <c:v>4.6028230875361772E-2</c:v>
                  </c:pt>
                  <c:pt idx="7">
                    <c:v>2.8745833982030851E-2</c:v>
                  </c:pt>
                  <c:pt idx="8">
                    <c:v>5.4181588783378455E-2</c:v>
                  </c:pt>
                  <c:pt idx="9">
                    <c:v>3.4662798319559179E-2</c:v>
                  </c:pt>
                </c:numCache>
              </c:numRef>
            </c:minus>
          </c:errBars>
          <c:cat>
            <c:numRef>
              <c:f>[1]補正後!$AQ$94:$AZ$94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[1]補正後!$AQ$95:$AZ$95</c:f>
              <c:numCache>
                <c:formatCode>General</c:formatCode>
                <c:ptCount val="10"/>
                <c:pt idx="0">
                  <c:v>0.28243333846330643</c:v>
                </c:pt>
                <c:pt idx="1">
                  <c:v>0.29791666815678253</c:v>
                </c:pt>
                <c:pt idx="2">
                  <c:v>0.3082500174641607</c:v>
                </c:pt>
                <c:pt idx="3">
                  <c:v>0.29621667414903619</c:v>
                </c:pt>
                <c:pt idx="4">
                  <c:v>0.29908333967129369</c:v>
                </c:pt>
                <c:pt idx="5">
                  <c:v>0.28715000798304852</c:v>
                </c:pt>
                <c:pt idx="6">
                  <c:v>0.2639666870236394</c:v>
                </c:pt>
                <c:pt idx="7">
                  <c:v>0.2963166758418081</c:v>
                </c:pt>
                <c:pt idx="8">
                  <c:v>0.3190166577696798</c:v>
                </c:pt>
                <c:pt idx="9">
                  <c:v>0.354983337223529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4F2-431A-B1B3-CFD2DB97DA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/>
              <a:t>DHA</a:t>
            </a:r>
            <a:endParaRPr lang="ja-JP" sz="1050"/>
          </a:p>
        </c:rich>
      </c:tx>
      <c:layout>
        <c:manualLayout>
          <c:xMode val="edge"/>
          <c:yMode val="edge"/>
          <c:x val="0.37855490233263789"/>
          <c:y val="0.627053806643685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7.2085532577658568E-2"/>
          <c:y val="3.5244953376735881E-2"/>
          <c:w val="0.88516721467508874"/>
          <c:h val="0.86471460504606301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109:$BC$109</c:f>
                <c:numCache>
                  <c:formatCode>General</c:formatCode>
                  <c:ptCount val="10"/>
                  <c:pt idx="0">
                    <c:v>2.0659203584086624E-2</c:v>
                  </c:pt>
                  <c:pt idx="1">
                    <c:v>3.4773307703957861E-2</c:v>
                  </c:pt>
                  <c:pt idx="2">
                    <c:v>5.0218977008435924E-2</c:v>
                  </c:pt>
                  <c:pt idx="3">
                    <c:v>4.2689966083071441E-2</c:v>
                  </c:pt>
                  <c:pt idx="4">
                    <c:v>3.6148664098729806E-2</c:v>
                  </c:pt>
                  <c:pt idx="5">
                    <c:v>2.5240582850230425E-2</c:v>
                  </c:pt>
                  <c:pt idx="6">
                    <c:v>2.9038095679139543E-2</c:v>
                  </c:pt>
                  <c:pt idx="7">
                    <c:v>3.7935566890530507E-2</c:v>
                  </c:pt>
                  <c:pt idx="8">
                    <c:v>1.8979426031318043E-2</c:v>
                  </c:pt>
                  <c:pt idx="9">
                    <c:v>1.118649321941264E-2</c:v>
                  </c:pt>
                </c:numCache>
              </c:numRef>
            </c:plus>
            <c:minus>
              <c:numRef>
                <c:f>[1]補正前!$AT$109:$BC$109</c:f>
                <c:numCache>
                  <c:formatCode>General</c:formatCode>
                  <c:ptCount val="10"/>
                  <c:pt idx="0">
                    <c:v>2.0659203584086624E-2</c:v>
                  </c:pt>
                  <c:pt idx="1">
                    <c:v>3.4773307703957861E-2</c:v>
                  </c:pt>
                  <c:pt idx="2">
                    <c:v>5.0218977008435924E-2</c:v>
                  </c:pt>
                  <c:pt idx="3">
                    <c:v>4.2689966083071441E-2</c:v>
                  </c:pt>
                  <c:pt idx="4">
                    <c:v>3.6148664098729806E-2</c:v>
                  </c:pt>
                  <c:pt idx="5">
                    <c:v>2.5240582850230425E-2</c:v>
                  </c:pt>
                  <c:pt idx="6">
                    <c:v>2.9038095679139543E-2</c:v>
                  </c:pt>
                  <c:pt idx="7">
                    <c:v>3.7935566890530507E-2</c:v>
                  </c:pt>
                  <c:pt idx="8">
                    <c:v>1.8979426031318043E-2</c:v>
                  </c:pt>
                  <c:pt idx="9">
                    <c:v>1.118649321941264E-2</c:v>
                  </c:pt>
                </c:numCache>
              </c:numRef>
            </c:minus>
          </c:errBars>
          <c:cat>
            <c:numRef>
              <c:f>[1]補正前!$AT$107:$BC$107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[1]補正前!$AT$108:$BC$108</c:f>
              <c:numCache>
                <c:formatCode>General</c:formatCode>
                <c:ptCount val="10"/>
                <c:pt idx="0">
                  <c:v>0.26213333507378894</c:v>
                </c:pt>
                <c:pt idx="1">
                  <c:v>0.28526666760444641</c:v>
                </c:pt>
                <c:pt idx="2">
                  <c:v>0.30901667475700378</c:v>
                </c:pt>
                <c:pt idx="3">
                  <c:v>0.32438333829243976</c:v>
                </c:pt>
                <c:pt idx="4">
                  <c:v>0.3188166618347168</c:v>
                </c:pt>
                <c:pt idx="5">
                  <c:v>0.31293333570162457</c:v>
                </c:pt>
                <c:pt idx="6">
                  <c:v>0.32473333179950714</c:v>
                </c:pt>
                <c:pt idx="7">
                  <c:v>0.32034999628861743</c:v>
                </c:pt>
                <c:pt idx="8">
                  <c:v>0.2458666612704595</c:v>
                </c:pt>
                <c:pt idx="9">
                  <c:v>2.341666693488756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122-440F-B4B3-5C403274346B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110:$AZ$110</c:f>
                <c:numCache>
                  <c:formatCode>General</c:formatCode>
                  <c:ptCount val="10"/>
                  <c:pt idx="0">
                    <c:v>2.0659203584086624E-2</c:v>
                  </c:pt>
                  <c:pt idx="1">
                    <c:v>3.477330770395802E-2</c:v>
                  </c:pt>
                  <c:pt idx="2">
                    <c:v>5.0218977008435924E-2</c:v>
                  </c:pt>
                  <c:pt idx="3">
                    <c:v>4.268996608307131E-2</c:v>
                  </c:pt>
                  <c:pt idx="4">
                    <c:v>3.6148664098729959E-2</c:v>
                  </c:pt>
                  <c:pt idx="5">
                    <c:v>2.5240582850229912E-2</c:v>
                  </c:pt>
                  <c:pt idx="6">
                    <c:v>2.9038095679139543E-2</c:v>
                  </c:pt>
                  <c:pt idx="7">
                    <c:v>3.7935566890530355E-2</c:v>
                  </c:pt>
                  <c:pt idx="8">
                    <c:v>1.8979426031318043E-2</c:v>
                  </c:pt>
                  <c:pt idx="9">
                    <c:v>1.1186493219412638E-2</c:v>
                  </c:pt>
                </c:numCache>
              </c:numRef>
            </c:plus>
            <c:minus>
              <c:numRef>
                <c:f>[1]補正後!$AQ$110:$AZ$110</c:f>
                <c:numCache>
                  <c:formatCode>General</c:formatCode>
                  <c:ptCount val="10"/>
                  <c:pt idx="0">
                    <c:v>2.0659203584086624E-2</c:v>
                  </c:pt>
                  <c:pt idx="1">
                    <c:v>3.477330770395802E-2</c:v>
                  </c:pt>
                  <c:pt idx="2">
                    <c:v>5.0218977008435924E-2</c:v>
                  </c:pt>
                  <c:pt idx="3">
                    <c:v>4.268996608307131E-2</c:v>
                  </c:pt>
                  <c:pt idx="4">
                    <c:v>3.6148664098729959E-2</c:v>
                  </c:pt>
                  <c:pt idx="5">
                    <c:v>2.5240582850229912E-2</c:v>
                  </c:pt>
                  <c:pt idx="6">
                    <c:v>2.9038095679139543E-2</c:v>
                  </c:pt>
                  <c:pt idx="7">
                    <c:v>3.7935566890530355E-2</c:v>
                  </c:pt>
                  <c:pt idx="8">
                    <c:v>1.8979426031318043E-2</c:v>
                  </c:pt>
                  <c:pt idx="9">
                    <c:v>1.1186493219412638E-2</c:v>
                  </c:pt>
                </c:numCache>
              </c:numRef>
            </c:minus>
          </c:errBars>
          <c:cat>
            <c:numRef>
              <c:f>[1]補正後!$AQ$108:$AZ$108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26</c:v>
                </c:pt>
                <c:pt idx="5">
                  <c:v>0.4</c:v>
                </c:pt>
                <c:pt idx="6">
                  <c:v>1.26</c:v>
                </c:pt>
                <c:pt idx="7">
                  <c:v>4</c:v>
                </c:pt>
                <c:pt idx="8">
                  <c:v>12.6</c:v>
                </c:pt>
                <c:pt idx="9">
                  <c:v>40</c:v>
                </c:pt>
              </c:numCache>
            </c:numRef>
          </c:cat>
          <c:val>
            <c:numRef>
              <c:f>[1]補正後!$AQ$109:$AZ$109</c:f>
              <c:numCache>
                <c:formatCode>General</c:formatCode>
                <c:ptCount val="10"/>
                <c:pt idx="0">
                  <c:v>0.26213333507378894</c:v>
                </c:pt>
                <c:pt idx="1">
                  <c:v>0.24366666873296075</c:v>
                </c:pt>
                <c:pt idx="2">
                  <c:v>0.25330001115798928</c:v>
                </c:pt>
                <c:pt idx="3">
                  <c:v>0.236900006731351</c:v>
                </c:pt>
                <c:pt idx="4">
                  <c:v>0.22309999167919137</c:v>
                </c:pt>
                <c:pt idx="5">
                  <c:v>0.2220333417256671</c:v>
                </c:pt>
                <c:pt idx="6">
                  <c:v>0.21458334227402978</c:v>
                </c:pt>
                <c:pt idx="7">
                  <c:v>0.23133333524068175</c:v>
                </c:pt>
                <c:pt idx="8">
                  <c:v>0.18419998884201025</c:v>
                </c:pt>
                <c:pt idx="9">
                  <c:v>-1.388333365321183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122-440F-B4B3-5C40327434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 dirty="0"/>
              <a:t>Coenzyme Q10</a:t>
            </a:r>
            <a:endParaRPr lang="ja-JP" sz="1050" dirty="0"/>
          </a:p>
        </c:rich>
      </c:tx>
      <c:layout>
        <c:manualLayout>
          <c:xMode val="edge"/>
          <c:yMode val="edge"/>
          <c:x val="0.19644521067304463"/>
          <c:y val="0.5067487832228595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7.2085532577658568E-2"/>
          <c:y val="4.8078045623332046E-2"/>
          <c:w val="0.87890347841135241"/>
          <c:h val="0.85135140670688791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19050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123:$BC$123</c:f>
                <c:numCache>
                  <c:formatCode>General</c:formatCode>
                  <c:ptCount val="10"/>
                  <c:pt idx="0">
                    <c:v>2.2904558750726545E-2</c:v>
                  </c:pt>
                  <c:pt idx="1">
                    <c:v>2.0183622205602846E-2</c:v>
                  </c:pt>
                  <c:pt idx="2">
                    <c:v>4.4304883146723428E-2</c:v>
                  </c:pt>
                  <c:pt idx="3">
                    <c:v>4.1090436252396292E-2</c:v>
                  </c:pt>
                  <c:pt idx="4">
                    <c:v>3.1169538948045219E-2</c:v>
                  </c:pt>
                  <c:pt idx="5">
                    <c:v>2.522495345311573E-2</c:v>
                  </c:pt>
                  <c:pt idx="6">
                    <c:v>3.5759511654519051E-2</c:v>
                  </c:pt>
                  <c:pt idx="7">
                    <c:v>2.5419080232055764E-2</c:v>
                  </c:pt>
                  <c:pt idx="8">
                    <c:v>1.6489477173161932E-2</c:v>
                  </c:pt>
                  <c:pt idx="9">
                    <c:v>1.4529963155559749E-2</c:v>
                  </c:pt>
                </c:numCache>
              </c:numRef>
            </c:plus>
            <c:minus>
              <c:numRef>
                <c:f>[1]補正前!$AT$123:$BC$123</c:f>
                <c:numCache>
                  <c:formatCode>General</c:formatCode>
                  <c:ptCount val="10"/>
                  <c:pt idx="0">
                    <c:v>2.2904558750726545E-2</c:v>
                  </c:pt>
                  <c:pt idx="1">
                    <c:v>2.0183622205602846E-2</c:v>
                  </c:pt>
                  <c:pt idx="2">
                    <c:v>4.4304883146723428E-2</c:v>
                  </c:pt>
                  <c:pt idx="3">
                    <c:v>4.1090436252396292E-2</c:v>
                  </c:pt>
                  <c:pt idx="4">
                    <c:v>3.1169538948045219E-2</c:v>
                  </c:pt>
                  <c:pt idx="5">
                    <c:v>2.522495345311573E-2</c:v>
                  </c:pt>
                  <c:pt idx="6">
                    <c:v>3.5759511654519051E-2</c:v>
                  </c:pt>
                  <c:pt idx="7">
                    <c:v>2.5419080232055764E-2</c:v>
                  </c:pt>
                  <c:pt idx="8">
                    <c:v>1.6489477173161932E-2</c:v>
                  </c:pt>
                  <c:pt idx="9">
                    <c:v>1.4529963155559749E-2</c:v>
                  </c:pt>
                </c:numCache>
              </c:numRef>
            </c:minus>
          </c:errBars>
          <c:cat>
            <c:numRef>
              <c:f>[1]補正前!$AT$121:$BC$12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前!$AT$122:$BC$122</c:f>
              <c:numCache>
                <c:formatCode>General</c:formatCode>
                <c:ptCount val="10"/>
                <c:pt idx="0">
                  <c:v>0.24555000166098276</c:v>
                </c:pt>
                <c:pt idx="1">
                  <c:v>0.28943333029747009</c:v>
                </c:pt>
                <c:pt idx="2">
                  <c:v>0.32003333667914075</c:v>
                </c:pt>
                <c:pt idx="3">
                  <c:v>0.3294999897480011</c:v>
                </c:pt>
                <c:pt idx="4">
                  <c:v>0.32050000131130219</c:v>
                </c:pt>
                <c:pt idx="5">
                  <c:v>0.31586666405200958</c:v>
                </c:pt>
                <c:pt idx="6">
                  <c:v>0.31643333037694293</c:v>
                </c:pt>
                <c:pt idx="7">
                  <c:v>0.2694833328326543</c:v>
                </c:pt>
                <c:pt idx="8">
                  <c:v>0.21583333611488342</c:v>
                </c:pt>
                <c:pt idx="9">
                  <c:v>0.15049999455610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1E9-4767-B72D-FA6E449CAC39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>
                  <a:alpha val="90000"/>
                </a:schemeClr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124:$AZ$124</c:f>
                <c:numCache>
                  <c:formatCode>General</c:formatCode>
                  <c:ptCount val="10"/>
                  <c:pt idx="0">
                    <c:v>2.2904558750726545E-2</c:v>
                  </c:pt>
                  <c:pt idx="1">
                    <c:v>2.0183622205602846E-2</c:v>
                  </c:pt>
                  <c:pt idx="2">
                    <c:v>4.4304883146723428E-2</c:v>
                  </c:pt>
                  <c:pt idx="3">
                    <c:v>4.1090436252396292E-2</c:v>
                  </c:pt>
                  <c:pt idx="4">
                    <c:v>3.1169538948045399E-2</c:v>
                  </c:pt>
                  <c:pt idx="5">
                    <c:v>2.522495345311529E-2</c:v>
                  </c:pt>
                  <c:pt idx="6">
                    <c:v>3.575951165451921E-2</c:v>
                  </c:pt>
                  <c:pt idx="7">
                    <c:v>2.5419080232055802E-2</c:v>
                  </c:pt>
                  <c:pt idx="8">
                    <c:v>1.6489477173161932E-2</c:v>
                  </c:pt>
                  <c:pt idx="9">
                    <c:v>1.4529963155559907E-2</c:v>
                  </c:pt>
                </c:numCache>
              </c:numRef>
            </c:plus>
            <c:minus>
              <c:numRef>
                <c:f>[1]補正後!$AQ$124:$AZ$124</c:f>
                <c:numCache>
                  <c:formatCode>General</c:formatCode>
                  <c:ptCount val="10"/>
                  <c:pt idx="0">
                    <c:v>2.2904558750726545E-2</c:v>
                  </c:pt>
                  <c:pt idx="1">
                    <c:v>2.0183622205602846E-2</c:v>
                  </c:pt>
                  <c:pt idx="2">
                    <c:v>4.4304883146723428E-2</c:v>
                  </c:pt>
                  <c:pt idx="3">
                    <c:v>4.1090436252396292E-2</c:v>
                  </c:pt>
                  <c:pt idx="4">
                    <c:v>3.1169538948045399E-2</c:v>
                  </c:pt>
                  <c:pt idx="5">
                    <c:v>2.522495345311529E-2</c:v>
                  </c:pt>
                  <c:pt idx="6">
                    <c:v>3.575951165451921E-2</c:v>
                  </c:pt>
                  <c:pt idx="7">
                    <c:v>2.5419080232055802E-2</c:v>
                  </c:pt>
                  <c:pt idx="8">
                    <c:v>1.6489477173161932E-2</c:v>
                  </c:pt>
                  <c:pt idx="9">
                    <c:v>1.4529963155559907E-2</c:v>
                  </c:pt>
                </c:numCache>
              </c:numRef>
            </c:minus>
          </c:errBars>
          <c:cat>
            <c:numRef>
              <c:f>[1]補正後!$AQ$122:$AZ$122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後!$AQ$123:$AZ$123</c:f>
              <c:numCache>
                <c:formatCode>General</c:formatCode>
                <c:ptCount val="10"/>
                <c:pt idx="0">
                  <c:v>0.24555000166098276</c:v>
                </c:pt>
                <c:pt idx="1">
                  <c:v>0.24783333142598443</c:v>
                </c:pt>
                <c:pt idx="2">
                  <c:v>0.26431667308012624</c:v>
                </c:pt>
                <c:pt idx="3">
                  <c:v>0.24201665818691231</c:v>
                </c:pt>
                <c:pt idx="4">
                  <c:v>0.22478333115577676</c:v>
                </c:pt>
                <c:pt idx="5">
                  <c:v>0.22496667007605212</c:v>
                </c:pt>
                <c:pt idx="6">
                  <c:v>0.2062833408514656</c:v>
                </c:pt>
                <c:pt idx="7">
                  <c:v>0.18046667178471862</c:v>
                </c:pt>
                <c:pt idx="8">
                  <c:v>0.15416666368643417</c:v>
                </c:pt>
                <c:pt idx="9">
                  <c:v>0.113199993968009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1E9-4767-B72D-FA6E449CAC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/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lang="ja-JP" sz="1050"/>
            </a:pPr>
            <a:r>
              <a:rPr lang="en-US" sz="1050" dirty="0"/>
              <a:t>EGCG</a:t>
            </a:r>
            <a:endParaRPr lang="ja-JP" sz="1050" dirty="0"/>
          </a:p>
        </c:rich>
      </c:tx>
      <c:layout>
        <c:manualLayout>
          <c:xMode val="edge"/>
          <c:yMode val="edge"/>
          <c:x val="0.3082022894527881"/>
          <c:y val="0.6243318633714817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137299019869689"/>
          <c:y val="3.4755288149069731E-2"/>
          <c:w val="0.87890347841135241"/>
          <c:h val="0.8726683045072704"/>
        </c:manualLayout>
      </c:layout>
      <c:lineChart>
        <c:grouping val="standard"/>
        <c:varyColors val="0"/>
        <c:ser>
          <c:idx val="0"/>
          <c:order val="0"/>
          <c:tx>
            <c:v>補正前</c:v>
          </c:tx>
          <c:spPr>
            <a:ln w="28575">
              <a:solidFill>
                <a:schemeClr val="accent1"/>
              </a:solidFill>
            </a:ln>
          </c:spPr>
          <c:marker>
            <c:symbol val="circle"/>
            <c:size val="5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前!$AT$138:$BC$138</c:f>
                <c:numCache>
                  <c:formatCode>General</c:formatCode>
                  <c:ptCount val="10"/>
                  <c:pt idx="0">
                    <c:v>8.9919212363496273E-3</c:v>
                  </c:pt>
                  <c:pt idx="1">
                    <c:v>2.6312408014422754E-2</c:v>
                  </c:pt>
                  <c:pt idx="2">
                    <c:v>1.6826572101215173E-2</c:v>
                  </c:pt>
                  <c:pt idx="3">
                    <c:v>2.7556170545582806E-2</c:v>
                  </c:pt>
                  <c:pt idx="4">
                    <c:v>3.522248150236125E-2</c:v>
                  </c:pt>
                  <c:pt idx="5">
                    <c:v>3.7813407868090516E-2</c:v>
                  </c:pt>
                  <c:pt idx="6">
                    <c:v>4.3519870304384409E-2</c:v>
                  </c:pt>
                  <c:pt idx="7">
                    <c:v>4.1519050192885563E-2</c:v>
                  </c:pt>
                  <c:pt idx="8">
                    <c:v>1.0344742127753704E-2</c:v>
                  </c:pt>
                  <c:pt idx="9">
                    <c:v>1.7547077426782445E-3</c:v>
                  </c:pt>
                </c:numCache>
              </c:numRef>
            </c:plus>
            <c:minus>
              <c:numRef>
                <c:f>[1]補正前!$AT$138:$BC$138</c:f>
                <c:numCache>
                  <c:formatCode>General</c:formatCode>
                  <c:ptCount val="10"/>
                  <c:pt idx="0">
                    <c:v>8.9919212363496273E-3</c:v>
                  </c:pt>
                  <c:pt idx="1">
                    <c:v>2.6312408014422754E-2</c:v>
                  </c:pt>
                  <c:pt idx="2">
                    <c:v>1.6826572101215173E-2</c:v>
                  </c:pt>
                  <c:pt idx="3">
                    <c:v>2.7556170545582806E-2</c:v>
                  </c:pt>
                  <c:pt idx="4">
                    <c:v>3.522248150236125E-2</c:v>
                  </c:pt>
                  <c:pt idx="5">
                    <c:v>3.7813407868090516E-2</c:v>
                  </c:pt>
                  <c:pt idx="6">
                    <c:v>4.3519870304384409E-2</c:v>
                  </c:pt>
                  <c:pt idx="7">
                    <c:v>4.1519050192885563E-2</c:v>
                  </c:pt>
                  <c:pt idx="8">
                    <c:v>1.0344742127753704E-2</c:v>
                  </c:pt>
                  <c:pt idx="9">
                    <c:v>1.7547077426782445E-3</c:v>
                  </c:pt>
                </c:numCache>
              </c:numRef>
            </c:minus>
          </c:errBars>
          <c:cat>
            <c:numRef>
              <c:f>[1]補正前!$AT$136:$BC$136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前!$AT$137:$BC$137</c:f>
              <c:numCache>
                <c:formatCode>General</c:formatCode>
                <c:ptCount val="10"/>
                <c:pt idx="0">
                  <c:v>0.27356665829817456</c:v>
                </c:pt>
                <c:pt idx="1">
                  <c:v>0.31476666529973346</c:v>
                </c:pt>
                <c:pt idx="2">
                  <c:v>0.32661665976047516</c:v>
                </c:pt>
                <c:pt idx="3">
                  <c:v>0.35606666405995685</c:v>
                </c:pt>
                <c:pt idx="4">
                  <c:v>0.36984999974568683</c:v>
                </c:pt>
                <c:pt idx="5">
                  <c:v>0.37171666324138641</c:v>
                </c:pt>
                <c:pt idx="6">
                  <c:v>0.36996667087078094</c:v>
                </c:pt>
                <c:pt idx="7">
                  <c:v>0.2906999985376994</c:v>
                </c:pt>
                <c:pt idx="8">
                  <c:v>-1.0116670280694962E-2</c:v>
                </c:pt>
                <c:pt idx="9">
                  <c:v>-6.245000349978605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DA6-4D61-B179-03BD7B23E136}"/>
            </c:ext>
          </c:extLst>
        </c:ser>
        <c:ser>
          <c:idx val="1"/>
          <c:order val="1"/>
          <c:tx>
            <c:v>補正後</c:v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7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補正後!$AQ$139:$AZ$139</c:f>
                <c:numCache>
                  <c:formatCode>General</c:formatCode>
                  <c:ptCount val="10"/>
                  <c:pt idx="0">
                    <c:v>8.9919212363496273E-3</c:v>
                  </c:pt>
                  <c:pt idx="1">
                    <c:v>2.6312408014422754E-2</c:v>
                  </c:pt>
                  <c:pt idx="2">
                    <c:v>1.6826572101215173E-2</c:v>
                  </c:pt>
                  <c:pt idx="3">
                    <c:v>2.7556170545582806E-2</c:v>
                  </c:pt>
                  <c:pt idx="4">
                    <c:v>3.5222481502361201E-2</c:v>
                  </c:pt>
                  <c:pt idx="5">
                    <c:v>3.7813407868090218E-2</c:v>
                  </c:pt>
                  <c:pt idx="6">
                    <c:v>4.3519870304384534E-2</c:v>
                  </c:pt>
                  <c:pt idx="7">
                    <c:v>4.1519050192885626E-2</c:v>
                  </c:pt>
                  <c:pt idx="8">
                    <c:v>1.0344742127753739E-2</c:v>
                  </c:pt>
                  <c:pt idx="9">
                    <c:v>1.7547077426782445E-3</c:v>
                  </c:pt>
                </c:numCache>
              </c:numRef>
            </c:plus>
            <c:minus>
              <c:numRef>
                <c:f>[1]補正後!$AQ$139:$AZ$139</c:f>
                <c:numCache>
                  <c:formatCode>General</c:formatCode>
                  <c:ptCount val="10"/>
                  <c:pt idx="0">
                    <c:v>8.9919212363496273E-3</c:v>
                  </c:pt>
                  <c:pt idx="1">
                    <c:v>2.6312408014422754E-2</c:v>
                  </c:pt>
                  <c:pt idx="2">
                    <c:v>1.6826572101215173E-2</c:v>
                  </c:pt>
                  <c:pt idx="3">
                    <c:v>2.7556170545582806E-2</c:v>
                  </c:pt>
                  <c:pt idx="4">
                    <c:v>3.5222481502361201E-2</c:v>
                  </c:pt>
                  <c:pt idx="5">
                    <c:v>3.7813407868090218E-2</c:v>
                  </c:pt>
                  <c:pt idx="6">
                    <c:v>4.3519870304384534E-2</c:v>
                  </c:pt>
                  <c:pt idx="7">
                    <c:v>4.1519050192885626E-2</c:v>
                  </c:pt>
                  <c:pt idx="8">
                    <c:v>1.0344742127753739E-2</c:v>
                  </c:pt>
                  <c:pt idx="9">
                    <c:v>1.7547077426782445E-3</c:v>
                  </c:pt>
                </c:numCache>
              </c:numRef>
            </c:minus>
          </c:errBars>
          <c:cat>
            <c:numRef>
              <c:f>[1]補正後!$AQ$137:$AZ$137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1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[1]補正後!$AQ$138:$AZ$138</c:f>
              <c:numCache>
                <c:formatCode>General</c:formatCode>
                <c:ptCount val="10"/>
                <c:pt idx="0">
                  <c:v>0.27356665829817456</c:v>
                </c:pt>
                <c:pt idx="1">
                  <c:v>0.27316666642824783</c:v>
                </c:pt>
                <c:pt idx="2">
                  <c:v>0.27089999616146065</c:v>
                </c:pt>
                <c:pt idx="3">
                  <c:v>0.26858333249886807</c:v>
                </c:pt>
                <c:pt idx="4">
                  <c:v>0.2741333295901614</c:v>
                </c:pt>
                <c:pt idx="5">
                  <c:v>0.28081666926542898</c:v>
                </c:pt>
                <c:pt idx="6">
                  <c:v>0.25981668134530361</c:v>
                </c:pt>
                <c:pt idx="7">
                  <c:v>0.20168333748976366</c:v>
                </c:pt>
                <c:pt idx="8">
                  <c:v>-7.1783342709144216E-2</c:v>
                </c:pt>
                <c:pt idx="9">
                  <c:v>-9.975000408788546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DA6-4D61-B179-03BD7B23E1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09184"/>
        <c:axId val="291607264"/>
      </c:lineChart>
      <c:catAx>
        <c:axId val="29160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600" b="1"/>
            </a:pPr>
            <a:endParaRPr lang="en-US"/>
          </a:p>
        </c:txPr>
        <c:crossAx val="291607264"/>
        <c:crosses val="autoZero"/>
        <c:auto val="1"/>
        <c:lblAlgn val="ctr"/>
        <c:lblOffset val="100"/>
        <c:noMultiLvlLbl val="0"/>
      </c:catAx>
      <c:valAx>
        <c:axId val="2916072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600" b="1"/>
            </a:pPr>
            <a:endParaRPr lang="en-US"/>
          </a:p>
        </c:txPr>
        <c:crossAx val="291609184"/>
        <c:crosses val="autoZero"/>
        <c:crossBetween val="midCat"/>
        <c:majorUnit val="0.1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2.5428331875182269E-2"/>
          <c:w val="0.89655796150481193"/>
          <c:h val="0.89032042869641292"/>
        </c:manualLayout>
      </c:layout>
      <c:lineChart>
        <c:grouping val="standard"/>
        <c:varyColors val="0"/>
        <c:ser>
          <c:idx val="0"/>
          <c:order val="0"/>
          <c:tx>
            <c:strRef>
              <c:f>計算!$CS$10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2:$DC$12</c:f>
                <c:numCache>
                  <c:formatCode>General</c:formatCode>
                  <c:ptCount val="10"/>
                  <c:pt idx="0">
                    <c:v>2.6065364975144639E-2</c:v>
                  </c:pt>
                  <c:pt idx="1">
                    <c:v>2.152846633733832E-2</c:v>
                  </c:pt>
                  <c:pt idx="2">
                    <c:v>3.07087881250333E-2</c:v>
                  </c:pt>
                  <c:pt idx="3">
                    <c:v>3.9812312342563279E-2</c:v>
                  </c:pt>
                  <c:pt idx="4">
                    <c:v>3.4940716359369663E-2</c:v>
                  </c:pt>
                  <c:pt idx="5">
                    <c:v>3.0403822347491369E-2</c:v>
                  </c:pt>
                  <c:pt idx="6">
                    <c:v>3.8648127173961329E-2</c:v>
                  </c:pt>
                  <c:pt idx="7">
                    <c:v>2.7744334878139383E-2</c:v>
                  </c:pt>
                  <c:pt idx="8">
                    <c:v>1.414906684083409E-2</c:v>
                  </c:pt>
                  <c:pt idx="9">
                    <c:v>5.864122914579252E-3</c:v>
                  </c:pt>
                </c:numCache>
              </c:numRef>
            </c:plus>
            <c:minus>
              <c:numRef>
                <c:f>計算!$CT$12:$DC$12</c:f>
                <c:numCache>
                  <c:formatCode>General</c:formatCode>
                  <c:ptCount val="10"/>
                  <c:pt idx="0">
                    <c:v>2.6065364975144639E-2</c:v>
                  </c:pt>
                  <c:pt idx="1">
                    <c:v>2.152846633733832E-2</c:v>
                  </c:pt>
                  <c:pt idx="2">
                    <c:v>3.07087881250333E-2</c:v>
                  </c:pt>
                  <c:pt idx="3">
                    <c:v>3.9812312342563279E-2</c:v>
                  </c:pt>
                  <c:pt idx="4">
                    <c:v>3.4940716359369663E-2</c:v>
                  </c:pt>
                  <c:pt idx="5">
                    <c:v>3.0403822347491369E-2</c:v>
                  </c:pt>
                  <c:pt idx="6">
                    <c:v>3.8648127173961329E-2</c:v>
                  </c:pt>
                  <c:pt idx="7">
                    <c:v>2.7744334878139383E-2</c:v>
                  </c:pt>
                  <c:pt idx="8">
                    <c:v>1.414906684083409E-2</c:v>
                  </c:pt>
                  <c:pt idx="9">
                    <c:v>5.86412291457925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9:$DC$9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T$10:$DC$10</c:f>
              <c:numCache>
                <c:formatCode>General</c:formatCode>
                <c:ptCount val="10"/>
                <c:pt idx="0">
                  <c:v>0.1939499999086062</c:v>
                </c:pt>
                <c:pt idx="1">
                  <c:v>0.22964999824762344</c:v>
                </c:pt>
                <c:pt idx="2">
                  <c:v>0.25388333698113758</c:v>
                </c:pt>
                <c:pt idx="3">
                  <c:v>0.26139999677737552</c:v>
                </c:pt>
                <c:pt idx="4">
                  <c:v>0.26558333386977512</c:v>
                </c:pt>
                <c:pt idx="5">
                  <c:v>0.2661000018318494</c:v>
                </c:pt>
                <c:pt idx="6">
                  <c:v>0.25121666242678958</c:v>
                </c:pt>
                <c:pt idx="7">
                  <c:v>0.26019999633232754</c:v>
                </c:pt>
                <c:pt idx="8">
                  <c:v>0.23749999950329462</c:v>
                </c:pt>
                <c:pt idx="9">
                  <c:v>0.213699998954931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0E9-4CBD-B329-D67890D20D77}"/>
            </c:ext>
          </c:extLst>
        </c:ser>
        <c:ser>
          <c:idx val="1"/>
          <c:order val="1"/>
          <c:tx>
            <c:strRef>
              <c:f>計算!$CS$11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3:$DC$13</c:f>
                <c:numCache>
                  <c:formatCode>General</c:formatCode>
                  <c:ptCount val="10"/>
                  <c:pt idx="0">
                    <c:v>2.6065364975144639E-2</c:v>
                  </c:pt>
                  <c:pt idx="1">
                    <c:v>2.1528466337338452E-2</c:v>
                  </c:pt>
                  <c:pt idx="2">
                    <c:v>3.0708788125033391E-2</c:v>
                  </c:pt>
                  <c:pt idx="3">
                    <c:v>3.9812312342563279E-2</c:v>
                  </c:pt>
                  <c:pt idx="4">
                    <c:v>3.4940716359369663E-2</c:v>
                  </c:pt>
                  <c:pt idx="5">
                    <c:v>3.0403822347491279E-2</c:v>
                  </c:pt>
                  <c:pt idx="6">
                    <c:v>3.8648127173961329E-2</c:v>
                  </c:pt>
                  <c:pt idx="7">
                    <c:v>2.7744334878139418E-2</c:v>
                  </c:pt>
                  <c:pt idx="8">
                    <c:v>1.414906684083409E-2</c:v>
                  </c:pt>
                  <c:pt idx="9">
                    <c:v>5.864122914579252E-3</c:v>
                  </c:pt>
                </c:numCache>
              </c:numRef>
            </c:plus>
            <c:minus>
              <c:numRef>
                <c:f>計算!$CT$13:$DC$13</c:f>
                <c:numCache>
                  <c:formatCode>General</c:formatCode>
                  <c:ptCount val="10"/>
                  <c:pt idx="0">
                    <c:v>2.6065364975144639E-2</c:v>
                  </c:pt>
                  <c:pt idx="1">
                    <c:v>2.1528466337338452E-2</c:v>
                  </c:pt>
                  <c:pt idx="2">
                    <c:v>3.0708788125033391E-2</c:v>
                  </c:pt>
                  <c:pt idx="3">
                    <c:v>3.9812312342563279E-2</c:v>
                  </c:pt>
                  <c:pt idx="4">
                    <c:v>3.4940716359369663E-2</c:v>
                  </c:pt>
                  <c:pt idx="5">
                    <c:v>3.0403822347491279E-2</c:v>
                  </c:pt>
                  <c:pt idx="6">
                    <c:v>3.8648127173961329E-2</c:v>
                  </c:pt>
                  <c:pt idx="7">
                    <c:v>2.7744334878139418E-2</c:v>
                  </c:pt>
                  <c:pt idx="8">
                    <c:v>1.414906684083409E-2</c:v>
                  </c:pt>
                  <c:pt idx="9">
                    <c:v>5.86412291457925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9:$DC$9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T$11:$DC$11</c:f>
              <c:numCache>
                <c:formatCode>General</c:formatCode>
                <c:ptCount val="10"/>
                <c:pt idx="0">
                  <c:v>0.1939499999086062</c:v>
                </c:pt>
                <c:pt idx="1">
                  <c:v>0.1939499999086062</c:v>
                </c:pt>
                <c:pt idx="2">
                  <c:v>0.1939499999086062</c:v>
                </c:pt>
                <c:pt idx="3">
                  <c:v>0.1939499999086062</c:v>
                </c:pt>
                <c:pt idx="4">
                  <c:v>0.1939499999086062</c:v>
                </c:pt>
                <c:pt idx="5">
                  <c:v>0.1939499999086062</c:v>
                </c:pt>
                <c:pt idx="6">
                  <c:v>0.1939499999086062</c:v>
                </c:pt>
                <c:pt idx="7">
                  <c:v>0.19394999990860617</c:v>
                </c:pt>
                <c:pt idx="8">
                  <c:v>0.1939499999086062</c:v>
                </c:pt>
                <c:pt idx="9">
                  <c:v>0.19394999990860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0E9-4CBD-B329-D67890D20D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32454703"/>
        <c:axId val="1832452303"/>
      </c:lineChart>
      <c:catAx>
        <c:axId val="18324547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2452303"/>
        <c:crosses val="autoZero"/>
        <c:auto val="1"/>
        <c:lblAlgn val="ctr"/>
        <c:lblOffset val="100"/>
        <c:noMultiLvlLbl val="0"/>
      </c:catAx>
      <c:valAx>
        <c:axId val="1832452303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2454703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683543665892012"/>
          <c:y val="2.1857612812730975E-2"/>
          <c:w val="0.81591556202500737"/>
          <c:h val="0.3383090091133960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09377820163407"/>
          <c:y val="2.74488646947912E-2"/>
          <c:w val="0.88890507436570432"/>
          <c:h val="0.94303186060075828"/>
        </c:manualLayout>
      </c:layout>
      <c:lineChart>
        <c:grouping val="standard"/>
        <c:varyColors val="0"/>
        <c:ser>
          <c:idx val="0"/>
          <c:order val="0"/>
          <c:tx>
            <c:strRef>
              <c:f>計算!$CS$23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5:$DC$25</c:f>
                <c:numCache>
                  <c:formatCode>General</c:formatCode>
                  <c:ptCount val="10"/>
                  <c:pt idx="0">
                    <c:v>1.4568515600244901E-2</c:v>
                  </c:pt>
                  <c:pt idx="1">
                    <c:v>2.9139759852875067E-2</c:v>
                  </c:pt>
                  <c:pt idx="2">
                    <c:v>3.6774415187411334E-2</c:v>
                  </c:pt>
                  <c:pt idx="3">
                    <c:v>3.1937747132901297E-2</c:v>
                  </c:pt>
                  <c:pt idx="4">
                    <c:v>3.5299774886019264E-2</c:v>
                  </c:pt>
                  <c:pt idx="5">
                    <c:v>2.9418865277036504E-2</c:v>
                  </c:pt>
                  <c:pt idx="6">
                    <c:v>4.793764775088652E-2</c:v>
                  </c:pt>
                  <c:pt idx="7">
                    <c:v>2.0103074813864655E-2</c:v>
                  </c:pt>
                  <c:pt idx="8">
                    <c:v>3.0232235492829322E-2</c:v>
                  </c:pt>
                  <c:pt idx="9">
                    <c:v>4.7902674786065302E-3</c:v>
                  </c:pt>
                </c:numCache>
              </c:numRef>
            </c:plus>
            <c:minus>
              <c:numRef>
                <c:f>計算!$CT$25:$DC$25</c:f>
                <c:numCache>
                  <c:formatCode>General</c:formatCode>
                  <c:ptCount val="10"/>
                  <c:pt idx="0">
                    <c:v>1.4568515600244901E-2</c:v>
                  </c:pt>
                  <c:pt idx="1">
                    <c:v>2.9139759852875067E-2</c:v>
                  </c:pt>
                  <c:pt idx="2">
                    <c:v>3.6774415187411334E-2</c:v>
                  </c:pt>
                  <c:pt idx="3">
                    <c:v>3.1937747132901297E-2</c:v>
                  </c:pt>
                  <c:pt idx="4">
                    <c:v>3.5299774886019264E-2</c:v>
                  </c:pt>
                  <c:pt idx="5">
                    <c:v>2.9418865277036504E-2</c:v>
                  </c:pt>
                  <c:pt idx="6">
                    <c:v>4.793764775088652E-2</c:v>
                  </c:pt>
                  <c:pt idx="7">
                    <c:v>2.0103074813864655E-2</c:v>
                  </c:pt>
                  <c:pt idx="8">
                    <c:v>3.0232235492829322E-2</c:v>
                  </c:pt>
                  <c:pt idx="9">
                    <c:v>4.790267478606530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2:$DC$22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3:$DC$23</c:f>
              <c:numCache>
                <c:formatCode>General</c:formatCode>
                <c:ptCount val="10"/>
                <c:pt idx="0">
                  <c:v>0.19608333085974058</c:v>
                </c:pt>
                <c:pt idx="1">
                  <c:v>0.22098333016037941</c:v>
                </c:pt>
                <c:pt idx="2">
                  <c:v>0.23341666534543037</c:v>
                </c:pt>
                <c:pt idx="3">
                  <c:v>0.25140000010530156</c:v>
                </c:pt>
                <c:pt idx="4">
                  <c:v>0.28433332964777946</c:v>
                </c:pt>
                <c:pt idx="5">
                  <c:v>0.30988332753380138</c:v>
                </c:pt>
                <c:pt idx="6">
                  <c:v>0.38366666560371715</c:v>
                </c:pt>
                <c:pt idx="7">
                  <c:v>0.43768333022793132</c:v>
                </c:pt>
                <c:pt idx="8">
                  <c:v>0.15329999849200249</c:v>
                </c:pt>
                <c:pt idx="9">
                  <c:v>-4.0666678299506502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D95-476E-B034-C3AFEBDED5C1}"/>
            </c:ext>
          </c:extLst>
        </c:ser>
        <c:ser>
          <c:idx val="1"/>
          <c:order val="1"/>
          <c:tx>
            <c:strRef>
              <c:f>計算!$CS$24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6:$DC$26</c:f>
                <c:numCache>
                  <c:formatCode>General</c:formatCode>
                  <c:ptCount val="10"/>
                  <c:pt idx="0">
                    <c:v>1.4568515600244901E-2</c:v>
                  </c:pt>
                  <c:pt idx="1">
                    <c:v>2.9139759852875067E-2</c:v>
                  </c:pt>
                  <c:pt idx="2">
                    <c:v>3.6774415187411487E-2</c:v>
                  </c:pt>
                  <c:pt idx="3">
                    <c:v>3.193774713290138E-2</c:v>
                  </c:pt>
                  <c:pt idx="4">
                    <c:v>3.5299774886019424E-2</c:v>
                  </c:pt>
                  <c:pt idx="5">
                    <c:v>2.9418865277036819E-2</c:v>
                  </c:pt>
                  <c:pt idx="6">
                    <c:v>4.7937647750886048E-2</c:v>
                  </c:pt>
                  <c:pt idx="7">
                    <c:v>2.0103074813864655E-2</c:v>
                  </c:pt>
                  <c:pt idx="8">
                    <c:v>3.0232235492829322E-2</c:v>
                  </c:pt>
                  <c:pt idx="9">
                    <c:v>4.7902674786065302E-3</c:v>
                  </c:pt>
                </c:numCache>
              </c:numRef>
            </c:plus>
            <c:minus>
              <c:numRef>
                <c:f>計算!$CT$26:$DC$26</c:f>
                <c:numCache>
                  <c:formatCode>General</c:formatCode>
                  <c:ptCount val="10"/>
                  <c:pt idx="0">
                    <c:v>1.4568515600244901E-2</c:v>
                  </c:pt>
                  <c:pt idx="1">
                    <c:v>2.9139759852875067E-2</c:v>
                  </c:pt>
                  <c:pt idx="2">
                    <c:v>3.6774415187411487E-2</c:v>
                  </c:pt>
                  <c:pt idx="3">
                    <c:v>3.193774713290138E-2</c:v>
                  </c:pt>
                  <c:pt idx="4">
                    <c:v>3.5299774886019424E-2</c:v>
                  </c:pt>
                  <c:pt idx="5">
                    <c:v>2.9418865277036819E-2</c:v>
                  </c:pt>
                  <c:pt idx="6">
                    <c:v>4.7937647750886048E-2</c:v>
                  </c:pt>
                  <c:pt idx="7">
                    <c:v>2.0103074813864655E-2</c:v>
                  </c:pt>
                  <c:pt idx="8">
                    <c:v>3.0232235492829322E-2</c:v>
                  </c:pt>
                  <c:pt idx="9">
                    <c:v>4.790267478606530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2:$DC$22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4:$DC$24</c:f>
              <c:numCache>
                <c:formatCode>General</c:formatCode>
                <c:ptCount val="10"/>
                <c:pt idx="0">
                  <c:v>0.19608333085974058</c:v>
                </c:pt>
                <c:pt idx="1">
                  <c:v>0.18528333182136217</c:v>
                </c:pt>
                <c:pt idx="2">
                  <c:v>0.173483328272899</c:v>
                </c:pt>
                <c:pt idx="3">
                  <c:v>0.18395000323653221</c:v>
                </c:pt>
                <c:pt idx="4">
                  <c:v>0.21269999568661055</c:v>
                </c:pt>
                <c:pt idx="5">
                  <c:v>0.23773332561055818</c:v>
                </c:pt>
                <c:pt idx="6">
                  <c:v>0.32640000308553385</c:v>
                </c:pt>
                <c:pt idx="7">
                  <c:v>0.37143333380421001</c:v>
                </c:pt>
                <c:pt idx="8">
                  <c:v>0.10974999889731407</c:v>
                </c:pt>
                <c:pt idx="9">
                  <c:v>-2.381666687627633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D95-476E-B034-C3AFEBDED5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35031823"/>
        <c:axId val="1835033263"/>
      </c:lineChart>
      <c:catAx>
        <c:axId val="18350318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5033263"/>
        <c:crosses val="autoZero"/>
        <c:auto val="1"/>
        <c:lblAlgn val="ctr"/>
        <c:lblOffset val="100"/>
        <c:noMultiLvlLbl val="0"/>
      </c:catAx>
      <c:valAx>
        <c:axId val="1835033263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35031823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5.2916666666666667E-2"/>
          <c:w val="0.88389129483814521"/>
          <c:h val="0.86283209390492854"/>
        </c:manualLayout>
      </c:layout>
      <c:lineChart>
        <c:grouping val="standard"/>
        <c:varyColors val="0"/>
        <c:ser>
          <c:idx val="0"/>
          <c:order val="0"/>
          <c:tx>
            <c:strRef>
              <c:f>計算!$CS$35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37:$DC$37</c:f>
                <c:numCache>
                  <c:formatCode>General</c:formatCode>
                  <c:ptCount val="10"/>
                  <c:pt idx="0">
                    <c:v>1.829816740088009E-2</c:v>
                  </c:pt>
                  <c:pt idx="1">
                    <c:v>2.0970525182054195E-2</c:v>
                  </c:pt>
                  <c:pt idx="2">
                    <c:v>2.8176776391529001E-2</c:v>
                  </c:pt>
                  <c:pt idx="3">
                    <c:v>2.6169637677198435E-2</c:v>
                  </c:pt>
                  <c:pt idx="4">
                    <c:v>3.7478893803880996E-2</c:v>
                  </c:pt>
                  <c:pt idx="5">
                    <c:v>3.63589572420931E-2</c:v>
                  </c:pt>
                  <c:pt idx="6">
                    <c:v>2.6456809683929251E-2</c:v>
                  </c:pt>
                  <c:pt idx="7">
                    <c:v>1.4400236848644202E-2</c:v>
                  </c:pt>
                  <c:pt idx="8">
                    <c:v>2.8156699388923196E-3</c:v>
                  </c:pt>
                  <c:pt idx="9">
                    <c:v>1.7974059800837001E-3</c:v>
                  </c:pt>
                </c:numCache>
              </c:numRef>
            </c:plus>
            <c:minus>
              <c:numRef>
                <c:f>計算!$CT$37:$DC$37</c:f>
                <c:numCache>
                  <c:formatCode>General</c:formatCode>
                  <c:ptCount val="10"/>
                  <c:pt idx="0">
                    <c:v>1.829816740088009E-2</c:v>
                  </c:pt>
                  <c:pt idx="1">
                    <c:v>2.0970525182054195E-2</c:v>
                  </c:pt>
                  <c:pt idx="2">
                    <c:v>2.8176776391529001E-2</c:v>
                  </c:pt>
                  <c:pt idx="3">
                    <c:v>2.6169637677198435E-2</c:v>
                  </c:pt>
                  <c:pt idx="4">
                    <c:v>3.7478893803880996E-2</c:v>
                  </c:pt>
                  <c:pt idx="5">
                    <c:v>3.63589572420931E-2</c:v>
                  </c:pt>
                  <c:pt idx="6">
                    <c:v>2.6456809683929251E-2</c:v>
                  </c:pt>
                  <c:pt idx="7">
                    <c:v>1.4400236848644202E-2</c:v>
                  </c:pt>
                  <c:pt idx="8">
                    <c:v>2.8156699388923196E-3</c:v>
                  </c:pt>
                  <c:pt idx="9">
                    <c:v>1.79740598008370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34:$DC$34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35:$DC$35</c:f>
              <c:numCache>
                <c:formatCode>General</c:formatCode>
                <c:ptCount val="10"/>
                <c:pt idx="0">
                  <c:v>0.18574999893705049</c:v>
                </c:pt>
                <c:pt idx="1">
                  <c:v>0.19805000349879265</c:v>
                </c:pt>
                <c:pt idx="2">
                  <c:v>0.22183333461483321</c:v>
                </c:pt>
                <c:pt idx="3">
                  <c:v>0.24148333693544069</c:v>
                </c:pt>
                <c:pt idx="4">
                  <c:v>0.28064999853571254</c:v>
                </c:pt>
                <c:pt idx="5">
                  <c:v>0.32678332800666493</c:v>
                </c:pt>
                <c:pt idx="6">
                  <c:v>0.33166666701436043</c:v>
                </c:pt>
                <c:pt idx="7">
                  <c:v>0.193466667085886</c:v>
                </c:pt>
                <c:pt idx="8">
                  <c:v>2.1600000560283661E-2</c:v>
                </c:pt>
                <c:pt idx="9">
                  <c:v>2.736666922767956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6F7-4D21-87A6-1286496CAA47}"/>
            </c:ext>
          </c:extLst>
        </c:ser>
        <c:ser>
          <c:idx val="1"/>
          <c:order val="1"/>
          <c:tx>
            <c:strRef>
              <c:f>計算!$CS$36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38:$DC$38</c:f>
                <c:numCache>
                  <c:formatCode>General</c:formatCode>
                  <c:ptCount val="10"/>
                  <c:pt idx="0">
                    <c:v>1.829816740088009E-2</c:v>
                  </c:pt>
                  <c:pt idx="1">
                    <c:v>2.0970525182054195E-2</c:v>
                  </c:pt>
                  <c:pt idx="2">
                    <c:v>2.8176776391529001E-2</c:v>
                  </c:pt>
                  <c:pt idx="3">
                    <c:v>2.616963767719847E-2</c:v>
                  </c:pt>
                  <c:pt idx="4">
                    <c:v>3.7478893803881141E-2</c:v>
                  </c:pt>
                  <c:pt idx="5">
                    <c:v>3.63589572420931E-2</c:v>
                  </c:pt>
                  <c:pt idx="6">
                    <c:v>2.6456809683929262E-2</c:v>
                  </c:pt>
                  <c:pt idx="7">
                    <c:v>1.440023684864401E-2</c:v>
                  </c:pt>
                  <c:pt idx="8">
                    <c:v>2.8156699388923196E-3</c:v>
                  </c:pt>
                  <c:pt idx="9">
                    <c:v>1.7974059800837001E-3</c:v>
                  </c:pt>
                </c:numCache>
              </c:numRef>
            </c:plus>
            <c:minus>
              <c:numRef>
                <c:f>計算!$CT$38:$DC$38</c:f>
                <c:numCache>
                  <c:formatCode>General</c:formatCode>
                  <c:ptCount val="10"/>
                  <c:pt idx="0">
                    <c:v>1.829816740088009E-2</c:v>
                  </c:pt>
                  <c:pt idx="1">
                    <c:v>2.0970525182054195E-2</c:v>
                  </c:pt>
                  <c:pt idx="2">
                    <c:v>2.8176776391529001E-2</c:v>
                  </c:pt>
                  <c:pt idx="3">
                    <c:v>2.616963767719847E-2</c:v>
                  </c:pt>
                  <c:pt idx="4">
                    <c:v>3.7478893803881141E-2</c:v>
                  </c:pt>
                  <c:pt idx="5">
                    <c:v>3.63589572420931E-2</c:v>
                  </c:pt>
                  <c:pt idx="6">
                    <c:v>2.6456809683929262E-2</c:v>
                  </c:pt>
                  <c:pt idx="7">
                    <c:v>1.440023684864401E-2</c:v>
                  </c:pt>
                  <c:pt idx="8">
                    <c:v>2.8156699388923196E-3</c:v>
                  </c:pt>
                  <c:pt idx="9">
                    <c:v>1.79740598008370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34:$DC$34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36:$DC$36</c:f>
              <c:numCache>
                <c:formatCode>General</c:formatCode>
                <c:ptCount val="10"/>
                <c:pt idx="0">
                  <c:v>0.18574999893705049</c:v>
                </c:pt>
                <c:pt idx="1">
                  <c:v>0.16235000515977541</c:v>
                </c:pt>
                <c:pt idx="2">
                  <c:v>0.16189999754230183</c:v>
                </c:pt>
                <c:pt idx="3">
                  <c:v>0.17403334006667137</c:v>
                </c:pt>
                <c:pt idx="4">
                  <c:v>0.20901666457454363</c:v>
                </c:pt>
                <c:pt idx="5">
                  <c:v>0.25463332608342176</c:v>
                </c:pt>
                <c:pt idx="6">
                  <c:v>0.27440000449617707</c:v>
                </c:pt>
                <c:pt idx="7">
                  <c:v>0.12721667066216466</c:v>
                </c:pt>
                <c:pt idx="8">
                  <c:v>-2.1949999034404755E-2</c:v>
                </c:pt>
                <c:pt idx="9">
                  <c:v>7.6166701813538866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6F7-4D21-87A6-1286496CAA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568559"/>
        <c:axId val="1655563279"/>
      </c:lineChart>
      <c:catAx>
        <c:axId val="16555685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63279"/>
        <c:crosses val="autoZero"/>
        <c:auto val="1"/>
        <c:lblAlgn val="ctr"/>
        <c:lblOffset val="100"/>
        <c:noMultiLvlLbl val="0"/>
      </c:catAx>
      <c:valAx>
        <c:axId val="1655563279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6855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76098467297821"/>
          <c:y val="4.6713125615771754E-2"/>
          <c:w val="0.88511351706036745"/>
          <c:h val="0.86903579760863225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BU$80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^N1610.2025.04.30.xlsx]計算'!$BV$79:$CE$79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BV$80:$CE$80</c:f>
              <c:numCache>
                <c:formatCode>General</c:formatCode>
                <c:ptCount val="10"/>
                <c:pt idx="0">
                  <c:v>0.25365000342329341</c:v>
                </c:pt>
                <c:pt idx="1">
                  <c:v>0.44941333110133802</c:v>
                </c:pt>
                <c:pt idx="2">
                  <c:v>0.38350000356634456</c:v>
                </c:pt>
                <c:pt idx="3">
                  <c:v>0.33006666476527846</c:v>
                </c:pt>
                <c:pt idx="4">
                  <c:v>0.34918332969148957</c:v>
                </c:pt>
                <c:pt idx="5">
                  <c:v>0.24758333340287209</c:v>
                </c:pt>
                <c:pt idx="6">
                  <c:v>0.20868332559863723</c:v>
                </c:pt>
                <c:pt idx="7">
                  <c:v>2.5516662746667848E-2</c:v>
                </c:pt>
                <c:pt idx="8">
                  <c:v>-2.0766672988732655E-2</c:v>
                </c:pt>
                <c:pt idx="9">
                  <c:v>2.6833278437455683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7D5-4A66-B08D-CD014A958994}"/>
            </c:ext>
          </c:extLst>
        </c:ser>
        <c:ser>
          <c:idx val="1"/>
          <c:order val="1"/>
          <c:tx>
            <c:strRef>
              <c:f>'[^N1610.2025.04.30.xlsx]計算'!$BU$81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^N1610.2025.04.30.xlsx]計算'!$BV$79:$CE$79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BV$81:$CE$81</c:f>
              <c:numCache>
                <c:formatCode>General</c:formatCode>
                <c:ptCount val="10"/>
                <c:pt idx="0">
                  <c:v>0.31251666819055873</c:v>
                </c:pt>
                <c:pt idx="1">
                  <c:v>0.54950000221530593</c:v>
                </c:pt>
                <c:pt idx="2">
                  <c:v>0.49789998804529512</c:v>
                </c:pt>
                <c:pt idx="3">
                  <c:v>0.42350001012285554</c:v>
                </c:pt>
                <c:pt idx="4">
                  <c:v>0.39133334035674733</c:v>
                </c:pt>
                <c:pt idx="5">
                  <c:v>0.36089999849597615</c:v>
                </c:pt>
                <c:pt idx="6">
                  <c:v>0.22033333157499635</c:v>
                </c:pt>
                <c:pt idx="7">
                  <c:v>0.10668333495656651</c:v>
                </c:pt>
                <c:pt idx="8">
                  <c:v>2.1716676652431488E-2</c:v>
                </c:pt>
                <c:pt idx="9">
                  <c:v>1.52666624635457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7D5-4A66-B08D-CD014A958994}"/>
            </c:ext>
          </c:extLst>
        </c:ser>
        <c:ser>
          <c:idx val="2"/>
          <c:order val="2"/>
          <c:tx>
            <c:strRef>
              <c:f>'[^N1610.2025.04.30.xlsx]計算'!$BU$82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[^N1610.2025.04.30.xlsx]計算'!$BV$79:$CE$79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BV$82:$CE$82</c:f>
              <c:numCache>
                <c:formatCode>General</c:formatCode>
                <c:ptCount val="10"/>
                <c:pt idx="0">
                  <c:v>0.37074999387065571</c:v>
                </c:pt>
                <c:pt idx="1">
                  <c:v>0.66306667402386665</c:v>
                </c:pt>
                <c:pt idx="2">
                  <c:v>0.62173332149783767</c:v>
                </c:pt>
                <c:pt idx="3">
                  <c:v>0.52889999126394582</c:v>
                </c:pt>
                <c:pt idx="4">
                  <c:v>0.52698332940538717</c:v>
                </c:pt>
                <c:pt idx="5">
                  <c:v>0.40284999584158265</c:v>
                </c:pt>
                <c:pt idx="6">
                  <c:v>0.29521666839718824</c:v>
                </c:pt>
                <c:pt idx="7">
                  <c:v>0.14458332583308223</c:v>
                </c:pt>
                <c:pt idx="8">
                  <c:v>7.6666661848624584E-2</c:v>
                </c:pt>
                <c:pt idx="9">
                  <c:v>1.23999938368797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7D5-4A66-B08D-CD014A958994}"/>
            </c:ext>
          </c:extLst>
        </c:ser>
        <c:ser>
          <c:idx val="3"/>
          <c:order val="3"/>
          <c:tx>
            <c:strRef>
              <c:f>'[^N1610.2025.04.30.xlsx]計算'!$BU$83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[^N1610.2025.04.30.xlsx]計算'!$BV$79:$CE$79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^N1610.2025.04.30.xlsx]計算'!$BV$83:$CE$83</c:f>
              <c:numCache>
                <c:formatCode>General</c:formatCode>
                <c:ptCount val="10"/>
                <c:pt idx="0">
                  <c:v>0.43993333478768665</c:v>
                </c:pt>
                <c:pt idx="1">
                  <c:v>0.78029166658719373</c:v>
                </c:pt>
                <c:pt idx="2">
                  <c:v>0.70667500297228503</c:v>
                </c:pt>
                <c:pt idx="3">
                  <c:v>0.65317501127719879</c:v>
                </c:pt>
                <c:pt idx="4">
                  <c:v>0.60405832529067993</c:v>
                </c:pt>
                <c:pt idx="5">
                  <c:v>0.56825832525889075</c:v>
                </c:pt>
                <c:pt idx="6">
                  <c:v>0.41437500218550366</c:v>
                </c:pt>
                <c:pt idx="7">
                  <c:v>0.24894166489442193</c:v>
                </c:pt>
                <c:pt idx="8">
                  <c:v>0.14874165505170825</c:v>
                </c:pt>
                <c:pt idx="9">
                  <c:v>1.777500410874682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7D5-4A66-B08D-CD014A9589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6778272"/>
        <c:axId val="1336778752"/>
      </c:lineChart>
      <c:catAx>
        <c:axId val="133677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6778752"/>
        <c:crosses val="autoZero"/>
        <c:auto val="1"/>
        <c:lblAlgn val="ctr"/>
        <c:lblOffset val="100"/>
        <c:noMultiLvlLbl val="0"/>
      </c:catAx>
      <c:valAx>
        <c:axId val="1336778752"/>
        <c:scaling>
          <c:orientation val="minMax"/>
          <c:max val="0.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6778272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5.2916666666666667E-2"/>
          <c:w val="0.89655796150481193"/>
          <c:h val="0.84489173228346459"/>
        </c:manualLayout>
      </c:layout>
      <c:lineChart>
        <c:grouping val="standard"/>
        <c:varyColors val="0"/>
        <c:ser>
          <c:idx val="0"/>
          <c:order val="0"/>
          <c:tx>
            <c:strRef>
              <c:f>計算!$CS$47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50:$DC$50</c:f>
                <c:numCache>
                  <c:formatCode>General</c:formatCode>
                  <c:ptCount val="10"/>
                  <c:pt idx="0">
                    <c:v>1.247067063863567E-2</c:v>
                  </c:pt>
                  <c:pt idx="1">
                    <c:v>1.929688157737116E-2</c:v>
                  </c:pt>
                  <c:pt idx="2">
                    <c:v>2.0918256758383168E-2</c:v>
                  </c:pt>
                  <c:pt idx="3">
                    <c:v>2.6326918964660162E-2</c:v>
                  </c:pt>
                  <c:pt idx="4">
                    <c:v>3.2156475760500861E-2</c:v>
                  </c:pt>
                  <c:pt idx="5">
                    <c:v>2.945122927838234E-2</c:v>
                  </c:pt>
                  <c:pt idx="6">
                    <c:v>1.1293302373792863E-2</c:v>
                  </c:pt>
                  <c:pt idx="7">
                    <c:v>4.6111833852109305E-3</c:v>
                  </c:pt>
                  <c:pt idx="8">
                    <c:v>1.8554434156974528E-3</c:v>
                  </c:pt>
                  <c:pt idx="9">
                    <c:v>3.4440769325387414E-3</c:v>
                  </c:pt>
                </c:numCache>
              </c:numRef>
            </c:plus>
            <c:minus>
              <c:numRef>
                <c:f>計算!$CT$50:$DC$50</c:f>
                <c:numCache>
                  <c:formatCode>General</c:formatCode>
                  <c:ptCount val="10"/>
                  <c:pt idx="0">
                    <c:v>1.247067063863567E-2</c:v>
                  </c:pt>
                  <c:pt idx="1">
                    <c:v>1.929688157737116E-2</c:v>
                  </c:pt>
                  <c:pt idx="2">
                    <c:v>2.0918256758383168E-2</c:v>
                  </c:pt>
                  <c:pt idx="3">
                    <c:v>2.6326918964660162E-2</c:v>
                  </c:pt>
                  <c:pt idx="4">
                    <c:v>3.2156475760500861E-2</c:v>
                  </c:pt>
                  <c:pt idx="5">
                    <c:v>2.945122927838234E-2</c:v>
                  </c:pt>
                  <c:pt idx="6">
                    <c:v>1.1293302373792863E-2</c:v>
                  </c:pt>
                  <c:pt idx="7">
                    <c:v>4.6111833852109305E-3</c:v>
                  </c:pt>
                  <c:pt idx="8">
                    <c:v>1.8554434156974528E-3</c:v>
                  </c:pt>
                  <c:pt idx="9">
                    <c:v>3.444076932538741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46:$DC$46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47:$DC$47</c:f>
              <c:numCache>
                <c:formatCode>General</c:formatCode>
                <c:ptCount val="10"/>
                <c:pt idx="0">
                  <c:v>0.16531666864951453</c:v>
                </c:pt>
                <c:pt idx="1">
                  <c:v>0.20261666427055994</c:v>
                </c:pt>
                <c:pt idx="2">
                  <c:v>0.23448333640893301</c:v>
                </c:pt>
                <c:pt idx="3">
                  <c:v>0.29563333094120026</c:v>
                </c:pt>
                <c:pt idx="4">
                  <c:v>0.3455333411693573</c:v>
                </c:pt>
                <c:pt idx="5">
                  <c:v>0.33156666656335193</c:v>
                </c:pt>
                <c:pt idx="6">
                  <c:v>0.17266666640837988</c:v>
                </c:pt>
                <c:pt idx="7">
                  <c:v>2.0850001523892086E-2</c:v>
                </c:pt>
                <c:pt idx="8">
                  <c:v>3.0066665261983871E-2</c:v>
                </c:pt>
                <c:pt idx="9">
                  <c:v>5.368333309888839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7F9-411B-B2AD-D5CC39B62AE1}"/>
            </c:ext>
          </c:extLst>
        </c:ser>
        <c:ser>
          <c:idx val="1"/>
          <c:order val="1"/>
          <c:tx>
            <c:strRef>
              <c:f>計算!$CS$48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50:$DC$50</c:f>
                <c:numCache>
                  <c:formatCode>General</c:formatCode>
                  <c:ptCount val="10"/>
                  <c:pt idx="0">
                    <c:v>1.247067063863567E-2</c:v>
                  </c:pt>
                  <c:pt idx="1">
                    <c:v>1.929688157737116E-2</c:v>
                  </c:pt>
                  <c:pt idx="2">
                    <c:v>2.0918256758383168E-2</c:v>
                  </c:pt>
                  <c:pt idx="3">
                    <c:v>2.6326918964660162E-2</c:v>
                  </c:pt>
                  <c:pt idx="4">
                    <c:v>3.2156475760500861E-2</c:v>
                  </c:pt>
                  <c:pt idx="5">
                    <c:v>2.945122927838234E-2</c:v>
                  </c:pt>
                  <c:pt idx="6">
                    <c:v>1.1293302373792863E-2</c:v>
                  </c:pt>
                  <c:pt idx="7">
                    <c:v>4.6111833852109305E-3</c:v>
                  </c:pt>
                  <c:pt idx="8">
                    <c:v>1.8554434156974528E-3</c:v>
                  </c:pt>
                  <c:pt idx="9">
                    <c:v>3.4440769325387414E-3</c:v>
                  </c:pt>
                </c:numCache>
              </c:numRef>
            </c:plus>
            <c:minus>
              <c:numRef>
                <c:f>計算!$CT$50:$DC$50</c:f>
                <c:numCache>
                  <c:formatCode>General</c:formatCode>
                  <c:ptCount val="10"/>
                  <c:pt idx="0">
                    <c:v>1.247067063863567E-2</c:v>
                  </c:pt>
                  <c:pt idx="1">
                    <c:v>1.929688157737116E-2</c:v>
                  </c:pt>
                  <c:pt idx="2">
                    <c:v>2.0918256758383168E-2</c:v>
                  </c:pt>
                  <c:pt idx="3">
                    <c:v>2.6326918964660162E-2</c:v>
                  </c:pt>
                  <c:pt idx="4">
                    <c:v>3.2156475760500861E-2</c:v>
                  </c:pt>
                  <c:pt idx="5">
                    <c:v>2.945122927838234E-2</c:v>
                  </c:pt>
                  <c:pt idx="6">
                    <c:v>1.1293302373792863E-2</c:v>
                  </c:pt>
                  <c:pt idx="7">
                    <c:v>4.6111833852109305E-3</c:v>
                  </c:pt>
                  <c:pt idx="8">
                    <c:v>1.8554434156974528E-3</c:v>
                  </c:pt>
                  <c:pt idx="9">
                    <c:v>3.444076932538741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46:$DC$46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48:$DC$48</c:f>
              <c:numCache>
                <c:formatCode>General</c:formatCode>
                <c:ptCount val="10"/>
                <c:pt idx="0">
                  <c:v>0.16531666864951453</c:v>
                </c:pt>
                <c:pt idx="1">
                  <c:v>0.16691666593154272</c:v>
                </c:pt>
                <c:pt idx="2">
                  <c:v>0.17454999933640161</c:v>
                </c:pt>
                <c:pt idx="3">
                  <c:v>0.22818333407243094</c:v>
                </c:pt>
                <c:pt idx="4">
                  <c:v>0.27390000720818841</c:v>
                </c:pt>
                <c:pt idx="5">
                  <c:v>0.25941666464010876</c:v>
                </c:pt>
                <c:pt idx="6">
                  <c:v>0.1154000038901965</c:v>
                </c:pt>
                <c:pt idx="7">
                  <c:v>-4.5399994899829259E-2</c:v>
                </c:pt>
                <c:pt idx="8">
                  <c:v>-1.3483334332704544E-2</c:v>
                </c:pt>
                <c:pt idx="9">
                  <c:v>3.393333405256271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7F9-411B-B2AD-D5CC39B62A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578159"/>
        <c:axId val="1655578639"/>
      </c:lineChart>
      <c:catAx>
        <c:axId val="16555781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78639"/>
        <c:crosses val="autoZero"/>
        <c:auto val="1"/>
        <c:lblAlgn val="ctr"/>
        <c:lblOffset val="100"/>
        <c:noMultiLvlLbl val="0"/>
      </c:catAx>
      <c:valAx>
        <c:axId val="1655578639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78159"/>
        <c:crosses val="autoZero"/>
        <c:crossBetween val="midCat"/>
        <c:majorUnit val="0.1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75764197639282"/>
          <c:y val="3.2824287028518861E-2"/>
          <c:w val="0.7659546649635256"/>
          <c:h val="0.85977653834937284"/>
        </c:manualLayout>
      </c:layout>
      <c:lineChart>
        <c:grouping val="standard"/>
        <c:varyColors val="0"/>
        <c:ser>
          <c:idx val="0"/>
          <c:order val="0"/>
          <c:tx>
            <c:strRef>
              <c:f>計算!$CS$95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97:$DC$97</c:f>
                <c:numCache>
                  <c:formatCode>General</c:formatCode>
                  <c:ptCount val="10"/>
                  <c:pt idx="0">
                    <c:v>2.6151207900160008E-2</c:v>
                  </c:pt>
                  <c:pt idx="1">
                    <c:v>3.6354626154391979E-2</c:v>
                  </c:pt>
                  <c:pt idx="2">
                    <c:v>4.2441572820463326E-2</c:v>
                  </c:pt>
                  <c:pt idx="3">
                    <c:v>4.6343715153358868E-2</c:v>
                  </c:pt>
                  <c:pt idx="4">
                    <c:v>6.0262312410239341E-2</c:v>
                  </c:pt>
                  <c:pt idx="5">
                    <c:v>3.9001101590230486E-2</c:v>
                  </c:pt>
                  <c:pt idx="6">
                    <c:v>4.4737418429189622E-2</c:v>
                  </c:pt>
                  <c:pt idx="7">
                    <c:v>3.9513109007114036E-2</c:v>
                  </c:pt>
                  <c:pt idx="8">
                    <c:v>6.1028610553762963E-2</c:v>
                  </c:pt>
                  <c:pt idx="9">
                    <c:v>3.3012621335024001E-2</c:v>
                  </c:pt>
                </c:numCache>
              </c:numRef>
            </c:plus>
            <c:minus>
              <c:numRef>
                <c:f>計算!$CT$97:$DC$97</c:f>
                <c:numCache>
                  <c:formatCode>General</c:formatCode>
                  <c:ptCount val="10"/>
                  <c:pt idx="0">
                    <c:v>2.6151207900160008E-2</c:v>
                  </c:pt>
                  <c:pt idx="1">
                    <c:v>3.6354626154391979E-2</c:v>
                  </c:pt>
                  <c:pt idx="2">
                    <c:v>4.2441572820463326E-2</c:v>
                  </c:pt>
                  <c:pt idx="3">
                    <c:v>4.6343715153358868E-2</c:v>
                  </c:pt>
                  <c:pt idx="4">
                    <c:v>6.0262312410239341E-2</c:v>
                  </c:pt>
                  <c:pt idx="5">
                    <c:v>3.9001101590230486E-2</c:v>
                  </c:pt>
                  <c:pt idx="6">
                    <c:v>4.4737418429189622E-2</c:v>
                  </c:pt>
                  <c:pt idx="7">
                    <c:v>3.9513109007114036E-2</c:v>
                  </c:pt>
                  <c:pt idx="8">
                    <c:v>6.1028610553762963E-2</c:v>
                  </c:pt>
                  <c:pt idx="9">
                    <c:v>3.3012621335024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94:$DC$94</c:f>
              <c:numCache>
                <c:formatCode>General</c:formatCode>
                <c:ptCount val="10"/>
                <c:pt idx="0">
                  <c:v>0</c:v>
                </c:pt>
                <c:pt idx="1">
                  <c:v>1E-4</c:v>
                </c:pt>
                <c:pt idx="2">
                  <c:v>3.2000000000000003E-4</c:v>
                </c:pt>
                <c:pt idx="3">
                  <c:v>1E-3</c:v>
                </c:pt>
                <c:pt idx="4">
                  <c:v>3.2000000000000002E-3</c:v>
                </c:pt>
                <c:pt idx="5">
                  <c:v>0.01</c:v>
                </c:pt>
                <c:pt idx="6">
                  <c:v>3.2000000000000001E-2</c:v>
                </c:pt>
                <c:pt idx="7">
                  <c:v>0.1</c:v>
                </c:pt>
                <c:pt idx="8">
                  <c:v>0.32</c:v>
                </c:pt>
                <c:pt idx="9">
                  <c:v>1</c:v>
                </c:pt>
              </c:numCache>
            </c:numRef>
          </c:cat>
          <c:val>
            <c:numRef>
              <c:f>計算!$CT$95:$DC$95</c:f>
              <c:numCache>
                <c:formatCode>General</c:formatCode>
                <c:ptCount val="10"/>
                <c:pt idx="0">
                  <c:v>0.18091666450103125</c:v>
                </c:pt>
                <c:pt idx="1">
                  <c:v>0.29453333218892414</c:v>
                </c:pt>
                <c:pt idx="2">
                  <c:v>0.38235000272591907</c:v>
                </c:pt>
                <c:pt idx="3">
                  <c:v>0.48440000414848328</c:v>
                </c:pt>
                <c:pt idx="4">
                  <c:v>0.5051666647195816</c:v>
                </c:pt>
                <c:pt idx="5">
                  <c:v>0.48251666625340778</c:v>
                </c:pt>
                <c:pt idx="6">
                  <c:v>0.45929999649524689</c:v>
                </c:pt>
                <c:pt idx="7">
                  <c:v>0.42508332928021747</c:v>
                </c:pt>
                <c:pt idx="8">
                  <c:v>0.38625000417232513</c:v>
                </c:pt>
                <c:pt idx="9">
                  <c:v>0.285983329017957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D7B-4055-AEAF-E5623C7D2B88}"/>
            </c:ext>
          </c:extLst>
        </c:ser>
        <c:ser>
          <c:idx val="1"/>
          <c:order val="1"/>
          <c:tx>
            <c:strRef>
              <c:f>計算!$CS$96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98:$DC$98</c:f>
                <c:numCache>
                  <c:formatCode>General</c:formatCode>
                  <c:ptCount val="10"/>
                  <c:pt idx="0">
                    <c:v>2.6151207900160008E-2</c:v>
                  </c:pt>
                  <c:pt idx="1">
                    <c:v>3.6354626154391528E-2</c:v>
                  </c:pt>
                  <c:pt idx="2">
                    <c:v>4.2441572820462806E-2</c:v>
                  </c:pt>
                  <c:pt idx="3">
                    <c:v>4.634371515335791E-2</c:v>
                  </c:pt>
                  <c:pt idx="4">
                    <c:v>6.0262312410238238E-2</c:v>
                  </c:pt>
                  <c:pt idx="5">
                    <c:v>3.9001101590230486E-2</c:v>
                  </c:pt>
                  <c:pt idx="6">
                    <c:v>4.4737418429189379E-2</c:v>
                  </c:pt>
                  <c:pt idx="7">
                    <c:v>3.9513109007114133E-2</c:v>
                  </c:pt>
                  <c:pt idx="8">
                    <c:v>6.1028610553762963E-2</c:v>
                  </c:pt>
                  <c:pt idx="9">
                    <c:v>3.3012621335024001E-2</c:v>
                  </c:pt>
                </c:numCache>
              </c:numRef>
            </c:plus>
            <c:minus>
              <c:numRef>
                <c:f>計算!$CT$98:$DC$98</c:f>
                <c:numCache>
                  <c:formatCode>General</c:formatCode>
                  <c:ptCount val="10"/>
                  <c:pt idx="0">
                    <c:v>2.6151207900160008E-2</c:v>
                  </c:pt>
                  <c:pt idx="1">
                    <c:v>3.6354626154391528E-2</c:v>
                  </c:pt>
                  <c:pt idx="2">
                    <c:v>4.2441572820462806E-2</c:v>
                  </c:pt>
                  <c:pt idx="3">
                    <c:v>4.634371515335791E-2</c:v>
                  </c:pt>
                  <c:pt idx="4">
                    <c:v>6.0262312410238238E-2</c:v>
                  </c:pt>
                  <c:pt idx="5">
                    <c:v>3.9001101590230486E-2</c:v>
                  </c:pt>
                  <c:pt idx="6">
                    <c:v>4.4737418429189379E-2</c:v>
                  </c:pt>
                  <c:pt idx="7">
                    <c:v>3.9513109007114133E-2</c:v>
                  </c:pt>
                  <c:pt idx="8">
                    <c:v>6.1028610553762963E-2</c:v>
                  </c:pt>
                  <c:pt idx="9">
                    <c:v>3.3012621335024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94:$DC$94</c:f>
              <c:numCache>
                <c:formatCode>General</c:formatCode>
                <c:ptCount val="10"/>
                <c:pt idx="0">
                  <c:v>0</c:v>
                </c:pt>
                <c:pt idx="1">
                  <c:v>1E-4</c:v>
                </c:pt>
                <c:pt idx="2">
                  <c:v>3.2000000000000003E-4</c:v>
                </c:pt>
                <c:pt idx="3">
                  <c:v>1E-3</c:v>
                </c:pt>
                <c:pt idx="4">
                  <c:v>3.2000000000000002E-3</c:v>
                </c:pt>
                <c:pt idx="5">
                  <c:v>0.01</c:v>
                </c:pt>
                <c:pt idx="6">
                  <c:v>3.2000000000000001E-2</c:v>
                </c:pt>
                <c:pt idx="7">
                  <c:v>0.1</c:v>
                </c:pt>
                <c:pt idx="8">
                  <c:v>0.32</c:v>
                </c:pt>
                <c:pt idx="9">
                  <c:v>1</c:v>
                </c:pt>
              </c:numCache>
            </c:numRef>
          </c:cat>
          <c:val>
            <c:numRef>
              <c:f>計算!$CT$96:$DC$96</c:f>
              <c:numCache>
                <c:formatCode>General</c:formatCode>
                <c:ptCount val="10"/>
                <c:pt idx="0">
                  <c:v>0.18091666450103125</c:v>
                </c:pt>
                <c:pt idx="1">
                  <c:v>0.25883333384990692</c:v>
                </c:pt>
                <c:pt idx="2">
                  <c:v>0.32241666565338778</c:v>
                </c:pt>
                <c:pt idx="3">
                  <c:v>0.41695000727971404</c:v>
                </c:pt>
                <c:pt idx="4">
                  <c:v>0.43353333075841277</c:v>
                </c:pt>
                <c:pt idx="5">
                  <c:v>0.41036666433016467</c:v>
                </c:pt>
                <c:pt idx="6">
                  <c:v>0.40203333397706359</c:v>
                </c:pt>
                <c:pt idx="7">
                  <c:v>0.35883333285649616</c:v>
                </c:pt>
                <c:pt idx="8">
                  <c:v>0.34270000457763672</c:v>
                </c:pt>
                <c:pt idx="9">
                  <c:v>0.266233329971631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D7B-4055-AEAF-E5623C7D2B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586319"/>
        <c:axId val="1655602159"/>
      </c:lineChart>
      <c:catAx>
        <c:axId val="16555863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602159"/>
        <c:crosses val="autoZero"/>
        <c:auto val="1"/>
        <c:lblAlgn val="ctr"/>
        <c:lblOffset val="100"/>
        <c:noMultiLvlLbl val="0"/>
      </c:catAx>
      <c:valAx>
        <c:axId val="165560215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8631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4.8287037037037038E-2"/>
          <c:w val="0.89655796150481193"/>
          <c:h val="0.84431357538641005"/>
        </c:manualLayout>
      </c:layout>
      <c:lineChart>
        <c:grouping val="standard"/>
        <c:varyColors val="0"/>
        <c:ser>
          <c:idx val="0"/>
          <c:order val="0"/>
          <c:tx>
            <c:strRef>
              <c:f>計算!$CS$125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27:$DC$127</c:f>
                <c:numCache>
                  <c:formatCode>General</c:formatCode>
                  <c:ptCount val="10"/>
                  <c:pt idx="0">
                    <c:v>1.7424695625821735E-2</c:v>
                  </c:pt>
                  <c:pt idx="1">
                    <c:v>2.427500575816913E-2</c:v>
                  </c:pt>
                  <c:pt idx="2">
                    <c:v>2.6877774504672745E-2</c:v>
                  </c:pt>
                  <c:pt idx="3">
                    <c:v>3.0609410687381901E-2</c:v>
                  </c:pt>
                  <c:pt idx="4">
                    <c:v>3.9641642580846771E-2</c:v>
                  </c:pt>
                  <c:pt idx="5">
                    <c:v>3.0080339467527386E-2</c:v>
                  </c:pt>
                  <c:pt idx="6">
                    <c:v>3.8181402005046577E-2</c:v>
                  </c:pt>
                  <c:pt idx="7">
                    <c:v>2.4308819570163284E-2</c:v>
                  </c:pt>
                  <c:pt idx="8">
                    <c:v>1.0986663019421725E-2</c:v>
                  </c:pt>
                  <c:pt idx="9">
                    <c:v>8.3665985199447553E-4</c:v>
                  </c:pt>
                </c:numCache>
              </c:numRef>
            </c:plus>
            <c:minus>
              <c:numRef>
                <c:f>計算!$CT$127:$DC$127</c:f>
                <c:numCache>
                  <c:formatCode>General</c:formatCode>
                  <c:ptCount val="10"/>
                  <c:pt idx="0">
                    <c:v>1.7424695625821735E-2</c:v>
                  </c:pt>
                  <c:pt idx="1">
                    <c:v>2.427500575816913E-2</c:v>
                  </c:pt>
                  <c:pt idx="2">
                    <c:v>2.6877774504672745E-2</c:v>
                  </c:pt>
                  <c:pt idx="3">
                    <c:v>3.0609410687381901E-2</c:v>
                  </c:pt>
                  <c:pt idx="4">
                    <c:v>3.9641642580846771E-2</c:v>
                  </c:pt>
                  <c:pt idx="5">
                    <c:v>3.0080339467527386E-2</c:v>
                  </c:pt>
                  <c:pt idx="6">
                    <c:v>3.8181402005046577E-2</c:v>
                  </c:pt>
                  <c:pt idx="7">
                    <c:v>2.4308819570163284E-2</c:v>
                  </c:pt>
                  <c:pt idx="8">
                    <c:v>1.0986663019421725E-2</c:v>
                  </c:pt>
                  <c:pt idx="9">
                    <c:v>8.3665985199447553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24:$DC$124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125:$DC$125</c:f>
              <c:numCache>
                <c:formatCode>General</c:formatCode>
                <c:ptCount val="10"/>
                <c:pt idx="0">
                  <c:v>0.13230000187953314</c:v>
                </c:pt>
                <c:pt idx="1">
                  <c:v>0.16069999585549036</c:v>
                </c:pt>
                <c:pt idx="2">
                  <c:v>0.16593333085378012</c:v>
                </c:pt>
                <c:pt idx="3">
                  <c:v>0.18290000408887863</c:v>
                </c:pt>
                <c:pt idx="4">
                  <c:v>0.21129999806483588</c:v>
                </c:pt>
                <c:pt idx="5">
                  <c:v>0.22914999971787134</c:v>
                </c:pt>
                <c:pt idx="6">
                  <c:v>0.30513333280881244</c:v>
                </c:pt>
                <c:pt idx="7">
                  <c:v>0.35833332935969037</c:v>
                </c:pt>
                <c:pt idx="8">
                  <c:v>0.19766666491826376</c:v>
                </c:pt>
                <c:pt idx="9">
                  <c:v>1.99999970694383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4E3-4A5D-9ED2-AC7352D2D753}"/>
            </c:ext>
          </c:extLst>
        </c:ser>
        <c:ser>
          <c:idx val="1"/>
          <c:order val="1"/>
          <c:tx>
            <c:strRef>
              <c:f>計算!$CS$126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28:$DC$128</c:f>
                <c:numCache>
                  <c:formatCode>General</c:formatCode>
                  <c:ptCount val="10"/>
                  <c:pt idx="0">
                    <c:v>1.7424695625821735E-2</c:v>
                  </c:pt>
                  <c:pt idx="1">
                    <c:v>2.4275005758169245E-2</c:v>
                  </c:pt>
                  <c:pt idx="2">
                    <c:v>2.6877774504672693E-2</c:v>
                  </c:pt>
                  <c:pt idx="3">
                    <c:v>3.0609410687381943E-2</c:v>
                  </c:pt>
                  <c:pt idx="4">
                    <c:v>3.9641642580846841E-2</c:v>
                  </c:pt>
                  <c:pt idx="5">
                    <c:v>3.008033946752748E-2</c:v>
                  </c:pt>
                  <c:pt idx="6">
                    <c:v>3.8181402005046577E-2</c:v>
                  </c:pt>
                  <c:pt idx="7">
                    <c:v>2.4308819570163284E-2</c:v>
                  </c:pt>
                  <c:pt idx="8">
                    <c:v>1.0986663019421724E-2</c:v>
                  </c:pt>
                  <c:pt idx="9">
                    <c:v>8.3665985199447542E-4</c:v>
                  </c:pt>
                </c:numCache>
              </c:numRef>
            </c:plus>
            <c:minus>
              <c:numRef>
                <c:f>計算!$CT$128:$DC$128</c:f>
                <c:numCache>
                  <c:formatCode>General</c:formatCode>
                  <c:ptCount val="10"/>
                  <c:pt idx="0">
                    <c:v>1.7424695625821735E-2</c:v>
                  </c:pt>
                  <c:pt idx="1">
                    <c:v>2.4275005758169245E-2</c:v>
                  </c:pt>
                  <c:pt idx="2">
                    <c:v>2.6877774504672693E-2</c:v>
                  </c:pt>
                  <c:pt idx="3">
                    <c:v>3.0609410687381943E-2</c:v>
                  </c:pt>
                  <c:pt idx="4">
                    <c:v>3.9641642580846841E-2</c:v>
                  </c:pt>
                  <c:pt idx="5">
                    <c:v>3.008033946752748E-2</c:v>
                  </c:pt>
                  <c:pt idx="6">
                    <c:v>3.8181402005046577E-2</c:v>
                  </c:pt>
                  <c:pt idx="7">
                    <c:v>2.4308819570163284E-2</c:v>
                  </c:pt>
                  <c:pt idx="8">
                    <c:v>1.0986663019421724E-2</c:v>
                  </c:pt>
                  <c:pt idx="9">
                    <c:v>8.366598519944754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24:$DC$124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126:$DC$126</c:f>
              <c:numCache>
                <c:formatCode>General</c:formatCode>
                <c:ptCount val="10"/>
                <c:pt idx="0">
                  <c:v>0.13230000187953314</c:v>
                </c:pt>
                <c:pt idx="1">
                  <c:v>0.13163332641124723</c:v>
                </c:pt>
                <c:pt idx="2">
                  <c:v>0.13534999390443167</c:v>
                </c:pt>
                <c:pt idx="3">
                  <c:v>0.13013333578904465</c:v>
                </c:pt>
                <c:pt idx="4">
                  <c:v>0.16828333338101706</c:v>
                </c:pt>
                <c:pt idx="5">
                  <c:v>0.18200000127156576</c:v>
                </c:pt>
                <c:pt idx="6">
                  <c:v>0.25471666206916171</c:v>
                </c:pt>
                <c:pt idx="7">
                  <c:v>0.32969999561707181</c:v>
                </c:pt>
                <c:pt idx="8">
                  <c:v>0.17086666325728095</c:v>
                </c:pt>
                <c:pt idx="9">
                  <c:v>8.4999979784091319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4E3-4A5D-9ED2-AC7352D2D7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68564591"/>
        <c:axId val="1868562191"/>
      </c:lineChart>
      <c:catAx>
        <c:axId val="18685645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68562191"/>
        <c:crosses val="autoZero"/>
        <c:auto val="1"/>
        <c:lblAlgn val="ctr"/>
        <c:lblOffset val="100"/>
        <c:noMultiLvlLbl val="0"/>
      </c:catAx>
      <c:valAx>
        <c:axId val="1868562191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8564591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4.2083333333333355E-2"/>
          <c:w val="0.88389129483814521"/>
          <c:h val="0.85051727909011376"/>
        </c:manualLayout>
      </c:layout>
      <c:lineChart>
        <c:grouping val="standard"/>
        <c:varyColors val="0"/>
        <c:ser>
          <c:idx val="0"/>
          <c:order val="0"/>
          <c:tx>
            <c:strRef>
              <c:f>計算!$CS$112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14:$DC$114</c:f>
                <c:numCache>
                  <c:formatCode>General</c:formatCode>
                  <c:ptCount val="10"/>
                  <c:pt idx="0">
                    <c:v>1.5428888053411768E-2</c:v>
                  </c:pt>
                  <c:pt idx="1">
                    <c:v>2.64541614473306E-2</c:v>
                  </c:pt>
                  <c:pt idx="2">
                    <c:v>2.2615281592441715E-2</c:v>
                  </c:pt>
                  <c:pt idx="3">
                    <c:v>2.6228740439422957E-2</c:v>
                  </c:pt>
                  <c:pt idx="4">
                    <c:v>3.0225578095372838E-2</c:v>
                  </c:pt>
                  <c:pt idx="5">
                    <c:v>1.7968010939958576E-2</c:v>
                  </c:pt>
                  <c:pt idx="6">
                    <c:v>2.2883567350817119E-2</c:v>
                  </c:pt>
                  <c:pt idx="7">
                    <c:v>1.8193297689195965E-2</c:v>
                  </c:pt>
                  <c:pt idx="8">
                    <c:v>2.3828275021040308E-2</c:v>
                  </c:pt>
                  <c:pt idx="9">
                    <c:v>1.5363422495338393E-2</c:v>
                  </c:pt>
                </c:numCache>
              </c:numRef>
            </c:plus>
            <c:minus>
              <c:numRef>
                <c:f>計算!$CT$114:$DC$114</c:f>
                <c:numCache>
                  <c:formatCode>General</c:formatCode>
                  <c:ptCount val="10"/>
                  <c:pt idx="0">
                    <c:v>1.5428888053411768E-2</c:v>
                  </c:pt>
                  <c:pt idx="1">
                    <c:v>2.64541614473306E-2</c:v>
                  </c:pt>
                  <c:pt idx="2">
                    <c:v>2.2615281592441715E-2</c:v>
                  </c:pt>
                  <c:pt idx="3">
                    <c:v>2.6228740439422957E-2</c:v>
                  </c:pt>
                  <c:pt idx="4">
                    <c:v>3.0225578095372838E-2</c:v>
                  </c:pt>
                  <c:pt idx="5">
                    <c:v>1.7968010939958576E-2</c:v>
                  </c:pt>
                  <c:pt idx="6">
                    <c:v>2.2883567350817119E-2</c:v>
                  </c:pt>
                  <c:pt idx="7">
                    <c:v>1.8193297689195965E-2</c:v>
                  </c:pt>
                  <c:pt idx="8">
                    <c:v>2.3828275021040308E-2</c:v>
                  </c:pt>
                  <c:pt idx="9">
                    <c:v>1.53634224953383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11:$DC$111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T$112:$DC$112</c:f>
              <c:numCache>
                <c:formatCode>General</c:formatCode>
                <c:ptCount val="10"/>
                <c:pt idx="0">
                  <c:v>0.14176666612426439</c:v>
                </c:pt>
                <c:pt idx="1">
                  <c:v>0.17083333556850752</c:v>
                </c:pt>
                <c:pt idx="2">
                  <c:v>0.17235000307361284</c:v>
                </c:pt>
                <c:pt idx="3">
                  <c:v>0.19453333442409834</c:v>
                </c:pt>
                <c:pt idx="4">
                  <c:v>0.18478333080808321</c:v>
                </c:pt>
                <c:pt idx="5">
                  <c:v>0.18891666457056999</c:v>
                </c:pt>
                <c:pt idx="6">
                  <c:v>0.19218333686391512</c:v>
                </c:pt>
                <c:pt idx="7">
                  <c:v>0.17039999986688295</c:v>
                </c:pt>
                <c:pt idx="8">
                  <c:v>0.16856666778524718</c:v>
                </c:pt>
                <c:pt idx="9">
                  <c:v>0.135266667852799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E6E-4659-9473-C28881E2D6F7}"/>
            </c:ext>
          </c:extLst>
        </c:ser>
        <c:ser>
          <c:idx val="1"/>
          <c:order val="1"/>
          <c:tx>
            <c:strRef>
              <c:f>計算!$CS$113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15:$DC$115</c:f>
                <c:numCache>
                  <c:formatCode>General</c:formatCode>
                  <c:ptCount val="10"/>
                  <c:pt idx="0">
                    <c:v>1.5428888053411768E-2</c:v>
                  </c:pt>
                  <c:pt idx="1">
                    <c:v>2.6454161447330808E-2</c:v>
                  </c:pt>
                  <c:pt idx="2">
                    <c:v>2.2615281592441836E-2</c:v>
                  </c:pt>
                  <c:pt idx="3">
                    <c:v>2.6228740439423168E-2</c:v>
                  </c:pt>
                  <c:pt idx="4">
                    <c:v>3.0225578095372928E-2</c:v>
                  </c:pt>
                  <c:pt idx="5">
                    <c:v>1.7968010939958576E-2</c:v>
                  </c:pt>
                  <c:pt idx="6">
                    <c:v>2.288356735081724E-2</c:v>
                  </c:pt>
                  <c:pt idx="7">
                    <c:v>1.8193297689196013E-2</c:v>
                  </c:pt>
                  <c:pt idx="8">
                    <c:v>2.3828275021040485E-2</c:v>
                  </c:pt>
                  <c:pt idx="9">
                    <c:v>1.5363422495338333E-2</c:v>
                  </c:pt>
                </c:numCache>
              </c:numRef>
            </c:plus>
            <c:minus>
              <c:numRef>
                <c:f>計算!$CT$115:$DC$115</c:f>
                <c:numCache>
                  <c:formatCode>General</c:formatCode>
                  <c:ptCount val="10"/>
                  <c:pt idx="0">
                    <c:v>1.5428888053411768E-2</c:v>
                  </c:pt>
                  <c:pt idx="1">
                    <c:v>2.6454161447330808E-2</c:v>
                  </c:pt>
                  <c:pt idx="2">
                    <c:v>2.2615281592441836E-2</c:v>
                  </c:pt>
                  <c:pt idx="3">
                    <c:v>2.6228740439423168E-2</c:v>
                  </c:pt>
                  <c:pt idx="4">
                    <c:v>3.0225578095372928E-2</c:v>
                  </c:pt>
                  <c:pt idx="5">
                    <c:v>1.7968010939958576E-2</c:v>
                  </c:pt>
                  <c:pt idx="6">
                    <c:v>2.288356735081724E-2</c:v>
                  </c:pt>
                  <c:pt idx="7">
                    <c:v>1.8193297689196013E-2</c:v>
                  </c:pt>
                  <c:pt idx="8">
                    <c:v>2.3828275021040485E-2</c:v>
                  </c:pt>
                  <c:pt idx="9">
                    <c:v>1.53634224953383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11:$DC$111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T$113:$DC$113</c:f>
              <c:numCache>
                <c:formatCode>General</c:formatCode>
                <c:ptCount val="10"/>
                <c:pt idx="0">
                  <c:v>0.14176666612426439</c:v>
                </c:pt>
                <c:pt idx="1">
                  <c:v>0.14176666612426436</c:v>
                </c:pt>
                <c:pt idx="2">
                  <c:v>0.14176666612426439</c:v>
                </c:pt>
                <c:pt idx="3">
                  <c:v>0.14176666612426436</c:v>
                </c:pt>
                <c:pt idx="4">
                  <c:v>0.14176666612426439</c:v>
                </c:pt>
                <c:pt idx="5">
                  <c:v>0.14176666612426439</c:v>
                </c:pt>
                <c:pt idx="6">
                  <c:v>0.14176666612426439</c:v>
                </c:pt>
                <c:pt idx="7">
                  <c:v>0.14176666612426439</c:v>
                </c:pt>
                <c:pt idx="8">
                  <c:v>0.14176666612426436</c:v>
                </c:pt>
                <c:pt idx="9">
                  <c:v>0.141766666124264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E6E-4659-9473-C28881E2D6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25903999"/>
        <c:axId val="1725894879"/>
      </c:lineChart>
      <c:catAx>
        <c:axId val="17259039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5894879"/>
        <c:crosses val="autoZero"/>
        <c:auto val="1"/>
        <c:lblAlgn val="ctr"/>
        <c:lblOffset val="100"/>
        <c:noMultiLvlLbl val="0"/>
      </c:catAx>
      <c:valAx>
        <c:axId val="1725894879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590399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15907237368743232"/>
          <c:y val="6.0994167585889658E-2"/>
          <c:w val="0.81720299477327296"/>
          <c:h val="0.290328543855283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96564549413711"/>
          <c:y val="3.6633511508694143E-2"/>
          <c:w val="0.89655796150481193"/>
          <c:h val="0.85820246427529889"/>
        </c:manualLayout>
      </c:layout>
      <c:lineChart>
        <c:grouping val="standard"/>
        <c:varyColors val="0"/>
        <c:ser>
          <c:idx val="0"/>
          <c:order val="0"/>
          <c:tx>
            <c:strRef>
              <c:f>計算!$CS$137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39:$DC$139</c:f>
                <c:numCache>
                  <c:formatCode>General</c:formatCode>
                  <c:ptCount val="10"/>
                  <c:pt idx="0">
                    <c:v>8.1754911171002653E-3</c:v>
                  </c:pt>
                  <c:pt idx="1">
                    <c:v>1.8686187354878425E-2</c:v>
                  </c:pt>
                  <c:pt idx="2">
                    <c:v>2.3775313084056098E-2</c:v>
                  </c:pt>
                  <c:pt idx="3">
                    <c:v>2.1141398919577965E-2</c:v>
                  </c:pt>
                  <c:pt idx="4">
                    <c:v>2.6618159256598523E-2</c:v>
                  </c:pt>
                  <c:pt idx="5">
                    <c:v>2.7139667440305042E-2</c:v>
                  </c:pt>
                  <c:pt idx="6">
                    <c:v>2.392359943538435E-2</c:v>
                  </c:pt>
                  <c:pt idx="7">
                    <c:v>8.6859467661714665E-3</c:v>
                  </c:pt>
                  <c:pt idx="8">
                    <c:v>1.9808962584657346E-2</c:v>
                  </c:pt>
                  <c:pt idx="9">
                    <c:v>1.177709111895633E-3</c:v>
                  </c:pt>
                </c:numCache>
              </c:numRef>
            </c:plus>
            <c:minus>
              <c:numRef>
                <c:f>計算!$CT$139:$DC$139</c:f>
                <c:numCache>
                  <c:formatCode>General</c:formatCode>
                  <c:ptCount val="10"/>
                  <c:pt idx="0">
                    <c:v>8.1754911171002653E-3</c:v>
                  </c:pt>
                  <c:pt idx="1">
                    <c:v>1.8686187354878425E-2</c:v>
                  </c:pt>
                  <c:pt idx="2">
                    <c:v>2.3775313084056098E-2</c:v>
                  </c:pt>
                  <c:pt idx="3">
                    <c:v>2.1141398919577965E-2</c:v>
                  </c:pt>
                  <c:pt idx="4">
                    <c:v>2.6618159256598523E-2</c:v>
                  </c:pt>
                  <c:pt idx="5">
                    <c:v>2.7139667440305042E-2</c:v>
                  </c:pt>
                  <c:pt idx="6">
                    <c:v>2.392359943538435E-2</c:v>
                  </c:pt>
                  <c:pt idx="7">
                    <c:v>8.6859467661714665E-3</c:v>
                  </c:pt>
                  <c:pt idx="8">
                    <c:v>1.9808962584657346E-2</c:v>
                  </c:pt>
                  <c:pt idx="9">
                    <c:v>1.17770911189563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36:$DC$136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137:$DC$137</c:f>
              <c:numCache>
                <c:formatCode>General</c:formatCode>
                <c:ptCount val="10"/>
                <c:pt idx="0">
                  <c:v>0.10633333027362823</c:v>
                </c:pt>
                <c:pt idx="1">
                  <c:v>0.13238333165645599</c:v>
                </c:pt>
                <c:pt idx="2">
                  <c:v>0.14878333111604056</c:v>
                </c:pt>
                <c:pt idx="3">
                  <c:v>0.17056666811307272</c:v>
                </c:pt>
                <c:pt idx="4">
                  <c:v>0.21496666222810745</c:v>
                </c:pt>
                <c:pt idx="5">
                  <c:v>0.2598833292722702</c:v>
                </c:pt>
                <c:pt idx="6">
                  <c:v>0.25323332846164703</c:v>
                </c:pt>
                <c:pt idx="7">
                  <c:v>0.15638333310683569</c:v>
                </c:pt>
                <c:pt idx="8">
                  <c:v>1.4549997945626577E-2</c:v>
                </c:pt>
                <c:pt idx="9">
                  <c:v>9.8499984790881481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236-46E8-B605-BC0D0DBE0B29}"/>
            </c:ext>
          </c:extLst>
        </c:ser>
        <c:ser>
          <c:idx val="1"/>
          <c:order val="1"/>
          <c:tx>
            <c:strRef>
              <c:f>計算!$CS$138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40:$DC$140</c:f>
                <c:numCache>
                  <c:formatCode>General</c:formatCode>
                  <c:ptCount val="10"/>
                  <c:pt idx="0">
                    <c:v>8.1754911171002653E-3</c:v>
                  </c:pt>
                  <c:pt idx="1">
                    <c:v>1.8686187354878574E-2</c:v>
                  </c:pt>
                  <c:pt idx="2">
                    <c:v>2.3775313084056039E-2</c:v>
                  </c:pt>
                  <c:pt idx="3">
                    <c:v>2.1141398919578031E-2</c:v>
                  </c:pt>
                  <c:pt idx="4">
                    <c:v>2.6618159256598523E-2</c:v>
                  </c:pt>
                  <c:pt idx="5">
                    <c:v>2.7139667440305042E-2</c:v>
                  </c:pt>
                  <c:pt idx="6">
                    <c:v>2.392359943538435E-2</c:v>
                  </c:pt>
                  <c:pt idx="7">
                    <c:v>8.6859467661714665E-3</c:v>
                  </c:pt>
                  <c:pt idx="8">
                    <c:v>1.980896258465735E-2</c:v>
                  </c:pt>
                  <c:pt idx="9">
                    <c:v>1.177709111895633E-3</c:v>
                  </c:pt>
                </c:numCache>
              </c:numRef>
            </c:plus>
            <c:minus>
              <c:numRef>
                <c:f>計算!$CT$140:$DC$140</c:f>
                <c:numCache>
                  <c:formatCode>General</c:formatCode>
                  <c:ptCount val="10"/>
                  <c:pt idx="0">
                    <c:v>8.1754911171002653E-3</c:v>
                  </c:pt>
                  <c:pt idx="1">
                    <c:v>1.8686187354878574E-2</c:v>
                  </c:pt>
                  <c:pt idx="2">
                    <c:v>2.3775313084056039E-2</c:v>
                  </c:pt>
                  <c:pt idx="3">
                    <c:v>2.1141398919578031E-2</c:v>
                  </c:pt>
                  <c:pt idx="4">
                    <c:v>2.6618159256598523E-2</c:v>
                  </c:pt>
                  <c:pt idx="5">
                    <c:v>2.7139667440305042E-2</c:v>
                  </c:pt>
                  <c:pt idx="6">
                    <c:v>2.392359943538435E-2</c:v>
                  </c:pt>
                  <c:pt idx="7">
                    <c:v>8.6859467661714665E-3</c:v>
                  </c:pt>
                  <c:pt idx="8">
                    <c:v>1.980896258465735E-2</c:v>
                  </c:pt>
                  <c:pt idx="9">
                    <c:v>1.17770911189563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36:$DC$136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138:$DC$138</c:f>
              <c:numCache>
                <c:formatCode>General</c:formatCode>
                <c:ptCount val="10"/>
                <c:pt idx="0">
                  <c:v>0.10633333027362823</c:v>
                </c:pt>
                <c:pt idx="1">
                  <c:v>0.10331666221221285</c:v>
                </c:pt>
                <c:pt idx="2">
                  <c:v>0.11819999416669209</c:v>
                </c:pt>
                <c:pt idx="3">
                  <c:v>0.11779999981323874</c:v>
                </c:pt>
                <c:pt idx="4">
                  <c:v>0.17194999754428864</c:v>
                </c:pt>
                <c:pt idx="5">
                  <c:v>0.2127333308259646</c:v>
                </c:pt>
                <c:pt idx="6">
                  <c:v>0.20281665772199631</c:v>
                </c:pt>
                <c:pt idx="7">
                  <c:v>0.12774999936421713</c:v>
                </c:pt>
                <c:pt idx="8">
                  <c:v>-1.2250003715356209E-2</c:v>
                </c:pt>
                <c:pt idx="9">
                  <c:v>1.634999675055344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236-46E8-B605-BC0D0DBE0B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616079"/>
        <c:axId val="1655609839"/>
      </c:lineChart>
      <c:catAx>
        <c:axId val="165561607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609839"/>
        <c:crosses val="autoZero"/>
        <c:auto val="1"/>
        <c:lblAlgn val="ctr"/>
        <c:lblOffset val="100"/>
        <c:noMultiLvlLbl val="0"/>
      </c:catAx>
      <c:valAx>
        <c:axId val="1655609839"/>
        <c:scaling>
          <c:orientation val="minMax"/>
          <c:max val="0.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61607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3.9027777777777779E-2"/>
          <c:w val="0.88389129483814521"/>
          <c:h val="0.85357283464566924"/>
        </c:manualLayout>
      </c:layout>
      <c:lineChart>
        <c:grouping val="standard"/>
        <c:varyColors val="0"/>
        <c:ser>
          <c:idx val="0"/>
          <c:order val="0"/>
          <c:tx>
            <c:strRef>
              <c:f>計算!$CS$149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51:$DC$151</c:f>
                <c:numCache>
                  <c:formatCode>General</c:formatCode>
                  <c:ptCount val="10"/>
                  <c:pt idx="0">
                    <c:v>1.2601691360171696E-2</c:v>
                  </c:pt>
                  <c:pt idx="1">
                    <c:v>1.0969667947642904E-2</c:v>
                  </c:pt>
                  <c:pt idx="2">
                    <c:v>1.575136996833483E-2</c:v>
                  </c:pt>
                  <c:pt idx="3">
                    <c:v>3.1858860355773136E-2</c:v>
                  </c:pt>
                  <c:pt idx="4">
                    <c:v>2.8037737634821543E-2</c:v>
                  </c:pt>
                  <c:pt idx="5">
                    <c:v>1.1778184924409327E-2</c:v>
                  </c:pt>
                  <c:pt idx="6">
                    <c:v>8.1965031610554007E-3</c:v>
                  </c:pt>
                  <c:pt idx="7">
                    <c:v>9.9338645125920388E-3</c:v>
                  </c:pt>
                  <c:pt idx="8">
                    <c:v>1.5633289826693726E-3</c:v>
                  </c:pt>
                  <c:pt idx="9">
                    <c:v>3.4581306671529746E-3</c:v>
                  </c:pt>
                </c:numCache>
              </c:numRef>
            </c:plus>
            <c:minus>
              <c:numRef>
                <c:f>計算!$CT$151:$DC$151</c:f>
                <c:numCache>
                  <c:formatCode>General</c:formatCode>
                  <c:ptCount val="10"/>
                  <c:pt idx="0">
                    <c:v>1.2601691360171696E-2</c:v>
                  </c:pt>
                  <c:pt idx="1">
                    <c:v>1.0969667947642904E-2</c:v>
                  </c:pt>
                  <c:pt idx="2">
                    <c:v>1.575136996833483E-2</c:v>
                  </c:pt>
                  <c:pt idx="3">
                    <c:v>3.1858860355773136E-2</c:v>
                  </c:pt>
                  <c:pt idx="4">
                    <c:v>2.8037737634821543E-2</c:v>
                  </c:pt>
                  <c:pt idx="5">
                    <c:v>1.1778184924409327E-2</c:v>
                  </c:pt>
                  <c:pt idx="6">
                    <c:v>8.1965031610554007E-3</c:v>
                  </c:pt>
                  <c:pt idx="7">
                    <c:v>9.9338645125920388E-3</c:v>
                  </c:pt>
                  <c:pt idx="8">
                    <c:v>1.5633289826693726E-3</c:v>
                  </c:pt>
                  <c:pt idx="9">
                    <c:v>3.458130667152974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48:$DC$148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149:$DC$149</c:f>
              <c:numCache>
                <c:formatCode>General</c:formatCode>
                <c:ptCount val="10"/>
                <c:pt idx="0">
                  <c:v>0.11526666829983394</c:v>
                </c:pt>
                <c:pt idx="1">
                  <c:v>0.1480166663726171</c:v>
                </c:pt>
                <c:pt idx="2">
                  <c:v>0.17208333313465118</c:v>
                </c:pt>
                <c:pt idx="3">
                  <c:v>0.21605000396569571</c:v>
                </c:pt>
                <c:pt idx="4">
                  <c:v>0.27435000240802765</c:v>
                </c:pt>
                <c:pt idx="5">
                  <c:v>0.2524166653553645</c:v>
                </c:pt>
                <c:pt idx="6">
                  <c:v>0.15923333416382471</c:v>
                </c:pt>
                <c:pt idx="7">
                  <c:v>3.0783335367838543E-2</c:v>
                </c:pt>
                <c:pt idx="8">
                  <c:v>2.2300002475579579E-2</c:v>
                </c:pt>
                <c:pt idx="9">
                  <c:v>4.033333435654640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1E-4FB8-A6CF-784FFE4D3180}"/>
            </c:ext>
          </c:extLst>
        </c:ser>
        <c:ser>
          <c:idx val="1"/>
          <c:order val="1"/>
          <c:tx>
            <c:strRef>
              <c:f>計算!$CS$150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52:$DC$152</c:f>
                <c:numCache>
                  <c:formatCode>General</c:formatCode>
                  <c:ptCount val="10"/>
                  <c:pt idx="0">
                    <c:v>1.2601691360171696E-2</c:v>
                  </c:pt>
                  <c:pt idx="1">
                    <c:v>1.0969667947642904E-2</c:v>
                  </c:pt>
                  <c:pt idx="2">
                    <c:v>1.575136996833483E-2</c:v>
                  </c:pt>
                  <c:pt idx="3">
                    <c:v>3.1858860355773309E-2</c:v>
                  </c:pt>
                  <c:pt idx="4">
                    <c:v>2.8037737634821543E-2</c:v>
                  </c:pt>
                  <c:pt idx="5">
                    <c:v>1.1778184924409327E-2</c:v>
                  </c:pt>
                  <c:pt idx="6">
                    <c:v>8.1965031610554025E-3</c:v>
                  </c:pt>
                  <c:pt idx="7">
                    <c:v>9.9338645125920423E-3</c:v>
                  </c:pt>
                  <c:pt idx="8">
                    <c:v>1.5633289826693726E-3</c:v>
                  </c:pt>
                  <c:pt idx="9">
                    <c:v>3.4581306671529746E-3</c:v>
                  </c:pt>
                </c:numCache>
              </c:numRef>
            </c:plus>
            <c:minus>
              <c:numRef>
                <c:f>計算!$CT$152:$DC$152</c:f>
                <c:numCache>
                  <c:formatCode>General</c:formatCode>
                  <c:ptCount val="10"/>
                  <c:pt idx="0">
                    <c:v>1.2601691360171696E-2</c:v>
                  </c:pt>
                  <c:pt idx="1">
                    <c:v>1.0969667947642904E-2</c:v>
                  </c:pt>
                  <c:pt idx="2">
                    <c:v>1.575136996833483E-2</c:v>
                  </c:pt>
                  <c:pt idx="3">
                    <c:v>3.1858860355773309E-2</c:v>
                  </c:pt>
                  <c:pt idx="4">
                    <c:v>2.8037737634821543E-2</c:v>
                  </c:pt>
                  <c:pt idx="5">
                    <c:v>1.1778184924409327E-2</c:v>
                  </c:pt>
                  <c:pt idx="6">
                    <c:v>8.1965031610554025E-3</c:v>
                  </c:pt>
                  <c:pt idx="7">
                    <c:v>9.9338645125920423E-3</c:v>
                  </c:pt>
                  <c:pt idx="8">
                    <c:v>1.5633289826693726E-3</c:v>
                  </c:pt>
                  <c:pt idx="9">
                    <c:v>3.458130667152974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48:$DC$148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150:$DC$150</c:f>
              <c:numCache>
                <c:formatCode>General</c:formatCode>
                <c:ptCount val="10"/>
                <c:pt idx="0">
                  <c:v>0.11526666829983394</c:v>
                </c:pt>
                <c:pt idx="1">
                  <c:v>0.11894999692837394</c:v>
                </c:pt>
                <c:pt idx="2">
                  <c:v>0.14149999618530273</c:v>
                </c:pt>
                <c:pt idx="3">
                  <c:v>0.16328333566586173</c:v>
                </c:pt>
                <c:pt idx="4">
                  <c:v>0.23133333772420883</c:v>
                </c:pt>
                <c:pt idx="5">
                  <c:v>0.2052666669090589</c:v>
                </c:pt>
                <c:pt idx="6">
                  <c:v>0.108816663424174</c:v>
                </c:pt>
                <c:pt idx="7">
                  <c:v>2.1500016252199807E-3</c:v>
                </c:pt>
                <c:pt idx="8">
                  <c:v>-4.4999991854032069E-3</c:v>
                </c:pt>
                <c:pt idx="9">
                  <c:v>4.68333326280117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1E-4FB8-A6CF-784FFE4D31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25897759"/>
        <c:axId val="1725893439"/>
      </c:lineChart>
      <c:catAx>
        <c:axId val="17258977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5893439"/>
        <c:crosses val="autoZero"/>
        <c:auto val="1"/>
        <c:lblAlgn val="ctr"/>
        <c:lblOffset val="100"/>
        <c:noMultiLvlLbl val="0"/>
      </c:catAx>
      <c:valAx>
        <c:axId val="1725893439"/>
        <c:scaling>
          <c:orientation val="minMax"/>
          <c:max val="0.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589775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17054692220866"/>
          <c:y val="5.1342663715337862E-2"/>
          <c:w val="0.89022462817147852"/>
          <c:h val="0.8644061679790026"/>
        </c:manualLayout>
      </c:layout>
      <c:lineChart>
        <c:grouping val="standard"/>
        <c:varyColors val="0"/>
        <c:ser>
          <c:idx val="0"/>
          <c:order val="0"/>
          <c:tx>
            <c:strRef>
              <c:f>計算!$CS$197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199:$DC$199</c:f>
                <c:numCache>
                  <c:formatCode>General</c:formatCode>
                  <c:ptCount val="10"/>
                  <c:pt idx="0">
                    <c:v>1.3228367805413354E-2</c:v>
                  </c:pt>
                  <c:pt idx="1">
                    <c:v>2.4370099123860112E-2</c:v>
                  </c:pt>
                  <c:pt idx="2">
                    <c:v>1.952356229879959E-2</c:v>
                  </c:pt>
                  <c:pt idx="3">
                    <c:v>1.837687673583056E-2</c:v>
                  </c:pt>
                  <c:pt idx="4">
                    <c:v>2.524305674746484E-2</c:v>
                  </c:pt>
                  <c:pt idx="5">
                    <c:v>3.0934750598149492E-2</c:v>
                  </c:pt>
                  <c:pt idx="6">
                    <c:v>4.6127598796505992E-2</c:v>
                  </c:pt>
                  <c:pt idx="7">
                    <c:v>2.6757473997845921E-2</c:v>
                  </c:pt>
                  <c:pt idx="8">
                    <c:v>3.6881144964292074E-2</c:v>
                  </c:pt>
                  <c:pt idx="9">
                    <c:v>1.0318799061638252E-2</c:v>
                  </c:pt>
                </c:numCache>
              </c:numRef>
            </c:plus>
            <c:minus>
              <c:numRef>
                <c:f>計算!$CT$199:$DC$199</c:f>
                <c:numCache>
                  <c:formatCode>General</c:formatCode>
                  <c:ptCount val="10"/>
                  <c:pt idx="0">
                    <c:v>1.3228367805413354E-2</c:v>
                  </c:pt>
                  <c:pt idx="1">
                    <c:v>2.4370099123860112E-2</c:v>
                  </c:pt>
                  <c:pt idx="2">
                    <c:v>1.952356229879959E-2</c:v>
                  </c:pt>
                  <c:pt idx="3">
                    <c:v>1.837687673583056E-2</c:v>
                  </c:pt>
                  <c:pt idx="4">
                    <c:v>2.524305674746484E-2</c:v>
                  </c:pt>
                  <c:pt idx="5">
                    <c:v>3.0934750598149492E-2</c:v>
                  </c:pt>
                  <c:pt idx="6">
                    <c:v>4.6127598796505992E-2</c:v>
                  </c:pt>
                  <c:pt idx="7">
                    <c:v>2.6757473997845921E-2</c:v>
                  </c:pt>
                  <c:pt idx="8">
                    <c:v>3.6881144964292074E-2</c:v>
                  </c:pt>
                  <c:pt idx="9">
                    <c:v>1.03187990616382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96:$DC$196</c:f>
              <c:numCache>
                <c:formatCode>General</c:formatCode>
                <c:ptCount val="10"/>
                <c:pt idx="0">
                  <c:v>0</c:v>
                </c:pt>
                <c:pt idx="1">
                  <c:v>1E-4</c:v>
                </c:pt>
                <c:pt idx="2">
                  <c:v>3.2000000000000003E-4</c:v>
                </c:pt>
                <c:pt idx="3">
                  <c:v>1E-3</c:v>
                </c:pt>
                <c:pt idx="4">
                  <c:v>3.2000000000000002E-3</c:v>
                </c:pt>
                <c:pt idx="5">
                  <c:v>0.01</c:v>
                </c:pt>
                <c:pt idx="6">
                  <c:v>3.2000000000000001E-2</c:v>
                </c:pt>
                <c:pt idx="7">
                  <c:v>0.1</c:v>
                </c:pt>
                <c:pt idx="8">
                  <c:v>0.32</c:v>
                </c:pt>
                <c:pt idx="9">
                  <c:v>1</c:v>
                </c:pt>
              </c:numCache>
            </c:numRef>
          </c:cat>
          <c:val>
            <c:numRef>
              <c:f>計算!$CT$197:$DC$197</c:f>
              <c:numCache>
                <c:formatCode>General</c:formatCode>
                <c:ptCount val="10"/>
                <c:pt idx="0">
                  <c:v>0.14268332843979201</c:v>
                </c:pt>
                <c:pt idx="1">
                  <c:v>0.2039166676501433</c:v>
                </c:pt>
                <c:pt idx="2">
                  <c:v>0.26248333230614662</c:v>
                </c:pt>
                <c:pt idx="3">
                  <c:v>0.34621666247646016</c:v>
                </c:pt>
                <c:pt idx="4">
                  <c:v>0.37039999539653462</c:v>
                </c:pt>
                <c:pt idx="5">
                  <c:v>0.35473332678278285</c:v>
                </c:pt>
                <c:pt idx="6">
                  <c:v>0.30554999783635139</c:v>
                </c:pt>
                <c:pt idx="7">
                  <c:v>0.2790333318213622</c:v>
                </c:pt>
                <c:pt idx="8">
                  <c:v>0.25756666188438732</c:v>
                </c:pt>
                <c:pt idx="9">
                  <c:v>0.199683332194884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F31-41D0-A0F7-43FD57AA91A2}"/>
            </c:ext>
          </c:extLst>
        </c:ser>
        <c:ser>
          <c:idx val="1"/>
          <c:order val="1"/>
          <c:tx>
            <c:strRef>
              <c:f>計算!$CS$198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00:$DC$200</c:f>
                <c:numCache>
                  <c:formatCode>General</c:formatCode>
                  <c:ptCount val="10"/>
                  <c:pt idx="0">
                    <c:v>1.3228367805413354E-2</c:v>
                  </c:pt>
                  <c:pt idx="1">
                    <c:v>2.4370099123860338E-2</c:v>
                  </c:pt>
                  <c:pt idx="2">
                    <c:v>1.952356229879959E-2</c:v>
                  </c:pt>
                  <c:pt idx="3">
                    <c:v>1.837687673583056E-2</c:v>
                  </c:pt>
                  <c:pt idx="4">
                    <c:v>2.524305674746484E-2</c:v>
                  </c:pt>
                  <c:pt idx="5">
                    <c:v>3.0934750598149492E-2</c:v>
                  </c:pt>
                  <c:pt idx="6">
                    <c:v>4.6127598796505992E-2</c:v>
                  </c:pt>
                  <c:pt idx="7">
                    <c:v>2.6757473997845921E-2</c:v>
                  </c:pt>
                  <c:pt idx="8">
                    <c:v>3.6881144964292227E-2</c:v>
                  </c:pt>
                  <c:pt idx="9">
                    <c:v>1.0318799061638252E-2</c:v>
                  </c:pt>
                </c:numCache>
              </c:numRef>
            </c:plus>
            <c:minus>
              <c:numRef>
                <c:f>計算!$CT$200:$DC$200</c:f>
                <c:numCache>
                  <c:formatCode>General</c:formatCode>
                  <c:ptCount val="10"/>
                  <c:pt idx="0">
                    <c:v>1.3228367805413354E-2</c:v>
                  </c:pt>
                  <c:pt idx="1">
                    <c:v>2.4370099123860338E-2</c:v>
                  </c:pt>
                  <c:pt idx="2">
                    <c:v>1.952356229879959E-2</c:v>
                  </c:pt>
                  <c:pt idx="3">
                    <c:v>1.837687673583056E-2</c:v>
                  </c:pt>
                  <c:pt idx="4">
                    <c:v>2.524305674746484E-2</c:v>
                  </c:pt>
                  <c:pt idx="5">
                    <c:v>3.0934750598149492E-2</c:v>
                  </c:pt>
                  <c:pt idx="6">
                    <c:v>4.6127598796505992E-2</c:v>
                  </c:pt>
                  <c:pt idx="7">
                    <c:v>2.6757473997845921E-2</c:v>
                  </c:pt>
                  <c:pt idx="8">
                    <c:v>3.6881144964292227E-2</c:v>
                  </c:pt>
                  <c:pt idx="9">
                    <c:v>1.03187990616382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196:$DC$196</c:f>
              <c:numCache>
                <c:formatCode>General</c:formatCode>
                <c:ptCount val="10"/>
                <c:pt idx="0">
                  <c:v>0</c:v>
                </c:pt>
                <c:pt idx="1">
                  <c:v>1E-4</c:v>
                </c:pt>
                <c:pt idx="2">
                  <c:v>3.2000000000000003E-4</c:v>
                </c:pt>
                <c:pt idx="3">
                  <c:v>1E-3</c:v>
                </c:pt>
                <c:pt idx="4">
                  <c:v>3.2000000000000002E-3</c:v>
                </c:pt>
                <c:pt idx="5">
                  <c:v>0.01</c:v>
                </c:pt>
                <c:pt idx="6">
                  <c:v>3.2000000000000001E-2</c:v>
                </c:pt>
                <c:pt idx="7">
                  <c:v>0.1</c:v>
                </c:pt>
                <c:pt idx="8">
                  <c:v>0.32</c:v>
                </c:pt>
                <c:pt idx="9">
                  <c:v>1</c:v>
                </c:pt>
              </c:numCache>
            </c:numRef>
          </c:cat>
          <c:val>
            <c:numRef>
              <c:f>計算!$CT$198:$DC$198</c:f>
              <c:numCache>
                <c:formatCode>General</c:formatCode>
                <c:ptCount val="10"/>
                <c:pt idx="0">
                  <c:v>0.14268332843979201</c:v>
                </c:pt>
                <c:pt idx="1">
                  <c:v>0.17484999820590016</c:v>
                </c:pt>
                <c:pt idx="2">
                  <c:v>0.23189999535679817</c:v>
                </c:pt>
                <c:pt idx="3">
                  <c:v>0.29344999417662615</c:v>
                </c:pt>
                <c:pt idx="4">
                  <c:v>0.3273833307127158</c:v>
                </c:pt>
                <c:pt idx="5">
                  <c:v>0.30758332833647722</c:v>
                </c:pt>
                <c:pt idx="6">
                  <c:v>0.25513332709670067</c:v>
                </c:pt>
                <c:pt idx="7">
                  <c:v>0.25039999807874364</c:v>
                </c:pt>
                <c:pt idx="8">
                  <c:v>0.23076666022340453</c:v>
                </c:pt>
                <c:pt idx="9">
                  <c:v>0.20618333046634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F31-41D0-A0F7-43FD57AA91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25895359"/>
        <c:axId val="1725899199"/>
      </c:lineChart>
      <c:catAx>
        <c:axId val="17258953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5899199"/>
        <c:crosses val="autoZero"/>
        <c:auto val="1"/>
        <c:lblAlgn val="ctr"/>
        <c:lblOffset val="100"/>
        <c:noMultiLvlLbl val="0"/>
      </c:catAx>
      <c:valAx>
        <c:axId val="1725899199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589535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22046994747518"/>
          <c:y val="3.9110582036977468E-2"/>
          <c:w val="0.68369855161923232"/>
          <c:h val="0.86903579760863225"/>
        </c:manualLayout>
      </c:layout>
      <c:lineChart>
        <c:grouping val="standard"/>
        <c:varyColors val="0"/>
        <c:ser>
          <c:idx val="0"/>
          <c:order val="0"/>
          <c:tx>
            <c:strRef>
              <c:f>計算!$CS$213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15:$DC$215</c:f>
                <c:numCache>
                  <c:formatCode>General</c:formatCode>
                  <c:ptCount val="10"/>
                  <c:pt idx="0">
                    <c:v>2.3621154959009318E-2</c:v>
                  </c:pt>
                  <c:pt idx="1">
                    <c:v>2.2370467444984568E-2</c:v>
                  </c:pt>
                  <c:pt idx="2">
                    <c:v>1.9148448964002498E-2</c:v>
                  </c:pt>
                  <c:pt idx="3">
                    <c:v>4.3986077789634821E-2</c:v>
                  </c:pt>
                  <c:pt idx="4">
                    <c:v>2.4299606710930632E-2</c:v>
                  </c:pt>
                  <c:pt idx="5">
                    <c:v>3.6040409930383738E-2</c:v>
                  </c:pt>
                  <c:pt idx="6">
                    <c:v>4.6973937723609624E-2</c:v>
                  </c:pt>
                  <c:pt idx="7">
                    <c:v>3.7997149968133248E-2</c:v>
                  </c:pt>
                  <c:pt idx="8">
                    <c:v>5.3421298556069217E-2</c:v>
                  </c:pt>
                  <c:pt idx="9">
                    <c:v>2.7727310903984136E-2</c:v>
                  </c:pt>
                </c:numCache>
              </c:numRef>
            </c:plus>
            <c:minus>
              <c:numRef>
                <c:f>計算!$CT$215:$DC$215</c:f>
                <c:numCache>
                  <c:formatCode>General</c:formatCode>
                  <c:ptCount val="10"/>
                  <c:pt idx="0">
                    <c:v>2.3621154959009318E-2</c:v>
                  </c:pt>
                  <c:pt idx="1">
                    <c:v>2.2370467444984568E-2</c:v>
                  </c:pt>
                  <c:pt idx="2">
                    <c:v>1.9148448964002498E-2</c:v>
                  </c:pt>
                  <c:pt idx="3">
                    <c:v>4.3986077789634821E-2</c:v>
                  </c:pt>
                  <c:pt idx="4">
                    <c:v>2.4299606710930632E-2</c:v>
                  </c:pt>
                  <c:pt idx="5">
                    <c:v>3.6040409930383738E-2</c:v>
                  </c:pt>
                  <c:pt idx="6">
                    <c:v>4.6973937723609624E-2</c:v>
                  </c:pt>
                  <c:pt idx="7">
                    <c:v>3.7997149968133248E-2</c:v>
                  </c:pt>
                  <c:pt idx="8">
                    <c:v>5.3421298556069217E-2</c:v>
                  </c:pt>
                  <c:pt idx="9">
                    <c:v>2.77273109039841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12:$DC$212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T$213:$DC$213</c:f>
              <c:numCache>
                <c:formatCode>General</c:formatCode>
                <c:ptCount val="10"/>
                <c:pt idx="0">
                  <c:v>0.40554999684294063</c:v>
                </c:pt>
                <c:pt idx="1">
                  <c:v>0.41998333608110744</c:v>
                </c:pt>
                <c:pt idx="2">
                  <c:v>0.45605000232656795</c:v>
                </c:pt>
                <c:pt idx="3">
                  <c:v>0.45313333347439766</c:v>
                </c:pt>
                <c:pt idx="4">
                  <c:v>0.4330499954521656</c:v>
                </c:pt>
                <c:pt idx="5">
                  <c:v>0.45883333062132198</c:v>
                </c:pt>
                <c:pt idx="6">
                  <c:v>0.44923334196209908</c:v>
                </c:pt>
                <c:pt idx="7">
                  <c:v>0.42769999677936238</c:v>
                </c:pt>
                <c:pt idx="8">
                  <c:v>0.42776666457454365</c:v>
                </c:pt>
                <c:pt idx="9">
                  <c:v>0.40790000930428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E57-43EE-9B4B-FFB922957E01}"/>
            </c:ext>
          </c:extLst>
        </c:ser>
        <c:ser>
          <c:idx val="1"/>
          <c:order val="1"/>
          <c:tx>
            <c:strRef>
              <c:f>計算!$CS$214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16:$DC$216</c:f>
                <c:numCache>
                  <c:formatCode>General</c:formatCode>
                  <c:ptCount val="10"/>
                  <c:pt idx="0">
                    <c:v>2.3621154959009318E-2</c:v>
                  </c:pt>
                  <c:pt idx="1">
                    <c:v>2.2370467444984568E-2</c:v>
                  </c:pt>
                  <c:pt idx="2">
                    <c:v>1.9148448964002498E-2</c:v>
                  </c:pt>
                  <c:pt idx="3">
                    <c:v>4.3986077789634821E-2</c:v>
                  </c:pt>
                  <c:pt idx="4">
                    <c:v>2.4299606710930632E-2</c:v>
                  </c:pt>
                  <c:pt idx="5">
                    <c:v>3.6040409930383738E-2</c:v>
                  </c:pt>
                  <c:pt idx="6">
                    <c:v>4.6973937723609152E-2</c:v>
                  </c:pt>
                  <c:pt idx="7">
                    <c:v>3.7997149968133248E-2</c:v>
                  </c:pt>
                  <c:pt idx="8">
                    <c:v>5.3421298556069835E-2</c:v>
                  </c:pt>
                  <c:pt idx="9">
                    <c:v>2.7727310903984136E-2</c:v>
                  </c:pt>
                </c:numCache>
              </c:numRef>
            </c:plus>
            <c:minus>
              <c:numRef>
                <c:f>計算!$CT$216:$DC$216</c:f>
                <c:numCache>
                  <c:formatCode>General</c:formatCode>
                  <c:ptCount val="10"/>
                  <c:pt idx="0">
                    <c:v>2.3621154959009318E-2</c:v>
                  </c:pt>
                  <c:pt idx="1">
                    <c:v>2.2370467444984568E-2</c:v>
                  </c:pt>
                  <c:pt idx="2">
                    <c:v>1.9148448964002498E-2</c:v>
                  </c:pt>
                  <c:pt idx="3">
                    <c:v>4.3986077789634821E-2</c:v>
                  </c:pt>
                  <c:pt idx="4">
                    <c:v>2.4299606710930632E-2</c:v>
                  </c:pt>
                  <c:pt idx="5">
                    <c:v>3.6040409930383738E-2</c:v>
                  </c:pt>
                  <c:pt idx="6">
                    <c:v>4.6973937723609152E-2</c:v>
                  </c:pt>
                  <c:pt idx="7">
                    <c:v>3.7997149968133248E-2</c:v>
                  </c:pt>
                  <c:pt idx="8">
                    <c:v>5.3421298556069835E-2</c:v>
                  </c:pt>
                  <c:pt idx="9">
                    <c:v>2.77273109039841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12:$DC$212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計算!$CT$214:$DC$214</c:f>
              <c:numCache>
                <c:formatCode>General</c:formatCode>
                <c:ptCount val="10"/>
                <c:pt idx="0">
                  <c:v>0.40554999684294063</c:v>
                </c:pt>
                <c:pt idx="1">
                  <c:v>0.40554999684294063</c:v>
                </c:pt>
                <c:pt idx="2">
                  <c:v>0.40554999684294063</c:v>
                </c:pt>
                <c:pt idx="3">
                  <c:v>0.40554999684294063</c:v>
                </c:pt>
                <c:pt idx="4">
                  <c:v>0.40554999684294063</c:v>
                </c:pt>
                <c:pt idx="5">
                  <c:v>0.40554999684294063</c:v>
                </c:pt>
                <c:pt idx="6">
                  <c:v>0.40554999684294063</c:v>
                </c:pt>
                <c:pt idx="7">
                  <c:v>0.40554999684294057</c:v>
                </c:pt>
                <c:pt idx="8">
                  <c:v>0.40554999684294057</c:v>
                </c:pt>
                <c:pt idx="9">
                  <c:v>0.405549996842940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E57-43EE-9B4B-FFB922957E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5701327"/>
        <c:axId val="1735702287"/>
      </c:lineChart>
      <c:catAx>
        <c:axId val="17357013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702287"/>
        <c:crosses val="autoZero"/>
        <c:auto val="1"/>
        <c:lblAlgn val="ctr"/>
        <c:lblOffset val="100"/>
        <c:noMultiLvlLbl val="0"/>
      </c:catAx>
      <c:valAx>
        <c:axId val="1735702287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701327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623586340689139"/>
          <c:y val="0.5243338740669764"/>
          <c:w val="0.73444033684284471"/>
          <c:h val="0.256746411977106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61505736274236"/>
          <c:y val="3.4398041752246228E-2"/>
          <c:w val="0.88389129483814521"/>
          <c:h val="0.85878062117235343"/>
        </c:manualLayout>
      </c:layout>
      <c:lineChart>
        <c:grouping val="standard"/>
        <c:varyColors val="0"/>
        <c:ser>
          <c:idx val="0"/>
          <c:order val="0"/>
          <c:tx>
            <c:strRef>
              <c:f>計算!$CS$226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28:$DC$228</c:f>
                <c:numCache>
                  <c:formatCode>General</c:formatCode>
                  <c:ptCount val="10"/>
                  <c:pt idx="0">
                    <c:v>2.3224618713447009E-2</c:v>
                  </c:pt>
                  <c:pt idx="1">
                    <c:v>1.340770315136324E-2</c:v>
                  </c:pt>
                  <c:pt idx="2">
                    <c:v>1.9126390313905124E-2</c:v>
                  </c:pt>
                  <c:pt idx="3">
                    <c:v>2.6159168065262361E-2</c:v>
                  </c:pt>
                  <c:pt idx="4">
                    <c:v>1.6596869578664582E-2</c:v>
                  </c:pt>
                  <c:pt idx="5">
                    <c:v>2.1730778991143545E-2</c:v>
                  </c:pt>
                  <c:pt idx="6">
                    <c:v>2.6805876110254961E-2</c:v>
                  </c:pt>
                  <c:pt idx="7">
                    <c:v>1.9526898653468943E-2</c:v>
                  </c:pt>
                  <c:pt idx="8">
                    <c:v>3.1899830644486001E-3</c:v>
                  </c:pt>
                  <c:pt idx="9">
                    <c:v>2.6033952825796061E-3</c:v>
                  </c:pt>
                </c:numCache>
              </c:numRef>
            </c:plus>
            <c:minus>
              <c:numRef>
                <c:f>計算!$CT$228:$DC$228</c:f>
                <c:numCache>
                  <c:formatCode>General</c:formatCode>
                  <c:ptCount val="10"/>
                  <c:pt idx="0">
                    <c:v>2.3224618713447009E-2</c:v>
                  </c:pt>
                  <c:pt idx="1">
                    <c:v>1.340770315136324E-2</c:v>
                  </c:pt>
                  <c:pt idx="2">
                    <c:v>1.9126390313905124E-2</c:v>
                  </c:pt>
                  <c:pt idx="3">
                    <c:v>2.6159168065262361E-2</c:v>
                  </c:pt>
                  <c:pt idx="4">
                    <c:v>1.6596869578664582E-2</c:v>
                  </c:pt>
                  <c:pt idx="5">
                    <c:v>2.1730778991143545E-2</c:v>
                  </c:pt>
                  <c:pt idx="6">
                    <c:v>2.6805876110254961E-2</c:v>
                  </c:pt>
                  <c:pt idx="7">
                    <c:v>1.9526898653468943E-2</c:v>
                  </c:pt>
                  <c:pt idx="8">
                    <c:v>3.1899830644486001E-3</c:v>
                  </c:pt>
                  <c:pt idx="9">
                    <c:v>2.603395282579606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25:$DC$225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26:$DC$226</c:f>
              <c:numCache>
                <c:formatCode>General</c:formatCode>
                <c:ptCount val="10"/>
                <c:pt idx="0">
                  <c:v>0.37643333400289219</c:v>
                </c:pt>
                <c:pt idx="1">
                  <c:v>0.38326666876673698</c:v>
                </c:pt>
                <c:pt idx="2">
                  <c:v>0.37806667014956474</c:v>
                </c:pt>
                <c:pt idx="3">
                  <c:v>0.41278334086139995</c:v>
                </c:pt>
                <c:pt idx="4">
                  <c:v>0.39940000201265019</c:v>
                </c:pt>
                <c:pt idx="5">
                  <c:v>0.38593333090345067</c:v>
                </c:pt>
                <c:pt idx="6">
                  <c:v>0.39676666880647343</c:v>
                </c:pt>
                <c:pt idx="7">
                  <c:v>0.17339999849597612</c:v>
                </c:pt>
                <c:pt idx="8">
                  <c:v>5.4000013818343478E-3</c:v>
                </c:pt>
                <c:pt idx="9">
                  <c:v>6.7833339174588518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E79-47AC-B0D7-79B8660BC982}"/>
            </c:ext>
          </c:extLst>
        </c:ser>
        <c:ser>
          <c:idx val="1"/>
          <c:order val="1"/>
          <c:tx>
            <c:strRef>
              <c:f>計算!$CS$227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29:$DC$229</c:f>
                <c:numCache>
                  <c:formatCode>General</c:formatCode>
                  <c:ptCount val="10"/>
                  <c:pt idx="0">
                    <c:v>2.3224618713447009E-2</c:v>
                  </c:pt>
                  <c:pt idx="1">
                    <c:v>1.340770315136324E-2</c:v>
                  </c:pt>
                  <c:pt idx="2">
                    <c:v>1.9126390313905124E-2</c:v>
                  </c:pt>
                  <c:pt idx="3">
                    <c:v>2.6159168065262361E-2</c:v>
                  </c:pt>
                  <c:pt idx="4">
                    <c:v>1.6596869578664582E-2</c:v>
                  </c:pt>
                  <c:pt idx="5">
                    <c:v>2.1730778991143545E-2</c:v>
                  </c:pt>
                  <c:pt idx="6">
                    <c:v>2.6805876110254961E-2</c:v>
                  </c:pt>
                  <c:pt idx="7">
                    <c:v>1.9526898653468943E-2</c:v>
                  </c:pt>
                  <c:pt idx="8">
                    <c:v>3.1899830644486001E-3</c:v>
                  </c:pt>
                  <c:pt idx="9">
                    <c:v>2.6033952825796061E-3</c:v>
                  </c:pt>
                </c:numCache>
              </c:numRef>
            </c:plus>
            <c:minus>
              <c:numRef>
                <c:f>計算!$CT$229:$DC$229</c:f>
                <c:numCache>
                  <c:formatCode>General</c:formatCode>
                  <c:ptCount val="10"/>
                  <c:pt idx="0">
                    <c:v>2.3224618713447009E-2</c:v>
                  </c:pt>
                  <c:pt idx="1">
                    <c:v>1.340770315136324E-2</c:v>
                  </c:pt>
                  <c:pt idx="2">
                    <c:v>1.9126390313905124E-2</c:v>
                  </c:pt>
                  <c:pt idx="3">
                    <c:v>2.6159168065262361E-2</c:v>
                  </c:pt>
                  <c:pt idx="4">
                    <c:v>1.6596869578664582E-2</c:v>
                  </c:pt>
                  <c:pt idx="5">
                    <c:v>2.1730778991143545E-2</c:v>
                  </c:pt>
                  <c:pt idx="6">
                    <c:v>2.6805876110254961E-2</c:v>
                  </c:pt>
                  <c:pt idx="7">
                    <c:v>1.9526898653468943E-2</c:v>
                  </c:pt>
                  <c:pt idx="8">
                    <c:v>3.1899830644486001E-3</c:v>
                  </c:pt>
                  <c:pt idx="9">
                    <c:v>2.603395282579606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25:$DC$225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27:$DC$227</c:f>
              <c:numCache>
                <c:formatCode>General</c:formatCode>
                <c:ptCount val="10"/>
                <c:pt idx="0">
                  <c:v>0.37643333400289214</c:v>
                </c:pt>
                <c:pt idx="1">
                  <c:v>0.36883332952857018</c:v>
                </c:pt>
                <c:pt idx="2">
                  <c:v>0.32756666466593742</c:v>
                </c:pt>
                <c:pt idx="3">
                  <c:v>0.36520000422994292</c:v>
                </c:pt>
                <c:pt idx="4">
                  <c:v>0.37190000340342522</c:v>
                </c:pt>
                <c:pt idx="5">
                  <c:v>0.33264999712506926</c:v>
                </c:pt>
                <c:pt idx="6">
                  <c:v>0.35308332368731499</c:v>
                </c:pt>
                <c:pt idx="7">
                  <c:v>0.15124999855955437</c:v>
                </c:pt>
                <c:pt idx="8">
                  <c:v>-1.6816666349768677E-2</c:v>
                </c:pt>
                <c:pt idx="9">
                  <c:v>4.4333214561144323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E79-47AC-B0D7-79B8660BC9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558959"/>
        <c:axId val="1655573839"/>
      </c:lineChart>
      <c:catAx>
        <c:axId val="16555589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73839"/>
        <c:crosses val="autoZero"/>
        <c:auto val="1"/>
        <c:lblAlgn val="ctr"/>
        <c:lblOffset val="100"/>
        <c:noMultiLvlLbl val="0"/>
      </c:catAx>
      <c:valAx>
        <c:axId val="1655573839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5895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3.9027777777777779E-2"/>
          <c:w val="0.88389129483814521"/>
          <c:h val="0.85357283464566924"/>
        </c:manualLayout>
      </c:layout>
      <c:lineChart>
        <c:grouping val="standard"/>
        <c:varyColors val="0"/>
        <c:ser>
          <c:idx val="0"/>
          <c:order val="0"/>
          <c:tx>
            <c:strRef>
              <c:f>計算!$CS$250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52:$DC$252</c:f>
                <c:numCache>
                  <c:formatCode>General</c:formatCode>
                  <c:ptCount val="10"/>
                  <c:pt idx="0">
                    <c:v>2.7455541997997261E-2</c:v>
                  </c:pt>
                  <c:pt idx="1">
                    <c:v>2.3254228941873335E-2</c:v>
                  </c:pt>
                  <c:pt idx="2">
                    <c:v>2.1435983898911708E-2</c:v>
                  </c:pt>
                  <c:pt idx="3">
                    <c:v>3.8504651331049924E-2</c:v>
                  </c:pt>
                  <c:pt idx="4">
                    <c:v>4.4499338486317389E-2</c:v>
                  </c:pt>
                  <c:pt idx="5">
                    <c:v>1.0723556671100457E-2</c:v>
                  </c:pt>
                  <c:pt idx="6">
                    <c:v>1.2685014628922266E-2</c:v>
                  </c:pt>
                  <c:pt idx="7">
                    <c:v>2.081868573852938E-2</c:v>
                  </c:pt>
                  <c:pt idx="8">
                    <c:v>2.3619209474068361E-3</c:v>
                  </c:pt>
                  <c:pt idx="9">
                    <c:v>2.2205101693326883E-3</c:v>
                  </c:pt>
                </c:numCache>
              </c:numRef>
            </c:plus>
            <c:minus>
              <c:numRef>
                <c:f>計算!$CT$252:$DC$252</c:f>
                <c:numCache>
                  <c:formatCode>General</c:formatCode>
                  <c:ptCount val="10"/>
                  <c:pt idx="0">
                    <c:v>2.7455541997997261E-2</c:v>
                  </c:pt>
                  <c:pt idx="1">
                    <c:v>2.3254228941873335E-2</c:v>
                  </c:pt>
                  <c:pt idx="2">
                    <c:v>2.1435983898911708E-2</c:v>
                  </c:pt>
                  <c:pt idx="3">
                    <c:v>3.8504651331049924E-2</c:v>
                  </c:pt>
                  <c:pt idx="4">
                    <c:v>4.4499338486317389E-2</c:v>
                  </c:pt>
                  <c:pt idx="5">
                    <c:v>1.0723556671100457E-2</c:v>
                  </c:pt>
                  <c:pt idx="6">
                    <c:v>1.2685014628922266E-2</c:v>
                  </c:pt>
                  <c:pt idx="7">
                    <c:v>2.081868573852938E-2</c:v>
                  </c:pt>
                  <c:pt idx="8">
                    <c:v>2.3619209474068361E-3</c:v>
                  </c:pt>
                  <c:pt idx="9">
                    <c:v>2.220510169332688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49:$DC$249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50:$DC$250</c:f>
              <c:numCache>
                <c:formatCode>General</c:formatCode>
                <c:ptCount val="10"/>
                <c:pt idx="0">
                  <c:v>0.32926666860779125</c:v>
                </c:pt>
                <c:pt idx="1">
                  <c:v>0.36445000395178795</c:v>
                </c:pt>
                <c:pt idx="2">
                  <c:v>0.36898333951830864</c:v>
                </c:pt>
                <c:pt idx="3">
                  <c:v>0.37919999783237773</c:v>
                </c:pt>
                <c:pt idx="4">
                  <c:v>0.41896667207280797</c:v>
                </c:pt>
                <c:pt idx="5">
                  <c:v>0.36036666855216026</c:v>
                </c:pt>
                <c:pt idx="6">
                  <c:v>0.14551666751503944</c:v>
                </c:pt>
                <c:pt idx="7">
                  <c:v>0.10398333643873532</c:v>
                </c:pt>
                <c:pt idx="8">
                  <c:v>3.0166668196519215E-2</c:v>
                </c:pt>
                <c:pt idx="9">
                  <c:v>4.376666868726412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B4B-4036-B167-71B9558FF4CD}"/>
            </c:ext>
          </c:extLst>
        </c:ser>
        <c:ser>
          <c:idx val="1"/>
          <c:order val="1"/>
          <c:tx>
            <c:strRef>
              <c:f>計算!$CS$251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52:$DC$252</c:f>
                <c:numCache>
                  <c:formatCode>General</c:formatCode>
                  <c:ptCount val="10"/>
                  <c:pt idx="0">
                    <c:v>2.7455541997997261E-2</c:v>
                  </c:pt>
                  <c:pt idx="1">
                    <c:v>2.3254228941873335E-2</c:v>
                  </c:pt>
                  <c:pt idx="2">
                    <c:v>2.1435983898911708E-2</c:v>
                  </c:pt>
                  <c:pt idx="3">
                    <c:v>3.8504651331049924E-2</c:v>
                  </c:pt>
                  <c:pt idx="4">
                    <c:v>4.4499338486317389E-2</c:v>
                  </c:pt>
                  <c:pt idx="5">
                    <c:v>1.0723556671100457E-2</c:v>
                  </c:pt>
                  <c:pt idx="6">
                    <c:v>1.2685014628922266E-2</c:v>
                  </c:pt>
                  <c:pt idx="7">
                    <c:v>2.081868573852938E-2</c:v>
                  </c:pt>
                  <c:pt idx="8">
                    <c:v>2.3619209474068361E-3</c:v>
                  </c:pt>
                  <c:pt idx="9">
                    <c:v>2.2205101693326883E-3</c:v>
                  </c:pt>
                </c:numCache>
              </c:numRef>
            </c:plus>
            <c:minus>
              <c:numRef>
                <c:f>計算!$CT$252:$DC$252</c:f>
                <c:numCache>
                  <c:formatCode>General</c:formatCode>
                  <c:ptCount val="10"/>
                  <c:pt idx="0">
                    <c:v>2.7455541997997261E-2</c:v>
                  </c:pt>
                  <c:pt idx="1">
                    <c:v>2.3254228941873335E-2</c:v>
                  </c:pt>
                  <c:pt idx="2">
                    <c:v>2.1435983898911708E-2</c:v>
                  </c:pt>
                  <c:pt idx="3">
                    <c:v>3.8504651331049924E-2</c:v>
                  </c:pt>
                  <c:pt idx="4">
                    <c:v>4.4499338486317389E-2</c:v>
                  </c:pt>
                  <c:pt idx="5">
                    <c:v>1.0723556671100457E-2</c:v>
                  </c:pt>
                  <c:pt idx="6">
                    <c:v>1.2685014628922266E-2</c:v>
                  </c:pt>
                  <c:pt idx="7">
                    <c:v>2.081868573852938E-2</c:v>
                  </c:pt>
                  <c:pt idx="8">
                    <c:v>2.3619209474068361E-3</c:v>
                  </c:pt>
                  <c:pt idx="9">
                    <c:v>2.220510169332688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49:$DC$249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51:$DC$251</c:f>
              <c:numCache>
                <c:formatCode>General</c:formatCode>
                <c:ptCount val="10"/>
                <c:pt idx="0">
                  <c:v>0.32926666860779125</c:v>
                </c:pt>
                <c:pt idx="1">
                  <c:v>0.35001666471362114</c:v>
                </c:pt>
                <c:pt idx="2">
                  <c:v>0.31848333403468132</c:v>
                </c:pt>
                <c:pt idx="3">
                  <c:v>0.3316166612009207</c:v>
                </c:pt>
                <c:pt idx="4">
                  <c:v>0.39146667346358299</c:v>
                </c:pt>
                <c:pt idx="5">
                  <c:v>0.30708333477377892</c:v>
                </c:pt>
                <c:pt idx="6">
                  <c:v>0.101833322395881</c:v>
                </c:pt>
                <c:pt idx="7">
                  <c:v>8.1833336502313572E-2</c:v>
                </c:pt>
                <c:pt idx="8">
                  <c:v>7.9500004649161928E-3</c:v>
                </c:pt>
                <c:pt idx="9">
                  <c:v>4.14166562259197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B4B-4036-B167-71B9558FF4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562799"/>
        <c:axId val="1655563759"/>
      </c:lineChart>
      <c:catAx>
        <c:axId val="16555627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63759"/>
        <c:crosses val="autoZero"/>
        <c:auto val="1"/>
        <c:lblAlgn val="ctr"/>
        <c:lblOffset val="100"/>
        <c:noMultiLvlLbl val="0"/>
      </c:catAx>
      <c:valAx>
        <c:axId val="1655563759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6279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34588865683337"/>
          <c:y val="2.6817220764071156E-2"/>
          <c:w val="0.87755796150481191"/>
          <c:h val="0.86961395450568679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BU$134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^N1610.2025.04.30.xlsx]計算'!$BV$133:$CE$133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BV$134:$CE$134</c:f>
              <c:numCache>
                <c:formatCode>General</c:formatCode>
                <c:ptCount val="10"/>
                <c:pt idx="0">
                  <c:v>0.24998333429296812</c:v>
                </c:pt>
                <c:pt idx="1">
                  <c:v>0.21961333528161048</c:v>
                </c:pt>
                <c:pt idx="2">
                  <c:v>0.20998333767056465</c:v>
                </c:pt>
                <c:pt idx="3">
                  <c:v>0.23539999003211654</c:v>
                </c:pt>
                <c:pt idx="4">
                  <c:v>0.26896665369470918</c:v>
                </c:pt>
                <c:pt idx="5">
                  <c:v>0.24504999692241353</c:v>
                </c:pt>
                <c:pt idx="6">
                  <c:v>0.30841666335860884</c:v>
                </c:pt>
                <c:pt idx="7">
                  <c:v>0.29419999197125435</c:v>
                </c:pt>
                <c:pt idx="8">
                  <c:v>7.0066656917333603E-2</c:v>
                </c:pt>
                <c:pt idx="9">
                  <c:v>4.383332779010138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14B-4A25-922B-DBE4A1CED0C9}"/>
            </c:ext>
          </c:extLst>
        </c:ser>
        <c:ser>
          <c:idx val="1"/>
          <c:order val="1"/>
          <c:tx>
            <c:strRef>
              <c:f>'[^N1610.2025.04.30.xlsx]計算'!$BU$135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^N1610.2025.04.30.xlsx]計算'!$BV$133:$CE$133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BV$135:$CE$135</c:f>
              <c:numCache>
                <c:formatCode>General</c:formatCode>
                <c:ptCount val="10"/>
                <c:pt idx="0">
                  <c:v>0.2589000016450882</c:v>
                </c:pt>
                <c:pt idx="1">
                  <c:v>0.296916663646698</c:v>
                </c:pt>
                <c:pt idx="2">
                  <c:v>0.26829999685287476</c:v>
                </c:pt>
                <c:pt idx="3">
                  <c:v>0.27545000116030377</c:v>
                </c:pt>
                <c:pt idx="4">
                  <c:v>0.29309999942779541</c:v>
                </c:pt>
                <c:pt idx="5">
                  <c:v>0.35966666539510095</c:v>
                </c:pt>
                <c:pt idx="6">
                  <c:v>0.36634999513626099</c:v>
                </c:pt>
                <c:pt idx="7">
                  <c:v>0.31740000347296399</c:v>
                </c:pt>
                <c:pt idx="8">
                  <c:v>0.10926667352517447</c:v>
                </c:pt>
                <c:pt idx="9">
                  <c:v>5.643333246310550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14B-4A25-922B-DBE4A1CED0C9}"/>
            </c:ext>
          </c:extLst>
        </c:ser>
        <c:ser>
          <c:idx val="2"/>
          <c:order val="2"/>
          <c:tx>
            <c:strRef>
              <c:f>'[^N1610.2025.04.30.xlsx]計算'!$BU$136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[^N1610.2025.04.30.xlsx]計算'!$BV$133:$CE$133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BV$136:$CE$136</c:f>
              <c:numCache>
                <c:formatCode>General</c:formatCode>
                <c:ptCount val="10"/>
                <c:pt idx="0">
                  <c:v>0.34326666841904324</c:v>
                </c:pt>
                <c:pt idx="1">
                  <c:v>0.33081665883461636</c:v>
                </c:pt>
                <c:pt idx="2">
                  <c:v>0.36824999004602432</c:v>
                </c:pt>
                <c:pt idx="3">
                  <c:v>0.33451666186253232</c:v>
                </c:pt>
                <c:pt idx="4">
                  <c:v>0.38254999866088235</c:v>
                </c:pt>
                <c:pt idx="5">
                  <c:v>0.39229999730984372</c:v>
                </c:pt>
                <c:pt idx="6">
                  <c:v>0.41838334252436959</c:v>
                </c:pt>
                <c:pt idx="7">
                  <c:v>0.47231665501991915</c:v>
                </c:pt>
                <c:pt idx="8">
                  <c:v>0.23928332577149075</c:v>
                </c:pt>
                <c:pt idx="9">
                  <c:v>0.153049995501836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14B-4A25-922B-DBE4A1CED0C9}"/>
            </c:ext>
          </c:extLst>
        </c:ser>
        <c:ser>
          <c:idx val="3"/>
          <c:order val="3"/>
          <c:tx>
            <c:strRef>
              <c:f>'[^N1610.2025.04.30.xlsx]計算'!$BU$137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[^N1610.2025.04.30.xlsx]計算'!$BV$133:$CE$133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^N1610.2025.04.30.xlsx]計算'!$BV$137:$CE$137</c:f>
              <c:numCache>
                <c:formatCode>General</c:formatCode>
                <c:ptCount val="10"/>
                <c:pt idx="0">
                  <c:v>0.3577750027179718</c:v>
                </c:pt>
                <c:pt idx="1">
                  <c:v>0.36373333881298697</c:v>
                </c:pt>
                <c:pt idx="2">
                  <c:v>0.4195083230733872</c:v>
                </c:pt>
                <c:pt idx="3">
                  <c:v>0.44135833779970807</c:v>
                </c:pt>
                <c:pt idx="4">
                  <c:v>0.44282500445842743</c:v>
                </c:pt>
                <c:pt idx="5">
                  <c:v>0.45494166513284051</c:v>
                </c:pt>
                <c:pt idx="6">
                  <c:v>0.48832500477631891</c:v>
                </c:pt>
                <c:pt idx="7">
                  <c:v>0.48257499436537432</c:v>
                </c:pt>
                <c:pt idx="8">
                  <c:v>0.28935832281907403</c:v>
                </c:pt>
                <c:pt idx="9">
                  <c:v>0.269208341836929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14B-4A25-922B-DBE4A1CED0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3217840"/>
        <c:axId val="1393211600"/>
      </c:lineChart>
      <c:catAx>
        <c:axId val="1393217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3211600"/>
        <c:crosses val="autoZero"/>
        <c:auto val="1"/>
        <c:lblAlgn val="ctr"/>
        <c:lblOffset val="100"/>
        <c:noMultiLvlLbl val="0"/>
      </c:catAx>
      <c:valAx>
        <c:axId val="1393211600"/>
        <c:scaling>
          <c:orientation val="minMax"/>
          <c:max val="0.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3217840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30568314120853"/>
          <c:y val="2.5179636837965529E-2"/>
          <c:w val="0.68523464387610189"/>
          <c:h val="0.73846793938895361"/>
        </c:manualLayout>
      </c:layout>
      <c:lineChart>
        <c:grouping val="standard"/>
        <c:varyColors val="0"/>
        <c:ser>
          <c:idx val="0"/>
          <c:order val="0"/>
          <c:tx>
            <c:strRef>
              <c:f>計算!$CS$298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300:$DC$300</c:f>
                <c:numCache>
                  <c:formatCode>General</c:formatCode>
                  <c:ptCount val="10"/>
                  <c:pt idx="0">
                    <c:v>5.4900366588033413E-2</c:v>
                  </c:pt>
                  <c:pt idx="1">
                    <c:v>4.5323926120833351E-2</c:v>
                  </c:pt>
                  <c:pt idx="2">
                    <c:v>3.5814320090288461E-2</c:v>
                  </c:pt>
                  <c:pt idx="3">
                    <c:v>5.2773219761606538E-2</c:v>
                  </c:pt>
                  <c:pt idx="4">
                    <c:v>4.7699860057431369E-2</c:v>
                  </c:pt>
                  <c:pt idx="5">
                    <c:v>3.3217149753562034E-2</c:v>
                  </c:pt>
                  <c:pt idx="6">
                    <c:v>3.400684566491121E-2</c:v>
                  </c:pt>
                  <c:pt idx="7">
                    <c:v>4.8791329041196485E-2</c:v>
                  </c:pt>
                  <c:pt idx="8">
                    <c:v>4.1901017209283679E-2</c:v>
                  </c:pt>
                  <c:pt idx="9">
                    <c:v>2.3912124783468727E-2</c:v>
                  </c:pt>
                </c:numCache>
              </c:numRef>
            </c:plus>
            <c:minus>
              <c:numRef>
                <c:f>計算!$CT$300:$DC$300</c:f>
                <c:numCache>
                  <c:formatCode>General</c:formatCode>
                  <c:ptCount val="10"/>
                  <c:pt idx="0">
                    <c:v>5.4900366588033413E-2</c:v>
                  </c:pt>
                  <c:pt idx="1">
                    <c:v>4.5323926120833351E-2</c:v>
                  </c:pt>
                  <c:pt idx="2">
                    <c:v>3.5814320090288461E-2</c:v>
                  </c:pt>
                  <c:pt idx="3">
                    <c:v>5.2773219761606538E-2</c:v>
                  </c:pt>
                  <c:pt idx="4">
                    <c:v>4.7699860057431369E-2</c:v>
                  </c:pt>
                  <c:pt idx="5">
                    <c:v>3.3217149753562034E-2</c:v>
                  </c:pt>
                  <c:pt idx="6">
                    <c:v>3.400684566491121E-2</c:v>
                  </c:pt>
                  <c:pt idx="7">
                    <c:v>4.8791329041196485E-2</c:v>
                  </c:pt>
                  <c:pt idx="8">
                    <c:v>4.1901017209283679E-2</c:v>
                  </c:pt>
                  <c:pt idx="9">
                    <c:v>2.391212478346872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97:$DC$297</c:f>
              <c:numCache>
                <c:formatCode>General</c:formatCode>
                <c:ptCount val="10"/>
                <c:pt idx="0">
                  <c:v>0</c:v>
                </c:pt>
                <c:pt idx="1">
                  <c:v>1E-4</c:v>
                </c:pt>
                <c:pt idx="2">
                  <c:v>3.2000000000000003E-4</c:v>
                </c:pt>
                <c:pt idx="3">
                  <c:v>1E-3</c:v>
                </c:pt>
                <c:pt idx="4">
                  <c:v>3.2000000000000002E-3</c:v>
                </c:pt>
                <c:pt idx="5">
                  <c:v>0.01</c:v>
                </c:pt>
                <c:pt idx="6">
                  <c:v>3.2000000000000001E-2</c:v>
                </c:pt>
                <c:pt idx="7">
                  <c:v>0.1</c:v>
                </c:pt>
                <c:pt idx="8">
                  <c:v>0.32</c:v>
                </c:pt>
                <c:pt idx="9">
                  <c:v>1</c:v>
                </c:pt>
              </c:numCache>
            </c:numRef>
          </c:cat>
          <c:val>
            <c:numRef>
              <c:f>計算!$CT$298:$DC$298</c:f>
              <c:numCache>
                <c:formatCode>General</c:formatCode>
                <c:ptCount val="10"/>
                <c:pt idx="0">
                  <c:v>0.49111667027076084</c:v>
                </c:pt>
                <c:pt idx="1">
                  <c:v>0.51801665872335434</c:v>
                </c:pt>
                <c:pt idx="2">
                  <c:v>0.5441333378354708</c:v>
                </c:pt>
                <c:pt idx="3">
                  <c:v>0.55439998954534531</c:v>
                </c:pt>
                <c:pt idx="4">
                  <c:v>0.53719999641180038</c:v>
                </c:pt>
                <c:pt idx="5">
                  <c:v>0.50423333297173178</c:v>
                </c:pt>
                <c:pt idx="6">
                  <c:v>0.49828333407640457</c:v>
                </c:pt>
                <c:pt idx="7">
                  <c:v>0.45385000358025235</c:v>
                </c:pt>
                <c:pt idx="8">
                  <c:v>0.43415000786383945</c:v>
                </c:pt>
                <c:pt idx="9">
                  <c:v>0.378383335967858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B5B-4BB8-BC51-19DED24BFDC5}"/>
            </c:ext>
          </c:extLst>
        </c:ser>
        <c:ser>
          <c:idx val="1"/>
          <c:order val="1"/>
          <c:tx>
            <c:strRef>
              <c:f>計算!$CS$299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計算!$CT$297:$DC$297</c:f>
              <c:numCache>
                <c:formatCode>General</c:formatCode>
                <c:ptCount val="10"/>
                <c:pt idx="0">
                  <c:v>0</c:v>
                </c:pt>
                <c:pt idx="1">
                  <c:v>1E-4</c:v>
                </c:pt>
                <c:pt idx="2">
                  <c:v>3.2000000000000003E-4</c:v>
                </c:pt>
                <c:pt idx="3">
                  <c:v>1E-3</c:v>
                </c:pt>
                <c:pt idx="4">
                  <c:v>3.2000000000000002E-3</c:v>
                </c:pt>
                <c:pt idx="5">
                  <c:v>0.01</c:v>
                </c:pt>
                <c:pt idx="6">
                  <c:v>3.2000000000000001E-2</c:v>
                </c:pt>
                <c:pt idx="7">
                  <c:v>0.1</c:v>
                </c:pt>
                <c:pt idx="8">
                  <c:v>0.32</c:v>
                </c:pt>
                <c:pt idx="9">
                  <c:v>1</c:v>
                </c:pt>
              </c:numCache>
            </c:numRef>
          </c:cat>
          <c:val>
            <c:numRef>
              <c:f>計算!$CT$299:$DC$299</c:f>
              <c:numCache>
                <c:formatCode>General</c:formatCode>
                <c:ptCount val="10"/>
                <c:pt idx="0">
                  <c:v>0.49111667027076084</c:v>
                </c:pt>
                <c:pt idx="1">
                  <c:v>0.50358331948518753</c:v>
                </c:pt>
                <c:pt idx="2">
                  <c:v>0.49363333235184353</c:v>
                </c:pt>
                <c:pt idx="3">
                  <c:v>0.50681665291388822</c:v>
                </c:pt>
                <c:pt idx="4">
                  <c:v>0.50969999780257524</c:v>
                </c:pt>
                <c:pt idx="5">
                  <c:v>0.45094999919335049</c:v>
                </c:pt>
                <c:pt idx="6">
                  <c:v>0.45459998895724613</c:v>
                </c:pt>
                <c:pt idx="7">
                  <c:v>0.43170000364383054</c:v>
                </c:pt>
                <c:pt idx="8">
                  <c:v>0.41193334013223643</c:v>
                </c:pt>
                <c:pt idx="9">
                  <c:v>0.376033323506514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B5B-4BB8-BC51-19DED24BFD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5702767"/>
        <c:axId val="1735705647"/>
      </c:lineChart>
      <c:catAx>
        <c:axId val="173570276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705647"/>
        <c:crosses val="autoZero"/>
        <c:auto val="1"/>
        <c:lblAlgn val="ctr"/>
        <c:lblOffset val="100"/>
        <c:noMultiLvlLbl val="0"/>
      </c:catAx>
      <c:valAx>
        <c:axId val="1735705647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5702767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9096041246937611E-2"/>
          <c:y val="4.8341467157710205E-2"/>
          <c:w val="0.88389129483814521"/>
          <c:h val="0.8396839457567804"/>
        </c:manualLayout>
      </c:layout>
      <c:lineChart>
        <c:grouping val="standard"/>
        <c:varyColors val="0"/>
        <c:ser>
          <c:idx val="0"/>
          <c:order val="0"/>
          <c:tx>
            <c:strRef>
              <c:f>計算!$CS$238</c:f>
              <c:strCache>
                <c:ptCount val="1"/>
                <c:pt idx="0">
                  <c:v>Before correction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40:$DC$240</c:f>
                <c:numCache>
                  <c:formatCode>General</c:formatCode>
                  <c:ptCount val="10"/>
                  <c:pt idx="0">
                    <c:v>3.0550068465518894E-2</c:v>
                  </c:pt>
                  <c:pt idx="1">
                    <c:v>2.4274767407955783E-2</c:v>
                  </c:pt>
                  <c:pt idx="2">
                    <c:v>1.7126991674055313E-2</c:v>
                  </c:pt>
                  <c:pt idx="3">
                    <c:v>2.9797654541894439E-2</c:v>
                  </c:pt>
                  <c:pt idx="4">
                    <c:v>5.6103213958415388E-2</c:v>
                  </c:pt>
                  <c:pt idx="5">
                    <c:v>1.6375469345369858E-2</c:v>
                  </c:pt>
                  <c:pt idx="6">
                    <c:v>3.9783599573351862E-2</c:v>
                  </c:pt>
                  <c:pt idx="7">
                    <c:v>2.4096230643099476E-2</c:v>
                  </c:pt>
                  <c:pt idx="8">
                    <c:v>1.2037216292723293E-2</c:v>
                  </c:pt>
                  <c:pt idx="9">
                    <c:v>2.1583943654676055E-3</c:v>
                  </c:pt>
                </c:numCache>
              </c:numRef>
            </c:plus>
            <c:minus>
              <c:numRef>
                <c:f>計算!$CT$240:$DC$240</c:f>
                <c:numCache>
                  <c:formatCode>General</c:formatCode>
                  <c:ptCount val="10"/>
                  <c:pt idx="0">
                    <c:v>3.0550068465518894E-2</c:v>
                  </c:pt>
                  <c:pt idx="1">
                    <c:v>2.4274767407955783E-2</c:v>
                  </c:pt>
                  <c:pt idx="2">
                    <c:v>1.7126991674055313E-2</c:v>
                  </c:pt>
                  <c:pt idx="3">
                    <c:v>2.9797654541894439E-2</c:v>
                  </c:pt>
                  <c:pt idx="4">
                    <c:v>5.6103213958415388E-2</c:v>
                  </c:pt>
                  <c:pt idx="5">
                    <c:v>1.6375469345369858E-2</c:v>
                  </c:pt>
                  <c:pt idx="6">
                    <c:v>3.9783599573351862E-2</c:v>
                  </c:pt>
                  <c:pt idx="7">
                    <c:v>2.4096230643099476E-2</c:v>
                  </c:pt>
                  <c:pt idx="8">
                    <c:v>1.2037216292723293E-2</c:v>
                  </c:pt>
                  <c:pt idx="9">
                    <c:v>2.158394365467605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37:$DC$237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38:$DC$238</c:f>
              <c:numCache>
                <c:formatCode>General</c:formatCode>
                <c:ptCount val="10"/>
                <c:pt idx="0">
                  <c:v>0.34603333473205566</c:v>
                </c:pt>
                <c:pt idx="1">
                  <c:v>0.34940000375111896</c:v>
                </c:pt>
                <c:pt idx="2">
                  <c:v>0.34528333445390064</c:v>
                </c:pt>
                <c:pt idx="3">
                  <c:v>0.36129999657471973</c:v>
                </c:pt>
                <c:pt idx="4">
                  <c:v>0.31364999711513519</c:v>
                </c:pt>
                <c:pt idx="5">
                  <c:v>0.31</c:v>
                </c:pt>
                <c:pt idx="6">
                  <c:v>0.28000000000000003</c:v>
                </c:pt>
                <c:pt idx="7">
                  <c:v>0.26960000395774841</c:v>
                </c:pt>
                <c:pt idx="8">
                  <c:v>0.11806666851043701</c:v>
                </c:pt>
                <c:pt idx="9">
                  <c:v>2.746666719516118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611-45CC-8D0A-26837662A8DA}"/>
            </c:ext>
          </c:extLst>
        </c:ser>
        <c:ser>
          <c:idx val="1"/>
          <c:order val="1"/>
          <c:tx>
            <c:strRef>
              <c:f>計算!$CS$239</c:f>
              <c:strCache>
                <c:ptCount val="1"/>
                <c:pt idx="0">
                  <c:v>After correctio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計算!$CT$240:$DC$240</c:f>
                <c:numCache>
                  <c:formatCode>General</c:formatCode>
                  <c:ptCount val="10"/>
                  <c:pt idx="0">
                    <c:v>3.0550068465518894E-2</c:v>
                  </c:pt>
                  <c:pt idx="1">
                    <c:v>2.4274767407955783E-2</c:v>
                  </c:pt>
                  <c:pt idx="2">
                    <c:v>1.7126991674055313E-2</c:v>
                  </c:pt>
                  <c:pt idx="3">
                    <c:v>2.9797654541894439E-2</c:v>
                  </c:pt>
                  <c:pt idx="4">
                    <c:v>5.6103213958415388E-2</c:v>
                  </c:pt>
                  <c:pt idx="5">
                    <c:v>1.6375469345369858E-2</c:v>
                  </c:pt>
                  <c:pt idx="6">
                    <c:v>3.9783599573351862E-2</c:v>
                  </c:pt>
                  <c:pt idx="7">
                    <c:v>2.4096230643099476E-2</c:v>
                  </c:pt>
                  <c:pt idx="8">
                    <c:v>1.2037216292723293E-2</c:v>
                  </c:pt>
                  <c:pt idx="9">
                    <c:v>2.1583943654676055E-3</c:v>
                  </c:pt>
                </c:numCache>
              </c:numRef>
            </c:plus>
            <c:minus>
              <c:numRef>
                <c:f>計算!$CT$240:$DC$240</c:f>
                <c:numCache>
                  <c:formatCode>General</c:formatCode>
                  <c:ptCount val="10"/>
                  <c:pt idx="0">
                    <c:v>3.0550068465518894E-2</c:v>
                  </c:pt>
                  <c:pt idx="1">
                    <c:v>2.4274767407955783E-2</c:v>
                  </c:pt>
                  <c:pt idx="2">
                    <c:v>1.7126991674055313E-2</c:v>
                  </c:pt>
                  <c:pt idx="3">
                    <c:v>2.9797654541894439E-2</c:v>
                  </c:pt>
                  <c:pt idx="4">
                    <c:v>5.6103213958415388E-2</c:v>
                  </c:pt>
                  <c:pt idx="5">
                    <c:v>1.6375469345369858E-2</c:v>
                  </c:pt>
                  <c:pt idx="6">
                    <c:v>3.9783599573351862E-2</c:v>
                  </c:pt>
                  <c:pt idx="7">
                    <c:v>2.4096230643099476E-2</c:v>
                  </c:pt>
                  <c:pt idx="8">
                    <c:v>1.2037216292723293E-2</c:v>
                  </c:pt>
                  <c:pt idx="9">
                    <c:v>2.158394365467605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計算!$CT$237:$DC$237</c:f>
              <c:numCache>
                <c:formatCode>General</c:formatCode>
                <c:ptCount val="10"/>
                <c:pt idx="0">
                  <c:v>0</c:v>
                </c:pt>
                <c:pt idx="1">
                  <c:v>4.0000000000000001E-3</c:v>
                </c:pt>
                <c:pt idx="2">
                  <c:v>1.2999999999999999E-2</c:v>
                </c:pt>
                <c:pt idx="3">
                  <c:v>0.04</c:v>
                </c:pt>
                <c:pt idx="4">
                  <c:v>0.13</c:v>
                </c:pt>
                <c:pt idx="5">
                  <c:v>0.4</c:v>
                </c:pt>
                <c:pt idx="6">
                  <c:v>1.3</c:v>
                </c:pt>
                <c:pt idx="7">
                  <c:v>4</c:v>
                </c:pt>
                <c:pt idx="8">
                  <c:v>13</c:v>
                </c:pt>
                <c:pt idx="9">
                  <c:v>40</c:v>
                </c:pt>
              </c:numCache>
            </c:numRef>
          </c:cat>
          <c:val>
            <c:numRef>
              <c:f>計算!$CT$239:$DC$239</c:f>
              <c:numCache>
                <c:formatCode>General</c:formatCode>
                <c:ptCount val="10"/>
                <c:pt idx="0">
                  <c:v>0.34603333473205566</c:v>
                </c:pt>
                <c:pt idx="1">
                  <c:v>0.33496666451295215</c:v>
                </c:pt>
                <c:pt idx="2">
                  <c:v>0.29478332897027332</c:v>
                </c:pt>
                <c:pt idx="3">
                  <c:v>0.3137166599432627</c:v>
                </c:pt>
                <c:pt idx="4">
                  <c:v>0.28614999850591022</c:v>
                </c:pt>
                <c:pt idx="5">
                  <c:v>0.22</c:v>
                </c:pt>
                <c:pt idx="6">
                  <c:v>0.26</c:v>
                </c:pt>
                <c:pt idx="7">
                  <c:v>0.24745000402132664</c:v>
                </c:pt>
                <c:pt idx="8">
                  <c:v>9.5850000778833988E-2</c:v>
                </c:pt>
                <c:pt idx="9">
                  <c:v>2.511665473381676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611-45CC-8D0A-26837662A8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55566159"/>
        <c:axId val="1655572879"/>
      </c:lineChart>
      <c:catAx>
        <c:axId val="16555661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72879"/>
        <c:crosses val="autoZero"/>
        <c:auto val="1"/>
        <c:lblAlgn val="ctr"/>
        <c:lblOffset val="100"/>
        <c:noMultiLvlLbl val="0"/>
      </c:catAx>
      <c:valAx>
        <c:axId val="1655572879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56615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430155962618507"/>
          <c:y val="4.0177088784447798E-2"/>
          <c:w val="0.88389129483814521"/>
          <c:h val="0.87209135316418762"/>
        </c:manualLayout>
      </c:layout>
      <c:lineChart>
        <c:grouping val="standard"/>
        <c:varyColors val="0"/>
        <c:ser>
          <c:idx val="0"/>
          <c:order val="0"/>
          <c:tx>
            <c:strRef>
              <c:f>'[^N1610.2025.04.30.xlsx]計算'!$BU$185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[^N1610.2025.04.30.xlsx]計算'!$BV$184:$CE$184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BV$185:$CE$185</c:f>
              <c:numCache>
                <c:formatCode>General</c:formatCode>
                <c:ptCount val="10"/>
                <c:pt idx="0">
                  <c:v>0.223150002459685</c:v>
                </c:pt>
                <c:pt idx="1">
                  <c:v>0.19957999438047408</c:v>
                </c:pt>
                <c:pt idx="2">
                  <c:v>0.19503333916266757</c:v>
                </c:pt>
                <c:pt idx="3">
                  <c:v>0.17875000089406967</c:v>
                </c:pt>
                <c:pt idx="4">
                  <c:v>0.21004998932282132</c:v>
                </c:pt>
                <c:pt idx="5">
                  <c:v>0.20206666737794876</c:v>
                </c:pt>
                <c:pt idx="6">
                  <c:v>0.23058332254489261</c:v>
                </c:pt>
                <c:pt idx="7">
                  <c:v>0.18783333649237949</c:v>
                </c:pt>
                <c:pt idx="8">
                  <c:v>0.21286666641632718</c:v>
                </c:pt>
                <c:pt idx="9">
                  <c:v>0.147433333098888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DDA-4056-B35B-9057250000AB}"/>
            </c:ext>
          </c:extLst>
        </c:ser>
        <c:ser>
          <c:idx val="1"/>
          <c:order val="1"/>
          <c:tx>
            <c:strRef>
              <c:f>'[^N1610.2025.04.30.xlsx]計算'!$BU$186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^N1610.2025.04.30.xlsx]計算'!$BV$184:$CE$184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BV$186:$CE$186</c:f>
              <c:numCache>
                <c:formatCode>General</c:formatCode>
                <c:ptCount val="10"/>
                <c:pt idx="0">
                  <c:v>0.26915000379085541</c:v>
                </c:pt>
                <c:pt idx="1">
                  <c:v>0.26931666334470111</c:v>
                </c:pt>
                <c:pt idx="2">
                  <c:v>0.25849999487400055</c:v>
                </c:pt>
                <c:pt idx="3">
                  <c:v>0.26270001133282983</c:v>
                </c:pt>
                <c:pt idx="4">
                  <c:v>0.2410166660944621</c:v>
                </c:pt>
                <c:pt idx="5">
                  <c:v>0.2770666629076004</c:v>
                </c:pt>
                <c:pt idx="6">
                  <c:v>0.24758332471052807</c:v>
                </c:pt>
                <c:pt idx="7">
                  <c:v>0.25818333029747009</c:v>
                </c:pt>
                <c:pt idx="8">
                  <c:v>0.25230000913143158</c:v>
                </c:pt>
                <c:pt idx="9">
                  <c:v>0.235716660817464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DDA-4056-B35B-9057250000AB}"/>
            </c:ext>
          </c:extLst>
        </c:ser>
        <c:ser>
          <c:idx val="2"/>
          <c:order val="2"/>
          <c:tx>
            <c:strRef>
              <c:f>'[^N1610.2025.04.30.xlsx]計算'!$BU$187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[^N1610.2025.04.30.xlsx]計算'!$BV$184:$CE$184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BV$187:$CE$187</c:f>
              <c:numCache>
                <c:formatCode>General</c:formatCode>
                <c:ptCount val="10"/>
                <c:pt idx="0">
                  <c:v>0.36806666602691013</c:v>
                </c:pt>
                <c:pt idx="1">
                  <c:v>0.33946666866540909</c:v>
                </c:pt>
                <c:pt idx="2">
                  <c:v>0.37750000009934109</c:v>
                </c:pt>
                <c:pt idx="3">
                  <c:v>0.31108332425355911</c:v>
                </c:pt>
                <c:pt idx="4">
                  <c:v>0.34293333441019058</c:v>
                </c:pt>
                <c:pt idx="5">
                  <c:v>0.3369999999801318</c:v>
                </c:pt>
                <c:pt idx="6">
                  <c:v>0.31143333762884146</c:v>
                </c:pt>
                <c:pt idx="7">
                  <c:v>0.2952499960859617</c:v>
                </c:pt>
                <c:pt idx="8">
                  <c:v>0.34051666408777242</c:v>
                </c:pt>
                <c:pt idx="9">
                  <c:v>0.299949991206328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DDA-4056-B35B-9057250000AB}"/>
            </c:ext>
          </c:extLst>
        </c:ser>
        <c:ser>
          <c:idx val="3"/>
          <c:order val="3"/>
          <c:tx>
            <c:strRef>
              <c:f>'[^N1610.2025.04.30.xlsx]計算'!$BU$188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[^N1610.2025.04.30.xlsx]計算'!$BV$184:$CE$184</c:f>
              <c:numCache>
                <c:formatCode>General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1.6000000000000001E-3</c:v>
                </c:pt>
                <c:pt idx="3">
                  <c:v>0.05</c:v>
                </c:pt>
                <c:pt idx="4">
                  <c:v>0.16</c:v>
                </c:pt>
                <c:pt idx="5">
                  <c:v>0.5</c:v>
                </c:pt>
                <c:pt idx="6">
                  <c:v>1.6</c:v>
                </c:pt>
                <c:pt idx="7">
                  <c:v>5</c:v>
                </c:pt>
                <c:pt idx="8">
                  <c:v>15.8</c:v>
                </c:pt>
                <c:pt idx="9">
                  <c:v>50</c:v>
                </c:pt>
              </c:numCache>
            </c:numRef>
          </c:cat>
          <c:val>
            <c:numRef>
              <c:f>'[^N1610.2025.04.30.xlsx]計算'!$BV$188:$CE$188</c:f>
              <c:numCache>
                <c:formatCode>General</c:formatCode>
                <c:ptCount val="10"/>
                <c:pt idx="0">
                  <c:v>0.43974998965859413</c:v>
                </c:pt>
                <c:pt idx="1">
                  <c:v>0.44780833895007766</c:v>
                </c:pt>
                <c:pt idx="2">
                  <c:v>0.46494167422254884</c:v>
                </c:pt>
                <c:pt idx="3">
                  <c:v>0.4446083394189676</c:v>
                </c:pt>
                <c:pt idx="4">
                  <c:v>0.43782499805092812</c:v>
                </c:pt>
                <c:pt idx="5">
                  <c:v>0.40555833652615547</c:v>
                </c:pt>
                <c:pt idx="6">
                  <c:v>0.40472498908638954</c:v>
                </c:pt>
                <c:pt idx="7">
                  <c:v>0.38214166338245076</c:v>
                </c:pt>
                <c:pt idx="8">
                  <c:v>0.40227498983343446</c:v>
                </c:pt>
                <c:pt idx="9">
                  <c:v>0.324691671878099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DDA-4056-B35B-9057250000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7870544"/>
        <c:axId val="1337867664"/>
      </c:lineChart>
      <c:catAx>
        <c:axId val="1337870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7867664"/>
        <c:crosses val="autoZero"/>
        <c:auto val="1"/>
        <c:lblAlgn val="ctr"/>
        <c:lblOffset val="100"/>
        <c:noMultiLvlLbl val="0"/>
      </c:catAx>
      <c:valAx>
        <c:axId val="1337867664"/>
        <c:scaling>
          <c:orientation val="minMax"/>
          <c:max val="0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7870544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Harada 2025.04.30^LN1 (1).xlsx]計算'!$AP$54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58:$AZ$58</c:f>
                <c:numCache>
                  <c:formatCode>General</c:formatCode>
                  <c:ptCount val="10"/>
                  <c:pt idx="0">
                    <c:v>7.0652181803969538E-2</c:v>
                  </c:pt>
                  <c:pt idx="1">
                    <c:v>4.3941352548185604E-2</c:v>
                  </c:pt>
                  <c:pt idx="2">
                    <c:v>6.452284968798222E-2</c:v>
                  </c:pt>
                  <c:pt idx="3">
                    <c:v>7.0593074717791207E-2</c:v>
                  </c:pt>
                  <c:pt idx="4">
                    <c:v>5.799409055353974E-2</c:v>
                  </c:pt>
                  <c:pt idx="5">
                    <c:v>3.0586301109443274E-2</c:v>
                  </c:pt>
                  <c:pt idx="6">
                    <c:v>3.2431078063442295E-2</c:v>
                  </c:pt>
                  <c:pt idx="7">
                    <c:v>1.5763839220335103E-2</c:v>
                  </c:pt>
                  <c:pt idx="8">
                    <c:v>1.9446505028123692E-3</c:v>
                  </c:pt>
                  <c:pt idx="9">
                    <c:v>1.8812233653038054E-3</c:v>
                  </c:pt>
                </c:numCache>
              </c:numRef>
            </c:plus>
            <c:minus>
              <c:numRef>
                <c:f>'[Harada 2025.04.30^LN1 (1).xlsx]計算'!$AQ$58:$AZ$58</c:f>
                <c:numCache>
                  <c:formatCode>General</c:formatCode>
                  <c:ptCount val="10"/>
                  <c:pt idx="0">
                    <c:v>7.0652181803969538E-2</c:v>
                  </c:pt>
                  <c:pt idx="1">
                    <c:v>4.3941352548185604E-2</c:v>
                  </c:pt>
                  <c:pt idx="2">
                    <c:v>6.452284968798222E-2</c:v>
                  </c:pt>
                  <c:pt idx="3">
                    <c:v>7.0593074717791207E-2</c:v>
                  </c:pt>
                  <c:pt idx="4">
                    <c:v>5.799409055353974E-2</c:v>
                  </c:pt>
                  <c:pt idx="5">
                    <c:v>3.0586301109443274E-2</c:v>
                  </c:pt>
                  <c:pt idx="6">
                    <c:v>3.2431078063442295E-2</c:v>
                  </c:pt>
                  <c:pt idx="7">
                    <c:v>1.5763839220335103E-2</c:v>
                  </c:pt>
                  <c:pt idx="8">
                    <c:v>1.9446505028123692E-3</c:v>
                  </c:pt>
                  <c:pt idx="9">
                    <c:v>1.881223365303805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3:$AZ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AQ$54:$AZ$54</c:f>
              <c:numCache>
                <c:formatCode>General</c:formatCode>
                <c:ptCount val="10"/>
                <c:pt idx="0">
                  <c:v>0.21225000048677126</c:v>
                </c:pt>
                <c:pt idx="1">
                  <c:v>0.57071667537093163</c:v>
                </c:pt>
                <c:pt idx="2">
                  <c:v>0.47468333070476848</c:v>
                </c:pt>
                <c:pt idx="3">
                  <c:v>0.45784999057650566</c:v>
                </c:pt>
                <c:pt idx="4">
                  <c:v>0.4088500055174033</c:v>
                </c:pt>
                <c:pt idx="5">
                  <c:v>0.3536166710158189</c:v>
                </c:pt>
                <c:pt idx="6">
                  <c:v>0.18055000031987825</c:v>
                </c:pt>
                <c:pt idx="7">
                  <c:v>5.9733333686987557E-2</c:v>
                </c:pt>
                <c:pt idx="8">
                  <c:v>2.2833328694105148E-3</c:v>
                </c:pt>
                <c:pt idx="9">
                  <c:v>-7.6500003536542254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766-4B58-8D82-5F1C3B70A801}"/>
            </c:ext>
          </c:extLst>
        </c:ser>
        <c:ser>
          <c:idx val="1"/>
          <c:order val="1"/>
          <c:tx>
            <c:strRef>
              <c:f>'[Harada 2025.04.30^LN1 (1).xlsx]計算'!$AP$55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59:$AZ$59</c:f>
                <c:numCache>
                  <c:formatCode>General</c:formatCode>
                  <c:ptCount val="10"/>
                  <c:pt idx="0">
                    <c:v>5.8460129081713712E-2</c:v>
                  </c:pt>
                  <c:pt idx="1">
                    <c:v>5.2934521075714926E-2</c:v>
                  </c:pt>
                  <c:pt idx="2">
                    <c:v>2.8074655369307141E-2</c:v>
                  </c:pt>
                  <c:pt idx="3">
                    <c:v>7.6821157623605973E-2</c:v>
                  </c:pt>
                  <c:pt idx="4">
                    <c:v>1.5458552206645918E-2</c:v>
                  </c:pt>
                  <c:pt idx="5">
                    <c:v>4.1006399125451294E-2</c:v>
                  </c:pt>
                  <c:pt idx="6">
                    <c:v>3.1449006679751146E-2</c:v>
                  </c:pt>
                  <c:pt idx="7">
                    <c:v>1.9553594896152462E-2</c:v>
                  </c:pt>
                  <c:pt idx="8">
                    <c:v>3.9924918651088916E-3</c:v>
                  </c:pt>
                  <c:pt idx="9">
                    <c:v>1.3356647024654199E-3</c:v>
                  </c:pt>
                </c:numCache>
              </c:numRef>
            </c:plus>
            <c:minus>
              <c:numRef>
                <c:f>'[Harada 2025.04.30^LN1 (1).xlsx]計算'!$AQ$59:$AZ$59</c:f>
                <c:numCache>
                  <c:formatCode>General</c:formatCode>
                  <c:ptCount val="10"/>
                  <c:pt idx="0">
                    <c:v>5.8460129081713712E-2</c:v>
                  </c:pt>
                  <c:pt idx="1">
                    <c:v>5.2934521075714926E-2</c:v>
                  </c:pt>
                  <c:pt idx="2">
                    <c:v>2.8074655369307141E-2</c:v>
                  </c:pt>
                  <c:pt idx="3">
                    <c:v>7.6821157623605973E-2</c:v>
                  </c:pt>
                  <c:pt idx="4">
                    <c:v>1.5458552206645918E-2</c:v>
                  </c:pt>
                  <c:pt idx="5">
                    <c:v>4.1006399125451294E-2</c:v>
                  </c:pt>
                  <c:pt idx="6">
                    <c:v>3.1449006679751146E-2</c:v>
                  </c:pt>
                  <c:pt idx="7">
                    <c:v>1.9553594896152462E-2</c:v>
                  </c:pt>
                  <c:pt idx="8">
                    <c:v>3.9924918651088916E-3</c:v>
                  </c:pt>
                  <c:pt idx="9">
                    <c:v>1.33566470246541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3:$AZ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AQ$55:$AZ$55</c:f>
              <c:numCache>
                <c:formatCode>General</c:formatCode>
                <c:ptCount val="10"/>
                <c:pt idx="0">
                  <c:v>0.29796666279435158</c:v>
                </c:pt>
                <c:pt idx="1">
                  <c:v>0.62889999523758888</c:v>
                </c:pt>
                <c:pt idx="2">
                  <c:v>0.60248334581653273</c:v>
                </c:pt>
                <c:pt idx="3">
                  <c:v>0.54484999552369118</c:v>
                </c:pt>
                <c:pt idx="4">
                  <c:v>0.47553333019216854</c:v>
                </c:pt>
                <c:pt idx="5">
                  <c:v>0.44220000381271046</c:v>
                </c:pt>
                <c:pt idx="6">
                  <c:v>0.31090000147620839</c:v>
                </c:pt>
                <c:pt idx="7">
                  <c:v>0.13184999550382295</c:v>
                </c:pt>
                <c:pt idx="8">
                  <c:v>2.4499998738368351E-2</c:v>
                </c:pt>
                <c:pt idx="9">
                  <c:v>-1.9000004976987839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766-4B58-8D82-5F1C3B70A801}"/>
            </c:ext>
          </c:extLst>
        </c:ser>
        <c:ser>
          <c:idx val="2"/>
          <c:order val="2"/>
          <c:tx>
            <c:strRef>
              <c:f>'[Harada 2025.04.30^LN1 (1).xlsx]計算'!$AP$56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60:$AZ$60</c:f>
                <c:numCache>
                  <c:formatCode>General</c:formatCode>
                  <c:ptCount val="10"/>
                  <c:pt idx="0">
                    <c:v>2.6444767662446422E-2</c:v>
                  </c:pt>
                  <c:pt idx="1">
                    <c:v>6.1883496478775855E-2</c:v>
                  </c:pt>
                  <c:pt idx="2">
                    <c:v>3.7720649804800027E-2</c:v>
                  </c:pt>
                  <c:pt idx="3">
                    <c:v>4.4195413454322416E-2</c:v>
                  </c:pt>
                  <c:pt idx="4">
                    <c:v>4.8951597246602335E-2</c:v>
                  </c:pt>
                  <c:pt idx="5">
                    <c:v>4.1019339895314783E-2</c:v>
                  </c:pt>
                  <c:pt idx="6">
                    <c:v>2.7813999122445258E-2</c:v>
                  </c:pt>
                  <c:pt idx="7">
                    <c:v>1.3502094754781235E-2</c:v>
                  </c:pt>
                  <c:pt idx="8">
                    <c:v>4.0638260278838701E-3</c:v>
                  </c:pt>
                  <c:pt idx="9">
                    <c:v>1.0647383573966281E-3</c:v>
                  </c:pt>
                </c:numCache>
              </c:numRef>
            </c:plus>
            <c:minus>
              <c:numRef>
                <c:f>'[Harada 2025.04.30^LN1 (1).xlsx]計算'!$AQ$60:$AZ$60</c:f>
                <c:numCache>
                  <c:formatCode>General</c:formatCode>
                  <c:ptCount val="10"/>
                  <c:pt idx="0">
                    <c:v>2.6444767662446422E-2</c:v>
                  </c:pt>
                  <c:pt idx="1">
                    <c:v>6.1883496478775855E-2</c:v>
                  </c:pt>
                  <c:pt idx="2">
                    <c:v>3.7720649804800027E-2</c:v>
                  </c:pt>
                  <c:pt idx="3">
                    <c:v>4.4195413454322416E-2</c:v>
                  </c:pt>
                  <c:pt idx="4">
                    <c:v>4.8951597246602335E-2</c:v>
                  </c:pt>
                  <c:pt idx="5">
                    <c:v>4.1019339895314783E-2</c:v>
                  </c:pt>
                  <c:pt idx="6">
                    <c:v>2.7813999122445258E-2</c:v>
                  </c:pt>
                  <c:pt idx="7">
                    <c:v>1.3502094754781235E-2</c:v>
                  </c:pt>
                  <c:pt idx="8">
                    <c:v>4.0638260278838701E-3</c:v>
                  </c:pt>
                  <c:pt idx="9">
                    <c:v>1.064738357396628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3:$AZ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AQ$56:$AZ$56</c:f>
              <c:numCache>
                <c:formatCode>General</c:formatCode>
                <c:ptCount val="10"/>
                <c:pt idx="0">
                  <c:v>0.29428333913286525</c:v>
                </c:pt>
                <c:pt idx="1">
                  <c:v>0.78194999073942506</c:v>
                </c:pt>
                <c:pt idx="2">
                  <c:v>0.6744999922811985</c:v>
                </c:pt>
                <c:pt idx="3">
                  <c:v>0.64644999677936232</c:v>
                </c:pt>
                <c:pt idx="4">
                  <c:v>0.57433332378665602</c:v>
                </c:pt>
                <c:pt idx="5">
                  <c:v>0.56021665905912721</c:v>
                </c:pt>
                <c:pt idx="6">
                  <c:v>0.43096666410565376</c:v>
                </c:pt>
                <c:pt idx="7">
                  <c:v>0.21553332979480425</c:v>
                </c:pt>
                <c:pt idx="8">
                  <c:v>6.513333196441333E-2</c:v>
                </c:pt>
                <c:pt idx="9">
                  <c:v>-8.3334123094876603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766-4B58-8D82-5F1C3B70A801}"/>
            </c:ext>
          </c:extLst>
        </c:ser>
        <c:ser>
          <c:idx val="3"/>
          <c:order val="3"/>
          <c:tx>
            <c:strRef>
              <c:f>'[Harada 2025.04.30^LN1 (1).xlsx]計算'!$AP$57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61:$AZ$61</c:f>
                <c:numCache>
                  <c:formatCode>General</c:formatCode>
                  <c:ptCount val="10"/>
                  <c:pt idx="0">
                    <c:v>5.4670802917703896E-2</c:v>
                  </c:pt>
                  <c:pt idx="1">
                    <c:v>5.7135647979763941E-2</c:v>
                  </c:pt>
                  <c:pt idx="2">
                    <c:v>6.1397832424828699E-2</c:v>
                  </c:pt>
                  <c:pt idx="3">
                    <c:v>5.8489588815876292E-2</c:v>
                  </c:pt>
                  <c:pt idx="4">
                    <c:v>5.8841973268750215E-2</c:v>
                  </c:pt>
                  <c:pt idx="5">
                    <c:v>2.6140510899002854E-2</c:v>
                  </c:pt>
                  <c:pt idx="6">
                    <c:v>2.9144505779383295E-2</c:v>
                  </c:pt>
                  <c:pt idx="7">
                    <c:v>1.102845362188948E-2</c:v>
                  </c:pt>
                  <c:pt idx="8">
                    <c:v>1.0208756143842772E-2</c:v>
                  </c:pt>
                  <c:pt idx="9">
                    <c:v>6.8605193177939878E-4</c:v>
                  </c:pt>
                </c:numCache>
              </c:numRef>
            </c:plus>
            <c:minus>
              <c:numRef>
                <c:f>'[Harada 2025.04.30^LN1 (1).xlsx]計算'!$AQ$61:$AZ$61</c:f>
                <c:numCache>
                  <c:formatCode>General</c:formatCode>
                  <c:ptCount val="10"/>
                  <c:pt idx="0">
                    <c:v>5.4670802917703896E-2</c:v>
                  </c:pt>
                  <c:pt idx="1">
                    <c:v>5.7135647979763941E-2</c:v>
                  </c:pt>
                  <c:pt idx="2">
                    <c:v>6.1397832424828699E-2</c:v>
                  </c:pt>
                  <c:pt idx="3">
                    <c:v>5.8489588815876292E-2</c:v>
                  </c:pt>
                  <c:pt idx="4">
                    <c:v>5.8841973268750215E-2</c:v>
                  </c:pt>
                  <c:pt idx="5">
                    <c:v>2.6140510899002854E-2</c:v>
                  </c:pt>
                  <c:pt idx="6">
                    <c:v>2.9144505779383295E-2</c:v>
                  </c:pt>
                  <c:pt idx="7">
                    <c:v>1.102845362188948E-2</c:v>
                  </c:pt>
                  <c:pt idx="8">
                    <c:v>1.0208756143842772E-2</c:v>
                  </c:pt>
                  <c:pt idx="9">
                    <c:v>6.860519317793987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53:$AZ$53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32</c:v>
                </c:pt>
                <c:pt idx="3">
                  <c:v>1</c:v>
                </c:pt>
                <c:pt idx="4">
                  <c:v>3.2</c:v>
                </c:pt>
                <c:pt idx="5">
                  <c:v>10</c:v>
                </c:pt>
                <c:pt idx="6">
                  <c:v>32</c:v>
                </c:pt>
                <c:pt idx="7">
                  <c:v>100</c:v>
                </c:pt>
                <c:pt idx="8">
                  <c:v>316</c:v>
                </c:pt>
                <c:pt idx="9">
                  <c:v>1000</c:v>
                </c:pt>
              </c:numCache>
            </c:numRef>
          </c:cat>
          <c:val>
            <c:numRef>
              <c:f>'[Harada 2025.04.30^LN1 (1).xlsx]計算'!$AQ$57:$AZ$57</c:f>
              <c:numCache>
                <c:formatCode>General</c:formatCode>
                <c:ptCount val="10"/>
                <c:pt idx="0">
                  <c:v>0.43228333195050556</c:v>
                </c:pt>
                <c:pt idx="1">
                  <c:v>0.92883333563804626</c:v>
                </c:pt>
                <c:pt idx="2">
                  <c:v>0.81998333334922791</c:v>
                </c:pt>
                <c:pt idx="3">
                  <c:v>0.80871666471163428</c:v>
                </c:pt>
                <c:pt idx="4">
                  <c:v>0.71946666638056433</c:v>
                </c:pt>
                <c:pt idx="5">
                  <c:v>0.64854999383290612</c:v>
                </c:pt>
                <c:pt idx="6">
                  <c:v>0.52321666479110718</c:v>
                </c:pt>
                <c:pt idx="7">
                  <c:v>0.31136667231718701</c:v>
                </c:pt>
                <c:pt idx="8">
                  <c:v>0.13513333598772684</c:v>
                </c:pt>
                <c:pt idx="9">
                  <c:v>-2.4333316832780838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766-4B58-8D82-5F1C3B70A8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130704"/>
        <c:axId val="176148944"/>
      </c:lineChart>
      <c:catAx>
        <c:axId val="176130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48944"/>
        <c:crosses val="autoZero"/>
        <c:auto val="0"/>
        <c:lblAlgn val="ctr"/>
        <c:lblOffset val="100"/>
        <c:noMultiLvlLbl val="0"/>
      </c:catAx>
      <c:valAx>
        <c:axId val="176148944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30704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10936382628963"/>
          <c:y val="3.2862332478895417E-2"/>
          <c:w val="0.92930849985086472"/>
          <c:h val="0.93109188048120495"/>
        </c:manualLayout>
      </c:layout>
      <c:lineChart>
        <c:grouping val="standard"/>
        <c:varyColors val="0"/>
        <c:ser>
          <c:idx val="0"/>
          <c:order val="0"/>
          <c:tx>
            <c:strRef>
              <c:f>'[Harada 2025.04.30^LN1 (1).xlsx]計算'!$AP$102</c:f>
              <c:strCache>
                <c:ptCount val="1"/>
                <c:pt idx="0">
                  <c:v>12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06:$AZ$106</c:f>
                <c:numCache>
                  <c:formatCode>General</c:formatCode>
                  <c:ptCount val="10"/>
                  <c:pt idx="0">
                    <c:v>2.8731819039345401E-2</c:v>
                  </c:pt>
                  <c:pt idx="1">
                    <c:v>1.5391121572265376E-2</c:v>
                  </c:pt>
                  <c:pt idx="2">
                    <c:v>3.2790997812386327E-2</c:v>
                  </c:pt>
                  <c:pt idx="3">
                    <c:v>2.9471341043521729E-2</c:v>
                  </c:pt>
                  <c:pt idx="4">
                    <c:v>3.2457827153508027E-2</c:v>
                  </c:pt>
                  <c:pt idx="5">
                    <c:v>3.7738947534639432E-2</c:v>
                  </c:pt>
                  <c:pt idx="6">
                    <c:v>2.7652370589357076E-2</c:v>
                  </c:pt>
                  <c:pt idx="7">
                    <c:v>1.6350098132581554E-2</c:v>
                  </c:pt>
                  <c:pt idx="8">
                    <c:v>1.3175038806646111E-2</c:v>
                  </c:pt>
                  <c:pt idx="9">
                    <c:v>5.034150456354961E-3</c:v>
                  </c:pt>
                </c:numCache>
              </c:numRef>
            </c:plus>
            <c:minus>
              <c:numRef>
                <c:f>'[Harada 2025.04.30^LN1 (1).xlsx]計算'!$AQ$106:$AZ$106</c:f>
                <c:numCache>
                  <c:formatCode>General</c:formatCode>
                  <c:ptCount val="10"/>
                  <c:pt idx="0">
                    <c:v>2.8731819039345401E-2</c:v>
                  </c:pt>
                  <c:pt idx="1">
                    <c:v>1.5391121572265376E-2</c:v>
                  </c:pt>
                  <c:pt idx="2">
                    <c:v>3.2790997812386327E-2</c:v>
                  </c:pt>
                  <c:pt idx="3">
                    <c:v>2.9471341043521729E-2</c:v>
                  </c:pt>
                  <c:pt idx="4">
                    <c:v>3.2457827153508027E-2</c:v>
                  </c:pt>
                  <c:pt idx="5">
                    <c:v>3.7738947534639432E-2</c:v>
                  </c:pt>
                  <c:pt idx="6">
                    <c:v>2.7652370589357076E-2</c:v>
                  </c:pt>
                  <c:pt idx="7">
                    <c:v>1.6350098132581554E-2</c:v>
                  </c:pt>
                  <c:pt idx="8">
                    <c:v>1.3175038806646111E-2</c:v>
                  </c:pt>
                  <c:pt idx="9">
                    <c:v>5.03415045635496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01:$AZ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AQ$102:$AZ$102</c:f>
              <c:numCache>
                <c:formatCode>General</c:formatCode>
                <c:ptCount val="10"/>
                <c:pt idx="0">
                  <c:v>0.15558333198229471</c:v>
                </c:pt>
                <c:pt idx="1">
                  <c:v>0.16896666586399078</c:v>
                </c:pt>
                <c:pt idx="2">
                  <c:v>0.18338333318630853</c:v>
                </c:pt>
                <c:pt idx="3">
                  <c:v>0.21330000211795172</c:v>
                </c:pt>
                <c:pt idx="4">
                  <c:v>0.22066666185855865</c:v>
                </c:pt>
                <c:pt idx="5">
                  <c:v>0.24859999865293503</c:v>
                </c:pt>
                <c:pt idx="6">
                  <c:v>0.26221666485071182</c:v>
                </c:pt>
                <c:pt idx="7">
                  <c:v>0.23838333537181219</c:v>
                </c:pt>
                <c:pt idx="8">
                  <c:v>0.14181666821241379</c:v>
                </c:pt>
                <c:pt idx="9">
                  <c:v>2.106666564941406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2D-4246-BE1F-D36D3FD5138F}"/>
            </c:ext>
          </c:extLst>
        </c:ser>
        <c:ser>
          <c:idx val="1"/>
          <c:order val="1"/>
          <c:tx>
            <c:strRef>
              <c:f>'[Harada 2025.04.30^LN1 (1).xlsx]計算'!$AP$103</c:f>
              <c:strCache>
                <c:ptCount val="1"/>
                <c:pt idx="0">
                  <c:v>256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07:$AZ$107</c:f>
                <c:numCache>
                  <c:formatCode>General</c:formatCode>
                  <c:ptCount val="10"/>
                  <c:pt idx="0">
                    <c:v>1.1862826858242942E-2</c:v>
                  </c:pt>
                  <c:pt idx="1">
                    <c:v>1.7154669837025155E-2</c:v>
                  </c:pt>
                  <c:pt idx="2">
                    <c:v>2.5924326249114085E-2</c:v>
                  </c:pt>
                  <c:pt idx="3">
                    <c:v>2.4528328755622403E-2</c:v>
                  </c:pt>
                  <c:pt idx="4">
                    <c:v>2.4060655510000865E-2</c:v>
                  </c:pt>
                  <c:pt idx="5">
                    <c:v>2.7392664225864647E-2</c:v>
                  </c:pt>
                  <c:pt idx="6">
                    <c:v>1.9561025402642925E-2</c:v>
                  </c:pt>
                  <c:pt idx="7">
                    <c:v>1.102538205698388E-2</c:v>
                  </c:pt>
                  <c:pt idx="8">
                    <c:v>1.5325586432718098E-2</c:v>
                  </c:pt>
                  <c:pt idx="9">
                    <c:v>6.8512777835235007E-3</c:v>
                  </c:pt>
                </c:numCache>
              </c:numRef>
            </c:plus>
            <c:minus>
              <c:numRef>
                <c:f>'[Harada 2025.04.30^LN1 (1).xlsx]計算'!$AQ$107:$AZ$107</c:f>
                <c:numCache>
                  <c:formatCode>General</c:formatCode>
                  <c:ptCount val="10"/>
                  <c:pt idx="0">
                    <c:v>1.1862826858242942E-2</c:v>
                  </c:pt>
                  <c:pt idx="1">
                    <c:v>1.7154669837025155E-2</c:v>
                  </c:pt>
                  <c:pt idx="2">
                    <c:v>2.5924326249114085E-2</c:v>
                  </c:pt>
                  <c:pt idx="3">
                    <c:v>2.4528328755622403E-2</c:v>
                  </c:pt>
                  <c:pt idx="4">
                    <c:v>2.4060655510000865E-2</c:v>
                  </c:pt>
                  <c:pt idx="5">
                    <c:v>2.7392664225864647E-2</c:v>
                  </c:pt>
                  <c:pt idx="6">
                    <c:v>1.9561025402642925E-2</c:v>
                  </c:pt>
                  <c:pt idx="7">
                    <c:v>1.102538205698388E-2</c:v>
                  </c:pt>
                  <c:pt idx="8">
                    <c:v>1.5325586432718098E-2</c:v>
                  </c:pt>
                  <c:pt idx="9">
                    <c:v>6.851277783523500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01:$AZ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AQ$103:$AZ$103</c:f>
              <c:numCache>
                <c:formatCode>General</c:formatCode>
                <c:ptCount val="10"/>
                <c:pt idx="0">
                  <c:v>0.22796666870514551</c:v>
                </c:pt>
                <c:pt idx="1">
                  <c:v>0.26336666196584702</c:v>
                </c:pt>
                <c:pt idx="2">
                  <c:v>0.25883332639932632</c:v>
                </c:pt>
                <c:pt idx="3">
                  <c:v>0.27505000183979672</c:v>
                </c:pt>
                <c:pt idx="4">
                  <c:v>0.29955000430345535</c:v>
                </c:pt>
                <c:pt idx="5">
                  <c:v>0.30801666527986526</c:v>
                </c:pt>
                <c:pt idx="6">
                  <c:v>0.33681666602691013</c:v>
                </c:pt>
                <c:pt idx="7">
                  <c:v>0.31564999371767044</c:v>
                </c:pt>
                <c:pt idx="8">
                  <c:v>0.18201666325330734</c:v>
                </c:pt>
                <c:pt idx="9">
                  <c:v>5.120000119010607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C2D-4246-BE1F-D36D3FD5138F}"/>
            </c:ext>
          </c:extLst>
        </c:ser>
        <c:ser>
          <c:idx val="2"/>
          <c:order val="2"/>
          <c:tx>
            <c:strRef>
              <c:f>'[Harada 2025.04.30^LN1 (1).xlsx]計算'!$AP$104</c:f>
              <c:strCache>
                <c:ptCount val="1"/>
                <c:pt idx="0">
                  <c:v>5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08:$AZ$108</c:f>
                <c:numCache>
                  <c:formatCode>General</c:formatCode>
                  <c:ptCount val="10"/>
                  <c:pt idx="0">
                    <c:v>1.0703590290886014E-2</c:v>
                  </c:pt>
                  <c:pt idx="1">
                    <c:v>2.2973963753698992E-2</c:v>
                  </c:pt>
                  <c:pt idx="2">
                    <c:v>2.1781186361343428E-2</c:v>
                  </c:pt>
                  <c:pt idx="3">
                    <c:v>4.0328032421623902E-2</c:v>
                  </c:pt>
                  <c:pt idx="4">
                    <c:v>2.7911050966176368E-2</c:v>
                  </c:pt>
                  <c:pt idx="5">
                    <c:v>3.1724974222973004E-2</c:v>
                  </c:pt>
                  <c:pt idx="6">
                    <c:v>4.2061747910417738E-2</c:v>
                  </c:pt>
                  <c:pt idx="7">
                    <c:v>3.2497804523450156E-2</c:v>
                  </c:pt>
                  <c:pt idx="8">
                    <c:v>2.3114392236963689E-2</c:v>
                  </c:pt>
                  <c:pt idx="9">
                    <c:v>1.4037520905681555E-2</c:v>
                  </c:pt>
                </c:numCache>
              </c:numRef>
            </c:plus>
            <c:minus>
              <c:numRef>
                <c:f>'[Harada 2025.04.30^LN1 (1).xlsx]計算'!$AQ$108:$AZ$108</c:f>
                <c:numCache>
                  <c:formatCode>General</c:formatCode>
                  <c:ptCount val="10"/>
                  <c:pt idx="0">
                    <c:v>1.0703590290886014E-2</c:v>
                  </c:pt>
                  <c:pt idx="1">
                    <c:v>2.2973963753698992E-2</c:v>
                  </c:pt>
                  <c:pt idx="2">
                    <c:v>2.1781186361343428E-2</c:v>
                  </c:pt>
                  <c:pt idx="3">
                    <c:v>4.0328032421623902E-2</c:v>
                  </c:pt>
                  <c:pt idx="4">
                    <c:v>2.7911050966176368E-2</c:v>
                  </c:pt>
                  <c:pt idx="5">
                    <c:v>3.1724974222973004E-2</c:v>
                  </c:pt>
                  <c:pt idx="6">
                    <c:v>4.2061747910417738E-2</c:v>
                  </c:pt>
                  <c:pt idx="7">
                    <c:v>3.2497804523450156E-2</c:v>
                  </c:pt>
                  <c:pt idx="8">
                    <c:v>2.3114392236963689E-2</c:v>
                  </c:pt>
                  <c:pt idx="9">
                    <c:v>1.40375209056815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01:$AZ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AQ$104:$AZ$104</c:f>
              <c:numCache>
                <c:formatCode>General</c:formatCode>
                <c:ptCount val="10"/>
                <c:pt idx="0">
                  <c:v>0.28823333978652954</c:v>
                </c:pt>
                <c:pt idx="1">
                  <c:v>0.30334999660650891</c:v>
                </c:pt>
                <c:pt idx="2">
                  <c:v>0.30630000432332355</c:v>
                </c:pt>
                <c:pt idx="3">
                  <c:v>0.34363333384195965</c:v>
                </c:pt>
                <c:pt idx="4">
                  <c:v>0.34756666421890259</c:v>
                </c:pt>
                <c:pt idx="5">
                  <c:v>0.38028333087762195</c:v>
                </c:pt>
                <c:pt idx="6">
                  <c:v>0.4092666705449422</c:v>
                </c:pt>
                <c:pt idx="7">
                  <c:v>0.40135000646114349</c:v>
                </c:pt>
                <c:pt idx="8">
                  <c:v>0.27726666629314423</c:v>
                </c:pt>
                <c:pt idx="9">
                  <c:v>0.110100003580252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C2D-4246-BE1F-D36D3FD5138F}"/>
            </c:ext>
          </c:extLst>
        </c:ser>
        <c:ser>
          <c:idx val="3"/>
          <c:order val="3"/>
          <c:tx>
            <c:strRef>
              <c:f>'[Harada 2025.04.30^LN1 (1).xlsx]計算'!$AP$105</c:f>
              <c:strCache>
                <c:ptCount val="1"/>
                <c:pt idx="0">
                  <c:v>102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Harada 2025.04.30^LN1 (1).xlsx]計算'!$AQ$109:$AZ$109</c:f>
                <c:numCache>
                  <c:formatCode>General</c:formatCode>
                  <c:ptCount val="10"/>
                  <c:pt idx="0">
                    <c:v>2.376868610785399E-2</c:v>
                  </c:pt>
                  <c:pt idx="1">
                    <c:v>5.0179873767643872E-2</c:v>
                  </c:pt>
                  <c:pt idx="2">
                    <c:v>5.3742693397989663E-2</c:v>
                  </c:pt>
                  <c:pt idx="3">
                    <c:v>4.1027973182949456E-2</c:v>
                  </c:pt>
                  <c:pt idx="4">
                    <c:v>4.2191633308437872E-2</c:v>
                  </c:pt>
                  <c:pt idx="5">
                    <c:v>2.0795054310578709E-2</c:v>
                  </c:pt>
                  <c:pt idx="6">
                    <c:v>3.1483324358066021E-2</c:v>
                  </c:pt>
                  <c:pt idx="7">
                    <c:v>6.0805094334196494E-2</c:v>
                  </c:pt>
                  <c:pt idx="8">
                    <c:v>3.8426527960063184E-2</c:v>
                  </c:pt>
                  <c:pt idx="9">
                    <c:v>9.9985496818260321E-3</c:v>
                  </c:pt>
                </c:numCache>
              </c:numRef>
            </c:plus>
            <c:minus>
              <c:numRef>
                <c:f>'[Harada 2025.04.30^LN1 (1).xlsx]計算'!$AQ$109:$AZ$109</c:f>
                <c:numCache>
                  <c:formatCode>General</c:formatCode>
                  <c:ptCount val="10"/>
                  <c:pt idx="0">
                    <c:v>2.376868610785399E-2</c:v>
                  </c:pt>
                  <c:pt idx="1">
                    <c:v>5.0179873767643872E-2</c:v>
                  </c:pt>
                  <c:pt idx="2">
                    <c:v>5.3742693397989663E-2</c:v>
                  </c:pt>
                  <c:pt idx="3">
                    <c:v>4.1027973182949456E-2</c:v>
                  </c:pt>
                  <c:pt idx="4">
                    <c:v>4.2191633308437872E-2</c:v>
                  </c:pt>
                  <c:pt idx="5">
                    <c:v>2.0795054310578709E-2</c:v>
                  </c:pt>
                  <c:pt idx="6">
                    <c:v>3.1483324358066021E-2</c:v>
                  </c:pt>
                  <c:pt idx="7">
                    <c:v>6.0805094334196494E-2</c:v>
                  </c:pt>
                  <c:pt idx="8">
                    <c:v>3.8426527960063184E-2</c:v>
                  </c:pt>
                  <c:pt idx="9">
                    <c:v>9.998549681826032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Harada 2025.04.30^LN1 (1).xlsx]計算'!$AQ$101:$AZ$101</c:f>
              <c:numCache>
                <c:formatCode>General</c:formatCode>
                <c:ptCount val="10"/>
                <c:pt idx="0">
                  <c:v>0</c:v>
                </c:pt>
                <c:pt idx="1">
                  <c:v>0.01</c:v>
                </c:pt>
                <c:pt idx="2">
                  <c:v>3.2000000000000001E-2</c:v>
                </c:pt>
                <c:pt idx="3">
                  <c:v>0.1</c:v>
                </c:pt>
                <c:pt idx="4">
                  <c:v>0.32</c:v>
                </c:pt>
                <c:pt idx="5">
                  <c:v>1</c:v>
                </c:pt>
                <c:pt idx="6">
                  <c:v>3.2</c:v>
                </c:pt>
                <c:pt idx="7">
                  <c:v>10</c:v>
                </c:pt>
                <c:pt idx="8">
                  <c:v>32</c:v>
                </c:pt>
                <c:pt idx="9">
                  <c:v>100</c:v>
                </c:pt>
              </c:numCache>
            </c:numRef>
          </c:cat>
          <c:val>
            <c:numRef>
              <c:f>'[Harada 2025.04.30^LN1 (1).xlsx]計算'!$AQ$105:$AZ$105</c:f>
              <c:numCache>
                <c:formatCode>General</c:formatCode>
                <c:ptCount val="10"/>
                <c:pt idx="0">
                  <c:v>0.361566665271918</c:v>
                </c:pt>
                <c:pt idx="1">
                  <c:v>0.39304999758799869</c:v>
                </c:pt>
                <c:pt idx="2">
                  <c:v>0.4197833314538002</c:v>
                </c:pt>
                <c:pt idx="3">
                  <c:v>0.44026667128006619</c:v>
                </c:pt>
                <c:pt idx="4">
                  <c:v>0.45638334006071091</c:v>
                </c:pt>
                <c:pt idx="5">
                  <c:v>0.46363332619269687</c:v>
                </c:pt>
                <c:pt idx="6">
                  <c:v>0.5256500169634819</c:v>
                </c:pt>
                <c:pt idx="7">
                  <c:v>0.52185000230868661</c:v>
                </c:pt>
                <c:pt idx="8">
                  <c:v>0.39518332729736966</c:v>
                </c:pt>
                <c:pt idx="9">
                  <c:v>0.237649994591871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C2D-4246-BE1F-D36D3FD513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49225808"/>
        <c:axId val="249226288"/>
      </c:lineChart>
      <c:catAx>
        <c:axId val="249225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49226288"/>
        <c:crosses val="autoZero"/>
        <c:auto val="1"/>
        <c:lblAlgn val="ctr"/>
        <c:lblOffset val="100"/>
        <c:noMultiLvlLbl val="0"/>
      </c:catAx>
      <c:valAx>
        <c:axId val="249226288"/>
        <c:scaling>
          <c:orientation val="minMax"/>
          <c:max val="0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4922580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B0B124-7D2F-4FDA-9B7B-C92551B3A4BB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3893FD-A458-4E8C-B943-E789633F7A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1874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893FD-A458-4E8C-B943-E789633F7A8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5834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893FD-A458-4E8C-B943-E789633F7A8A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2786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836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702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1202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6196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525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556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6139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626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1708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35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103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AFE28-7E1C-4DFF-B642-5ADFEB0302A0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20ABD-3F5E-4A4A-826E-40755FB6A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663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1.xml"/><Relationship Id="rId13" Type="http://schemas.openxmlformats.org/officeDocument/2006/relationships/chart" Target="../charts/chart26.xml"/><Relationship Id="rId3" Type="http://schemas.openxmlformats.org/officeDocument/2006/relationships/chart" Target="../charts/chart16.xml"/><Relationship Id="rId7" Type="http://schemas.openxmlformats.org/officeDocument/2006/relationships/chart" Target="../charts/chart20.xml"/><Relationship Id="rId12" Type="http://schemas.openxmlformats.org/officeDocument/2006/relationships/chart" Target="../charts/chart25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9.xml"/><Relationship Id="rId11" Type="http://schemas.openxmlformats.org/officeDocument/2006/relationships/chart" Target="../charts/chart24.xml"/><Relationship Id="rId5" Type="http://schemas.openxmlformats.org/officeDocument/2006/relationships/chart" Target="../charts/chart18.xml"/><Relationship Id="rId10" Type="http://schemas.openxmlformats.org/officeDocument/2006/relationships/chart" Target="../charts/chart23.xml"/><Relationship Id="rId4" Type="http://schemas.openxmlformats.org/officeDocument/2006/relationships/chart" Target="../charts/chart17.xml"/><Relationship Id="rId9" Type="http://schemas.openxmlformats.org/officeDocument/2006/relationships/chart" Target="../charts/chart2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3.xml"/><Relationship Id="rId13" Type="http://schemas.openxmlformats.org/officeDocument/2006/relationships/chart" Target="../charts/chart38.xml"/><Relationship Id="rId18" Type="http://schemas.openxmlformats.org/officeDocument/2006/relationships/chart" Target="../charts/chart43.xml"/><Relationship Id="rId3" Type="http://schemas.openxmlformats.org/officeDocument/2006/relationships/chart" Target="../charts/chart28.xml"/><Relationship Id="rId21" Type="http://schemas.openxmlformats.org/officeDocument/2006/relationships/chart" Target="../charts/chart46.xml"/><Relationship Id="rId7" Type="http://schemas.openxmlformats.org/officeDocument/2006/relationships/chart" Target="../charts/chart32.xml"/><Relationship Id="rId12" Type="http://schemas.openxmlformats.org/officeDocument/2006/relationships/chart" Target="../charts/chart37.xml"/><Relationship Id="rId17" Type="http://schemas.openxmlformats.org/officeDocument/2006/relationships/chart" Target="../charts/chart42.xml"/><Relationship Id="rId2" Type="http://schemas.openxmlformats.org/officeDocument/2006/relationships/chart" Target="../charts/chart27.xml"/><Relationship Id="rId16" Type="http://schemas.openxmlformats.org/officeDocument/2006/relationships/chart" Target="../charts/chart41.xml"/><Relationship Id="rId20" Type="http://schemas.openxmlformats.org/officeDocument/2006/relationships/chart" Target="../charts/chart4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1.xml"/><Relationship Id="rId11" Type="http://schemas.openxmlformats.org/officeDocument/2006/relationships/chart" Target="../charts/chart36.xml"/><Relationship Id="rId5" Type="http://schemas.openxmlformats.org/officeDocument/2006/relationships/chart" Target="../charts/chart30.xml"/><Relationship Id="rId15" Type="http://schemas.openxmlformats.org/officeDocument/2006/relationships/chart" Target="../charts/chart40.xml"/><Relationship Id="rId10" Type="http://schemas.openxmlformats.org/officeDocument/2006/relationships/chart" Target="../charts/chart35.xml"/><Relationship Id="rId19" Type="http://schemas.openxmlformats.org/officeDocument/2006/relationships/chart" Target="../charts/chart44.xml"/><Relationship Id="rId4" Type="http://schemas.openxmlformats.org/officeDocument/2006/relationships/chart" Target="../charts/chart29.xml"/><Relationship Id="rId9" Type="http://schemas.openxmlformats.org/officeDocument/2006/relationships/chart" Target="../charts/chart34.xml"/><Relationship Id="rId14" Type="http://schemas.openxmlformats.org/officeDocument/2006/relationships/chart" Target="../charts/chart39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3.xml"/><Relationship Id="rId13" Type="http://schemas.openxmlformats.org/officeDocument/2006/relationships/chart" Target="../charts/chart58.xml"/><Relationship Id="rId3" Type="http://schemas.openxmlformats.org/officeDocument/2006/relationships/chart" Target="../charts/chart48.xml"/><Relationship Id="rId7" Type="http://schemas.openxmlformats.org/officeDocument/2006/relationships/chart" Target="../charts/chart52.xml"/><Relationship Id="rId12" Type="http://schemas.openxmlformats.org/officeDocument/2006/relationships/chart" Target="../charts/chart57.xml"/><Relationship Id="rId2" Type="http://schemas.openxmlformats.org/officeDocument/2006/relationships/chart" Target="../charts/chart47.xml"/><Relationship Id="rId16" Type="http://schemas.openxmlformats.org/officeDocument/2006/relationships/chart" Target="../charts/chart6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1.xml"/><Relationship Id="rId11" Type="http://schemas.openxmlformats.org/officeDocument/2006/relationships/chart" Target="../charts/chart56.xml"/><Relationship Id="rId5" Type="http://schemas.openxmlformats.org/officeDocument/2006/relationships/chart" Target="../charts/chart50.xml"/><Relationship Id="rId15" Type="http://schemas.openxmlformats.org/officeDocument/2006/relationships/chart" Target="../charts/chart60.xml"/><Relationship Id="rId10" Type="http://schemas.openxmlformats.org/officeDocument/2006/relationships/chart" Target="../charts/chart55.xml"/><Relationship Id="rId4" Type="http://schemas.openxmlformats.org/officeDocument/2006/relationships/chart" Target="../charts/chart49.xml"/><Relationship Id="rId9" Type="http://schemas.openxmlformats.org/officeDocument/2006/relationships/chart" Target="../charts/chart54.xml"/><Relationship Id="rId14" Type="http://schemas.openxmlformats.org/officeDocument/2006/relationships/chart" Target="../charts/chart5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558BDAB-78D7-0911-3F95-A197C5119A2C}"/>
              </a:ext>
            </a:extLst>
          </p:cNvPr>
          <p:cNvSpPr txBox="1"/>
          <p:nvPr/>
        </p:nvSpPr>
        <p:spPr>
          <a:xfrm>
            <a:off x="1835522" y="1102224"/>
            <a:ext cx="3825689" cy="3539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buNone/>
            </a:pPr>
            <a:r>
              <a:rPr lang="en-US" altLang="ja-JP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le  </a:t>
            </a:r>
          </a:p>
          <a:p>
            <a:pPr algn="l">
              <a:buNone/>
            </a:pPr>
            <a:endParaRPr lang="en-US" altLang="ja-JP" sz="2800" b="1" kern="100" dirty="0">
              <a:solidFill>
                <a:srgbClr val="000000"/>
              </a:solidFill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buNone/>
            </a:pPr>
            <a:r>
              <a:rPr lang="en-US" altLang="ja-JP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</a:t>
            </a:r>
          </a:p>
          <a:p>
            <a:pPr algn="l">
              <a:buNone/>
            </a:pPr>
            <a:r>
              <a:rPr lang="en-US" altLang="ja-JP" sz="2800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</a:t>
            </a:r>
          </a:p>
          <a:p>
            <a:pPr algn="l">
              <a:buNone/>
            </a:pPr>
            <a:r>
              <a:rPr lang="en-US" altLang="ja-JP" sz="2800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</a:t>
            </a:r>
          </a:p>
          <a:p>
            <a:pPr algn="l">
              <a:buNone/>
            </a:pPr>
            <a:r>
              <a:rPr lang="en-US" altLang="ja-JP" sz="2800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4</a:t>
            </a:r>
          </a:p>
          <a:p>
            <a:pPr algn="l">
              <a:buNone/>
            </a:pPr>
            <a:endParaRPr lang="en-US" altLang="ja-JP" sz="2800" b="1" kern="100" dirty="0">
              <a:solidFill>
                <a:srgbClr val="000000"/>
              </a:solidFill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buNone/>
            </a:pPr>
            <a:r>
              <a:rPr lang="en-US" altLang="ja-JP" sz="2800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458951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3FFFA75-E2F0-677D-B07F-FDDB8F3AB57B}"/>
              </a:ext>
            </a:extLst>
          </p:cNvPr>
          <p:cNvGrpSpPr/>
          <p:nvPr/>
        </p:nvGrpSpPr>
        <p:grpSpPr>
          <a:xfrm>
            <a:off x="286564" y="1169894"/>
            <a:ext cx="6284871" cy="6432475"/>
            <a:chOff x="630112" y="0"/>
            <a:chExt cx="8989290" cy="9075390"/>
          </a:xfrm>
        </p:grpSpPr>
        <p:grpSp>
          <p:nvGrpSpPr>
            <p:cNvPr id="88" name="グループ化 87">
              <a:extLst>
                <a:ext uri="{FF2B5EF4-FFF2-40B4-BE49-F238E27FC236}">
                  <a16:creationId xmlns:a16="http://schemas.microsoft.com/office/drawing/2014/main" id="{14A60969-BA67-D54B-4189-B1B7DA7A0E21}"/>
                </a:ext>
              </a:extLst>
            </p:cNvPr>
            <p:cNvGrpSpPr/>
            <p:nvPr/>
          </p:nvGrpSpPr>
          <p:grpSpPr>
            <a:xfrm>
              <a:off x="630112" y="0"/>
              <a:ext cx="8989290" cy="9075390"/>
              <a:chOff x="638761" y="-40665"/>
              <a:chExt cx="8989273" cy="9075395"/>
            </a:xfrm>
          </p:grpSpPr>
          <p:graphicFrame>
            <p:nvGraphicFramePr>
              <p:cNvPr id="97" name="グラフ 96">
                <a:extLst>
                  <a:ext uri="{FF2B5EF4-FFF2-40B4-BE49-F238E27FC236}">
                    <a16:creationId xmlns:a16="http://schemas.microsoft.com/office/drawing/2014/main" id="{0F6F271D-42EE-5F85-94F0-417D28A95C2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70361728"/>
                  </p:ext>
                </p:extLst>
              </p:nvPr>
            </p:nvGraphicFramePr>
            <p:xfrm>
              <a:off x="5600568" y="816220"/>
              <a:ext cx="2001246" cy="183140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98" name="グラフ 97">
                <a:extLst>
                  <a:ext uri="{FF2B5EF4-FFF2-40B4-BE49-F238E27FC236}">
                    <a16:creationId xmlns:a16="http://schemas.microsoft.com/office/drawing/2014/main" id="{7193D403-E256-654D-34CB-0C0E3A59725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7254645"/>
                  </p:ext>
                </p:extLst>
              </p:nvPr>
            </p:nvGraphicFramePr>
            <p:xfrm>
              <a:off x="5653639" y="2885859"/>
              <a:ext cx="1971506" cy="18690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99" name="グラフ 98">
                <a:extLst>
                  <a:ext uri="{FF2B5EF4-FFF2-40B4-BE49-F238E27FC236}">
                    <a16:creationId xmlns:a16="http://schemas.microsoft.com/office/drawing/2014/main" id="{205A3F86-E872-A908-995F-E84AF0C8744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55368147"/>
                  </p:ext>
                </p:extLst>
              </p:nvPr>
            </p:nvGraphicFramePr>
            <p:xfrm>
              <a:off x="5640758" y="4897783"/>
              <a:ext cx="1984387" cy="199397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00" name="グラフ 99">
                <a:extLst>
                  <a:ext uri="{FF2B5EF4-FFF2-40B4-BE49-F238E27FC236}">
                    <a16:creationId xmlns:a16="http://schemas.microsoft.com/office/drawing/2014/main" id="{4E5CAB82-E823-6437-3F98-CEDCC2BDCF0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52131309"/>
                  </p:ext>
                </p:extLst>
              </p:nvPr>
            </p:nvGraphicFramePr>
            <p:xfrm>
              <a:off x="5627915" y="7142109"/>
              <a:ext cx="3477142" cy="171179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01" name="グラフ 100">
                <a:extLst>
                  <a:ext uri="{FF2B5EF4-FFF2-40B4-BE49-F238E27FC236}">
                    <a16:creationId xmlns:a16="http://schemas.microsoft.com/office/drawing/2014/main" id="{0AC30413-136D-30BD-D8F6-A191B995F00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86075306"/>
                  </p:ext>
                </p:extLst>
              </p:nvPr>
            </p:nvGraphicFramePr>
            <p:xfrm>
              <a:off x="7617415" y="872481"/>
              <a:ext cx="1918779" cy="178406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102" name="グラフ 101">
                <a:extLst>
                  <a:ext uri="{FF2B5EF4-FFF2-40B4-BE49-F238E27FC236}">
                    <a16:creationId xmlns:a16="http://schemas.microsoft.com/office/drawing/2014/main" id="{DA42E3C9-5B12-C08E-A8FE-D573516C052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96884606"/>
                  </p:ext>
                </p:extLst>
              </p:nvPr>
            </p:nvGraphicFramePr>
            <p:xfrm>
              <a:off x="7603056" y="2888609"/>
              <a:ext cx="1987945" cy="18918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103" name="グラフ 102">
                <a:extLst>
                  <a:ext uri="{FF2B5EF4-FFF2-40B4-BE49-F238E27FC236}">
                    <a16:creationId xmlns:a16="http://schemas.microsoft.com/office/drawing/2014/main" id="{D4D0911E-247B-B8B7-C8D2-285174AEC79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95358196"/>
                  </p:ext>
                </p:extLst>
              </p:nvPr>
            </p:nvGraphicFramePr>
            <p:xfrm>
              <a:off x="7683112" y="4964406"/>
              <a:ext cx="1944922" cy="19273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id="{B846A425-BA0B-C071-74E1-778FB06E0BDB}"/>
                  </a:ext>
                </a:extLst>
              </p:cNvPr>
              <p:cNvSpPr txBox="1"/>
              <p:nvPr/>
            </p:nvSpPr>
            <p:spPr>
              <a:xfrm>
                <a:off x="5889580" y="455539"/>
                <a:ext cx="1777364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 Correction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FC533E31-ACF6-25BD-4D36-C283A6A99A91}"/>
                  </a:ext>
                </a:extLst>
              </p:cNvPr>
              <p:cNvSpPr txBox="1"/>
              <p:nvPr/>
            </p:nvSpPr>
            <p:spPr>
              <a:xfrm>
                <a:off x="7892115" y="484592"/>
                <a:ext cx="1614577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fter Correction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7E7CF94F-548F-14C6-26E1-288CA61FCCC0}"/>
                  </a:ext>
                </a:extLst>
              </p:cNvPr>
              <p:cNvSpPr txBox="1"/>
              <p:nvPr/>
            </p:nvSpPr>
            <p:spPr>
              <a:xfrm>
                <a:off x="6020833" y="2512816"/>
                <a:ext cx="3153033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Hydrocortisone succinate (</a:t>
                </a:r>
                <a:r>
                  <a:rPr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g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56E6D9AB-C031-6169-5CE7-2385B1F88FF8}"/>
                  </a:ext>
                </a:extLst>
              </p:cNvPr>
              <p:cNvSpPr txBox="1"/>
              <p:nvPr/>
            </p:nvSpPr>
            <p:spPr>
              <a:xfrm>
                <a:off x="6755060" y="4631310"/>
                <a:ext cx="1552672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Quercetin (</a:t>
                </a:r>
                <a:r>
                  <a:rPr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8" name="直線コネクタ 107">
                <a:extLst>
                  <a:ext uri="{FF2B5EF4-FFF2-40B4-BE49-F238E27FC236}">
                    <a16:creationId xmlns:a16="http://schemas.microsoft.com/office/drawing/2014/main" id="{C41D3665-F6EC-AF4E-C2D5-A832A02A58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89894" y="443327"/>
                <a:ext cx="3166409" cy="0"/>
              </a:xfrm>
              <a:prstGeom prst="line">
                <a:avLst/>
              </a:prstGeom>
              <a:ln w="28575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EEF5E62F-1E92-77DA-8EA8-35B5415A8848}"/>
                  </a:ext>
                </a:extLst>
              </p:cNvPr>
              <p:cNvSpPr txBox="1"/>
              <p:nvPr/>
            </p:nvSpPr>
            <p:spPr>
              <a:xfrm>
                <a:off x="7021886" y="1"/>
                <a:ext cx="945568" cy="4198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99" dirty="0">
                    <a:latin typeface="Arial" panose="020B0604020202020204" pitchFamily="34" charset="0"/>
                    <a:cs typeface="Arial" panose="020B0604020202020204" pitchFamily="34" charset="0"/>
                  </a:rPr>
                  <a:t>Exp. II</a:t>
                </a:r>
                <a:endParaRPr lang="ja-JP" altLang="en-US" sz="139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DEBD970D-04E4-F827-FFFC-14A10EF901AE}"/>
                  </a:ext>
                </a:extLst>
              </p:cNvPr>
              <p:cNvSpPr txBox="1"/>
              <p:nvPr/>
            </p:nvSpPr>
            <p:spPr>
              <a:xfrm>
                <a:off x="6467574" y="6720892"/>
                <a:ext cx="1992885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staxanthin (</a:t>
                </a:r>
                <a:r>
                  <a:rPr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g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11" name="グラフ 110">
                <a:extLst>
                  <a:ext uri="{FF2B5EF4-FFF2-40B4-BE49-F238E27FC236}">
                    <a16:creationId xmlns:a16="http://schemas.microsoft.com/office/drawing/2014/main" id="{1D68F2FA-E0B8-4D6D-7D4D-A3BAF71F353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45254411"/>
                  </p:ext>
                </p:extLst>
              </p:nvPr>
            </p:nvGraphicFramePr>
            <p:xfrm>
              <a:off x="1032123" y="751228"/>
              <a:ext cx="2230031" cy="204094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graphicFrame>
            <p:nvGraphicFramePr>
              <p:cNvPr id="112" name="グラフ 111">
                <a:extLst>
                  <a:ext uri="{FF2B5EF4-FFF2-40B4-BE49-F238E27FC236}">
                    <a16:creationId xmlns:a16="http://schemas.microsoft.com/office/drawing/2014/main" id="{0D23AB7F-DD8C-8F41-D3B2-0A554C59DA2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50169725"/>
                  </p:ext>
                </p:extLst>
              </p:nvPr>
            </p:nvGraphicFramePr>
            <p:xfrm>
              <a:off x="1096516" y="2862042"/>
              <a:ext cx="1965748" cy="18788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graphicFrame>
            <p:nvGraphicFramePr>
              <p:cNvPr id="113" name="グラフ 112">
                <a:extLst>
                  <a:ext uri="{FF2B5EF4-FFF2-40B4-BE49-F238E27FC236}">
                    <a16:creationId xmlns:a16="http://schemas.microsoft.com/office/drawing/2014/main" id="{7E06C5B5-A517-33A8-9129-52A39504796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80053116"/>
                  </p:ext>
                </p:extLst>
              </p:nvPr>
            </p:nvGraphicFramePr>
            <p:xfrm>
              <a:off x="1030315" y="4850509"/>
              <a:ext cx="2209301" cy="204125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graphicFrame>
            <p:nvGraphicFramePr>
              <p:cNvPr id="114" name="グラフ 113">
                <a:extLst>
                  <a:ext uri="{FF2B5EF4-FFF2-40B4-BE49-F238E27FC236}">
                    <a16:creationId xmlns:a16="http://schemas.microsoft.com/office/drawing/2014/main" id="{CB7B4472-AD42-AD91-9B85-70B7596758A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30102046"/>
                  </p:ext>
                </p:extLst>
              </p:nvPr>
            </p:nvGraphicFramePr>
            <p:xfrm>
              <a:off x="1104423" y="6986439"/>
              <a:ext cx="4157280" cy="167385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graphicFrame>
            <p:nvGraphicFramePr>
              <p:cNvPr id="115" name="グラフ 114">
                <a:extLst>
                  <a:ext uri="{FF2B5EF4-FFF2-40B4-BE49-F238E27FC236}">
                    <a16:creationId xmlns:a16="http://schemas.microsoft.com/office/drawing/2014/main" id="{02A20356-7107-AE13-E121-F6F361D6F1F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73944118"/>
                  </p:ext>
                </p:extLst>
              </p:nvPr>
            </p:nvGraphicFramePr>
            <p:xfrm>
              <a:off x="3127000" y="882969"/>
              <a:ext cx="1996554" cy="175208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graphicFrame>
            <p:nvGraphicFramePr>
              <p:cNvPr id="116" name="グラフ 115">
                <a:extLst>
                  <a:ext uri="{FF2B5EF4-FFF2-40B4-BE49-F238E27FC236}">
                    <a16:creationId xmlns:a16="http://schemas.microsoft.com/office/drawing/2014/main" id="{0759C294-2341-9720-40B5-826D97AD28A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05809691"/>
                  </p:ext>
                </p:extLst>
              </p:nvPr>
            </p:nvGraphicFramePr>
            <p:xfrm>
              <a:off x="3142365" y="2827805"/>
              <a:ext cx="2065796" cy="190920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graphicFrame>
            <p:nvGraphicFramePr>
              <p:cNvPr id="117" name="グラフ 116">
                <a:extLst>
                  <a:ext uri="{FF2B5EF4-FFF2-40B4-BE49-F238E27FC236}">
                    <a16:creationId xmlns:a16="http://schemas.microsoft.com/office/drawing/2014/main" id="{4966BEC7-6FF7-21E0-2920-2F7E3D7E19A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31580554"/>
                  </p:ext>
                </p:extLst>
              </p:nvPr>
            </p:nvGraphicFramePr>
            <p:xfrm>
              <a:off x="3217399" y="4884119"/>
              <a:ext cx="1966995" cy="196034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3E10CBCF-BFF9-B25C-CD8C-3D6CCD77FB63}"/>
                  </a:ext>
                </a:extLst>
              </p:cNvPr>
              <p:cNvSpPr txBox="1"/>
              <p:nvPr/>
            </p:nvSpPr>
            <p:spPr>
              <a:xfrm>
                <a:off x="1411968" y="462678"/>
                <a:ext cx="1777364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 Correction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5F15CB12-49AE-18BE-3D4A-5A6D4C13D3D9}"/>
                  </a:ext>
                </a:extLst>
              </p:cNvPr>
              <p:cNvSpPr txBox="1"/>
              <p:nvPr/>
            </p:nvSpPr>
            <p:spPr>
              <a:xfrm>
                <a:off x="3296741" y="491733"/>
                <a:ext cx="1614577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fter Correction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0" name="直線コネクタ 119">
                <a:extLst>
                  <a:ext uri="{FF2B5EF4-FFF2-40B4-BE49-F238E27FC236}">
                    <a16:creationId xmlns:a16="http://schemas.microsoft.com/office/drawing/2014/main" id="{BA3486D6-3B1B-5CB8-F723-C0CE971323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39140" y="446442"/>
                <a:ext cx="3178368" cy="0"/>
              </a:xfrm>
              <a:prstGeom prst="line">
                <a:avLst/>
              </a:prstGeom>
              <a:ln w="28575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3E1C3F56-3359-1B36-2412-5E4BD5645519}"/>
                  </a:ext>
                </a:extLst>
              </p:cNvPr>
              <p:cNvSpPr txBox="1"/>
              <p:nvPr/>
            </p:nvSpPr>
            <p:spPr>
              <a:xfrm>
                <a:off x="2777477" y="-40665"/>
                <a:ext cx="877746" cy="4198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99" dirty="0">
                    <a:latin typeface="Arial" panose="020B0604020202020204" pitchFamily="34" charset="0"/>
                    <a:cs typeface="Arial" panose="020B0604020202020204" pitchFamily="34" charset="0"/>
                  </a:rPr>
                  <a:t>Exp. I</a:t>
                </a:r>
                <a:endParaRPr lang="ja-JP" altLang="en-US" sz="139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CFB64D58-CB44-17DA-DCC4-0560347B1EEF}"/>
                  </a:ext>
                </a:extLst>
              </p:cNvPr>
              <p:cNvSpPr txBox="1"/>
              <p:nvPr/>
            </p:nvSpPr>
            <p:spPr>
              <a:xfrm>
                <a:off x="1571982" y="2540186"/>
                <a:ext cx="3153033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Hydrocortisone succinate (</a:t>
                </a:r>
                <a:r>
                  <a:rPr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g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テキスト ボックス 122">
                <a:extLst>
                  <a:ext uri="{FF2B5EF4-FFF2-40B4-BE49-F238E27FC236}">
                    <a16:creationId xmlns:a16="http://schemas.microsoft.com/office/drawing/2014/main" id="{C8DA79D1-A19E-B8A9-5625-6BBBFC0AF317}"/>
                  </a:ext>
                </a:extLst>
              </p:cNvPr>
              <p:cNvSpPr txBox="1"/>
              <p:nvPr/>
            </p:nvSpPr>
            <p:spPr>
              <a:xfrm>
                <a:off x="2570208" y="4627362"/>
                <a:ext cx="1552672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Quercetin (</a:t>
                </a:r>
                <a:r>
                  <a:rPr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テキスト ボックス 123">
                <a:extLst>
                  <a:ext uri="{FF2B5EF4-FFF2-40B4-BE49-F238E27FC236}">
                    <a16:creationId xmlns:a16="http://schemas.microsoft.com/office/drawing/2014/main" id="{AD99B8A4-FD64-0271-878D-687DC3BA2717}"/>
                  </a:ext>
                </a:extLst>
              </p:cNvPr>
              <p:cNvSpPr txBox="1"/>
              <p:nvPr/>
            </p:nvSpPr>
            <p:spPr>
              <a:xfrm>
                <a:off x="2286616" y="6773402"/>
                <a:ext cx="1992885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staxanthin (</a:t>
                </a:r>
                <a:r>
                  <a:rPr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g</a:t>
                </a:r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6DBBD30C-D50E-2CA3-FE6C-88B67F466FDC}"/>
                  </a:ext>
                </a:extLst>
              </p:cNvPr>
              <p:cNvSpPr txBox="1"/>
              <p:nvPr/>
            </p:nvSpPr>
            <p:spPr>
              <a:xfrm>
                <a:off x="3501606" y="7341637"/>
                <a:ext cx="1499938" cy="5901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Inoculated cell</a:t>
                </a:r>
              </a:p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/ well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92C13CAB-BEA9-761C-AAA9-0B287B0E2F1D}"/>
                  </a:ext>
                </a:extLst>
              </p:cNvPr>
              <p:cNvSpPr txBox="1"/>
              <p:nvPr/>
            </p:nvSpPr>
            <p:spPr>
              <a:xfrm>
                <a:off x="7915145" y="7415219"/>
                <a:ext cx="1499938" cy="5901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Inoculated cell</a:t>
                </a:r>
              </a:p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/ well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8B7EF7D9-92F9-58F1-A9CD-CA68858C93BD}"/>
                  </a:ext>
                </a:extLst>
              </p:cNvPr>
              <p:cNvSpPr txBox="1"/>
              <p:nvPr/>
            </p:nvSpPr>
            <p:spPr>
              <a:xfrm>
                <a:off x="707743" y="8628636"/>
                <a:ext cx="3185132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ow number of 96-microwell plate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F3E90481-6B6B-448C-20F2-DC0B3847E4C8}"/>
                  </a:ext>
                </a:extLst>
              </p:cNvPr>
              <p:cNvSpPr txBox="1"/>
              <p:nvPr/>
            </p:nvSpPr>
            <p:spPr>
              <a:xfrm>
                <a:off x="5112127" y="8674055"/>
                <a:ext cx="3185132" cy="360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ow number of 96-microwell plate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1A480360-7DFF-9315-F56B-A8D750D4E731}"/>
                  </a:ext>
                </a:extLst>
              </p:cNvPr>
              <p:cNvSpPr txBox="1"/>
              <p:nvPr/>
            </p:nvSpPr>
            <p:spPr>
              <a:xfrm rot="16200000">
                <a:off x="-1308863" y="4206147"/>
                <a:ext cx="4258425" cy="3631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number at Day 14 (absorbance at 560 nm)</a:t>
                </a:r>
                <a:endPara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7AC71510-7F94-5B44-F503-DF78BB6E6C0C}"/>
                  </a:ext>
                </a:extLst>
              </p:cNvPr>
              <p:cNvSpPr txBox="1"/>
              <p:nvPr/>
            </p:nvSpPr>
            <p:spPr>
              <a:xfrm rot="16200000">
                <a:off x="3266839" y="4191553"/>
                <a:ext cx="4256146" cy="3631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number at Day 14 (absorbance at 560 nm</a:t>
                </a:r>
                <a:r>
                  <a:rPr lang="en-US" altLang="ja-JP" sz="1026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ja-JP" altLang="en-US" sz="1026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9DCBBFF0-9FBD-1FFA-A8FF-A71205590CA3}"/>
                </a:ext>
              </a:extLst>
            </p:cNvPr>
            <p:cNvSpPr txBox="1"/>
            <p:nvPr/>
          </p:nvSpPr>
          <p:spPr>
            <a:xfrm>
              <a:off x="6278164" y="341224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2C392EF-71AD-4136-1491-BA4B6C0E03E9}"/>
                </a:ext>
              </a:extLst>
            </p:cNvPr>
            <p:cNvSpPr txBox="1"/>
            <p:nvPr/>
          </p:nvSpPr>
          <p:spPr>
            <a:xfrm>
              <a:off x="6430564" y="3356210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BA174A1-03F0-9E21-A100-B3900C244D89}"/>
                </a:ext>
              </a:extLst>
            </p:cNvPr>
            <p:cNvSpPr txBox="1"/>
            <p:nvPr/>
          </p:nvSpPr>
          <p:spPr>
            <a:xfrm>
              <a:off x="6605385" y="3349485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71DB73A-314B-33D1-0AB1-CFCD40854EBE}"/>
                </a:ext>
              </a:extLst>
            </p:cNvPr>
            <p:cNvSpPr txBox="1"/>
            <p:nvPr/>
          </p:nvSpPr>
          <p:spPr>
            <a:xfrm>
              <a:off x="6793806" y="329906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E96CABD8-781F-1A60-D962-61B0C84B6A8D}"/>
                </a:ext>
              </a:extLst>
            </p:cNvPr>
            <p:cNvSpPr txBox="1"/>
            <p:nvPr/>
          </p:nvSpPr>
          <p:spPr>
            <a:xfrm>
              <a:off x="6934020" y="3334346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069304F-53C4-E3BA-DDD2-5CC5E5224C27}"/>
                </a:ext>
              </a:extLst>
            </p:cNvPr>
            <p:cNvSpPr txBox="1"/>
            <p:nvPr/>
          </p:nvSpPr>
          <p:spPr>
            <a:xfrm>
              <a:off x="6454082" y="352993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E3C4E2F-B575-F61F-E00B-FC311B3E69B1}"/>
                </a:ext>
              </a:extLst>
            </p:cNvPr>
            <p:cNvSpPr txBox="1"/>
            <p:nvPr/>
          </p:nvSpPr>
          <p:spPr>
            <a:xfrm>
              <a:off x="6601992" y="3499227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19E2F4E-49D9-83C7-7FFC-A9FA86F03FEA}"/>
                </a:ext>
              </a:extLst>
            </p:cNvPr>
            <p:cNvSpPr txBox="1"/>
            <p:nvPr/>
          </p:nvSpPr>
          <p:spPr>
            <a:xfrm>
              <a:off x="6770180" y="345912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6D87A7D-E36F-BE50-657B-B701856C2F88}"/>
                </a:ext>
              </a:extLst>
            </p:cNvPr>
            <p:cNvSpPr txBox="1"/>
            <p:nvPr/>
          </p:nvSpPr>
          <p:spPr>
            <a:xfrm>
              <a:off x="6608776" y="359313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78D9E3F-9EA9-1023-F20F-8BC9772C7A3F}"/>
                </a:ext>
              </a:extLst>
            </p:cNvPr>
            <p:cNvSpPr txBox="1"/>
            <p:nvPr/>
          </p:nvSpPr>
          <p:spPr>
            <a:xfrm>
              <a:off x="6781993" y="3608620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13B5FE59-5E61-C877-24B5-A6A08D8826BE}"/>
                </a:ext>
              </a:extLst>
            </p:cNvPr>
            <p:cNvSpPr txBox="1"/>
            <p:nvPr/>
          </p:nvSpPr>
          <p:spPr>
            <a:xfrm>
              <a:off x="6918199" y="366078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993F595C-A395-9B07-33E4-59429CAAD7CC}"/>
                </a:ext>
              </a:extLst>
            </p:cNvPr>
            <p:cNvSpPr txBox="1"/>
            <p:nvPr/>
          </p:nvSpPr>
          <p:spPr>
            <a:xfrm>
              <a:off x="6292604" y="382450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6F869282-AC1A-3F1D-D5CF-6BD985E2686B}"/>
                </a:ext>
              </a:extLst>
            </p:cNvPr>
            <p:cNvSpPr txBox="1"/>
            <p:nvPr/>
          </p:nvSpPr>
          <p:spPr>
            <a:xfrm>
              <a:off x="6469196" y="380286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DC37A7E-9645-4F9C-FDE3-A58C28E0F014}"/>
                </a:ext>
              </a:extLst>
            </p:cNvPr>
            <p:cNvSpPr txBox="1"/>
            <p:nvPr/>
          </p:nvSpPr>
          <p:spPr>
            <a:xfrm>
              <a:off x="6615564" y="381600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78AE6273-9A83-A30F-4D13-DEB9C8B524F2}"/>
                </a:ext>
              </a:extLst>
            </p:cNvPr>
            <p:cNvSpPr txBox="1"/>
            <p:nvPr/>
          </p:nvSpPr>
          <p:spPr>
            <a:xfrm>
              <a:off x="6756718" y="376882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ACCFFC74-8E50-380F-1E7A-2CB55DCDBCA5}"/>
                </a:ext>
              </a:extLst>
            </p:cNvPr>
            <p:cNvSpPr txBox="1"/>
            <p:nvPr/>
          </p:nvSpPr>
          <p:spPr>
            <a:xfrm>
              <a:off x="6871134" y="3822906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2" name="左大かっこ 21">
              <a:extLst>
                <a:ext uri="{FF2B5EF4-FFF2-40B4-BE49-F238E27FC236}">
                  <a16:creationId xmlns:a16="http://schemas.microsoft.com/office/drawing/2014/main" id="{A125E371-3313-4272-C99C-A2983659769D}"/>
                </a:ext>
              </a:extLst>
            </p:cNvPr>
            <p:cNvSpPr/>
            <p:nvPr/>
          </p:nvSpPr>
          <p:spPr>
            <a:xfrm rot="5400000">
              <a:off x="6662086" y="4864709"/>
              <a:ext cx="64942" cy="1109893"/>
            </a:xfrm>
            <a:prstGeom prst="leftBracket">
              <a:avLst/>
            </a:prstGeom>
            <a:ln w="127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 sz="1319">
                <a:solidFill>
                  <a:srgbClr val="FF0000"/>
                </a:solidFill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0D208AE2-642C-FBF4-2D6D-ECD13BCC95DC}"/>
                </a:ext>
              </a:extLst>
            </p:cNvPr>
            <p:cNvSpPr txBox="1"/>
            <p:nvPr/>
          </p:nvSpPr>
          <p:spPr>
            <a:xfrm>
              <a:off x="6525256" y="5023908"/>
              <a:ext cx="650215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</a:rPr>
                <a:t>N.S.</a:t>
              </a:r>
              <a:endParaRPr lang="ja-JP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4A3C882B-5722-1EE2-DC39-6344A1CB2EF0}"/>
                </a:ext>
              </a:extLst>
            </p:cNvPr>
            <p:cNvSpPr txBox="1"/>
            <p:nvPr/>
          </p:nvSpPr>
          <p:spPr>
            <a:xfrm>
              <a:off x="6292604" y="748176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583FBCA-B9E6-E15F-CCAF-4AB8A629C363}"/>
                </a:ext>
              </a:extLst>
            </p:cNvPr>
            <p:cNvSpPr txBox="1"/>
            <p:nvPr/>
          </p:nvSpPr>
          <p:spPr>
            <a:xfrm>
              <a:off x="6454082" y="7667037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986A853-57E1-731E-1178-BD21FCD823B3}"/>
                </a:ext>
              </a:extLst>
            </p:cNvPr>
            <p:cNvSpPr txBox="1"/>
            <p:nvPr/>
          </p:nvSpPr>
          <p:spPr>
            <a:xfrm>
              <a:off x="6576161" y="784597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D1E889A1-603D-042B-CD6A-9B26146F2FFA}"/>
                </a:ext>
              </a:extLst>
            </p:cNvPr>
            <p:cNvSpPr txBox="1"/>
            <p:nvPr/>
          </p:nvSpPr>
          <p:spPr>
            <a:xfrm>
              <a:off x="5985669" y="7877616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56549020-3F7C-0ACD-3291-7EB15F638B77}"/>
                </a:ext>
              </a:extLst>
            </p:cNvPr>
            <p:cNvSpPr txBox="1"/>
            <p:nvPr/>
          </p:nvSpPr>
          <p:spPr>
            <a:xfrm>
              <a:off x="6143874" y="784597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740BF69E-3AC9-4B0A-766C-11884E4EFD93}"/>
                </a:ext>
              </a:extLst>
            </p:cNvPr>
            <p:cNvSpPr txBox="1"/>
            <p:nvPr/>
          </p:nvSpPr>
          <p:spPr>
            <a:xfrm>
              <a:off x="1875726" y="754008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F6B83EDE-D9D5-AE8B-A951-17023D975D55}"/>
                </a:ext>
              </a:extLst>
            </p:cNvPr>
            <p:cNvSpPr txBox="1"/>
            <p:nvPr/>
          </p:nvSpPr>
          <p:spPr>
            <a:xfrm>
              <a:off x="1906438" y="7667037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F4120D30-7E8E-6320-664B-953586551640}"/>
                </a:ext>
              </a:extLst>
            </p:cNvPr>
            <p:cNvSpPr txBox="1"/>
            <p:nvPr/>
          </p:nvSpPr>
          <p:spPr>
            <a:xfrm>
              <a:off x="1582919" y="7992716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F1513F79-D790-9814-7C31-FB0EFC20850D}"/>
                </a:ext>
              </a:extLst>
            </p:cNvPr>
            <p:cNvSpPr txBox="1"/>
            <p:nvPr/>
          </p:nvSpPr>
          <p:spPr>
            <a:xfrm>
              <a:off x="1705000" y="7940740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0B2E4652-59C6-E0A8-6A94-6EA23323F299}"/>
                </a:ext>
              </a:extLst>
            </p:cNvPr>
            <p:cNvSpPr txBox="1"/>
            <p:nvPr/>
          </p:nvSpPr>
          <p:spPr>
            <a:xfrm>
              <a:off x="1882326" y="7940740"/>
              <a:ext cx="369597" cy="393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7DDC7A61-5B92-5649-9B47-877B03AEFB92}"/>
                </a:ext>
              </a:extLst>
            </p:cNvPr>
            <p:cNvSpPr txBox="1"/>
            <p:nvPr/>
          </p:nvSpPr>
          <p:spPr>
            <a:xfrm>
              <a:off x="2030832" y="7928722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B63752C7-7DD7-3188-72AA-4A8C1D631356}"/>
                </a:ext>
              </a:extLst>
            </p:cNvPr>
            <p:cNvSpPr txBox="1"/>
            <p:nvPr/>
          </p:nvSpPr>
          <p:spPr>
            <a:xfrm>
              <a:off x="2164924" y="7980696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530268F-8674-8F2E-7E50-2D6D5627B337}"/>
                </a:ext>
              </a:extLst>
            </p:cNvPr>
            <p:cNvSpPr txBox="1"/>
            <p:nvPr/>
          </p:nvSpPr>
          <p:spPr>
            <a:xfrm>
              <a:off x="2307050" y="7992716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98B229F-99C6-17D5-8424-E1DDE3D9873B}"/>
                </a:ext>
              </a:extLst>
            </p:cNvPr>
            <p:cNvSpPr txBox="1"/>
            <p:nvPr/>
          </p:nvSpPr>
          <p:spPr>
            <a:xfrm>
              <a:off x="1829753" y="769815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38" name="左大かっこ 37">
              <a:extLst>
                <a:ext uri="{FF2B5EF4-FFF2-40B4-BE49-F238E27FC236}">
                  <a16:creationId xmlns:a16="http://schemas.microsoft.com/office/drawing/2014/main" id="{4878E7C2-2342-0D7E-1A75-3A61AD0626AE}"/>
                </a:ext>
              </a:extLst>
            </p:cNvPr>
            <p:cNvSpPr/>
            <p:nvPr/>
          </p:nvSpPr>
          <p:spPr>
            <a:xfrm rot="5400000">
              <a:off x="1992101" y="570635"/>
              <a:ext cx="45719" cy="810109"/>
            </a:xfrm>
            <a:prstGeom prst="leftBracket">
              <a:avLst/>
            </a:prstGeom>
            <a:ln w="127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 sz="1319">
                <a:solidFill>
                  <a:srgbClr val="FF0000"/>
                </a:solidFill>
              </a:endParaRPr>
            </a:p>
          </p:txBody>
        </p:sp>
        <p:sp>
          <p:nvSpPr>
            <p:cNvPr id="39" name="左大かっこ 38">
              <a:extLst>
                <a:ext uri="{FF2B5EF4-FFF2-40B4-BE49-F238E27FC236}">
                  <a16:creationId xmlns:a16="http://schemas.microsoft.com/office/drawing/2014/main" id="{E7AECC63-2D6F-150A-6335-D7F389011D7A}"/>
                </a:ext>
              </a:extLst>
            </p:cNvPr>
            <p:cNvSpPr/>
            <p:nvPr/>
          </p:nvSpPr>
          <p:spPr>
            <a:xfrm rot="5400000">
              <a:off x="6484326" y="541439"/>
              <a:ext cx="45719" cy="810109"/>
            </a:xfrm>
            <a:prstGeom prst="leftBracket">
              <a:avLst/>
            </a:prstGeom>
            <a:ln w="127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 sz="1319">
                <a:solidFill>
                  <a:srgbClr val="FF0000"/>
                </a:solidFill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21A3231B-5862-A32E-BC4A-3276079C5B8C}"/>
                </a:ext>
              </a:extLst>
            </p:cNvPr>
            <p:cNvSpPr txBox="1"/>
            <p:nvPr/>
          </p:nvSpPr>
          <p:spPr>
            <a:xfrm>
              <a:off x="6338285" y="715059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6CD2AE13-0414-42F8-FCA5-9C675023D914}"/>
                </a:ext>
              </a:extLst>
            </p:cNvPr>
            <p:cNvSpPr txBox="1"/>
            <p:nvPr/>
          </p:nvSpPr>
          <p:spPr>
            <a:xfrm>
              <a:off x="1697216" y="342344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6B796E8C-B531-0433-CA40-6BA1B1FE8644}"/>
                </a:ext>
              </a:extLst>
            </p:cNvPr>
            <p:cNvSpPr txBox="1"/>
            <p:nvPr/>
          </p:nvSpPr>
          <p:spPr>
            <a:xfrm>
              <a:off x="1822718" y="3407750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DC40F486-82E4-FCAC-640D-91A62D7352CA}"/>
                </a:ext>
              </a:extLst>
            </p:cNvPr>
            <p:cNvSpPr txBox="1"/>
            <p:nvPr/>
          </p:nvSpPr>
          <p:spPr>
            <a:xfrm>
              <a:off x="1940035" y="3254017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C0DDF002-7F98-23C0-9B3C-3F63A37E3E31}"/>
                </a:ext>
              </a:extLst>
            </p:cNvPr>
            <p:cNvSpPr txBox="1"/>
            <p:nvPr/>
          </p:nvSpPr>
          <p:spPr>
            <a:xfrm>
              <a:off x="2444796" y="3057447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6634865C-109B-BDAC-ED6C-D13C87CD0273}"/>
                </a:ext>
              </a:extLst>
            </p:cNvPr>
            <p:cNvSpPr txBox="1"/>
            <p:nvPr/>
          </p:nvSpPr>
          <p:spPr>
            <a:xfrm>
              <a:off x="2274132" y="3164017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D9F84DFC-8954-BEA7-8BCE-703BEFDC8FA8}"/>
                </a:ext>
              </a:extLst>
            </p:cNvPr>
            <p:cNvSpPr txBox="1"/>
            <p:nvPr/>
          </p:nvSpPr>
          <p:spPr>
            <a:xfrm>
              <a:off x="1668079" y="361618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10CB4A95-D510-78BD-B9A2-C0F61615FEA9}"/>
                </a:ext>
              </a:extLst>
            </p:cNvPr>
            <p:cNvSpPr txBox="1"/>
            <p:nvPr/>
          </p:nvSpPr>
          <p:spPr>
            <a:xfrm>
              <a:off x="1793582" y="360049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79237066-3809-6D49-2EED-79B7E7EBFC12}"/>
                </a:ext>
              </a:extLst>
            </p:cNvPr>
            <p:cNvSpPr txBox="1"/>
            <p:nvPr/>
          </p:nvSpPr>
          <p:spPr>
            <a:xfrm>
              <a:off x="1948230" y="3553426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D6ADC9C-6958-6D61-C4B8-3E3073B8638E}"/>
                </a:ext>
              </a:extLst>
            </p:cNvPr>
            <p:cNvSpPr txBox="1"/>
            <p:nvPr/>
          </p:nvSpPr>
          <p:spPr>
            <a:xfrm>
              <a:off x="2100540" y="3323450"/>
              <a:ext cx="342083" cy="32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9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9F3B9529-68CE-CF60-BF23-C173317A2A1E}"/>
                </a:ext>
              </a:extLst>
            </p:cNvPr>
            <p:cNvSpPr txBox="1"/>
            <p:nvPr/>
          </p:nvSpPr>
          <p:spPr>
            <a:xfrm>
              <a:off x="2282329" y="350075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ED14F504-3417-52F8-987F-458289B83EA5}"/>
                </a:ext>
              </a:extLst>
            </p:cNvPr>
            <p:cNvSpPr txBox="1"/>
            <p:nvPr/>
          </p:nvSpPr>
          <p:spPr>
            <a:xfrm>
              <a:off x="1854093" y="3728252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D431DB1A-9B49-B944-89F2-91C0D62B51FE}"/>
                </a:ext>
              </a:extLst>
            </p:cNvPr>
            <p:cNvSpPr txBox="1"/>
            <p:nvPr/>
          </p:nvSpPr>
          <p:spPr>
            <a:xfrm>
              <a:off x="1988569" y="369462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6FC090F8-7922-37B3-7AD5-619005B59F44}"/>
                </a:ext>
              </a:extLst>
            </p:cNvPr>
            <p:cNvSpPr txBox="1"/>
            <p:nvPr/>
          </p:nvSpPr>
          <p:spPr>
            <a:xfrm>
              <a:off x="2136646" y="363748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2BA414F5-C207-26EF-6C59-31D393033F4C}"/>
                </a:ext>
              </a:extLst>
            </p:cNvPr>
            <p:cNvSpPr txBox="1"/>
            <p:nvPr/>
          </p:nvSpPr>
          <p:spPr>
            <a:xfrm>
              <a:off x="2282324" y="3682305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08594219-A10C-AFF8-E782-98C197C0E0F8}"/>
                </a:ext>
              </a:extLst>
            </p:cNvPr>
            <p:cNvSpPr txBox="1"/>
            <p:nvPr/>
          </p:nvSpPr>
          <p:spPr>
            <a:xfrm>
              <a:off x="1851844" y="387392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7BDA8988-2D65-E56D-6DC0-EA092603047A}"/>
                </a:ext>
              </a:extLst>
            </p:cNvPr>
            <p:cNvSpPr txBox="1"/>
            <p:nvPr/>
          </p:nvSpPr>
          <p:spPr>
            <a:xfrm>
              <a:off x="2266631" y="3841432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E3072AFD-2F75-4167-E162-A560A3E38672}"/>
                </a:ext>
              </a:extLst>
            </p:cNvPr>
            <p:cNvSpPr txBox="1"/>
            <p:nvPr/>
          </p:nvSpPr>
          <p:spPr>
            <a:xfrm>
              <a:off x="1993675" y="3829355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5A334EB2-BE05-B354-7778-DB83A113F8F9}"/>
                </a:ext>
              </a:extLst>
            </p:cNvPr>
            <p:cNvSpPr txBox="1"/>
            <p:nvPr/>
          </p:nvSpPr>
          <p:spPr>
            <a:xfrm>
              <a:off x="2161142" y="381340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D630ACA8-6AA2-C3BA-9703-C8210A2B3EF5}"/>
                </a:ext>
              </a:extLst>
            </p:cNvPr>
            <p:cNvSpPr txBox="1"/>
            <p:nvPr/>
          </p:nvSpPr>
          <p:spPr>
            <a:xfrm>
              <a:off x="2475073" y="5588769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470CE21D-8FB7-069B-8E2B-B64922664FD4}"/>
                </a:ext>
              </a:extLst>
            </p:cNvPr>
            <p:cNvSpPr txBox="1"/>
            <p:nvPr/>
          </p:nvSpPr>
          <p:spPr>
            <a:xfrm>
              <a:off x="1705000" y="5793598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374DE28C-D35F-11F4-C196-58CBD5FCA45D}"/>
                </a:ext>
              </a:extLst>
            </p:cNvPr>
            <p:cNvSpPr txBox="1"/>
            <p:nvPr/>
          </p:nvSpPr>
          <p:spPr>
            <a:xfrm>
              <a:off x="1851844" y="5785047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22EFA63D-AC98-D395-E247-F1AD70449C4A}"/>
                </a:ext>
              </a:extLst>
            </p:cNvPr>
            <p:cNvSpPr txBox="1"/>
            <p:nvPr/>
          </p:nvSpPr>
          <p:spPr>
            <a:xfrm>
              <a:off x="2005535" y="5804834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BC5B5F2B-B770-EAE4-5051-3EF0C0511624}"/>
                </a:ext>
              </a:extLst>
            </p:cNvPr>
            <p:cNvSpPr txBox="1"/>
            <p:nvPr/>
          </p:nvSpPr>
          <p:spPr>
            <a:xfrm>
              <a:off x="2174536" y="581152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7CEE3A55-8518-85A9-E9B9-2E40080D1C44}"/>
                </a:ext>
              </a:extLst>
            </p:cNvPr>
            <p:cNvSpPr txBox="1"/>
            <p:nvPr/>
          </p:nvSpPr>
          <p:spPr>
            <a:xfrm>
              <a:off x="2313035" y="581152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81322C68-532E-8C74-8999-12379A38CD87}"/>
                </a:ext>
              </a:extLst>
            </p:cNvPr>
            <p:cNvSpPr txBox="1"/>
            <p:nvPr/>
          </p:nvSpPr>
          <p:spPr>
            <a:xfrm>
              <a:off x="2415015" y="580057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4104166B-5D2B-77CE-7704-9DEAF2DC1305}"/>
                </a:ext>
              </a:extLst>
            </p:cNvPr>
            <p:cNvSpPr txBox="1"/>
            <p:nvPr/>
          </p:nvSpPr>
          <p:spPr>
            <a:xfrm>
              <a:off x="1543685" y="5972532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D70C5132-6915-EB9C-0DD2-31022094D753}"/>
                </a:ext>
              </a:extLst>
            </p:cNvPr>
            <p:cNvSpPr txBox="1"/>
            <p:nvPr/>
          </p:nvSpPr>
          <p:spPr>
            <a:xfrm>
              <a:off x="1714594" y="5971832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52F85FF8-D36D-B69B-C5AB-B8ED29B18145}"/>
                </a:ext>
              </a:extLst>
            </p:cNvPr>
            <p:cNvSpPr txBox="1"/>
            <p:nvPr/>
          </p:nvSpPr>
          <p:spPr>
            <a:xfrm>
              <a:off x="1849405" y="5954879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D69E54A4-162A-3078-E936-DB8570EC2E67}"/>
                </a:ext>
              </a:extLst>
            </p:cNvPr>
            <p:cNvSpPr txBox="1"/>
            <p:nvPr/>
          </p:nvSpPr>
          <p:spPr>
            <a:xfrm>
              <a:off x="2027735" y="595830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B817CFD9-B5DA-D08C-2F70-94BE61CA5722}"/>
                </a:ext>
              </a:extLst>
            </p:cNvPr>
            <p:cNvSpPr txBox="1"/>
            <p:nvPr/>
          </p:nvSpPr>
          <p:spPr>
            <a:xfrm>
              <a:off x="2163141" y="5945406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C8255C9C-2BD3-F38C-574C-3DED34F62FE3}"/>
                </a:ext>
              </a:extLst>
            </p:cNvPr>
            <p:cNvSpPr txBox="1"/>
            <p:nvPr/>
          </p:nvSpPr>
          <p:spPr>
            <a:xfrm>
              <a:off x="2324805" y="5944855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A5FF1C33-366A-A900-1BCE-3068A36E7989}"/>
                </a:ext>
              </a:extLst>
            </p:cNvPr>
            <p:cNvSpPr txBox="1"/>
            <p:nvPr/>
          </p:nvSpPr>
          <p:spPr>
            <a:xfrm>
              <a:off x="2440516" y="5929442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03ACE5BB-2524-80C0-0790-336C86710E77}"/>
                </a:ext>
              </a:extLst>
            </p:cNvPr>
            <p:cNvSpPr txBox="1"/>
            <p:nvPr/>
          </p:nvSpPr>
          <p:spPr>
            <a:xfrm>
              <a:off x="1714594" y="6057807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E388CB9A-7443-7327-6CDE-A48521E7555A}"/>
                </a:ext>
              </a:extLst>
            </p:cNvPr>
            <p:cNvSpPr txBox="1"/>
            <p:nvPr/>
          </p:nvSpPr>
          <p:spPr>
            <a:xfrm>
              <a:off x="1849405" y="6073987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F83808B3-55CA-B879-C978-CE5F559054E8}"/>
                </a:ext>
              </a:extLst>
            </p:cNvPr>
            <p:cNvSpPr txBox="1"/>
            <p:nvPr/>
          </p:nvSpPr>
          <p:spPr>
            <a:xfrm>
              <a:off x="2163141" y="6064513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0CCB1885-64C6-9FA0-564C-89043225F92B}"/>
                </a:ext>
              </a:extLst>
            </p:cNvPr>
            <p:cNvSpPr txBox="1"/>
            <p:nvPr/>
          </p:nvSpPr>
          <p:spPr>
            <a:xfrm>
              <a:off x="2406896" y="6081681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DE2747C5-74C1-1905-758C-393E9DA000EE}"/>
                </a:ext>
              </a:extLst>
            </p:cNvPr>
            <p:cNvSpPr txBox="1"/>
            <p:nvPr/>
          </p:nvSpPr>
          <p:spPr>
            <a:xfrm>
              <a:off x="2022082" y="6032272"/>
              <a:ext cx="352674" cy="378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D9009F4A-A013-B957-867D-F7F8F18EABE4}"/>
                </a:ext>
              </a:extLst>
            </p:cNvPr>
            <p:cNvSpPr txBox="1"/>
            <p:nvPr/>
          </p:nvSpPr>
          <p:spPr>
            <a:xfrm>
              <a:off x="2283646" y="6025242"/>
              <a:ext cx="315483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dirty="0">
                  <a:solidFill>
                    <a:srgbClr val="FF0000"/>
                  </a:solidFill>
                  <a:latin typeface="+mn-ea"/>
                  <a:cs typeface="Arial" panose="020B0604020202020204" pitchFamily="34" charset="0"/>
                </a:rPr>
                <a:t>*</a:t>
              </a:r>
              <a:endParaRPr lang="ja-JP" altLang="en-US" sz="769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40ECBDB0-77E2-5361-1276-0343DF85E17C}"/>
                </a:ext>
              </a:extLst>
            </p:cNvPr>
            <p:cNvSpPr txBox="1"/>
            <p:nvPr/>
          </p:nvSpPr>
          <p:spPr>
            <a:xfrm>
              <a:off x="4380338" y="791891"/>
              <a:ext cx="702724" cy="2875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69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769" dirty="0">
                  <a:latin typeface="Arial" panose="020B0604020202020204" pitchFamily="34" charset="0"/>
                  <a:cs typeface="Arial" panose="020B0604020202020204" pitchFamily="34" charset="0"/>
                </a:rPr>
                <a:t> &lt;0.05</a:t>
              </a:r>
              <a:endParaRPr lang="ja-JP" altLang="en-US" sz="76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32" name="表 131">
            <a:extLst>
              <a:ext uri="{FF2B5EF4-FFF2-40B4-BE49-F238E27FC236}">
                <a16:creationId xmlns:a16="http://schemas.microsoft.com/office/drawing/2014/main" id="{EDAB0A30-ED3D-002E-5F7D-1F6B0107D9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0631602"/>
              </p:ext>
            </p:extLst>
          </p:nvPr>
        </p:nvGraphicFramePr>
        <p:xfrm>
          <a:off x="471488" y="7775769"/>
          <a:ext cx="5915024" cy="1062840"/>
        </p:xfrm>
        <a:graphic>
          <a:graphicData uri="http://schemas.openxmlformats.org/drawingml/2006/table">
            <a:tbl>
              <a:tblPr/>
              <a:tblGrid>
                <a:gridCol w="1229260">
                  <a:extLst>
                    <a:ext uri="{9D8B030D-6E8A-4147-A177-3AD203B41FA5}">
                      <a16:colId xmlns:a16="http://schemas.microsoft.com/office/drawing/2014/main" val="439430252"/>
                    </a:ext>
                  </a:extLst>
                </a:gridCol>
                <a:gridCol w="902936">
                  <a:extLst>
                    <a:ext uri="{9D8B030D-6E8A-4147-A177-3AD203B41FA5}">
                      <a16:colId xmlns:a16="http://schemas.microsoft.com/office/drawing/2014/main" val="2113321398"/>
                    </a:ext>
                  </a:extLst>
                </a:gridCol>
                <a:gridCol w="893432">
                  <a:extLst>
                    <a:ext uri="{9D8B030D-6E8A-4147-A177-3AD203B41FA5}">
                      <a16:colId xmlns:a16="http://schemas.microsoft.com/office/drawing/2014/main" val="683572265"/>
                    </a:ext>
                  </a:extLst>
                </a:gridCol>
                <a:gridCol w="380184">
                  <a:extLst>
                    <a:ext uri="{9D8B030D-6E8A-4147-A177-3AD203B41FA5}">
                      <a16:colId xmlns:a16="http://schemas.microsoft.com/office/drawing/2014/main" val="2446644891"/>
                    </a:ext>
                  </a:extLst>
                </a:gridCol>
                <a:gridCol w="532257">
                  <a:extLst>
                    <a:ext uri="{9D8B030D-6E8A-4147-A177-3AD203B41FA5}">
                      <a16:colId xmlns:a16="http://schemas.microsoft.com/office/drawing/2014/main" val="3600657604"/>
                    </a:ext>
                  </a:extLst>
                </a:gridCol>
                <a:gridCol w="532257">
                  <a:extLst>
                    <a:ext uri="{9D8B030D-6E8A-4147-A177-3AD203B41FA5}">
                      <a16:colId xmlns:a16="http://schemas.microsoft.com/office/drawing/2014/main" val="2425827308"/>
                    </a:ext>
                  </a:extLst>
                </a:gridCol>
                <a:gridCol w="380184">
                  <a:extLst>
                    <a:ext uri="{9D8B030D-6E8A-4147-A177-3AD203B41FA5}">
                      <a16:colId xmlns:a16="http://schemas.microsoft.com/office/drawing/2014/main" val="1442828930"/>
                    </a:ext>
                  </a:extLst>
                </a:gridCol>
                <a:gridCol w="532257">
                  <a:extLst>
                    <a:ext uri="{9D8B030D-6E8A-4147-A177-3AD203B41FA5}">
                      <a16:colId xmlns:a16="http://schemas.microsoft.com/office/drawing/2014/main" val="4025949694"/>
                    </a:ext>
                  </a:extLst>
                </a:gridCol>
                <a:gridCol w="532257">
                  <a:extLst>
                    <a:ext uri="{9D8B030D-6E8A-4147-A177-3AD203B41FA5}">
                      <a16:colId xmlns:a16="http://schemas.microsoft.com/office/drawing/2014/main" val="4160063031"/>
                    </a:ext>
                  </a:extLst>
                </a:gridCol>
              </a:tblGrid>
              <a:tr h="17642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 Inoculated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Hydrocortizone succinate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Quercetin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Astaxanthin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2965568"/>
                  </a:ext>
                </a:extLst>
              </a:tr>
              <a:tr h="17642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 cell number/well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Exp. 1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Exp. 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Exp. 1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Exp. 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Exp. 1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Exp. 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1177262"/>
                  </a:ext>
                </a:extLst>
              </a:tr>
              <a:tr h="17642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128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16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77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2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23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2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3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6358408"/>
                  </a:ext>
                </a:extLst>
              </a:tr>
              <a:tr h="17642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25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10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7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35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4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2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3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066435"/>
                  </a:ext>
                </a:extLst>
              </a:tr>
              <a:tr h="17642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51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158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79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24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38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12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0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2054233"/>
                  </a:ext>
                </a:extLst>
              </a:tr>
              <a:tr h="17642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1024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115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77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33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3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1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6</a:t>
                      </a:r>
                    </a:p>
                  </a:txBody>
                  <a:tcPr marL="9500" marR="9500" marT="95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6609583"/>
                  </a:ext>
                </a:extLst>
              </a:tr>
            </a:tbl>
          </a:graphicData>
        </a:graphic>
      </p:graphicFrame>
      <p:sp>
        <p:nvSpPr>
          <p:cNvPr id="133" name="左大かっこ 132">
            <a:extLst>
              <a:ext uri="{FF2B5EF4-FFF2-40B4-BE49-F238E27FC236}">
                <a16:creationId xmlns:a16="http://schemas.microsoft.com/office/drawing/2014/main" id="{8FB23F63-551B-0962-DED0-5A40CDD6CA5C}"/>
              </a:ext>
            </a:extLst>
          </p:cNvPr>
          <p:cNvSpPr/>
          <p:nvPr/>
        </p:nvSpPr>
        <p:spPr>
          <a:xfrm rot="5400000">
            <a:off x="5798914" y="4545743"/>
            <a:ext cx="45719" cy="562153"/>
          </a:xfrm>
          <a:prstGeom prst="leftBracket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319">
              <a:solidFill>
                <a:srgbClr val="FF0000"/>
              </a:solidFill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DE5208A-9478-E83B-42B6-1FFC54749AB4}"/>
              </a:ext>
            </a:extLst>
          </p:cNvPr>
          <p:cNvSpPr txBox="1"/>
          <p:nvPr/>
        </p:nvSpPr>
        <p:spPr>
          <a:xfrm>
            <a:off x="5810322" y="4548212"/>
            <a:ext cx="454598" cy="2661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FF0000"/>
                </a:solidFill>
              </a:rPr>
              <a:t>N.S.</a:t>
            </a:r>
            <a:endParaRPr lang="ja-JP" altLang="en-US" sz="1200" dirty="0">
              <a:solidFill>
                <a:srgbClr val="FF0000"/>
              </a:solidFill>
            </a:endParaRPr>
          </a:p>
        </p:txBody>
      </p:sp>
      <p:sp>
        <p:nvSpPr>
          <p:cNvPr id="135" name="左大かっこ 134">
            <a:extLst>
              <a:ext uri="{FF2B5EF4-FFF2-40B4-BE49-F238E27FC236}">
                <a16:creationId xmlns:a16="http://schemas.microsoft.com/office/drawing/2014/main" id="{DA4F3C17-A30A-921E-C8D8-BF9E5EC6C84A}"/>
              </a:ext>
            </a:extLst>
          </p:cNvPr>
          <p:cNvSpPr/>
          <p:nvPr/>
        </p:nvSpPr>
        <p:spPr>
          <a:xfrm rot="5400000">
            <a:off x="5730225" y="1312317"/>
            <a:ext cx="32186" cy="566389"/>
          </a:xfrm>
          <a:prstGeom prst="leftBracket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319">
              <a:solidFill>
                <a:srgbClr val="FF0000"/>
              </a:solidFill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0BF1779B-E58F-17D6-8171-71F465C4D426}"/>
              </a:ext>
            </a:extLst>
          </p:cNvPr>
          <p:cNvSpPr txBox="1"/>
          <p:nvPr/>
        </p:nvSpPr>
        <p:spPr>
          <a:xfrm>
            <a:off x="5628231" y="1432581"/>
            <a:ext cx="246572" cy="2661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FF0000"/>
                </a:solidFill>
                <a:latin typeface="+mn-ea"/>
                <a:cs typeface="Arial" panose="020B0604020202020204" pitchFamily="34" charset="0"/>
              </a:rPr>
              <a:t>*</a:t>
            </a:r>
            <a:endParaRPr lang="ja-JP" altLang="en-US" sz="1200" dirty="0">
              <a:solidFill>
                <a:srgbClr val="FF0000"/>
              </a:solidFill>
              <a:latin typeface="+mn-ea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6CD6650B-C865-15E3-11F1-DDD323514FDA}"/>
              </a:ext>
            </a:extLst>
          </p:cNvPr>
          <p:cNvSpPr txBox="1"/>
          <p:nvPr/>
        </p:nvSpPr>
        <p:spPr>
          <a:xfrm>
            <a:off x="1237129" y="-37385"/>
            <a:ext cx="178845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buNone/>
            </a:pPr>
            <a:r>
              <a:rPr lang="en-US" altLang="ja-JP" sz="2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0FB50C7F-16A8-ECB0-0EC9-8AAD3CFC174F}"/>
              </a:ext>
            </a:extLst>
          </p:cNvPr>
          <p:cNvSpPr txBox="1"/>
          <p:nvPr/>
        </p:nvSpPr>
        <p:spPr>
          <a:xfrm>
            <a:off x="328886" y="439225"/>
            <a:ext cx="652911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buNone/>
            </a:pP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Linearity of RLE effect of hydrocortisone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was maintained between 0.2 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nd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1.0 of A</a:t>
            </a:r>
            <a:r>
              <a:rPr lang="en-US" altLang="ja-JP" sz="2000" b="1" kern="100" baseline="-250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560 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n </a:t>
            </a:r>
            <a:r>
              <a:rPr lang="en-US" altLang="ja-JP" sz="2000" b="1" kern="100" dirty="0" err="1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DFa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s.</a:t>
            </a:r>
            <a:endParaRPr lang="ja-JP" altLang="ja-JP" sz="2000" b="1" kern="100" dirty="0">
              <a:solidFill>
                <a:schemeClr val="accent5">
                  <a:lumMod val="75000"/>
                </a:schemeClr>
              </a:solidFill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87151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C0226C0-4E02-0B6A-47D3-B6087AC39337}"/>
              </a:ext>
            </a:extLst>
          </p:cNvPr>
          <p:cNvGrpSpPr/>
          <p:nvPr/>
        </p:nvGrpSpPr>
        <p:grpSpPr>
          <a:xfrm>
            <a:off x="313783" y="1344910"/>
            <a:ext cx="6479242" cy="7021092"/>
            <a:chOff x="860669" y="7883"/>
            <a:chExt cx="8171652" cy="7021092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E5F5C208-7386-7D46-2B65-0F150554B9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1111938"/>
                </p:ext>
              </p:extLst>
            </p:nvPr>
          </p:nvGraphicFramePr>
          <p:xfrm>
            <a:off x="1437226" y="7883"/>
            <a:ext cx="1820242" cy="13886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28ED1895-49AA-5A3B-E8D8-37FF3AF726CC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434591" y="35592"/>
            <a:ext cx="1775210" cy="155963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グラフ 4">
              <a:extLst>
                <a:ext uri="{FF2B5EF4-FFF2-40B4-BE49-F238E27FC236}">
                  <a16:creationId xmlns:a16="http://schemas.microsoft.com/office/drawing/2014/main" id="{1B502620-7F00-8645-CE06-A59A25B37BC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446270" y="7883"/>
            <a:ext cx="1775210" cy="15014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3F62006F-4242-AB3E-A7AB-2B4F79C010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12872617"/>
                </p:ext>
              </p:extLst>
            </p:nvPr>
          </p:nvGraphicFramePr>
          <p:xfrm>
            <a:off x="1375279" y="1627125"/>
            <a:ext cx="1866423" cy="13594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B527AB3B-0CF9-9389-A541-8204F2E7760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369938" y="1651901"/>
            <a:ext cx="1829454" cy="15596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94847F32-AB83-C0F6-74F0-0086CFFE608A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385888" y="1627125"/>
            <a:ext cx="1829454" cy="14735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9" name="グラフ 8">
              <a:extLst>
                <a:ext uri="{FF2B5EF4-FFF2-40B4-BE49-F238E27FC236}">
                  <a16:creationId xmlns:a16="http://schemas.microsoft.com/office/drawing/2014/main" id="{40E11728-5A2A-1286-E2DB-BAB6D1726DE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6452882"/>
                </p:ext>
              </p:extLst>
            </p:nvPr>
          </p:nvGraphicFramePr>
          <p:xfrm>
            <a:off x="1436078" y="3248142"/>
            <a:ext cx="1821389" cy="13886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0" name="グラフ 9">
              <a:extLst>
                <a:ext uri="{FF2B5EF4-FFF2-40B4-BE49-F238E27FC236}">
                  <a16:creationId xmlns:a16="http://schemas.microsoft.com/office/drawing/2014/main" id="{93D92513-5796-86CF-AC4F-5EF10327A0C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427310" y="3248143"/>
            <a:ext cx="1775210" cy="15834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619CF675-5D15-2279-A499-03C660CAD01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440131" y="3256110"/>
            <a:ext cx="1775210" cy="15014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2" name="グラフ 11">
              <a:extLst>
                <a:ext uri="{FF2B5EF4-FFF2-40B4-BE49-F238E27FC236}">
                  <a16:creationId xmlns:a16="http://schemas.microsoft.com/office/drawing/2014/main" id="{3E231F21-31EE-CCF1-4D8A-348B1F7CC78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438421" y="4899813"/>
            <a:ext cx="1819045" cy="13937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13" name="グラフ 12">
              <a:extLst>
                <a:ext uri="{FF2B5EF4-FFF2-40B4-BE49-F238E27FC236}">
                  <a16:creationId xmlns:a16="http://schemas.microsoft.com/office/drawing/2014/main" id="{4F3FCF1D-72BB-F936-3F83-7EA559B4790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426844" y="4934789"/>
            <a:ext cx="1775210" cy="15563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14" name="グラフ 13">
              <a:extLst>
                <a:ext uri="{FF2B5EF4-FFF2-40B4-BE49-F238E27FC236}">
                  <a16:creationId xmlns:a16="http://schemas.microsoft.com/office/drawing/2014/main" id="{FBE40601-0C70-91CF-557F-A5A05A48316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01681348"/>
                </p:ext>
              </p:extLst>
            </p:nvPr>
          </p:nvGraphicFramePr>
          <p:xfrm>
            <a:off x="5439398" y="4907081"/>
            <a:ext cx="3454396" cy="15014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D266BFB2-03CF-C541-4A4F-2CACFEA623C4}"/>
                </a:ext>
              </a:extLst>
            </p:cNvPr>
            <p:cNvSpPr txBox="1"/>
            <p:nvPr/>
          </p:nvSpPr>
          <p:spPr>
            <a:xfrm>
              <a:off x="7215340" y="775225"/>
              <a:ext cx="138691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DFa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29 PDL</a:t>
              </a:r>
            </a:p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52% lifespan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355DCEF8-22B8-48D9-529A-1847FB13A38F}"/>
                </a:ext>
              </a:extLst>
            </p:cNvPr>
            <p:cNvSpPr txBox="1"/>
            <p:nvPr/>
          </p:nvSpPr>
          <p:spPr>
            <a:xfrm>
              <a:off x="7202868" y="2242381"/>
              <a:ext cx="182945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DFa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55 PDL</a:t>
              </a:r>
            </a:p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98% lifespan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B0AA8263-A91B-AA9E-FA75-D1718C941E8B}"/>
                </a:ext>
              </a:extLst>
            </p:cNvPr>
            <p:cNvSpPr txBox="1"/>
            <p:nvPr/>
          </p:nvSpPr>
          <p:spPr>
            <a:xfrm>
              <a:off x="7272869" y="4093652"/>
              <a:ext cx="1210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GF 49 PDL</a:t>
              </a: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92064FB4-7463-7216-3395-C19B3CA7AFA8}"/>
                </a:ext>
              </a:extLst>
            </p:cNvPr>
            <p:cNvSpPr txBox="1"/>
            <p:nvPr/>
          </p:nvSpPr>
          <p:spPr>
            <a:xfrm>
              <a:off x="7331605" y="5033283"/>
              <a:ext cx="138691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PLF  78 PDL</a:t>
              </a:r>
            </a:p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91% lifespan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06DF716-395F-0BC6-E3B7-981F8E61A7F6}"/>
                </a:ext>
              </a:extLst>
            </p:cNvPr>
            <p:cNvSpPr txBox="1"/>
            <p:nvPr/>
          </p:nvSpPr>
          <p:spPr>
            <a:xfrm>
              <a:off x="2090344" y="6443463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8FE4DDB9-D735-B955-A8C0-36CCD4A13DA2}"/>
                </a:ext>
              </a:extLst>
            </p:cNvPr>
            <p:cNvSpPr txBox="1"/>
            <p:nvPr/>
          </p:nvSpPr>
          <p:spPr>
            <a:xfrm>
              <a:off x="3453720" y="6505755"/>
              <a:ext cx="207860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Hydrocortisone succinate (µg/mL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FF109B4C-EA0E-CA81-8CCC-A7F0D38AE9BE}"/>
                </a:ext>
              </a:extLst>
            </p:cNvPr>
            <p:cNvSpPr txBox="1"/>
            <p:nvPr/>
          </p:nvSpPr>
          <p:spPr>
            <a:xfrm>
              <a:off x="5729920" y="6456571"/>
              <a:ext cx="154294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uccinic acid (µg/mL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8C331A31-4FEC-898F-FFCF-D9A19E96A378}"/>
                </a:ext>
              </a:extLst>
            </p:cNvPr>
            <p:cNvCxnSpPr>
              <a:cxnSpLocks/>
            </p:cNvCxnSpPr>
            <p:nvPr/>
          </p:nvCxnSpPr>
          <p:spPr>
            <a:xfrm>
              <a:off x="1655550" y="1609496"/>
              <a:ext cx="6617843" cy="0"/>
            </a:xfrm>
            <a:prstGeom prst="line">
              <a:avLst/>
            </a:prstGeom>
            <a:ln w="57150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FDA8C60F-F2E3-F90C-C120-53D82731C4CE}"/>
                </a:ext>
              </a:extLst>
            </p:cNvPr>
            <p:cNvCxnSpPr>
              <a:cxnSpLocks/>
            </p:cNvCxnSpPr>
            <p:nvPr/>
          </p:nvCxnSpPr>
          <p:spPr>
            <a:xfrm>
              <a:off x="1650937" y="3217416"/>
              <a:ext cx="6617843" cy="0"/>
            </a:xfrm>
            <a:prstGeom prst="line">
              <a:avLst/>
            </a:prstGeom>
            <a:ln w="57150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2FFA49FE-68B9-88F6-9812-7C9699D25094}"/>
                </a:ext>
              </a:extLst>
            </p:cNvPr>
            <p:cNvCxnSpPr>
              <a:cxnSpLocks/>
            </p:cNvCxnSpPr>
            <p:nvPr/>
          </p:nvCxnSpPr>
          <p:spPr>
            <a:xfrm>
              <a:off x="1650936" y="4866907"/>
              <a:ext cx="6617843" cy="0"/>
            </a:xfrm>
            <a:prstGeom prst="line">
              <a:avLst/>
            </a:prstGeom>
            <a:ln w="57150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左大かっこ 24">
              <a:extLst>
                <a:ext uri="{FF2B5EF4-FFF2-40B4-BE49-F238E27FC236}">
                  <a16:creationId xmlns:a16="http://schemas.microsoft.com/office/drawing/2014/main" id="{956F2B7E-209E-DE71-69C5-F55C599F4CAB}"/>
                </a:ext>
              </a:extLst>
            </p:cNvPr>
            <p:cNvSpPr/>
            <p:nvPr/>
          </p:nvSpPr>
          <p:spPr>
            <a:xfrm rot="16200000">
              <a:off x="4459099" y="-28616"/>
              <a:ext cx="67845" cy="1350219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52019E4F-3A93-A3A1-4D0D-76454349573F}"/>
                </a:ext>
              </a:extLst>
            </p:cNvPr>
            <p:cNvSpPr txBox="1"/>
            <p:nvPr/>
          </p:nvSpPr>
          <p:spPr>
            <a:xfrm>
              <a:off x="4350069" y="658125"/>
              <a:ext cx="2696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sz="1400" dirty="0"/>
                <a:t>*</a:t>
              </a: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01C41D27-3797-6154-E7B2-BACDDBAE4BC3}"/>
                </a:ext>
              </a:extLst>
            </p:cNvPr>
            <p:cNvSpPr txBox="1"/>
            <p:nvPr/>
          </p:nvSpPr>
          <p:spPr>
            <a:xfrm>
              <a:off x="5739708" y="31592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左大かっこ 27">
              <a:extLst>
                <a:ext uri="{FF2B5EF4-FFF2-40B4-BE49-F238E27FC236}">
                  <a16:creationId xmlns:a16="http://schemas.microsoft.com/office/drawing/2014/main" id="{855BE2F9-C549-8C8F-602C-2C3490B0EF12}"/>
                </a:ext>
              </a:extLst>
            </p:cNvPr>
            <p:cNvSpPr/>
            <p:nvPr/>
          </p:nvSpPr>
          <p:spPr>
            <a:xfrm rot="16200000">
              <a:off x="4509052" y="1699970"/>
              <a:ext cx="81048" cy="882709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697EA59A-D472-97E7-6A8C-7A2B8C311110}"/>
                </a:ext>
              </a:extLst>
            </p:cNvPr>
            <p:cNvSpPr txBox="1"/>
            <p:nvPr/>
          </p:nvSpPr>
          <p:spPr>
            <a:xfrm>
              <a:off x="4417332" y="2153918"/>
              <a:ext cx="2824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sz="1600" dirty="0"/>
                <a:t>*</a:t>
              </a:r>
            </a:p>
          </p:txBody>
        </p:sp>
        <p:sp>
          <p:nvSpPr>
            <p:cNvPr id="30" name="左大かっこ 29">
              <a:extLst>
                <a:ext uri="{FF2B5EF4-FFF2-40B4-BE49-F238E27FC236}">
                  <a16:creationId xmlns:a16="http://schemas.microsoft.com/office/drawing/2014/main" id="{D0640760-CC28-7211-FE2B-68FAB4469322}"/>
                </a:ext>
              </a:extLst>
            </p:cNvPr>
            <p:cNvSpPr/>
            <p:nvPr/>
          </p:nvSpPr>
          <p:spPr>
            <a:xfrm rot="16200000">
              <a:off x="4752838" y="5353675"/>
              <a:ext cx="65167" cy="736176"/>
            </a:xfrm>
            <a:prstGeom prst="leftBracket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B8B16265-4B8D-3339-4B40-5569D0233806}"/>
                </a:ext>
              </a:extLst>
            </p:cNvPr>
            <p:cNvSpPr txBox="1"/>
            <p:nvPr/>
          </p:nvSpPr>
          <p:spPr>
            <a:xfrm>
              <a:off x="4672210" y="5703799"/>
              <a:ext cx="258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2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20BCCD71-CA69-EDB0-B784-E4E02B43D92E}"/>
                </a:ext>
              </a:extLst>
            </p:cNvPr>
            <p:cNvSpPr txBox="1"/>
            <p:nvPr/>
          </p:nvSpPr>
          <p:spPr>
            <a:xfrm>
              <a:off x="7071680" y="5512133"/>
              <a:ext cx="2623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2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2927C08-9EE6-4FD2-CCF8-D337E53AE9D2}"/>
                </a:ext>
              </a:extLst>
            </p:cNvPr>
            <p:cNvSpPr txBox="1"/>
            <p:nvPr/>
          </p:nvSpPr>
          <p:spPr>
            <a:xfrm>
              <a:off x="6959615" y="3899281"/>
              <a:ext cx="2623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2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9E45062E-56CD-2B91-2662-EA0FAC876176}"/>
                </a:ext>
              </a:extLst>
            </p:cNvPr>
            <p:cNvSpPr txBox="1"/>
            <p:nvPr/>
          </p:nvSpPr>
          <p:spPr>
            <a:xfrm rot="16200000">
              <a:off x="67439" y="2975079"/>
              <a:ext cx="1863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Viable cell number</a:t>
              </a:r>
              <a:r>
                <a: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A</a:t>
              </a:r>
              <a:r>
                <a:rPr kumimoji="1" lang="en-US" altLang="ja-JP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60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0C40272-C2CB-F59A-1F6E-46628D96B7D6}"/>
              </a:ext>
            </a:extLst>
          </p:cNvPr>
          <p:cNvSpPr txBox="1"/>
          <p:nvPr/>
        </p:nvSpPr>
        <p:spPr>
          <a:xfrm>
            <a:off x="1389724" y="0"/>
            <a:ext cx="41804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E063630-6754-AA7C-8FC4-369E8FB418F6}"/>
              </a:ext>
            </a:extLst>
          </p:cNvPr>
          <p:cNvSpPr txBox="1"/>
          <p:nvPr/>
        </p:nvSpPr>
        <p:spPr>
          <a:xfrm>
            <a:off x="770021" y="403127"/>
            <a:ext cx="57104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cortisone succinate, but not succinic acid, showed potent RLE effect on </a:t>
            </a:r>
            <a:r>
              <a:rPr kumimoji="1" lang="en-US" altLang="ja-JP" sz="2000" b="1" dirty="0" err="1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Fa</a:t>
            </a:r>
            <a:r>
              <a:rPr kumimoji="1" lang="en-US" altLang="ja-JP" sz="20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.</a:t>
            </a:r>
            <a:endParaRPr kumimoji="1" lang="ja-JP" altLang="en-US" sz="2000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372CA66-2C85-8690-CC76-4066D361EAFF}"/>
              </a:ext>
            </a:extLst>
          </p:cNvPr>
          <p:cNvSpPr txBox="1"/>
          <p:nvPr/>
        </p:nvSpPr>
        <p:spPr>
          <a:xfrm>
            <a:off x="455590" y="8511887"/>
            <a:ext cx="47828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 point represents mean</a:t>
            </a:r>
            <a:r>
              <a:rPr lang="ja-JP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±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.D. (n=6).  * p &lt; 0.05 vs. control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FBABE0C-B313-4C31-6606-D78AF7C73883}"/>
              </a:ext>
            </a:extLst>
          </p:cNvPr>
          <p:cNvSpPr txBox="1"/>
          <p:nvPr/>
        </p:nvSpPr>
        <p:spPr>
          <a:xfrm>
            <a:off x="4452187" y="1250163"/>
            <a:ext cx="2231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ubation time reduced to 7 days </a:t>
            </a:r>
            <a:endParaRPr kumimoji="1" lang="ja-JP" altLang="en-US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440C3B1-07F6-E6BF-DF5E-50E0B27F680E}"/>
              </a:ext>
            </a:extLst>
          </p:cNvPr>
          <p:cNvSpPr txBox="1"/>
          <p:nvPr/>
        </p:nvSpPr>
        <p:spPr>
          <a:xfrm>
            <a:off x="4584396" y="2944885"/>
            <a:ext cx="21647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LE effect halved</a:t>
            </a:r>
            <a:endParaRPr lang="ja-JP" altLang="en-US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7225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01E6C70C-FBA1-B0AE-4D55-00254253F643}"/>
              </a:ext>
            </a:extLst>
          </p:cNvPr>
          <p:cNvGrpSpPr/>
          <p:nvPr/>
        </p:nvGrpSpPr>
        <p:grpSpPr>
          <a:xfrm>
            <a:off x="169346" y="2105599"/>
            <a:ext cx="6597314" cy="5836961"/>
            <a:chOff x="-55383" y="52848"/>
            <a:chExt cx="9240051" cy="6702915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3D9C6598-A48F-730B-47F1-BDA815B3CDAF}"/>
                </a:ext>
              </a:extLst>
            </p:cNvPr>
            <p:cNvGrpSpPr/>
            <p:nvPr/>
          </p:nvGrpSpPr>
          <p:grpSpPr>
            <a:xfrm>
              <a:off x="-55383" y="52848"/>
              <a:ext cx="9240051" cy="6702915"/>
              <a:chOff x="-55383" y="52848"/>
              <a:chExt cx="9240051" cy="6702915"/>
            </a:xfrm>
          </p:grpSpPr>
          <p:graphicFrame>
            <p:nvGraphicFramePr>
              <p:cNvPr id="50" name="グラフ 49">
                <a:extLst>
                  <a:ext uri="{FF2B5EF4-FFF2-40B4-BE49-F238E27FC236}">
                    <a16:creationId xmlns:a16="http://schemas.microsoft.com/office/drawing/2014/main" id="{0CDFA482-F240-CEA6-CCB7-F3AA8A92EA3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11612367"/>
                  </p:ext>
                </p:extLst>
              </p:nvPr>
            </p:nvGraphicFramePr>
            <p:xfrm>
              <a:off x="467877" y="83439"/>
              <a:ext cx="1540950" cy="143215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1" name="グラフ 50">
                <a:extLst>
                  <a:ext uri="{FF2B5EF4-FFF2-40B4-BE49-F238E27FC236}">
                    <a16:creationId xmlns:a16="http://schemas.microsoft.com/office/drawing/2014/main" id="{8903260E-EAB7-ECC6-184C-C6C6A7FB853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48125650"/>
                  </p:ext>
                </p:extLst>
              </p:nvPr>
            </p:nvGraphicFramePr>
            <p:xfrm>
              <a:off x="1949443" y="79725"/>
              <a:ext cx="1536358" cy="152374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52" name="グラフ 51">
                <a:extLst>
                  <a:ext uri="{FF2B5EF4-FFF2-40B4-BE49-F238E27FC236}">
                    <a16:creationId xmlns:a16="http://schemas.microsoft.com/office/drawing/2014/main" id="{E9AF75A2-9553-E4C2-4672-A013938DF62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89004578"/>
                  </p:ext>
                </p:extLst>
              </p:nvPr>
            </p:nvGraphicFramePr>
            <p:xfrm>
              <a:off x="3508542" y="52848"/>
              <a:ext cx="1489618" cy="158150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53" name="グラフ 52">
                <a:extLst>
                  <a:ext uri="{FF2B5EF4-FFF2-40B4-BE49-F238E27FC236}">
                    <a16:creationId xmlns:a16="http://schemas.microsoft.com/office/drawing/2014/main" id="{2D6A9667-B96F-1241-696E-F6D6FBAB0F5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58230505"/>
                  </p:ext>
                </p:extLst>
              </p:nvPr>
            </p:nvGraphicFramePr>
            <p:xfrm>
              <a:off x="5073016" y="79722"/>
              <a:ext cx="1489617" cy="150830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54" name="グラフ 53">
                <a:extLst>
                  <a:ext uri="{FF2B5EF4-FFF2-40B4-BE49-F238E27FC236}">
                    <a16:creationId xmlns:a16="http://schemas.microsoft.com/office/drawing/2014/main" id="{2313F254-EACC-BC9F-2E4C-E9D71D5C97D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16868008"/>
                  </p:ext>
                </p:extLst>
              </p:nvPr>
            </p:nvGraphicFramePr>
            <p:xfrm>
              <a:off x="6594917" y="79723"/>
              <a:ext cx="1457200" cy="150830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55" name="グラフ 54">
                <a:extLst>
                  <a:ext uri="{FF2B5EF4-FFF2-40B4-BE49-F238E27FC236}">
                    <a16:creationId xmlns:a16="http://schemas.microsoft.com/office/drawing/2014/main" id="{BA38A2E7-60B6-C29A-466B-08229F041F4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21072833"/>
                  </p:ext>
                </p:extLst>
              </p:nvPr>
            </p:nvGraphicFramePr>
            <p:xfrm>
              <a:off x="466996" y="1534323"/>
              <a:ext cx="1489735" cy="15443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56" name="グラフ 55">
                <a:extLst>
                  <a:ext uri="{FF2B5EF4-FFF2-40B4-BE49-F238E27FC236}">
                    <a16:creationId xmlns:a16="http://schemas.microsoft.com/office/drawing/2014/main" id="{8BE3FC38-BCCC-9278-54ED-379AA4A6708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67570678"/>
                  </p:ext>
                </p:extLst>
              </p:nvPr>
            </p:nvGraphicFramePr>
            <p:xfrm>
              <a:off x="1978218" y="1543325"/>
              <a:ext cx="1476157" cy="15443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57" name="グラフ 56">
                <a:extLst>
                  <a:ext uri="{FF2B5EF4-FFF2-40B4-BE49-F238E27FC236}">
                    <a16:creationId xmlns:a16="http://schemas.microsoft.com/office/drawing/2014/main" id="{6F109776-22C6-6BB3-A654-1407011AD5D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69095460"/>
                  </p:ext>
                </p:extLst>
              </p:nvPr>
            </p:nvGraphicFramePr>
            <p:xfrm>
              <a:off x="3534734" y="1544521"/>
              <a:ext cx="1489618" cy="15341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graphicFrame>
            <p:nvGraphicFramePr>
              <p:cNvPr id="58" name="グラフ 57">
                <a:extLst>
                  <a:ext uri="{FF2B5EF4-FFF2-40B4-BE49-F238E27FC236}">
                    <a16:creationId xmlns:a16="http://schemas.microsoft.com/office/drawing/2014/main" id="{F01267B0-FEB4-814F-686D-06C451D5EA2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87967934"/>
                  </p:ext>
                </p:extLst>
              </p:nvPr>
            </p:nvGraphicFramePr>
            <p:xfrm>
              <a:off x="5079842" y="1543326"/>
              <a:ext cx="1489617" cy="15341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graphicFrame>
            <p:nvGraphicFramePr>
              <p:cNvPr id="59" name="グラフ 58">
                <a:extLst>
                  <a:ext uri="{FF2B5EF4-FFF2-40B4-BE49-F238E27FC236}">
                    <a16:creationId xmlns:a16="http://schemas.microsoft.com/office/drawing/2014/main" id="{662640B1-3673-7D74-DF82-C0C255CCBF8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29247207"/>
                  </p:ext>
                </p:extLst>
              </p:nvPr>
            </p:nvGraphicFramePr>
            <p:xfrm>
              <a:off x="6555675" y="1526341"/>
              <a:ext cx="1496442" cy="152253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graphicFrame>
            <p:nvGraphicFramePr>
              <p:cNvPr id="60" name="グラフ 59">
                <a:extLst>
                  <a:ext uri="{FF2B5EF4-FFF2-40B4-BE49-F238E27FC236}">
                    <a16:creationId xmlns:a16="http://schemas.microsoft.com/office/drawing/2014/main" id="{B344A25E-78CB-747A-544D-F66672E64BC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2281384"/>
                  </p:ext>
                </p:extLst>
              </p:nvPr>
            </p:nvGraphicFramePr>
            <p:xfrm>
              <a:off x="461660" y="3392924"/>
              <a:ext cx="1540951" cy="14321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graphicFrame>
            <p:nvGraphicFramePr>
              <p:cNvPr id="61" name="グラフ 60">
                <a:extLst>
                  <a:ext uri="{FF2B5EF4-FFF2-40B4-BE49-F238E27FC236}">
                    <a16:creationId xmlns:a16="http://schemas.microsoft.com/office/drawing/2014/main" id="{3B680182-2935-4E19-2F75-CAFF5BF2D3F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7163031"/>
                  </p:ext>
                </p:extLst>
              </p:nvPr>
            </p:nvGraphicFramePr>
            <p:xfrm>
              <a:off x="1975310" y="3362115"/>
              <a:ext cx="1714821" cy="159950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graphicFrame>
            <p:nvGraphicFramePr>
              <p:cNvPr id="62" name="グラフ 61">
                <a:extLst>
                  <a:ext uri="{FF2B5EF4-FFF2-40B4-BE49-F238E27FC236}">
                    <a16:creationId xmlns:a16="http://schemas.microsoft.com/office/drawing/2014/main" id="{8BF3321E-E90B-AF47-74F2-32EDB57A766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46927866"/>
                  </p:ext>
                </p:extLst>
              </p:nvPr>
            </p:nvGraphicFramePr>
            <p:xfrm>
              <a:off x="3546671" y="3385015"/>
              <a:ext cx="1485055" cy="161934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graphicFrame>
            <p:nvGraphicFramePr>
              <p:cNvPr id="63" name="グラフ 62">
                <a:extLst>
                  <a:ext uri="{FF2B5EF4-FFF2-40B4-BE49-F238E27FC236}">
                    <a16:creationId xmlns:a16="http://schemas.microsoft.com/office/drawing/2014/main" id="{65E86445-3481-7C68-BA92-E5FA682AC7B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83617531"/>
                  </p:ext>
                </p:extLst>
              </p:nvPr>
            </p:nvGraphicFramePr>
            <p:xfrm>
              <a:off x="5082407" y="3414565"/>
              <a:ext cx="1528899" cy="15375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graphicFrame>
            <p:nvGraphicFramePr>
              <p:cNvPr id="64" name="グラフ 63">
                <a:extLst>
                  <a:ext uri="{FF2B5EF4-FFF2-40B4-BE49-F238E27FC236}">
                    <a16:creationId xmlns:a16="http://schemas.microsoft.com/office/drawing/2014/main" id="{C438CBC9-0547-2D01-8943-C3F937317BC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89182449"/>
                  </p:ext>
                </p:extLst>
              </p:nvPr>
            </p:nvGraphicFramePr>
            <p:xfrm>
              <a:off x="6599019" y="3352589"/>
              <a:ext cx="1508223" cy="16159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graphicFrame>
            <p:nvGraphicFramePr>
              <p:cNvPr id="65" name="グラフ 64">
                <a:extLst>
                  <a:ext uri="{FF2B5EF4-FFF2-40B4-BE49-F238E27FC236}">
                    <a16:creationId xmlns:a16="http://schemas.microsoft.com/office/drawing/2014/main" id="{3DB14F77-03EE-20E6-1F11-9B8027734B8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17875219"/>
                  </p:ext>
                </p:extLst>
              </p:nvPr>
            </p:nvGraphicFramePr>
            <p:xfrm>
              <a:off x="421830" y="4856848"/>
              <a:ext cx="1534901" cy="15443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7"/>
              </a:graphicData>
            </a:graphic>
          </p:graphicFrame>
          <p:graphicFrame>
            <p:nvGraphicFramePr>
              <p:cNvPr id="66" name="グラフ 65">
                <a:extLst>
                  <a:ext uri="{FF2B5EF4-FFF2-40B4-BE49-F238E27FC236}">
                    <a16:creationId xmlns:a16="http://schemas.microsoft.com/office/drawing/2014/main" id="{470D5E34-7989-6C30-6E49-F175D446698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36542689"/>
                  </p:ext>
                </p:extLst>
              </p:nvPr>
            </p:nvGraphicFramePr>
            <p:xfrm>
              <a:off x="1976806" y="4850524"/>
              <a:ext cx="1485055" cy="15443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8"/>
              </a:graphicData>
            </a:graphic>
          </p:graphicFrame>
          <p:graphicFrame>
            <p:nvGraphicFramePr>
              <p:cNvPr id="67" name="グラフ 66">
                <a:extLst>
                  <a:ext uri="{FF2B5EF4-FFF2-40B4-BE49-F238E27FC236}">
                    <a16:creationId xmlns:a16="http://schemas.microsoft.com/office/drawing/2014/main" id="{01C5CC98-EBBB-275D-3B3B-423866EF830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93499053"/>
                  </p:ext>
                </p:extLst>
              </p:nvPr>
            </p:nvGraphicFramePr>
            <p:xfrm>
              <a:off x="3547303" y="4867620"/>
              <a:ext cx="1477049" cy="155139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9"/>
              </a:graphicData>
            </a:graphic>
          </p:graphicFrame>
          <p:graphicFrame>
            <p:nvGraphicFramePr>
              <p:cNvPr id="68" name="グラフ 67">
                <a:extLst>
                  <a:ext uri="{FF2B5EF4-FFF2-40B4-BE49-F238E27FC236}">
                    <a16:creationId xmlns:a16="http://schemas.microsoft.com/office/drawing/2014/main" id="{62C3214A-40EB-281E-3464-4716CD14558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92888285"/>
                  </p:ext>
                </p:extLst>
              </p:nvPr>
            </p:nvGraphicFramePr>
            <p:xfrm>
              <a:off x="5082405" y="4863768"/>
              <a:ext cx="1485055" cy="15647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0"/>
              </a:graphicData>
            </a:graphic>
          </p:graphicFrame>
          <p:graphicFrame>
            <p:nvGraphicFramePr>
              <p:cNvPr id="69" name="グラフ 68">
                <a:extLst>
                  <a:ext uri="{FF2B5EF4-FFF2-40B4-BE49-F238E27FC236}">
                    <a16:creationId xmlns:a16="http://schemas.microsoft.com/office/drawing/2014/main" id="{41669FE2-15B3-4A36-6A7C-279631CD400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95684587"/>
                  </p:ext>
                </p:extLst>
              </p:nvPr>
            </p:nvGraphicFramePr>
            <p:xfrm>
              <a:off x="6599019" y="4857104"/>
              <a:ext cx="1474567" cy="156191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1"/>
              </a:graphicData>
            </a:graphic>
          </p:graphicFrame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9FDDE439-CB01-E650-CF8D-7C9EB82060FB}"/>
                  </a:ext>
                </a:extLst>
              </p:cNvPr>
              <p:cNvSpPr txBox="1"/>
              <p:nvPr/>
            </p:nvSpPr>
            <p:spPr>
              <a:xfrm>
                <a:off x="3592105" y="6437669"/>
                <a:ext cx="3222211" cy="3180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centration (</a:t>
                </a:r>
                <a:r>
                  <a:rPr lang="en-US" altLang="ja-JP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r>
                  <a:rPr lang="ja-JP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r</a:t>
                </a:r>
                <a:r>
                  <a:rPr lang="ja-JP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g</a:t>
                </a:r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947AB28B-30A6-CD07-EE60-C8FB4C40B21D}"/>
                  </a:ext>
                </a:extLst>
              </p:cNvPr>
              <p:cNvSpPr txBox="1"/>
              <p:nvPr/>
            </p:nvSpPr>
            <p:spPr>
              <a:xfrm rot="16200000">
                <a:off x="-1961666" y="3168137"/>
                <a:ext cx="4200525" cy="3879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ell number at Day 14 (absorbance at 560 nm)</a:t>
                </a:r>
                <a:endParaRPr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右大かっこ 71">
                <a:extLst>
                  <a:ext uri="{FF2B5EF4-FFF2-40B4-BE49-F238E27FC236}">
                    <a16:creationId xmlns:a16="http://schemas.microsoft.com/office/drawing/2014/main" id="{3B936208-EC3F-4844-6B80-159C1DC99AAC}"/>
                  </a:ext>
                </a:extLst>
              </p:cNvPr>
              <p:cNvSpPr/>
              <p:nvPr/>
            </p:nvSpPr>
            <p:spPr>
              <a:xfrm>
                <a:off x="8073586" y="697093"/>
                <a:ext cx="111053" cy="1826173"/>
              </a:xfrm>
              <a:prstGeom prst="rightBracket">
                <a:avLst/>
              </a:prstGeom>
              <a:ln w="38100"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sp>
            <p:nvSpPr>
              <p:cNvPr id="73" name="右大かっこ 72">
                <a:extLst>
                  <a:ext uri="{FF2B5EF4-FFF2-40B4-BE49-F238E27FC236}">
                    <a16:creationId xmlns:a16="http://schemas.microsoft.com/office/drawing/2014/main" id="{6BBBF3C1-76C9-5058-165E-FA9E5216D75A}"/>
                  </a:ext>
                </a:extLst>
              </p:cNvPr>
              <p:cNvSpPr/>
              <p:nvPr/>
            </p:nvSpPr>
            <p:spPr>
              <a:xfrm>
                <a:off x="8083111" y="3828191"/>
                <a:ext cx="161925" cy="1914525"/>
              </a:xfrm>
              <a:prstGeom prst="rightBracket">
                <a:avLst/>
              </a:prstGeom>
              <a:ln w="38100"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cxnSp>
            <p:nvCxnSpPr>
              <p:cNvPr id="74" name="直線コネクタ 73">
                <a:extLst>
                  <a:ext uri="{FF2B5EF4-FFF2-40B4-BE49-F238E27FC236}">
                    <a16:creationId xmlns:a16="http://schemas.microsoft.com/office/drawing/2014/main" id="{F118DAB5-399B-8AC5-4E92-D2D56BB2432D}"/>
                  </a:ext>
                </a:extLst>
              </p:cNvPr>
              <p:cNvCxnSpPr/>
              <p:nvPr/>
            </p:nvCxnSpPr>
            <p:spPr>
              <a:xfrm>
                <a:off x="571500" y="3228975"/>
                <a:ext cx="7509192" cy="0"/>
              </a:xfrm>
              <a:prstGeom prst="line">
                <a:avLst/>
              </a:prstGeom>
              <a:ln w="76200"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77B1F76D-93D9-2139-657C-CDA6D0A2E467}"/>
                  </a:ext>
                </a:extLst>
              </p:cNvPr>
              <p:cNvSpPr txBox="1"/>
              <p:nvPr/>
            </p:nvSpPr>
            <p:spPr>
              <a:xfrm>
                <a:off x="8256980" y="1349658"/>
                <a:ext cx="927688" cy="35343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xp.1</a:t>
                </a: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ja-JP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テキスト ボックス 75">
                <a:extLst>
                  <a:ext uri="{FF2B5EF4-FFF2-40B4-BE49-F238E27FC236}">
                    <a16:creationId xmlns:a16="http://schemas.microsoft.com/office/drawing/2014/main" id="{B1123B29-E32A-22EB-73C7-A756AF69CBC6}"/>
                  </a:ext>
                </a:extLst>
              </p:cNvPr>
              <p:cNvSpPr txBox="1"/>
              <p:nvPr/>
            </p:nvSpPr>
            <p:spPr>
              <a:xfrm>
                <a:off x="8254561" y="4665857"/>
                <a:ext cx="927688" cy="3534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xp.2</a:t>
                </a:r>
                <a:endParaRPr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E6F71B06-891F-71D0-F956-75575254734C}"/>
                  </a:ext>
                </a:extLst>
              </p:cNvPr>
              <p:cNvSpPr txBox="1"/>
              <p:nvPr/>
            </p:nvSpPr>
            <p:spPr>
              <a:xfrm>
                <a:off x="861942" y="1410786"/>
                <a:ext cx="714353" cy="2650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Row)</a:t>
                </a:r>
                <a:endParaRPr lang="ja-JP" alt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D9E8C0C7-F208-4C94-E9AA-211D2E103917}"/>
                  </a:ext>
                </a:extLst>
              </p:cNvPr>
              <p:cNvSpPr txBox="1"/>
              <p:nvPr/>
            </p:nvSpPr>
            <p:spPr>
              <a:xfrm>
                <a:off x="979476" y="4417915"/>
                <a:ext cx="714353" cy="2650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Row)</a:t>
                </a:r>
                <a:endParaRPr lang="ja-JP" alt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A59D4DF1-24C7-2F43-4754-5FDAB3439752}"/>
                </a:ext>
              </a:extLst>
            </p:cNvPr>
            <p:cNvGrpSpPr/>
            <p:nvPr/>
          </p:nvGrpSpPr>
          <p:grpSpPr>
            <a:xfrm>
              <a:off x="847936" y="75542"/>
              <a:ext cx="6857994" cy="1971978"/>
              <a:chOff x="847936" y="75542"/>
              <a:chExt cx="6857994" cy="1971978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7B8CC96E-BABF-2079-9AA4-BC1079787B2B}"/>
                  </a:ext>
                </a:extLst>
              </p:cNvPr>
              <p:cNvSpPr txBox="1"/>
              <p:nvPr/>
            </p:nvSpPr>
            <p:spPr>
              <a:xfrm>
                <a:off x="847936" y="307453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63534151-233E-84F9-38A4-D12339E4DA74}"/>
                  </a:ext>
                </a:extLst>
              </p:cNvPr>
              <p:cNvSpPr txBox="1"/>
              <p:nvPr/>
            </p:nvSpPr>
            <p:spPr>
              <a:xfrm>
                <a:off x="1000336" y="27887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554EBAD8-EC09-C336-0C42-DEAD65CB7478}"/>
                  </a:ext>
                </a:extLst>
              </p:cNvPr>
              <p:cNvSpPr txBox="1"/>
              <p:nvPr/>
            </p:nvSpPr>
            <p:spPr>
              <a:xfrm>
                <a:off x="1143211" y="27887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24D19908-CCCB-2895-D57E-C7B505DDF00F}"/>
                  </a:ext>
                </a:extLst>
              </p:cNvPr>
              <p:cNvSpPr txBox="1"/>
              <p:nvPr/>
            </p:nvSpPr>
            <p:spPr>
              <a:xfrm>
                <a:off x="1257511" y="29792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ED267991-5405-B037-518F-477FCFD5DC4F}"/>
                  </a:ext>
                </a:extLst>
              </p:cNvPr>
              <p:cNvSpPr txBox="1"/>
              <p:nvPr/>
            </p:nvSpPr>
            <p:spPr>
              <a:xfrm>
                <a:off x="1381336" y="31697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7A6EC6F9-7484-A3F3-9821-BE06CEA429AA}"/>
                  </a:ext>
                </a:extLst>
              </p:cNvPr>
              <p:cNvSpPr txBox="1"/>
              <p:nvPr/>
            </p:nvSpPr>
            <p:spPr>
              <a:xfrm>
                <a:off x="1486111" y="35507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1BAAE150-9661-9ACD-DB03-CF511723F20E}"/>
                  </a:ext>
                </a:extLst>
              </p:cNvPr>
              <p:cNvSpPr txBox="1"/>
              <p:nvPr/>
            </p:nvSpPr>
            <p:spPr>
              <a:xfrm>
                <a:off x="4028453" y="33395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D822852E-4C26-F4D5-6801-2A213C72BD72}"/>
                  </a:ext>
                </a:extLst>
              </p:cNvPr>
              <p:cNvSpPr txBox="1"/>
              <p:nvPr/>
            </p:nvSpPr>
            <p:spPr>
              <a:xfrm>
                <a:off x="4160976" y="30745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0B26DE32-217E-4AA6-66B2-4735EF8440E1}"/>
                  </a:ext>
                </a:extLst>
              </p:cNvPr>
              <p:cNvSpPr txBox="1"/>
              <p:nvPr/>
            </p:nvSpPr>
            <p:spPr>
              <a:xfrm>
                <a:off x="4293500" y="29419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89A872CF-8AA7-B6AB-BA0D-348F35F30783}"/>
                  </a:ext>
                </a:extLst>
              </p:cNvPr>
              <p:cNvSpPr txBox="1"/>
              <p:nvPr/>
            </p:nvSpPr>
            <p:spPr>
              <a:xfrm>
                <a:off x="4412769" y="347206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4FF7E044-2927-2FF3-9312-74C0CEDFE837}"/>
                  </a:ext>
                </a:extLst>
              </p:cNvPr>
              <p:cNvSpPr txBox="1"/>
              <p:nvPr/>
            </p:nvSpPr>
            <p:spPr>
              <a:xfrm>
                <a:off x="4532036" y="25444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2E9B8909-9F61-DFDA-55B6-AD77323FA244}"/>
                  </a:ext>
                </a:extLst>
              </p:cNvPr>
              <p:cNvSpPr txBox="1"/>
              <p:nvPr/>
            </p:nvSpPr>
            <p:spPr>
              <a:xfrm>
                <a:off x="5446438" y="30745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BEA4A3E8-7706-50DB-3D81-B0E36B0B60AD}"/>
                  </a:ext>
                </a:extLst>
              </p:cNvPr>
              <p:cNvSpPr txBox="1"/>
              <p:nvPr/>
            </p:nvSpPr>
            <p:spPr>
              <a:xfrm>
                <a:off x="5572334" y="20806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47AA1641-63C7-DD9A-DBD4-7A0E6F4AA637}"/>
                  </a:ext>
                </a:extLst>
              </p:cNvPr>
              <p:cNvSpPr txBox="1"/>
              <p:nvPr/>
            </p:nvSpPr>
            <p:spPr>
              <a:xfrm>
                <a:off x="5837376" y="11529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97D89847-089C-E7FC-CDB0-56BC0FB2BC40}"/>
                  </a:ext>
                </a:extLst>
              </p:cNvPr>
              <p:cNvSpPr txBox="1"/>
              <p:nvPr/>
            </p:nvSpPr>
            <p:spPr>
              <a:xfrm>
                <a:off x="5704854" y="20806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834EA603-3283-E388-0AA4-9B69A2B79E18}"/>
                  </a:ext>
                </a:extLst>
              </p:cNvPr>
              <p:cNvSpPr txBox="1"/>
              <p:nvPr/>
            </p:nvSpPr>
            <p:spPr>
              <a:xfrm>
                <a:off x="5969894" y="7554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5F17049F-62FF-2013-9D31-8E1D6F17EE60}"/>
                  </a:ext>
                </a:extLst>
              </p:cNvPr>
              <p:cNvSpPr txBox="1"/>
              <p:nvPr/>
            </p:nvSpPr>
            <p:spPr>
              <a:xfrm>
                <a:off x="6089168" y="10204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51238639-B111-6A54-F256-02D11F4C75D9}"/>
                  </a:ext>
                </a:extLst>
              </p:cNvPr>
              <p:cNvSpPr txBox="1"/>
              <p:nvPr/>
            </p:nvSpPr>
            <p:spPr>
              <a:xfrm>
                <a:off x="6221686" y="8879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51A79257-72BD-D6F0-B317-A0625728CB4F}"/>
                  </a:ext>
                </a:extLst>
              </p:cNvPr>
              <p:cNvSpPr txBox="1"/>
              <p:nvPr/>
            </p:nvSpPr>
            <p:spPr>
              <a:xfrm>
                <a:off x="973825" y="162604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A641D87E-7C2B-33D7-19A4-80219F19B2D4}"/>
                  </a:ext>
                </a:extLst>
              </p:cNvPr>
              <p:cNvSpPr txBox="1"/>
              <p:nvPr/>
            </p:nvSpPr>
            <p:spPr>
              <a:xfrm>
                <a:off x="1232241" y="163267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C625D80D-DDA5-FE81-47EC-FFFD5146ED48}"/>
                  </a:ext>
                </a:extLst>
              </p:cNvPr>
              <p:cNvSpPr txBox="1"/>
              <p:nvPr/>
            </p:nvSpPr>
            <p:spPr>
              <a:xfrm>
                <a:off x="2603837" y="165255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E11B186C-92A9-4DC2-9801-543426DC2CA6}"/>
                  </a:ext>
                </a:extLst>
              </p:cNvPr>
              <p:cNvSpPr txBox="1"/>
              <p:nvPr/>
            </p:nvSpPr>
            <p:spPr>
              <a:xfrm>
                <a:off x="2742985" y="163267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56A1F7A5-30AB-7237-3478-02C9E64B5B9E}"/>
                  </a:ext>
                </a:extLst>
              </p:cNvPr>
              <p:cNvSpPr txBox="1"/>
              <p:nvPr/>
            </p:nvSpPr>
            <p:spPr>
              <a:xfrm>
                <a:off x="2994774" y="163267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8B7BFF97-E5A6-E740-59E9-47F0A0DD1B0B}"/>
                  </a:ext>
                </a:extLst>
              </p:cNvPr>
              <p:cNvSpPr txBox="1"/>
              <p:nvPr/>
            </p:nvSpPr>
            <p:spPr>
              <a:xfrm>
                <a:off x="2862253" y="160617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DC84A9B1-074F-F6CE-B47E-B5BDD91A5821}"/>
                  </a:ext>
                </a:extLst>
              </p:cNvPr>
              <p:cNvSpPr txBox="1"/>
              <p:nvPr/>
            </p:nvSpPr>
            <p:spPr>
              <a:xfrm>
                <a:off x="3246565" y="150015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B0186DD1-3F6B-B2E6-5E5B-0FD74BBC4FDB}"/>
                  </a:ext>
                </a:extLst>
              </p:cNvPr>
              <p:cNvSpPr txBox="1"/>
              <p:nvPr/>
            </p:nvSpPr>
            <p:spPr>
              <a:xfrm>
                <a:off x="3127298" y="160617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997BAA56-7735-3409-FD3B-A7F65D00CF6B}"/>
                  </a:ext>
                </a:extLst>
              </p:cNvPr>
              <p:cNvSpPr txBox="1"/>
              <p:nvPr/>
            </p:nvSpPr>
            <p:spPr>
              <a:xfrm>
                <a:off x="4432639" y="1665806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4EA5BA8A-55E5-0A2D-13D6-9D18C36ED92E}"/>
                  </a:ext>
                </a:extLst>
              </p:cNvPr>
              <p:cNvSpPr txBox="1"/>
              <p:nvPr/>
            </p:nvSpPr>
            <p:spPr>
              <a:xfrm>
                <a:off x="5843993" y="1619424"/>
                <a:ext cx="245175" cy="283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9BC09BFB-2E9B-4201-9DC3-F3440737C40A}"/>
                  </a:ext>
                </a:extLst>
              </p:cNvPr>
              <p:cNvSpPr txBox="1"/>
              <p:nvPr/>
            </p:nvSpPr>
            <p:spPr>
              <a:xfrm>
                <a:off x="7083069" y="1718816"/>
                <a:ext cx="245175" cy="283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CD151311-03F9-98FE-8843-F4C4ECFBD8DD}"/>
                  </a:ext>
                </a:extLst>
              </p:cNvPr>
              <p:cNvSpPr txBox="1"/>
              <p:nvPr/>
            </p:nvSpPr>
            <p:spPr>
              <a:xfrm>
                <a:off x="7215591" y="1626052"/>
                <a:ext cx="245175" cy="283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943CBBD9-1013-E993-630E-7A7193D8CA92}"/>
                  </a:ext>
                </a:extLst>
              </p:cNvPr>
              <p:cNvSpPr txBox="1"/>
              <p:nvPr/>
            </p:nvSpPr>
            <p:spPr>
              <a:xfrm>
                <a:off x="7460755" y="1659184"/>
                <a:ext cx="245175" cy="283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45D8648C-5F08-F036-9855-69DAB5A277DC}"/>
                  </a:ext>
                </a:extLst>
              </p:cNvPr>
              <p:cNvSpPr txBox="1"/>
              <p:nvPr/>
            </p:nvSpPr>
            <p:spPr>
              <a:xfrm>
                <a:off x="7341487" y="1659184"/>
                <a:ext cx="245175" cy="283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C5DCCA45-C282-A33F-F1C4-E8D96336A368}"/>
                  </a:ext>
                </a:extLst>
              </p:cNvPr>
              <p:cNvSpPr txBox="1"/>
              <p:nvPr/>
            </p:nvSpPr>
            <p:spPr>
              <a:xfrm>
                <a:off x="2239414" y="57249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A4F927BD-6E14-9615-5506-194CD9B46394}"/>
                  </a:ext>
                </a:extLst>
              </p:cNvPr>
              <p:cNvSpPr txBox="1"/>
              <p:nvPr/>
            </p:nvSpPr>
            <p:spPr>
              <a:xfrm>
                <a:off x="2378562" y="42009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B633093B-4BAF-0ADB-97E6-ED656A6DBBC4}"/>
                  </a:ext>
                </a:extLst>
              </p:cNvPr>
              <p:cNvSpPr txBox="1"/>
              <p:nvPr/>
            </p:nvSpPr>
            <p:spPr>
              <a:xfrm>
                <a:off x="2484578" y="499606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09A52C61-DAE8-0936-E85F-812702CA50D4}"/>
                  </a:ext>
                </a:extLst>
              </p:cNvPr>
              <p:cNvSpPr txBox="1"/>
              <p:nvPr/>
            </p:nvSpPr>
            <p:spPr>
              <a:xfrm>
                <a:off x="2617099" y="53936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5F44EAD6-C5C3-31F0-E0D0-75C5B4B0A3DB}"/>
                  </a:ext>
                </a:extLst>
              </p:cNvPr>
              <p:cNvSpPr txBox="1"/>
              <p:nvPr/>
            </p:nvSpPr>
            <p:spPr>
              <a:xfrm>
                <a:off x="2749623" y="61887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02F34040-C3B5-F994-78AD-E66AD95B6217}"/>
                  </a:ext>
                </a:extLst>
              </p:cNvPr>
              <p:cNvSpPr txBox="1"/>
              <p:nvPr/>
            </p:nvSpPr>
            <p:spPr>
              <a:xfrm>
                <a:off x="2882142" y="68513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F1E2798D-8783-9C6E-30D3-E097F5939B27}"/>
                  </a:ext>
                </a:extLst>
              </p:cNvPr>
              <p:cNvSpPr txBox="1"/>
              <p:nvPr/>
            </p:nvSpPr>
            <p:spPr>
              <a:xfrm>
                <a:off x="5844002" y="559245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AE59F0D8-BDFF-8927-5BF1-D5C49C3429C0}"/>
                  </a:ext>
                </a:extLst>
              </p:cNvPr>
              <p:cNvSpPr txBox="1"/>
              <p:nvPr/>
            </p:nvSpPr>
            <p:spPr>
              <a:xfrm>
                <a:off x="5983150" y="605629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30985D0F-A694-8243-43F3-E0E107FFF146}"/>
                  </a:ext>
                </a:extLst>
              </p:cNvPr>
              <p:cNvSpPr txBox="1"/>
              <p:nvPr/>
            </p:nvSpPr>
            <p:spPr>
              <a:xfrm>
                <a:off x="6102418" y="512865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3179C10F-8922-EB83-B63B-E842D195D21E}"/>
                  </a:ext>
                </a:extLst>
              </p:cNvPr>
              <p:cNvSpPr txBox="1"/>
              <p:nvPr/>
            </p:nvSpPr>
            <p:spPr>
              <a:xfrm>
                <a:off x="6221686" y="55262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DD65B10F-46A7-6064-05F4-B86126563ABA}"/>
                  </a:ext>
                </a:extLst>
              </p:cNvPr>
              <p:cNvSpPr txBox="1"/>
              <p:nvPr/>
            </p:nvSpPr>
            <p:spPr>
              <a:xfrm>
                <a:off x="3271590" y="177052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 b="1" dirty="0">
                    <a:latin typeface="+mn-ea"/>
                  </a:rPr>
                  <a:t>*</a:t>
                </a:r>
              </a:p>
            </p:txBody>
          </p:sp>
        </p:grpSp>
      </p:grp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36B21BC-C37E-6171-2804-4236287BB5E1}"/>
              </a:ext>
            </a:extLst>
          </p:cNvPr>
          <p:cNvSpPr txBox="1"/>
          <p:nvPr/>
        </p:nvSpPr>
        <p:spPr>
          <a:xfrm>
            <a:off x="256244" y="745524"/>
            <a:ext cx="656488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buNone/>
            </a:pP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ost antioxidants, except quercetin and sodium ascorbate, showed little or no RLE effect on </a:t>
            </a:r>
            <a:r>
              <a:rPr lang="en-US" altLang="ja-JP" sz="2000" b="1" kern="100" dirty="0" err="1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DFa</a:t>
            </a:r>
            <a:r>
              <a:rPr lang="en-US" altLang="ja-JP" sz="2000" b="1" kern="1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s.</a:t>
            </a:r>
            <a:endParaRPr lang="ja-JP" altLang="ja-JP" sz="2000" b="1" kern="100" dirty="0">
              <a:solidFill>
                <a:schemeClr val="accent5">
                  <a:lumMod val="75000"/>
                </a:schemeClr>
              </a:solidFill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503C4CC-593C-3BE2-98C6-05CAB349F7AA}"/>
              </a:ext>
            </a:extLst>
          </p:cNvPr>
          <p:cNvSpPr txBox="1"/>
          <p:nvPr/>
        </p:nvSpPr>
        <p:spPr>
          <a:xfrm>
            <a:off x="1626000" y="197462"/>
            <a:ext cx="388121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</a:t>
            </a:r>
            <a:r>
              <a:rPr lang="en-US" altLang="ja-JP" sz="2400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</a:t>
            </a:r>
            <a:r>
              <a:rPr lang="en-US" altLang="ja-JP" sz="2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endParaRPr lang="ja-JP" altLang="en-US" sz="24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19A9DEB2-EEE9-1BA1-9202-993848CBC05E}"/>
              </a:ext>
            </a:extLst>
          </p:cNvPr>
          <p:cNvSpPr txBox="1"/>
          <p:nvPr/>
        </p:nvSpPr>
        <p:spPr>
          <a:xfrm>
            <a:off x="196537" y="8247569"/>
            <a:ext cx="50696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 point represents mean</a:t>
            </a:r>
            <a:r>
              <a:rPr lang="ja-JP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±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.D. (n=6).  * p &lt; 0.05 vs. control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7B98FB47-9CEF-549A-6AB4-9998B18E3D1E}"/>
              </a:ext>
            </a:extLst>
          </p:cNvPr>
          <p:cNvGrpSpPr/>
          <p:nvPr/>
        </p:nvGrpSpPr>
        <p:grpSpPr>
          <a:xfrm>
            <a:off x="4781377" y="1658419"/>
            <a:ext cx="1699504" cy="461665"/>
            <a:chOff x="7261412" y="2735853"/>
            <a:chExt cx="1699504" cy="461665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5626BE09-E2ED-E149-33ED-9B0A665A7D2E}"/>
                </a:ext>
              </a:extLst>
            </p:cNvPr>
            <p:cNvSpPr txBox="1"/>
            <p:nvPr/>
          </p:nvSpPr>
          <p:spPr>
            <a:xfrm>
              <a:off x="7261412" y="2735853"/>
              <a:ext cx="16995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( </a:t>
              </a:r>
              <a:r>
                <a:rPr kumimoji="1" lang="ja-JP" altLang="en-US" sz="1200" dirty="0"/>
                <a:t>  </a:t>
              </a:r>
              <a:r>
                <a:rPr kumimoji="1" lang="en-US" altLang="ja-JP" sz="1200" dirty="0"/>
                <a:t>) 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efore correction</a:t>
              </a:r>
            </a:p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 After correction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楕円 81">
              <a:extLst>
                <a:ext uri="{FF2B5EF4-FFF2-40B4-BE49-F238E27FC236}">
                  <a16:creationId xmlns:a16="http://schemas.microsoft.com/office/drawing/2014/main" id="{8D502CED-C27A-6B18-17A6-B81DE34F94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409337" y="2864215"/>
              <a:ext cx="79450" cy="7945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84" name="楕円 83">
              <a:extLst>
                <a:ext uri="{FF2B5EF4-FFF2-40B4-BE49-F238E27FC236}">
                  <a16:creationId xmlns:a16="http://schemas.microsoft.com/office/drawing/2014/main" id="{4606ABE2-FB22-2D1D-07C9-14D5F6BF8ADD}"/>
                </a:ext>
              </a:extLst>
            </p:cNvPr>
            <p:cNvSpPr>
              <a:spLocks noChangeAspect="1"/>
            </p:cNvSpPr>
            <p:nvPr/>
          </p:nvSpPr>
          <p:spPr>
            <a:xfrm flipH="1" flipV="1">
              <a:off x="7397122" y="3030062"/>
              <a:ext cx="79450" cy="79450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</p:grpSp>
    </p:spTree>
    <p:extLst>
      <p:ext uri="{BB962C8B-B14F-4D97-AF65-F5344CB8AC3E}">
        <p14:creationId xmlns:p14="http://schemas.microsoft.com/office/powerpoint/2010/main" val="6611795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0919F13A-E610-FC5D-FD87-2DBC541F913C}"/>
              </a:ext>
            </a:extLst>
          </p:cNvPr>
          <p:cNvGrpSpPr/>
          <p:nvPr/>
        </p:nvGrpSpPr>
        <p:grpSpPr>
          <a:xfrm>
            <a:off x="188381" y="2232210"/>
            <a:ext cx="6736729" cy="5676075"/>
            <a:chOff x="-18983" y="16897"/>
            <a:chExt cx="8043656" cy="7132717"/>
          </a:xfrm>
        </p:grpSpPr>
        <p:graphicFrame>
          <p:nvGraphicFramePr>
            <p:cNvPr id="5" name="グラフ 4">
              <a:extLst>
                <a:ext uri="{FF2B5EF4-FFF2-40B4-BE49-F238E27FC236}">
                  <a16:creationId xmlns:a16="http://schemas.microsoft.com/office/drawing/2014/main" id="{1CF22E69-CFE1-08BD-7A73-E6E1BE68A76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51288108"/>
                </p:ext>
              </p:extLst>
            </p:nvPr>
          </p:nvGraphicFramePr>
          <p:xfrm>
            <a:off x="566029" y="66500"/>
            <a:ext cx="1315229" cy="17460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A5586045-17FB-DB41-25C1-74B2671E203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9105082"/>
                </p:ext>
              </p:extLst>
            </p:nvPr>
          </p:nvGraphicFramePr>
          <p:xfrm>
            <a:off x="3220519" y="80778"/>
            <a:ext cx="1327494" cy="18542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5A68DBAC-9900-F87F-117B-EEC7D0A4DB8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47182931"/>
                </p:ext>
              </p:extLst>
            </p:nvPr>
          </p:nvGraphicFramePr>
          <p:xfrm>
            <a:off x="4509972" y="16897"/>
            <a:ext cx="1370518" cy="19304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10892AE3-9F45-E304-915B-58ADA56525E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0023398"/>
                </p:ext>
              </p:extLst>
            </p:nvPr>
          </p:nvGraphicFramePr>
          <p:xfrm>
            <a:off x="5878971" y="34899"/>
            <a:ext cx="1327493" cy="19395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9" name="グラフ 8">
              <a:extLst>
                <a:ext uri="{FF2B5EF4-FFF2-40B4-BE49-F238E27FC236}">
                  <a16:creationId xmlns:a16="http://schemas.microsoft.com/office/drawing/2014/main" id="{16D5D568-1A56-4B4D-A292-ADFEAB2D016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5988411"/>
                </p:ext>
              </p:extLst>
            </p:nvPr>
          </p:nvGraphicFramePr>
          <p:xfrm>
            <a:off x="1874484" y="21544"/>
            <a:ext cx="1337706" cy="2062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6FCB223-C4FC-D584-6337-302E35E1525C}"/>
                </a:ext>
              </a:extLst>
            </p:cNvPr>
            <p:cNvSpPr txBox="1"/>
            <p:nvPr/>
          </p:nvSpPr>
          <p:spPr>
            <a:xfrm>
              <a:off x="7063751" y="342889"/>
              <a:ext cx="960922" cy="6144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i="0" u="none" strike="noStrike" dirty="0" err="1">
                  <a:solidFill>
                    <a:srgbClr val="000000"/>
                  </a:solidFill>
                  <a:effectLst/>
                  <a:latin typeface="游ゴシック" panose="020B0400000000000000" pitchFamily="50" charset="-128"/>
                  <a:ea typeface="游ゴシック" panose="020B0400000000000000" pitchFamily="50" charset="-128"/>
                </a:rPr>
                <a:t>HDFa</a:t>
              </a:r>
              <a:r>
                <a:rPr lang="en-US" altLang="ja-JP" sz="1200" b="1" i="0" u="none" strike="noStrike" dirty="0">
                  <a:solidFill>
                    <a:srgbClr val="000000"/>
                  </a:solidFill>
                  <a:effectLst/>
                  <a:latin typeface="游ゴシック" panose="020B0400000000000000" pitchFamily="50" charset="-128"/>
                  <a:ea typeface="游ゴシック" panose="020B0400000000000000" pitchFamily="50" charset="-128"/>
                </a:rPr>
                <a:t> 33PDL</a:t>
              </a:r>
              <a:r>
                <a:rPr lang="en-US" altLang="ja-JP" sz="1200" b="1" dirty="0"/>
                <a:t> </a:t>
              </a:r>
              <a:endParaRPr lang="ja-JP" altLang="en-US" sz="1200" b="1" dirty="0"/>
            </a:p>
          </p:txBody>
        </p:sp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631B635D-92C0-3FF1-7E59-D83E5D89C0D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25439998"/>
                </p:ext>
              </p:extLst>
            </p:nvPr>
          </p:nvGraphicFramePr>
          <p:xfrm>
            <a:off x="3212215" y="2099718"/>
            <a:ext cx="1327493" cy="19974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2" name="グラフ 11">
              <a:extLst>
                <a:ext uri="{FF2B5EF4-FFF2-40B4-BE49-F238E27FC236}">
                  <a16:creationId xmlns:a16="http://schemas.microsoft.com/office/drawing/2014/main" id="{944C14E0-3065-4BCD-9ED2-271DB671807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55656382"/>
                </p:ext>
              </p:extLst>
            </p:nvPr>
          </p:nvGraphicFramePr>
          <p:xfrm>
            <a:off x="552377" y="2154544"/>
            <a:ext cx="1353457" cy="18360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3" name="グラフ 12">
              <a:extLst>
                <a:ext uri="{FF2B5EF4-FFF2-40B4-BE49-F238E27FC236}">
                  <a16:creationId xmlns:a16="http://schemas.microsoft.com/office/drawing/2014/main" id="{E9BD2CC1-F3E6-A0DC-EB46-49B541A5DC9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41573929"/>
                </p:ext>
              </p:extLst>
            </p:nvPr>
          </p:nvGraphicFramePr>
          <p:xfrm>
            <a:off x="4509972" y="2113159"/>
            <a:ext cx="1370517" cy="19564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4" name="グラフ 13">
              <a:extLst>
                <a:ext uri="{FF2B5EF4-FFF2-40B4-BE49-F238E27FC236}">
                  <a16:creationId xmlns:a16="http://schemas.microsoft.com/office/drawing/2014/main" id="{2228EA4E-DF0A-FF13-3340-ADF235AB2EC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78369014"/>
                </p:ext>
              </p:extLst>
            </p:nvPr>
          </p:nvGraphicFramePr>
          <p:xfrm>
            <a:off x="5878971" y="2183274"/>
            <a:ext cx="1415686" cy="19584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5" name="グラフ 14">
              <a:extLst>
                <a:ext uri="{FF2B5EF4-FFF2-40B4-BE49-F238E27FC236}">
                  <a16:creationId xmlns:a16="http://schemas.microsoft.com/office/drawing/2014/main" id="{12459DF0-979C-4514-D9F2-1767A98C494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82113734"/>
                </p:ext>
              </p:extLst>
            </p:nvPr>
          </p:nvGraphicFramePr>
          <p:xfrm>
            <a:off x="1870044" y="2089650"/>
            <a:ext cx="1323892" cy="20738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28461C2F-B1C0-7E1E-D53F-C1CB1CCDA0E6}"/>
                </a:ext>
              </a:extLst>
            </p:cNvPr>
            <p:cNvSpPr txBox="1"/>
            <p:nvPr/>
          </p:nvSpPr>
          <p:spPr>
            <a:xfrm>
              <a:off x="6970859" y="2633950"/>
              <a:ext cx="898711" cy="6144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i="0" u="none" strike="noStrike" dirty="0" err="1">
                  <a:solidFill>
                    <a:srgbClr val="000000"/>
                  </a:solidFill>
                  <a:effectLst/>
                  <a:latin typeface="游ゴシック" panose="020B0400000000000000" pitchFamily="50" charset="-128"/>
                  <a:ea typeface="游ゴシック" panose="020B0400000000000000" pitchFamily="50" charset="-128"/>
                </a:rPr>
                <a:t>HDFa</a:t>
              </a:r>
              <a:r>
                <a:rPr lang="en-US" altLang="ja-JP" sz="1200" b="1" i="0" u="none" strike="noStrike" dirty="0">
                  <a:solidFill>
                    <a:srgbClr val="000000"/>
                  </a:solidFill>
                  <a:effectLst/>
                  <a:latin typeface="游ゴシック" panose="020B0400000000000000" pitchFamily="50" charset="-128"/>
                  <a:ea typeface="游ゴシック" panose="020B0400000000000000" pitchFamily="50" charset="-128"/>
                </a:rPr>
                <a:t> 37PDL</a:t>
              </a:r>
              <a:r>
                <a:rPr lang="en-US" altLang="ja-JP" sz="1200" b="1" dirty="0"/>
                <a:t> </a:t>
              </a:r>
              <a:endParaRPr lang="ja-JP" altLang="en-US" sz="1200" b="1" dirty="0"/>
            </a:p>
          </p:txBody>
        </p:sp>
        <p:graphicFrame>
          <p:nvGraphicFramePr>
            <p:cNvPr id="17" name="グラフ 16">
              <a:extLst>
                <a:ext uri="{FF2B5EF4-FFF2-40B4-BE49-F238E27FC236}">
                  <a16:creationId xmlns:a16="http://schemas.microsoft.com/office/drawing/2014/main" id="{84C12C7A-6A43-8E7E-2210-B1161921788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62485999"/>
                </p:ext>
              </p:extLst>
            </p:nvPr>
          </p:nvGraphicFramePr>
          <p:xfrm>
            <a:off x="560614" y="4292270"/>
            <a:ext cx="1451552" cy="17874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18" name="グラフ 17">
              <a:extLst>
                <a:ext uri="{FF2B5EF4-FFF2-40B4-BE49-F238E27FC236}">
                  <a16:creationId xmlns:a16="http://schemas.microsoft.com/office/drawing/2014/main" id="{FA2F403F-9C52-35F8-74D8-7D917F43FAA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21708406"/>
                </p:ext>
              </p:extLst>
            </p:nvPr>
          </p:nvGraphicFramePr>
          <p:xfrm>
            <a:off x="3207935" y="4292081"/>
            <a:ext cx="1383927" cy="19133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aphicFrame>
          <p:nvGraphicFramePr>
            <p:cNvPr id="19" name="グラフ 18">
              <a:extLst>
                <a:ext uri="{FF2B5EF4-FFF2-40B4-BE49-F238E27FC236}">
                  <a16:creationId xmlns:a16="http://schemas.microsoft.com/office/drawing/2014/main" id="{AADCE948-087E-8FBD-BF25-50DF1D6F50C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47899107"/>
                </p:ext>
              </p:extLst>
            </p:nvPr>
          </p:nvGraphicFramePr>
          <p:xfrm>
            <a:off x="5871504" y="4272745"/>
            <a:ext cx="1513978" cy="19584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20" name="グラフ 19">
              <a:extLst>
                <a:ext uri="{FF2B5EF4-FFF2-40B4-BE49-F238E27FC236}">
                  <a16:creationId xmlns:a16="http://schemas.microsoft.com/office/drawing/2014/main" id="{E16106F9-B5A2-F653-E237-8D4CAFF33CB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9203704"/>
                </p:ext>
              </p:extLst>
            </p:nvPr>
          </p:nvGraphicFramePr>
          <p:xfrm>
            <a:off x="1843193" y="4325877"/>
            <a:ext cx="1493188" cy="205568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956EAC4-A7F1-5E5A-926F-9B02E11CC0B4}"/>
                </a:ext>
              </a:extLst>
            </p:cNvPr>
            <p:cNvSpPr txBox="1"/>
            <p:nvPr/>
          </p:nvSpPr>
          <p:spPr>
            <a:xfrm>
              <a:off x="969348" y="6356537"/>
              <a:ext cx="587020" cy="28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Blank</a:t>
              </a:r>
              <a:endParaRPr kumimoji="1" lang="ja-JP" altLang="en-US" sz="12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593EF305-9566-83E2-D1F0-C775949077D6}"/>
                </a:ext>
              </a:extLst>
            </p:cNvPr>
            <p:cNvSpPr txBox="1"/>
            <p:nvPr/>
          </p:nvSpPr>
          <p:spPr>
            <a:xfrm>
              <a:off x="1990785" y="6293560"/>
              <a:ext cx="1309974" cy="6624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Hydrocortisone </a:t>
              </a:r>
            </a:p>
            <a:p>
              <a:pPr algn="ctr"/>
              <a:r>
                <a:rPr lang="en-US" altLang="ja-JP" sz="1200" dirty="0"/>
                <a:t>Succinate</a:t>
              </a:r>
            </a:p>
            <a:p>
              <a:pPr algn="ctr"/>
              <a:r>
                <a:rPr lang="en-US" altLang="ja-JP" sz="1200" dirty="0"/>
                <a:t> (µg/mL)</a:t>
              </a:r>
              <a:endParaRPr kumimoji="1" lang="ja-JP" altLang="en-US" sz="12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A54C62D0-3742-7F7F-E55A-DFC9E027DECA}"/>
                </a:ext>
              </a:extLst>
            </p:cNvPr>
            <p:cNvSpPr txBox="1"/>
            <p:nvPr/>
          </p:nvSpPr>
          <p:spPr>
            <a:xfrm>
              <a:off x="3458221" y="6337416"/>
              <a:ext cx="856853" cy="812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Taheebo</a:t>
              </a:r>
            </a:p>
            <a:p>
              <a:pPr algn="ctr"/>
              <a:r>
                <a:rPr lang="ja-JP" altLang="en-US" sz="1200" dirty="0"/>
                <a:t> </a:t>
              </a:r>
              <a:r>
                <a:rPr lang="en-US" altLang="ja-JP" sz="1200" dirty="0"/>
                <a:t>Tea</a:t>
              </a:r>
            </a:p>
            <a:p>
              <a:pPr algn="ctr"/>
              <a:r>
                <a:rPr kumimoji="1" lang="en-US" altLang="ja-JP" sz="1200" dirty="0"/>
                <a:t>(%)</a:t>
              </a:r>
              <a:endParaRPr kumimoji="1" lang="ja-JP" altLang="en-US" sz="12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6FE839A0-B4D8-CD04-6235-AD8F8D7835F8}"/>
                </a:ext>
              </a:extLst>
            </p:cNvPr>
            <p:cNvSpPr txBox="1"/>
            <p:nvPr/>
          </p:nvSpPr>
          <p:spPr>
            <a:xfrm>
              <a:off x="4689402" y="6236432"/>
              <a:ext cx="1007181" cy="8121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Pine cone extract</a:t>
              </a:r>
            </a:p>
            <a:p>
              <a:pPr algn="ctr"/>
              <a:r>
                <a:rPr lang="en-US" altLang="ja-JP" sz="1200" dirty="0"/>
                <a:t>(%)</a:t>
              </a:r>
              <a:endParaRPr kumimoji="1" lang="ja-JP" altLang="en-US" sz="12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F2F31CB3-C97B-0D28-E5A4-4B8EE8C798B8}"/>
                </a:ext>
              </a:extLst>
            </p:cNvPr>
            <p:cNvSpPr txBox="1"/>
            <p:nvPr/>
          </p:nvSpPr>
          <p:spPr>
            <a:xfrm>
              <a:off x="6326495" y="6320518"/>
              <a:ext cx="852107" cy="812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Sasa sp. </a:t>
              </a:r>
            </a:p>
            <a:p>
              <a:pPr algn="ctr"/>
              <a:r>
                <a:rPr kumimoji="1" lang="en-US" altLang="ja-JP" sz="1200" dirty="0"/>
                <a:t>extract</a:t>
              </a:r>
            </a:p>
            <a:p>
              <a:pPr algn="ctr"/>
              <a:r>
                <a:rPr lang="en-US" altLang="ja-JP" sz="1200" dirty="0"/>
                <a:t>(%)</a:t>
              </a:r>
              <a:endParaRPr kumimoji="1" lang="ja-JP" altLang="en-US" sz="1200" dirty="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C54D9B75-8472-EC76-EB61-461B209BBF9B}"/>
                </a:ext>
              </a:extLst>
            </p:cNvPr>
            <p:cNvSpPr txBox="1"/>
            <p:nvPr/>
          </p:nvSpPr>
          <p:spPr>
            <a:xfrm>
              <a:off x="6955388" y="4633958"/>
              <a:ext cx="898711" cy="6144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i="0" u="none" strike="noStrike" dirty="0">
                  <a:solidFill>
                    <a:srgbClr val="000000"/>
                  </a:solidFill>
                  <a:effectLst/>
                  <a:latin typeface="游ゴシック" panose="020B0400000000000000" pitchFamily="50" charset="-128"/>
                  <a:ea typeface="游ゴシック" panose="020B0400000000000000" pitchFamily="50" charset="-128"/>
                </a:rPr>
                <a:t>HPLF 67PDL</a:t>
              </a:r>
              <a:r>
                <a:rPr lang="en-US" altLang="ja-JP" sz="1200" b="1" dirty="0"/>
                <a:t> </a:t>
              </a:r>
              <a:endParaRPr lang="ja-JP" altLang="en-US" sz="1200" b="1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EA66A184-032F-815A-7F56-89AB17017B0C}"/>
                </a:ext>
              </a:extLst>
            </p:cNvPr>
            <p:cNvSpPr txBox="1"/>
            <p:nvPr/>
          </p:nvSpPr>
          <p:spPr>
            <a:xfrm rot="16200000">
              <a:off x="-835477" y="3176550"/>
              <a:ext cx="19099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Viable cell number (A</a:t>
              </a:r>
              <a:r>
                <a:rPr kumimoji="1" lang="en-US" altLang="ja-JP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60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E631F951-FC79-645F-3026-C7F12D516E63}"/>
                </a:ext>
              </a:extLst>
            </p:cNvPr>
            <p:cNvCxnSpPr>
              <a:cxnSpLocks/>
            </p:cNvCxnSpPr>
            <p:nvPr/>
          </p:nvCxnSpPr>
          <p:spPr>
            <a:xfrm>
              <a:off x="565156" y="2059072"/>
              <a:ext cx="6641308" cy="0"/>
            </a:xfrm>
            <a:prstGeom prst="line">
              <a:avLst/>
            </a:prstGeom>
            <a:ln w="57150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左大かっこ 28">
              <a:extLst>
                <a:ext uri="{FF2B5EF4-FFF2-40B4-BE49-F238E27FC236}">
                  <a16:creationId xmlns:a16="http://schemas.microsoft.com/office/drawing/2014/main" id="{861767CC-6F3A-7E23-872D-64C91607D64B}"/>
                </a:ext>
              </a:extLst>
            </p:cNvPr>
            <p:cNvSpPr/>
            <p:nvPr/>
          </p:nvSpPr>
          <p:spPr>
            <a:xfrm rot="5400000">
              <a:off x="1085483" y="587779"/>
              <a:ext cx="57146" cy="560775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C8617612-8628-605B-AA9F-69B0E67E68D7}"/>
                </a:ext>
              </a:extLst>
            </p:cNvPr>
            <p:cNvSpPr txBox="1"/>
            <p:nvPr/>
          </p:nvSpPr>
          <p:spPr>
            <a:xfrm>
              <a:off x="1003457" y="700095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31" name="左大かっこ 30">
              <a:extLst>
                <a:ext uri="{FF2B5EF4-FFF2-40B4-BE49-F238E27FC236}">
                  <a16:creationId xmlns:a16="http://schemas.microsoft.com/office/drawing/2014/main" id="{8F3C398D-F6FE-967C-6901-AF3F6EDCD243}"/>
                </a:ext>
              </a:extLst>
            </p:cNvPr>
            <p:cNvSpPr/>
            <p:nvPr/>
          </p:nvSpPr>
          <p:spPr>
            <a:xfrm rot="5400000">
              <a:off x="1237883" y="740179"/>
              <a:ext cx="57146" cy="560775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左大かっこ 31">
              <a:extLst>
                <a:ext uri="{FF2B5EF4-FFF2-40B4-BE49-F238E27FC236}">
                  <a16:creationId xmlns:a16="http://schemas.microsoft.com/office/drawing/2014/main" id="{EBB02B0D-2A39-E188-E9DA-39B8666E8BBE}"/>
                </a:ext>
              </a:extLst>
            </p:cNvPr>
            <p:cNvSpPr/>
            <p:nvPr/>
          </p:nvSpPr>
          <p:spPr>
            <a:xfrm rot="5400000">
              <a:off x="2594467" y="-215476"/>
              <a:ext cx="45719" cy="901311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D2DCAD9-3AF2-D499-A432-4015709FBE87}"/>
                </a:ext>
              </a:extLst>
            </p:cNvPr>
            <p:cNvSpPr txBox="1"/>
            <p:nvPr/>
          </p:nvSpPr>
          <p:spPr>
            <a:xfrm>
              <a:off x="2498886" y="42870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34" name="左大かっこ 33">
              <a:extLst>
                <a:ext uri="{FF2B5EF4-FFF2-40B4-BE49-F238E27FC236}">
                  <a16:creationId xmlns:a16="http://schemas.microsoft.com/office/drawing/2014/main" id="{D1192EFC-9887-A469-0B99-5994089F2E86}"/>
                </a:ext>
              </a:extLst>
            </p:cNvPr>
            <p:cNvSpPr/>
            <p:nvPr/>
          </p:nvSpPr>
          <p:spPr>
            <a:xfrm rot="5400000">
              <a:off x="4014317" y="282466"/>
              <a:ext cx="45719" cy="349481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2F89A6D1-B78C-A006-7953-059758C6521D}"/>
                </a:ext>
              </a:extLst>
            </p:cNvPr>
            <p:cNvSpPr txBox="1"/>
            <p:nvPr/>
          </p:nvSpPr>
          <p:spPr>
            <a:xfrm>
              <a:off x="3934166" y="268977"/>
              <a:ext cx="1558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36" name="左大かっこ 35">
              <a:extLst>
                <a:ext uri="{FF2B5EF4-FFF2-40B4-BE49-F238E27FC236}">
                  <a16:creationId xmlns:a16="http://schemas.microsoft.com/office/drawing/2014/main" id="{0F2A9C47-ACE1-A9BB-DF0E-8E6147FB55CD}"/>
                </a:ext>
              </a:extLst>
            </p:cNvPr>
            <p:cNvSpPr/>
            <p:nvPr/>
          </p:nvSpPr>
          <p:spPr>
            <a:xfrm rot="5400000">
              <a:off x="5135547" y="500182"/>
              <a:ext cx="45719" cy="349481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057914D-9C06-1ABD-7132-3963CF217DC9}"/>
                </a:ext>
              </a:extLst>
            </p:cNvPr>
            <p:cNvSpPr txBox="1"/>
            <p:nvPr/>
          </p:nvSpPr>
          <p:spPr>
            <a:xfrm>
              <a:off x="5035259" y="467005"/>
              <a:ext cx="2858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38" name="左大かっこ 37">
              <a:extLst>
                <a:ext uri="{FF2B5EF4-FFF2-40B4-BE49-F238E27FC236}">
                  <a16:creationId xmlns:a16="http://schemas.microsoft.com/office/drawing/2014/main" id="{B0126306-672B-D99C-5BA6-AE1EC1B173CA}"/>
                </a:ext>
              </a:extLst>
            </p:cNvPr>
            <p:cNvSpPr/>
            <p:nvPr/>
          </p:nvSpPr>
          <p:spPr>
            <a:xfrm rot="5400000">
              <a:off x="6457656" y="521098"/>
              <a:ext cx="45719" cy="438284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FD79B797-41A3-AF16-0060-7A1E30010459}"/>
                </a:ext>
              </a:extLst>
            </p:cNvPr>
            <p:cNvSpPr txBox="1"/>
            <p:nvPr/>
          </p:nvSpPr>
          <p:spPr>
            <a:xfrm>
              <a:off x="6368765" y="554093"/>
              <a:ext cx="2858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40" name="左大かっこ 39">
              <a:extLst>
                <a:ext uri="{FF2B5EF4-FFF2-40B4-BE49-F238E27FC236}">
                  <a16:creationId xmlns:a16="http://schemas.microsoft.com/office/drawing/2014/main" id="{B9309045-0961-2AD7-3082-515E71ED2900}"/>
                </a:ext>
              </a:extLst>
            </p:cNvPr>
            <p:cNvSpPr/>
            <p:nvPr/>
          </p:nvSpPr>
          <p:spPr>
            <a:xfrm rot="5400000" flipH="1">
              <a:off x="2588719" y="781673"/>
              <a:ext cx="45719" cy="812313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E97567EC-C5E9-E6F6-BBC7-996109242C49}"/>
                </a:ext>
              </a:extLst>
            </p:cNvPr>
            <p:cNvSpPr txBox="1"/>
            <p:nvPr/>
          </p:nvSpPr>
          <p:spPr>
            <a:xfrm>
              <a:off x="2490720" y="1195395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42" name="左大かっこ 41">
              <a:extLst>
                <a:ext uri="{FF2B5EF4-FFF2-40B4-BE49-F238E27FC236}">
                  <a16:creationId xmlns:a16="http://schemas.microsoft.com/office/drawing/2014/main" id="{89D31C9F-2686-B069-4A22-578471CD75A6}"/>
                </a:ext>
              </a:extLst>
            </p:cNvPr>
            <p:cNvSpPr/>
            <p:nvPr/>
          </p:nvSpPr>
          <p:spPr>
            <a:xfrm rot="5400000" flipH="1">
              <a:off x="4146063" y="1025111"/>
              <a:ext cx="45719" cy="155899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8040DF2A-C867-C720-27CD-34CCC9077DED}"/>
                </a:ext>
              </a:extLst>
            </p:cNvPr>
            <p:cNvSpPr txBox="1"/>
            <p:nvPr/>
          </p:nvSpPr>
          <p:spPr>
            <a:xfrm>
              <a:off x="4052820" y="1100145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44" name="左大かっこ 43">
              <a:extLst>
                <a:ext uri="{FF2B5EF4-FFF2-40B4-BE49-F238E27FC236}">
                  <a16:creationId xmlns:a16="http://schemas.microsoft.com/office/drawing/2014/main" id="{96914302-131E-F22C-4B8A-BF04EDC26882}"/>
                </a:ext>
              </a:extLst>
            </p:cNvPr>
            <p:cNvSpPr/>
            <p:nvPr/>
          </p:nvSpPr>
          <p:spPr>
            <a:xfrm rot="5400000" flipH="1">
              <a:off x="5327163" y="1120361"/>
              <a:ext cx="45719" cy="155899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CC25D27A-24F2-F2D6-B4C1-64D0E3444A3B}"/>
                </a:ext>
              </a:extLst>
            </p:cNvPr>
            <p:cNvSpPr txBox="1"/>
            <p:nvPr/>
          </p:nvSpPr>
          <p:spPr>
            <a:xfrm>
              <a:off x="5233920" y="1223970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46" name="左大かっこ 45">
              <a:extLst>
                <a:ext uri="{FF2B5EF4-FFF2-40B4-BE49-F238E27FC236}">
                  <a16:creationId xmlns:a16="http://schemas.microsoft.com/office/drawing/2014/main" id="{97C4EFC5-FC78-BC4E-68D8-E6AA77A585F5}"/>
                </a:ext>
              </a:extLst>
            </p:cNvPr>
            <p:cNvSpPr/>
            <p:nvPr/>
          </p:nvSpPr>
          <p:spPr>
            <a:xfrm rot="5400000" flipH="1">
              <a:off x="6535829" y="1146462"/>
              <a:ext cx="45719" cy="282213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B3C0C653-13E1-76BD-05BB-D27010F0955E}"/>
                </a:ext>
              </a:extLst>
            </p:cNvPr>
            <p:cNvSpPr txBox="1"/>
            <p:nvPr/>
          </p:nvSpPr>
          <p:spPr>
            <a:xfrm>
              <a:off x="6443602" y="1291604"/>
              <a:ext cx="2858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CC4DF757-B592-65C2-590A-A5BE06F69DB5}"/>
                </a:ext>
              </a:extLst>
            </p:cNvPr>
            <p:cNvSpPr txBox="1"/>
            <p:nvPr/>
          </p:nvSpPr>
          <p:spPr>
            <a:xfrm>
              <a:off x="981685" y="2757504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F20EED59-CFA5-962E-991F-D348928886AB}"/>
                </a:ext>
              </a:extLst>
            </p:cNvPr>
            <p:cNvSpPr txBox="1"/>
            <p:nvPr/>
          </p:nvSpPr>
          <p:spPr>
            <a:xfrm>
              <a:off x="1188515" y="2822816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0F2DF731-48F1-DF32-E0AF-467DC14DAA63}"/>
                </a:ext>
              </a:extLst>
            </p:cNvPr>
            <p:cNvSpPr txBox="1"/>
            <p:nvPr/>
          </p:nvSpPr>
          <p:spPr>
            <a:xfrm>
              <a:off x="1308259" y="2801044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51" name="左大かっこ 50">
              <a:extLst>
                <a:ext uri="{FF2B5EF4-FFF2-40B4-BE49-F238E27FC236}">
                  <a16:creationId xmlns:a16="http://schemas.microsoft.com/office/drawing/2014/main" id="{40D26E47-1C7B-74F2-D5E1-648D51934D14}"/>
                </a:ext>
              </a:extLst>
            </p:cNvPr>
            <p:cNvSpPr/>
            <p:nvPr/>
          </p:nvSpPr>
          <p:spPr>
            <a:xfrm rot="5400000">
              <a:off x="2629060" y="1809017"/>
              <a:ext cx="57262" cy="93849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979433EE-3818-E11E-3FFD-863742AFC9E8}"/>
                </a:ext>
              </a:extLst>
            </p:cNvPr>
            <p:cNvSpPr txBox="1"/>
            <p:nvPr/>
          </p:nvSpPr>
          <p:spPr>
            <a:xfrm>
              <a:off x="2534262" y="2098911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53" name="左大かっこ 52">
              <a:extLst>
                <a:ext uri="{FF2B5EF4-FFF2-40B4-BE49-F238E27FC236}">
                  <a16:creationId xmlns:a16="http://schemas.microsoft.com/office/drawing/2014/main" id="{1214DEE0-C48D-EFFA-A8F0-265FE29EF977}"/>
                </a:ext>
              </a:extLst>
            </p:cNvPr>
            <p:cNvSpPr/>
            <p:nvPr/>
          </p:nvSpPr>
          <p:spPr>
            <a:xfrm rot="5400000">
              <a:off x="4090798" y="2005409"/>
              <a:ext cx="54970" cy="548009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F7C1C06D-FDF6-4725-4F15-A96BEF77B2A6}"/>
                </a:ext>
              </a:extLst>
            </p:cNvPr>
            <p:cNvSpPr txBox="1"/>
            <p:nvPr/>
          </p:nvSpPr>
          <p:spPr>
            <a:xfrm>
              <a:off x="2686662" y="2251311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F5263EE3-C360-C1F0-FE2B-22BFE99A3E48}"/>
                </a:ext>
              </a:extLst>
            </p:cNvPr>
            <p:cNvSpPr txBox="1"/>
            <p:nvPr/>
          </p:nvSpPr>
          <p:spPr>
            <a:xfrm>
              <a:off x="4010637" y="2108436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56" name="左大かっこ 55">
              <a:extLst>
                <a:ext uri="{FF2B5EF4-FFF2-40B4-BE49-F238E27FC236}">
                  <a16:creationId xmlns:a16="http://schemas.microsoft.com/office/drawing/2014/main" id="{5A5A41D2-E215-973C-8E6F-E4D55D5A6065}"/>
                </a:ext>
              </a:extLst>
            </p:cNvPr>
            <p:cNvSpPr/>
            <p:nvPr/>
          </p:nvSpPr>
          <p:spPr>
            <a:xfrm rot="5400000">
              <a:off x="5220737" y="2313747"/>
              <a:ext cx="60714" cy="68002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左大かっこ 56">
              <a:extLst>
                <a:ext uri="{FF2B5EF4-FFF2-40B4-BE49-F238E27FC236}">
                  <a16:creationId xmlns:a16="http://schemas.microsoft.com/office/drawing/2014/main" id="{BFF3BDA6-90BE-42C2-4208-BD82BBF3B5D1}"/>
                </a:ext>
              </a:extLst>
            </p:cNvPr>
            <p:cNvSpPr/>
            <p:nvPr/>
          </p:nvSpPr>
          <p:spPr>
            <a:xfrm rot="5400000">
              <a:off x="6514911" y="2257822"/>
              <a:ext cx="54970" cy="748033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74501E8B-06FF-032C-4AB1-76A318C6A1F6}"/>
                </a:ext>
              </a:extLst>
            </p:cNvPr>
            <p:cNvSpPr txBox="1"/>
            <p:nvPr/>
          </p:nvSpPr>
          <p:spPr>
            <a:xfrm>
              <a:off x="5148881" y="2458777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5692EEFA-7F20-9CB3-F02D-5D9AE681683D}"/>
                </a:ext>
              </a:extLst>
            </p:cNvPr>
            <p:cNvSpPr txBox="1"/>
            <p:nvPr/>
          </p:nvSpPr>
          <p:spPr>
            <a:xfrm>
              <a:off x="6429987" y="2441811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60" name="左大かっこ 59">
              <a:extLst>
                <a:ext uri="{FF2B5EF4-FFF2-40B4-BE49-F238E27FC236}">
                  <a16:creationId xmlns:a16="http://schemas.microsoft.com/office/drawing/2014/main" id="{247D71A9-D7DF-EA0A-E22B-FEDFBD66BD11}"/>
                </a:ext>
              </a:extLst>
            </p:cNvPr>
            <p:cNvSpPr/>
            <p:nvPr/>
          </p:nvSpPr>
          <p:spPr>
            <a:xfrm rot="5400000" flipH="1">
              <a:off x="2660736" y="2804639"/>
              <a:ext cx="57261" cy="75722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左大かっこ 60">
              <a:extLst>
                <a:ext uri="{FF2B5EF4-FFF2-40B4-BE49-F238E27FC236}">
                  <a16:creationId xmlns:a16="http://schemas.microsoft.com/office/drawing/2014/main" id="{B109C1FD-6699-31E7-8D3F-B875561C0999}"/>
                </a:ext>
              </a:extLst>
            </p:cNvPr>
            <p:cNvSpPr/>
            <p:nvPr/>
          </p:nvSpPr>
          <p:spPr>
            <a:xfrm rot="5400000" flipH="1">
              <a:off x="4117432" y="3113417"/>
              <a:ext cx="72662" cy="220939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左大かっこ 61">
              <a:extLst>
                <a:ext uri="{FF2B5EF4-FFF2-40B4-BE49-F238E27FC236}">
                  <a16:creationId xmlns:a16="http://schemas.microsoft.com/office/drawing/2014/main" id="{35697FB7-8B6E-485D-AFF4-A4559EFF7B37}"/>
                </a:ext>
              </a:extLst>
            </p:cNvPr>
            <p:cNvSpPr/>
            <p:nvPr/>
          </p:nvSpPr>
          <p:spPr>
            <a:xfrm rot="5400000" flipH="1">
              <a:off x="5336632" y="2980067"/>
              <a:ext cx="72662" cy="220939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左大かっこ 62">
              <a:extLst>
                <a:ext uri="{FF2B5EF4-FFF2-40B4-BE49-F238E27FC236}">
                  <a16:creationId xmlns:a16="http://schemas.microsoft.com/office/drawing/2014/main" id="{FF1BEF82-8560-D1DB-6F97-000DAF74413B}"/>
                </a:ext>
              </a:extLst>
            </p:cNvPr>
            <p:cNvSpPr/>
            <p:nvPr/>
          </p:nvSpPr>
          <p:spPr>
            <a:xfrm rot="5400000" flipH="1">
              <a:off x="6563780" y="3229289"/>
              <a:ext cx="54971" cy="276299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B1AD6C44-44A7-FE6F-A844-6899AB6D77A0}"/>
                </a:ext>
              </a:extLst>
            </p:cNvPr>
            <p:cNvSpPr txBox="1"/>
            <p:nvPr/>
          </p:nvSpPr>
          <p:spPr>
            <a:xfrm>
              <a:off x="2591412" y="3175236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F91FB493-0513-0EB0-BC34-56E96FF409B4}"/>
                </a:ext>
              </a:extLst>
            </p:cNvPr>
            <p:cNvSpPr txBox="1"/>
            <p:nvPr/>
          </p:nvSpPr>
          <p:spPr>
            <a:xfrm>
              <a:off x="4029687" y="3241911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0737FE6E-0DCF-8D98-A263-93B6587DA08D}"/>
                </a:ext>
              </a:extLst>
            </p:cNvPr>
            <p:cNvSpPr txBox="1"/>
            <p:nvPr/>
          </p:nvSpPr>
          <p:spPr>
            <a:xfrm>
              <a:off x="5248887" y="3099036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B3BEF156-6180-2BF9-DD56-A66AFF974747}"/>
                </a:ext>
              </a:extLst>
            </p:cNvPr>
            <p:cNvSpPr txBox="1"/>
            <p:nvPr/>
          </p:nvSpPr>
          <p:spPr>
            <a:xfrm>
              <a:off x="6458562" y="3356211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86F237D8-2EEE-FDD0-3075-3443757162D5}"/>
                </a:ext>
              </a:extLst>
            </p:cNvPr>
            <p:cNvSpPr txBox="1"/>
            <p:nvPr/>
          </p:nvSpPr>
          <p:spPr>
            <a:xfrm>
              <a:off x="6287112" y="4661136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8BC27B12-73CC-BEBD-1D0F-337922E9675B}"/>
                </a:ext>
              </a:extLst>
            </p:cNvPr>
            <p:cNvSpPr txBox="1"/>
            <p:nvPr/>
          </p:nvSpPr>
          <p:spPr>
            <a:xfrm>
              <a:off x="6391887" y="4556361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B1200DBE-5E3E-3463-AA9E-34A5B5431E2D}"/>
                </a:ext>
              </a:extLst>
            </p:cNvPr>
            <p:cNvSpPr txBox="1"/>
            <p:nvPr/>
          </p:nvSpPr>
          <p:spPr>
            <a:xfrm>
              <a:off x="6481690" y="4940749"/>
              <a:ext cx="25359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b="1" dirty="0"/>
                <a:t>*</a:t>
              </a:r>
            </a:p>
          </p:txBody>
        </p:sp>
        <p:graphicFrame>
          <p:nvGraphicFramePr>
            <p:cNvPr id="71" name="グラフ 70">
              <a:extLst>
                <a:ext uri="{FF2B5EF4-FFF2-40B4-BE49-F238E27FC236}">
                  <a16:creationId xmlns:a16="http://schemas.microsoft.com/office/drawing/2014/main" id="{BD507ED7-FBFF-7C75-1645-89AA1C2C4D9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60496528"/>
                </p:ext>
              </p:extLst>
            </p:nvPr>
          </p:nvGraphicFramePr>
          <p:xfrm>
            <a:off x="4502197" y="4258285"/>
            <a:ext cx="1332890" cy="19667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B86D4AD5-4C41-80C5-DE2C-B85EE9C6D5C9}"/>
                </a:ext>
              </a:extLst>
            </p:cNvPr>
            <p:cNvCxnSpPr>
              <a:cxnSpLocks/>
            </p:cNvCxnSpPr>
            <p:nvPr/>
          </p:nvCxnSpPr>
          <p:spPr>
            <a:xfrm>
              <a:off x="717556" y="4202197"/>
              <a:ext cx="6641308" cy="0"/>
            </a:xfrm>
            <a:prstGeom prst="line">
              <a:avLst/>
            </a:prstGeom>
            <a:ln w="57150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F2BB76C4-E5B1-834F-218E-E8E862488546}"/>
                </a:ext>
              </a:extLst>
            </p:cNvPr>
            <p:cNvSpPr txBox="1"/>
            <p:nvPr/>
          </p:nvSpPr>
          <p:spPr>
            <a:xfrm>
              <a:off x="142518" y="823537"/>
              <a:ext cx="415497" cy="3693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i="1" dirty="0">
                  <a:solidFill>
                    <a:srgbClr val="FF0000"/>
                  </a:solidFill>
                </a:rPr>
                <a:t>Δ</a:t>
              </a:r>
              <a:endParaRPr kumimoji="1" lang="ja-JP" altLang="en-US" b="1" i="1" dirty="0">
                <a:solidFill>
                  <a:srgbClr val="FF0000"/>
                </a:solidFill>
              </a:endParaRPr>
            </a:p>
          </p:txBody>
        </p: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CB42BD85-4170-1CB1-D4A8-44739E6A5A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2848" y="937938"/>
              <a:ext cx="1624146" cy="641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455DAAD8-8383-D36C-035C-A821FCAE14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4273" y="1147488"/>
              <a:ext cx="1624146" cy="641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597EF38F-0218-DF15-F3F0-60AEB2150304}"/>
                </a:ext>
              </a:extLst>
            </p:cNvPr>
            <p:cNvSpPr txBox="1"/>
            <p:nvPr/>
          </p:nvSpPr>
          <p:spPr>
            <a:xfrm>
              <a:off x="180617" y="2922720"/>
              <a:ext cx="4775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i="1" dirty="0">
                  <a:solidFill>
                    <a:srgbClr val="FF0000"/>
                  </a:solidFill>
                </a:rPr>
                <a:t>Δ</a:t>
              </a:r>
              <a:endParaRPr kumimoji="1" lang="ja-JP" altLang="en-US" b="1" i="1" dirty="0">
                <a:solidFill>
                  <a:srgbClr val="FF0000"/>
                </a:solidFill>
              </a:endParaRPr>
            </a:p>
          </p:txBody>
        </p: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0C568CE3-673B-467D-4C46-9F7C55DCFBD9}"/>
                </a:ext>
              </a:extLst>
            </p:cNvPr>
            <p:cNvCxnSpPr>
              <a:cxnSpLocks/>
            </p:cNvCxnSpPr>
            <p:nvPr/>
          </p:nvCxnSpPr>
          <p:spPr>
            <a:xfrm>
              <a:off x="242373" y="3017877"/>
              <a:ext cx="1589605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9CB471D3-2719-CC18-0A77-B18BCFDC110C}"/>
                </a:ext>
              </a:extLst>
            </p:cNvPr>
            <p:cNvCxnSpPr>
              <a:cxnSpLocks/>
            </p:cNvCxnSpPr>
            <p:nvPr/>
          </p:nvCxnSpPr>
          <p:spPr>
            <a:xfrm>
              <a:off x="242373" y="3227427"/>
              <a:ext cx="1612824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F9740352-88E8-FBEC-0936-8820DF6190BF}"/>
                </a:ext>
              </a:extLst>
            </p:cNvPr>
            <p:cNvSpPr txBox="1"/>
            <p:nvPr/>
          </p:nvSpPr>
          <p:spPr>
            <a:xfrm>
              <a:off x="199667" y="4490360"/>
              <a:ext cx="4775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i="1" dirty="0">
                  <a:solidFill>
                    <a:srgbClr val="FF0000"/>
                  </a:solidFill>
                </a:rPr>
                <a:t>Δ</a:t>
              </a:r>
              <a:endParaRPr kumimoji="1" lang="ja-JP" altLang="en-US" b="1" i="1" dirty="0">
                <a:solidFill>
                  <a:srgbClr val="FF0000"/>
                </a:solidFill>
              </a:endParaRPr>
            </a:p>
          </p:txBody>
        </p: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43C949FA-8E7F-F534-550C-AABF9115B298}"/>
                </a:ext>
              </a:extLst>
            </p:cNvPr>
            <p:cNvCxnSpPr>
              <a:cxnSpLocks/>
            </p:cNvCxnSpPr>
            <p:nvPr/>
          </p:nvCxnSpPr>
          <p:spPr>
            <a:xfrm>
              <a:off x="293011" y="4674998"/>
              <a:ext cx="1589605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5E6AFD4B-B20E-6B21-FA81-F4004D8F0D46}"/>
                </a:ext>
              </a:extLst>
            </p:cNvPr>
            <p:cNvCxnSpPr>
              <a:cxnSpLocks/>
            </p:cNvCxnSpPr>
            <p:nvPr/>
          </p:nvCxnSpPr>
          <p:spPr>
            <a:xfrm>
              <a:off x="293011" y="4759580"/>
              <a:ext cx="1612824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oli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D405B2B-D36D-A4FD-8FB4-B9E355EBE288}"/>
              </a:ext>
            </a:extLst>
          </p:cNvPr>
          <p:cNvSpPr txBox="1"/>
          <p:nvPr/>
        </p:nvSpPr>
        <p:spPr>
          <a:xfrm>
            <a:off x="1572159" y="348259"/>
            <a:ext cx="41804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 Figure S4 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4705E6B-DD48-D8D3-E6E1-6C9BA42AD6E2}"/>
              </a:ext>
            </a:extLst>
          </p:cNvPr>
          <p:cNvSpPr txBox="1"/>
          <p:nvPr/>
        </p:nvSpPr>
        <p:spPr>
          <a:xfrm>
            <a:off x="336716" y="1010316"/>
            <a:ext cx="63046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heebo, pine cone and </a:t>
            </a:r>
            <a:r>
              <a:rPr kumimoji="1" lang="en-US" altLang="ja-JP" sz="2000" b="1" i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sa</a:t>
            </a:r>
            <a:r>
              <a:rPr kumimoji="1" lang="en-US" altLang="ja-JP" sz="20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p. extracts showed potent RLE effects on </a:t>
            </a:r>
            <a:r>
              <a:rPr kumimoji="1" lang="en-US" altLang="ja-JP" sz="2000" b="1" dirty="0" err="1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Fa</a:t>
            </a:r>
            <a:r>
              <a:rPr kumimoji="1" lang="en-US" altLang="ja-JP" sz="20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.</a:t>
            </a:r>
            <a:endParaRPr kumimoji="1" lang="ja-JP" altLang="en-US" sz="2000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4E43497-CB92-312E-BA63-8F77A95926C8}"/>
              </a:ext>
            </a:extLst>
          </p:cNvPr>
          <p:cNvSpPr txBox="1"/>
          <p:nvPr/>
        </p:nvSpPr>
        <p:spPr>
          <a:xfrm>
            <a:off x="599949" y="8287909"/>
            <a:ext cx="48595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 point represents mean</a:t>
            </a:r>
            <a:r>
              <a:rPr lang="ja-JP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±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.D. (n=6).  * p &lt; 0.05 vs. control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02DDFC1-59C3-B803-EB80-0482083A31F0}"/>
              </a:ext>
            </a:extLst>
          </p:cNvPr>
          <p:cNvSpPr txBox="1"/>
          <p:nvPr/>
        </p:nvSpPr>
        <p:spPr>
          <a:xfrm>
            <a:off x="403256" y="224566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2C419DF-9B4B-7924-AF8A-FCAAD6240072}"/>
              </a:ext>
            </a:extLst>
          </p:cNvPr>
          <p:cNvSpPr txBox="1"/>
          <p:nvPr/>
        </p:nvSpPr>
        <p:spPr>
          <a:xfrm>
            <a:off x="407739" y="3850336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86C6874-5474-77A4-4940-9A850C56376B}"/>
              </a:ext>
            </a:extLst>
          </p:cNvPr>
          <p:cNvSpPr txBox="1"/>
          <p:nvPr/>
        </p:nvSpPr>
        <p:spPr>
          <a:xfrm>
            <a:off x="412222" y="5589482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17825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DE69F313-FAE3-6244-7D6A-3A94A3F37B39}"/>
              </a:ext>
            </a:extLst>
          </p:cNvPr>
          <p:cNvGrpSpPr/>
          <p:nvPr/>
        </p:nvGrpSpPr>
        <p:grpSpPr>
          <a:xfrm>
            <a:off x="-125260" y="0"/>
            <a:ext cx="6983260" cy="9144001"/>
            <a:chOff x="-125260" y="0"/>
            <a:chExt cx="6983260" cy="9144001"/>
          </a:xfrm>
        </p:grpSpPr>
        <p:graphicFrame>
          <p:nvGraphicFramePr>
            <p:cNvPr id="24" name="オブジェクト 23">
              <a:extLst>
                <a:ext uri="{FF2B5EF4-FFF2-40B4-BE49-F238E27FC236}">
                  <a16:creationId xmlns:a16="http://schemas.microsoft.com/office/drawing/2014/main" id="{39E427CE-DDF9-3E24-DE39-26D9DD416B7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22227154"/>
                </p:ext>
              </p:extLst>
            </p:nvPr>
          </p:nvGraphicFramePr>
          <p:xfrm>
            <a:off x="192881" y="1224367"/>
            <a:ext cx="6472238" cy="791963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Document" r:id="rId3" imgW="5386812" imgH="7942367" progId="Word.Document.12">
                    <p:embed/>
                  </p:oleObj>
                </mc:Choice>
                <mc:Fallback>
                  <p:oleObj name="Document" r:id="rId3" imgW="5386812" imgH="7942367" progId="Word.Documen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92881" y="1224367"/>
                          <a:ext cx="6472238" cy="791963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EE87960E-2B74-F500-D26F-9D4B5ABA72E0}"/>
                </a:ext>
              </a:extLst>
            </p:cNvPr>
            <p:cNvSpPr txBox="1"/>
            <p:nvPr/>
          </p:nvSpPr>
          <p:spPr>
            <a:xfrm>
              <a:off x="1927691" y="0"/>
              <a:ext cx="41804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Table S1</a:t>
              </a:r>
              <a:endPara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74480FCA-7AC7-20B6-6BC8-4F3EE657181F}"/>
                </a:ext>
              </a:extLst>
            </p:cNvPr>
            <p:cNvSpPr txBox="1"/>
            <p:nvPr/>
          </p:nvSpPr>
          <p:spPr>
            <a:xfrm>
              <a:off x="-125260" y="461665"/>
              <a:ext cx="698326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LE activities of hormones, antioxidants, polyphenols, and plant and bacterial exudates on </a:t>
              </a:r>
              <a:r>
                <a:rPr kumimoji="1" lang="en-US" altLang="ja-JP" b="1" dirty="0" err="1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Fa</a:t>
              </a:r>
              <a:r>
                <a:rPr kumimoji="1" lang="en-US" altLang="ja-JP" b="1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nd HPLF cells.</a:t>
              </a:r>
              <a:endParaRPr kumimoji="1" lang="ja-JP" altLang="en-US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61102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01</TotalTime>
  <Words>650</Words>
  <Application>Microsoft Office PowerPoint</Application>
  <PresentationFormat>On-screen Show (4:3)</PresentationFormat>
  <Paragraphs>307</Paragraphs>
  <Slides>6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游ゴシック</vt:lpstr>
      <vt:lpstr>游ゴシック</vt:lpstr>
      <vt:lpstr>游明朝</vt:lpstr>
      <vt:lpstr>Arial</vt:lpstr>
      <vt:lpstr>Calibri</vt:lpstr>
      <vt:lpstr>Calibri Light</vt:lpstr>
      <vt:lpstr>Office テーマ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宏 坂上</dc:creator>
  <cp:lastModifiedBy>MDPI</cp:lastModifiedBy>
  <cp:revision>15</cp:revision>
  <dcterms:created xsi:type="dcterms:W3CDTF">2025-12-18T21:38:39Z</dcterms:created>
  <dcterms:modified xsi:type="dcterms:W3CDTF">2026-03-30T03:57:35Z</dcterms:modified>
</cp:coreProperties>
</file>